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67" r:id="rId3"/>
    <p:sldId id="265" r:id="rId4"/>
    <p:sldId id="260" r:id="rId5"/>
    <p:sldId id="261" r:id="rId6"/>
    <p:sldId id="268" r:id="rId7"/>
    <p:sldId id="256" r:id="rId8"/>
    <p:sldId id="257"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75" autoAdjust="0"/>
    <p:restoredTop sz="94660"/>
  </p:normalViewPr>
  <p:slideViewPr>
    <p:cSldViewPr snapToGrid="0">
      <p:cViewPr varScale="1">
        <p:scale>
          <a:sx n="49" d="100"/>
          <a:sy n="49" d="100"/>
        </p:scale>
        <p:origin x="797"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charts/_rels/chart1.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C:\Users\jstone\OneDrive%20-%20MRIGlobal\My%20Documents\Proposals\2021_DBPAO%20Biomeme%20Variant%20Panel\Publication\figures%20and%20tables\RADx%20Summary%20Results_COMPLETE.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C:\Users\jstone\OneDrive%20-%20MRIGlobal\My%20Documents\Proposals\2021_DBPAO%20Biomeme%20Variant%20Panel\Publication\figures%20and%20tables\NHRC%20Biomeme%20Triplex%20Validation%20Panel.xlsx" TargetMode="External"/><Relationship Id="rId2" Type="http://schemas.microsoft.com/office/2011/relationships/chartColorStyle" Target="colors11.xml"/><Relationship Id="rId1" Type="http://schemas.microsoft.com/office/2011/relationships/chartStyle" Target="style1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C:\Users\jstone\Desktop\BVP-014_Omicron%20Twist%20RNA.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Triplex 2</a:t>
            </a:r>
            <a:r>
              <a:rPr lang="en-US" baseline="0" dirty="0"/>
              <a:t> S:69/70del</a:t>
            </a:r>
            <a:endParaRPr lang="en-US"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62C!$A$27</c:f>
              <c:strCache>
                <c:ptCount val="1"/>
                <c:pt idx="0">
                  <c:v>NTC</c:v>
                </c:pt>
              </c:strCache>
            </c:strRef>
          </c:tx>
          <c:spPr>
            <a:ln w="28575" cap="rnd">
              <a:solidFill>
                <a:schemeClr val="accent1"/>
              </a:solidFill>
              <a:round/>
            </a:ln>
            <a:effectLst/>
          </c:spPr>
          <c:marker>
            <c:symbol val="none"/>
          </c:marker>
          <c:val>
            <c:numRef>
              <c:f>Triplex2_62C!$B$27:$AT$27</c:f>
              <c:numCache>
                <c:formatCode>General</c:formatCode>
                <c:ptCount val="45"/>
                <c:pt idx="0">
                  <c:v>-24.93955350093529</c:v>
                </c:pt>
                <c:pt idx="1">
                  <c:v>-20.858463048787598</c:v>
                </c:pt>
                <c:pt idx="2">
                  <c:v>-17.222629154182869</c:v>
                </c:pt>
                <c:pt idx="3">
                  <c:v>-14.350325495870493</c:v>
                </c:pt>
                <c:pt idx="4">
                  <c:v>-12.342207587933444</c:v>
                </c:pt>
                <c:pt idx="5">
                  <c:v>-10.973322864405418</c:v>
                </c:pt>
                <c:pt idx="6">
                  <c:v>-9.7072513928906119</c:v>
                </c:pt>
                <c:pt idx="7">
                  <c:v>-8.0483133201269084</c:v>
                </c:pt>
                <c:pt idx="8">
                  <c:v>-6.014377842147951</c:v>
                </c:pt>
                <c:pt idx="9">
                  <c:v>-4.0560306246024993</c:v>
                </c:pt>
                <c:pt idx="10">
                  <c:v>-2.433224687092661</c:v>
                </c:pt>
                <c:pt idx="11">
                  <c:v>-0.96137794203423255</c:v>
                </c:pt>
                <c:pt idx="12">
                  <c:v>0.61311077382742951</c:v>
                </c:pt>
                <c:pt idx="13">
                  <c:v>2.2754489306025789</c:v>
                </c:pt>
                <c:pt idx="14">
                  <c:v>3.763308741068613</c:v>
                </c:pt>
                <c:pt idx="15">
                  <c:v>4.7241175811941503</c:v>
                </c:pt>
                <c:pt idx="16">
                  <c:v>4.9642866099675302</c:v>
                </c:pt>
                <c:pt idx="17">
                  <c:v>4.6374412260411191</c:v>
                </c:pt>
                <c:pt idx="18">
                  <c:v>4.0931620531355293</c:v>
                </c:pt>
                <c:pt idx="19">
                  <c:v>3.6116894570495788</c:v>
                </c:pt>
                <c:pt idx="20">
                  <c:v>3.321307719385004</c:v>
                </c:pt>
                <c:pt idx="21">
                  <c:v>3.2815948158859101</c:v>
                </c:pt>
                <c:pt idx="22">
                  <c:v>3.5306606317899423</c:v>
                </c:pt>
                <c:pt idx="23">
                  <c:v>3.9352377036120743</c:v>
                </c:pt>
                <c:pt idx="24">
                  <c:v>4.168823050962601</c:v>
                </c:pt>
                <c:pt idx="25">
                  <c:v>4.0313858853260172</c:v>
                </c:pt>
                <c:pt idx="26">
                  <c:v>3.6205540945520625</c:v>
                </c:pt>
                <c:pt idx="27">
                  <c:v>3.1868566226912662</c:v>
                </c:pt>
                <c:pt idx="28">
                  <c:v>3.017623382522288</c:v>
                </c:pt>
                <c:pt idx="29">
                  <c:v>3.2460956999821065</c:v>
                </c:pt>
                <c:pt idx="30">
                  <c:v>3.6027762218927819</c:v>
                </c:pt>
                <c:pt idx="31">
                  <c:v>3.5823507966288162</c:v>
                </c:pt>
                <c:pt idx="32">
                  <c:v>2.9156805780112336</c:v>
                </c:pt>
                <c:pt idx="33">
                  <c:v>1.8079467849711364</c:v>
                </c:pt>
                <c:pt idx="34">
                  <c:v>0.72346451554585656</c:v>
                </c:pt>
                <c:pt idx="35">
                  <c:v>-9.0371908492670627E-2</c:v>
                </c:pt>
                <c:pt idx="36">
                  <c:v>-0.79856569923504139</c:v>
                </c:pt>
                <c:pt idx="37">
                  <c:v>-1.573128084100972</c:v>
                </c:pt>
                <c:pt idx="38">
                  <c:v>-2.2432757058049901</c:v>
                </c:pt>
                <c:pt idx="39">
                  <c:v>-2.6622197647193389</c:v>
                </c:pt>
                <c:pt idx="40">
                  <c:v>-3.0328352157448535</c:v>
                </c:pt>
                <c:pt idx="41">
                  <c:v>-3.6605440825132973</c:v>
                </c:pt>
                <c:pt idx="42">
                  <c:v>-4.8061417427798006</c:v>
                </c:pt>
                <c:pt idx="43">
                  <c:v>-6.6312042071240285</c:v>
                </c:pt>
                <c:pt idx="44">
                  <c:v>-8.9627387928303506</c:v>
                </c:pt>
              </c:numCache>
            </c:numRef>
          </c:val>
          <c:smooth val="0"/>
          <c:extLst>
            <c:ext xmlns:c16="http://schemas.microsoft.com/office/drawing/2014/chart" uri="{C3380CC4-5D6E-409C-BE32-E72D297353CC}">
              <c16:uniqueId val="{00000000-5C2A-483D-BE16-7C84262F9E2B}"/>
            </c:ext>
          </c:extLst>
        </c:ser>
        <c:ser>
          <c:idx val="1"/>
          <c:order val="1"/>
          <c:tx>
            <c:strRef>
              <c:f>Triplex2_62C!$A$30</c:f>
              <c:strCache>
                <c:ptCount val="1"/>
                <c:pt idx="0">
                  <c:v>50 copies</c:v>
                </c:pt>
              </c:strCache>
            </c:strRef>
          </c:tx>
          <c:spPr>
            <a:ln w="28575" cap="rnd">
              <a:solidFill>
                <a:schemeClr val="accent2"/>
              </a:solidFill>
              <a:round/>
            </a:ln>
            <a:effectLst/>
          </c:spPr>
          <c:marker>
            <c:symbol val="none"/>
          </c:marker>
          <c:val>
            <c:numRef>
              <c:f>Triplex2_62C!$B$30:$AT$30</c:f>
              <c:numCache>
                <c:formatCode>General</c:formatCode>
                <c:ptCount val="45"/>
                <c:pt idx="0">
                  <c:v>-6.9352301711642212</c:v>
                </c:pt>
                <c:pt idx="1">
                  <c:v>-3.8418768625633675</c:v>
                </c:pt>
                <c:pt idx="2">
                  <c:v>-1.8189310751295125</c:v>
                </c:pt>
                <c:pt idx="3">
                  <c:v>-1.1752771473074972</c:v>
                </c:pt>
                <c:pt idx="4">
                  <c:v>-1.3624682048957766</c:v>
                </c:pt>
                <c:pt idx="5">
                  <c:v>-1.5657697463811928</c:v>
                </c:pt>
                <c:pt idx="6">
                  <c:v>-1.3248555296322593</c:v>
                </c:pt>
                <c:pt idx="7">
                  <c:v>-0.69070732514956035</c:v>
                </c:pt>
                <c:pt idx="8">
                  <c:v>-2.9015741514740512E-2</c:v>
                </c:pt>
                <c:pt idx="9">
                  <c:v>0.29748815031780396</c:v>
                </c:pt>
                <c:pt idx="10">
                  <c:v>0.25314420597351273</c:v>
                </c:pt>
                <c:pt idx="11">
                  <c:v>0.1845150644385285</c:v>
                </c:pt>
                <c:pt idx="12">
                  <c:v>0.42568230430333642</c:v>
                </c:pt>
                <c:pt idx="13">
                  <c:v>0.91909032038893201</c:v>
                </c:pt>
                <c:pt idx="14">
                  <c:v>1.3465162827596941</c:v>
                </c:pt>
                <c:pt idx="15">
                  <c:v>1.4852808312007255</c:v>
                </c:pt>
                <c:pt idx="16">
                  <c:v>1.2934031181321188</c:v>
                </c:pt>
                <c:pt idx="17">
                  <c:v>0.82253556343857781</c:v>
                </c:pt>
                <c:pt idx="18">
                  <c:v>0.2290809788628394</c:v>
                </c:pt>
                <c:pt idx="19">
                  <c:v>-0.27223238976512221</c:v>
                </c:pt>
                <c:pt idx="20">
                  <c:v>-0.54118869161175098</c:v>
                </c:pt>
                <c:pt idx="21">
                  <c:v>-0.54103195786046854</c:v>
                </c:pt>
                <c:pt idx="22">
                  <c:v>-0.36626630768660107</c:v>
                </c:pt>
                <c:pt idx="23">
                  <c:v>-0.25601832642860245</c:v>
                </c:pt>
                <c:pt idx="24">
                  <c:v>-0.37011673250708554</c:v>
                </c:pt>
                <c:pt idx="25">
                  <c:v>-0.5935717296488292</c:v>
                </c:pt>
                <c:pt idx="26">
                  <c:v>-0.70596234165350324</c:v>
                </c:pt>
                <c:pt idx="27">
                  <c:v>-0.5130846128322446</c:v>
                </c:pt>
                <c:pt idx="28">
                  <c:v>0.40132159302993387</c:v>
                </c:pt>
                <c:pt idx="29">
                  <c:v>3.0274053306675341</c:v>
                </c:pt>
                <c:pt idx="30">
                  <c:v>9.0798366828057624</c:v>
                </c:pt>
                <c:pt idx="31">
                  <c:v>20.537872631359278</c:v>
                </c:pt>
                <c:pt idx="32">
                  <c:v>38.412470638073501</c:v>
                </c:pt>
                <c:pt idx="33">
                  <c:v>61.702520493814518</c:v>
                </c:pt>
                <c:pt idx="34">
                  <c:v>87.582143045621706</c:v>
                </c:pt>
                <c:pt idx="35">
                  <c:v>112.68091706822634</c:v>
                </c:pt>
                <c:pt idx="36">
                  <c:v>134.48172091234665</c:v>
                </c:pt>
                <c:pt idx="37">
                  <c:v>151.88161196301735</c:v>
                </c:pt>
                <c:pt idx="38">
                  <c:v>164.92818761963645</c:v>
                </c:pt>
                <c:pt idx="39">
                  <c:v>174.33255575315161</c:v>
                </c:pt>
                <c:pt idx="40">
                  <c:v>180.99977115413276</c:v>
                </c:pt>
                <c:pt idx="41">
                  <c:v>185.75913413566013</c:v>
                </c:pt>
                <c:pt idx="42">
                  <c:v>189.37136894519972</c:v>
                </c:pt>
                <c:pt idx="43">
                  <c:v>192.49781856236768</c:v>
                </c:pt>
                <c:pt idx="44">
                  <c:v>195.50750340618288</c:v>
                </c:pt>
              </c:numCache>
            </c:numRef>
          </c:val>
          <c:smooth val="0"/>
          <c:extLst>
            <c:ext xmlns:c16="http://schemas.microsoft.com/office/drawing/2014/chart" uri="{C3380CC4-5D6E-409C-BE32-E72D297353CC}">
              <c16:uniqueId val="{00000001-5C2A-483D-BE16-7C84262F9E2B}"/>
            </c:ext>
          </c:extLst>
        </c:ser>
        <c:ser>
          <c:idx val="2"/>
          <c:order val="2"/>
          <c:tx>
            <c:strRef>
              <c:f>Triplex2_62C!$A$33</c:f>
              <c:strCache>
                <c:ptCount val="1"/>
                <c:pt idx="0">
                  <c:v>50 copies</c:v>
                </c:pt>
              </c:strCache>
            </c:strRef>
          </c:tx>
          <c:spPr>
            <a:ln w="28575" cap="rnd">
              <a:solidFill>
                <a:schemeClr val="accent3"/>
              </a:solidFill>
              <a:round/>
            </a:ln>
            <a:effectLst/>
          </c:spPr>
          <c:marker>
            <c:symbol val="none"/>
          </c:marker>
          <c:val>
            <c:numRef>
              <c:f>Triplex2_62C!$B$33:$AT$33</c:f>
              <c:numCache>
                <c:formatCode>General</c:formatCode>
                <c:ptCount val="45"/>
                <c:pt idx="0">
                  <c:v>-6.6416443868256465</c:v>
                </c:pt>
                <c:pt idx="1">
                  <c:v>-3.0744477189891768</c:v>
                </c:pt>
                <c:pt idx="2">
                  <c:v>-0.53467208209622186</c:v>
                </c:pt>
                <c:pt idx="3">
                  <c:v>0.61397325222424115</c:v>
                </c:pt>
                <c:pt idx="4">
                  <c:v>0.7349098978429538</c:v>
                </c:pt>
                <c:pt idx="5">
                  <c:v>0.49186335542617599</c:v>
                </c:pt>
                <c:pt idx="6">
                  <c:v>0.33027224165562075</c:v>
                </c:pt>
                <c:pt idx="7">
                  <c:v>0.25331304091014317</c:v>
                </c:pt>
                <c:pt idx="8">
                  <c:v>0.13135139805126528</c:v>
                </c:pt>
                <c:pt idx="9">
                  <c:v>3.1950989297911292E-2</c:v>
                </c:pt>
                <c:pt idx="10">
                  <c:v>6.2354032301300322E-2</c:v>
                </c:pt>
                <c:pt idx="11">
                  <c:v>0.1624642212937033</c:v>
                </c:pt>
                <c:pt idx="12">
                  <c:v>0.1951849888828292</c:v>
                </c:pt>
                <c:pt idx="13">
                  <c:v>0.11092208276568272</c:v>
                </c:pt>
                <c:pt idx="14">
                  <c:v>-5.2438103539316216E-3</c:v>
                </c:pt>
                <c:pt idx="15">
                  <c:v>-8.7077939600931131E-2</c:v>
                </c:pt>
                <c:pt idx="16">
                  <c:v>-0.21770624997225241</c:v>
                </c:pt>
                <c:pt idx="17">
                  <c:v>-0.48047664893056208</c:v>
                </c:pt>
                <c:pt idx="18">
                  <c:v>-0.78803649089786632</c:v>
                </c:pt>
                <c:pt idx="19">
                  <c:v>-0.96641569336679822</c:v>
                </c:pt>
                <c:pt idx="20">
                  <c:v>-0.93553729176346678</c:v>
                </c:pt>
                <c:pt idx="21">
                  <c:v>-0.74008786266495008</c:v>
                </c:pt>
                <c:pt idx="22">
                  <c:v>-0.45202769265415554</c:v>
                </c:pt>
                <c:pt idx="23">
                  <c:v>-0.11064887917746091</c:v>
                </c:pt>
                <c:pt idx="24">
                  <c:v>0.24814079561292601</c:v>
                </c:pt>
                <c:pt idx="25">
                  <c:v>0.58120006205535901</c:v>
                </c:pt>
                <c:pt idx="26">
                  <c:v>0.88759753702106536</c:v>
                </c:pt>
                <c:pt idx="27">
                  <c:v>1.2966438141320396</c:v>
                </c:pt>
                <c:pt idx="28">
                  <c:v>2.3316606319949642</c:v>
                </c:pt>
                <c:pt idx="29">
                  <c:v>5.2067074893457175</c:v>
                </c:pt>
                <c:pt idx="30">
                  <c:v>11.834938232515924</c:v>
                </c:pt>
                <c:pt idx="31">
                  <c:v>24.552928312388758</c:v>
                </c:pt>
                <c:pt idx="32">
                  <c:v>45.213751412127749</c:v>
                </c:pt>
                <c:pt idx="33">
                  <c:v>73.635921489083557</c:v>
                </c:pt>
                <c:pt idx="34">
                  <c:v>106.90995029547776</c:v>
                </c:pt>
                <c:pt idx="35">
                  <c:v>140.62661438870055</c:v>
                </c:pt>
                <c:pt idx="36">
                  <c:v>170.98375674324234</c:v>
                </c:pt>
                <c:pt idx="37">
                  <c:v>196.06362355564488</c:v>
                </c:pt>
                <c:pt idx="38">
                  <c:v>215.74429080102345</c:v>
                </c:pt>
                <c:pt idx="39">
                  <c:v>230.91597283798546</c:v>
                </c:pt>
                <c:pt idx="40">
                  <c:v>242.79457910118981</c:v>
                </c:pt>
                <c:pt idx="41">
                  <c:v>252.51246068612454</c:v>
                </c:pt>
                <c:pt idx="42">
                  <c:v>260.82127947550725</c:v>
                </c:pt>
                <c:pt idx="43">
                  <c:v>268.10430540046218</c:v>
                </c:pt>
                <c:pt idx="44">
                  <c:v>274.74044578077337</c:v>
                </c:pt>
              </c:numCache>
            </c:numRef>
          </c:val>
          <c:smooth val="0"/>
          <c:extLst>
            <c:ext xmlns:c16="http://schemas.microsoft.com/office/drawing/2014/chart" uri="{C3380CC4-5D6E-409C-BE32-E72D297353CC}">
              <c16:uniqueId val="{00000002-5C2A-483D-BE16-7C84262F9E2B}"/>
            </c:ext>
          </c:extLst>
        </c:ser>
        <c:ser>
          <c:idx val="3"/>
          <c:order val="3"/>
          <c:tx>
            <c:strRef>
              <c:f>Triplex2_62C!$A$36</c:f>
              <c:strCache>
                <c:ptCount val="1"/>
                <c:pt idx="0">
                  <c:v>500 copies</c:v>
                </c:pt>
              </c:strCache>
            </c:strRef>
          </c:tx>
          <c:spPr>
            <a:ln w="28575" cap="rnd">
              <a:solidFill>
                <a:schemeClr val="accent4"/>
              </a:solidFill>
              <a:round/>
            </a:ln>
            <a:effectLst/>
          </c:spPr>
          <c:marker>
            <c:symbol val="none"/>
          </c:marker>
          <c:val>
            <c:numRef>
              <c:f>Triplex2_62C!$B$36:$AT$36</c:f>
              <c:numCache>
                <c:formatCode>General</c:formatCode>
                <c:ptCount val="45"/>
                <c:pt idx="0">
                  <c:v>-0.46230272792854521</c:v>
                </c:pt>
                <c:pt idx="1">
                  <c:v>-0.74629961212667695</c:v>
                </c:pt>
                <c:pt idx="2">
                  <c:v>-0.88882664150150958</c:v>
                </c:pt>
                <c:pt idx="3">
                  <c:v>-0.87370701053077937</c:v>
                </c:pt>
                <c:pt idx="4">
                  <c:v>-0.73274635097550345</c:v>
                </c:pt>
                <c:pt idx="5">
                  <c:v>-0.46698624263081001</c:v>
                </c:pt>
                <c:pt idx="6">
                  <c:v>-9.7811013763930532E-2</c:v>
                </c:pt>
                <c:pt idx="7">
                  <c:v>0.27343164645026263</c:v>
                </c:pt>
                <c:pt idx="8">
                  <c:v>0.51906990568022593</c:v>
                </c:pt>
                <c:pt idx="9">
                  <c:v>0.57696517750628118</c:v>
                </c:pt>
                <c:pt idx="10">
                  <c:v>0.4579539697006112</c:v>
                </c:pt>
                <c:pt idx="11">
                  <c:v>0.21728801745121018</c:v>
                </c:pt>
                <c:pt idx="12">
                  <c:v>-5.6006691378570395E-2</c:v>
                </c:pt>
                <c:pt idx="13">
                  <c:v>-0.26848532617805176</c:v>
                </c:pt>
                <c:pt idx="14">
                  <c:v>-0.38281785385152034</c:v>
                </c:pt>
                <c:pt idx="15">
                  <c:v>-0.43532504998802324</c:v>
                </c:pt>
                <c:pt idx="16">
                  <c:v>-0.45563290850986959</c:v>
                </c:pt>
                <c:pt idx="17">
                  <c:v>-0.41591311755291827</c:v>
                </c:pt>
                <c:pt idx="18">
                  <c:v>-0.31481263291243522</c:v>
                </c:pt>
                <c:pt idx="19">
                  <c:v>-0.22540857522290025</c:v>
                </c:pt>
                <c:pt idx="20">
                  <c:v>-0.17900752363129868</c:v>
                </c:pt>
                <c:pt idx="21">
                  <c:v>-5.8351749979919987E-2</c:v>
                </c:pt>
                <c:pt idx="22">
                  <c:v>0.31243492505200265</c:v>
                </c:pt>
                <c:pt idx="23">
                  <c:v>0.99941504379421531</c:v>
                </c:pt>
                <c:pt idx="24">
                  <c:v>2.03283675338389</c:v>
                </c:pt>
                <c:pt idx="25">
                  <c:v>3.766324452994013</c:v>
                </c:pt>
                <c:pt idx="26">
                  <c:v>7.2297058188069059</c:v>
                </c:pt>
                <c:pt idx="27">
                  <c:v>14.125951372921918</c:v>
                </c:pt>
                <c:pt idx="28">
                  <c:v>26.205488488858464</c:v>
                </c:pt>
                <c:pt idx="29">
                  <c:v>44.192903345925515</c:v>
                </c:pt>
                <c:pt idx="30">
                  <c:v>67.067514133632358</c:v>
                </c:pt>
                <c:pt idx="31">
                  <c:v>92.390057991824506</c:v>
                </c:pt>
                <c:pt idx="32">
                  <c:v>117.35216129331457</c:v>
                </c:pt>
                <c:pt idx="33">
                  <c:v>139.72275722653285</c:v>
                </c:pt>
                <c:pt idx="34">
                  <c:v>158.35102125628509</c:v>
                </c:pt>
                <c:pt idx="35">
                  <c:v>173.21927267850515</c:v>
                </c:pt>
                <c:pt idx="36">
                  <c:v>185.05593921407853</c:v>
                </c:pt>
                <c:pt idx="37">
                  <c:v>194.79028561682389</c:v>
                </c:pt>
                <c:pt idx="38">
                  <c:v>203.22544924733484</c:v>
                </c:pt>
                <c:pt idx="39">
                  <c:v>210.91346731374142</c:v>
                </c:pt>
                <c:pt idx="40">
                  <c:v>218.11397210182076</c:v>
                </c:pt>
                <c:pt idx="41">
                  <c:v>224.82211178634861</c:v>
                </c:pt>
                <c:pt idx="42">
                  <c:v>230.86208681231983</c:v>
                </c:pt>
                <c:pt idx="43">
                  <c:v>236.13209228766209</c:v>
                </c:pt>
                <c:pt idx="44">
                  <c:v>240.85425801598831</c:v>
                </c:pt>
              </c:numCache>
            </c:numRef>
          </c:val>
          <c:smooth val="0"/>
          <c:extLst>
            <c:ext xmlns:c16="http://schemas.microsoft.com/office/drawing/2014/chart" uri="{C3380CC4-5D6E-409C-BE32-E72D297353CC}">
              <c16:uniqueId val="{00000003-5C2A-483D-BE16-7C84262F9E2B}"/>
            </c:ext>
          </c:extLst>
        </c:ser>
        <c:ser>
          <c:idx val="4"/>
          <c:order val="4"/>
          <c:tx>
            <c:strRef>
              <c:f>Triplex2_62C!$A$39</c:f>
              <c:strCache>
                <c:ptCount val="1"/>
                <c:pt idx="0">
                  <c:v>500 copies</c:v>
                </c:pt>
              </c:strCache>
            </c:strRef>
          </c:tx>
          <c:spPr>
            <a:ln w="28575" cap="rnd">
              <a:solidFill>
                <a:schemeClr val="accent5"/>
              </a:solidFill>
              <a:round/>
            </a:ln>
            <a:effectLst/>
          </c:spPr>
          <c:marker>
            <c:symbol val="none"/>
          </c:marker>
          <c:val>
            <c:numRef>
              <c:f>Triplex2_62C!$B$39:$AT$39</c:f>
              <c:numCache>
                <c:formatCode>General</c:formatCode>
                <c:ptCount val="45"/>
                <c:pt idx="0">
                  <c:v>4.2240366652276862</c:v>
                </c:pt>
                <c:pt idx="1">
                  <c:v>3.0191624928374949</c:v>
                </c:pt>
                <c:pt idx="2">
                  <c:v>2.0309912319880823</c:v>
                </c:pt>
                <c:pt idx="3">
                  <c:v>1.3430812841779698</c:v>
                </c:pt>
                <c:pt idx="4">
                  <c:v>0.96567707119356783</c:v>
                </c:pt>
                <c:pt idx="5">
                  <c:v>0.90678057175864524</c:v>
                </c:pt>
                <c:pt idx="6">
                  <c:v>1.1431438831514242</c:v>
                </c:pt>
                <c:pt idx="7">
                  <c:v>1.5696525628281961</c:v>
                </c:pt>
                <c:pt idx="8">
                  <c:v>1.9317582233543362</c:v>
                </c:pt>
                <c:pt idx="9">
                  <c:v>1.7550018617093883</c:v>
                </c:pt>
                <c:pt idx="10">
                  <c:v>0.62939783004912897</c:v>
                </c:pt>
                <c:pt idx="11">
                  <c:v>-1.1397370607628545</c:v>
                </c:pt>
                <c:pt idx="12">
                  <c:v>-2.6169734571121808</c:v>
                </c:pt>
                <c:pt idx="13">
                  <c:v>-3.186267645265616</c:v>
                </c:pt>
                <c:pt idx="14">
                  <c:v>-2.9118127262081543</c:v>
                </c:pt>
                <c:pt idx="15">
                  <c:v>-2.1562765199287242</c:v>
                </c:pt>
                <c:pt idx="16">
                  <c:v>-1.2966472105072171</c:v>
                </c:pt>
                <c:pt idx="17">
                  <c:v>-0.57763572637668403</c:v>
                </c:pt>
                <c:pt idx="18">
                  <c:v>-3.9758717524819076E-2</c:v>
                </c:pt>
                <c:pt idx="19">
                  <c:v>0.39527957275095105</c:v>
                </c:pt>
                <c:pt idx="20">
                  <c:v>0.80001115024606406</c:v>
                </c:pt>
                <c:pt idx="21">
                  <c:v>1.1885368551684223</c:v>
                </c:pt>
                <c:pt idx="22">
                  <c:v>1.5671603573537141</c:v>
                </c:pt>
                <c:pt idx="23">
                  <c:v>2.0383861952996085</c:v>
                </c:pt>
                <c:pt idx="24">
                  <c:v>2.9320601300078124</c:v>
                </c:pt>
                <c:pt idx="25">
                  <c:v>5.0377889714072808</c:v>
                </c:pt>
                <c:pt idx="26">
                  <c:v>9.8786909925674991</c:v>
                </c:pt>
                <c:pt idx="27">
                  <c:v>19.718925732122443</c:v>
                </c:pt>
                <c:pt idx="28">
                  <c:v>36.905758370730837</c:v>
                </c:pt>
                <c:pt idx="29">
                  <c:v>62.491882629121392</c:v>
                </c:pt>
                <c:pt idx="30">
                  <c:v>94.990721557927827</c:v>
                </c:pt>
                <c:pt idx="31">
                  <c:v>130.55665683269581</c:v>
                </c:pt>
                <c:pt idx="32">
                  <c:v>164.73667941723579</c:v>
                </c:pt>
                <c:pt idx="33">
                  <c:v>194.39707147064109</c:v>
                </c:pt>
                <c:pt idx="34">
                  <c:v>218.48210834230304</c:v>
                </c:pt>
                <c:pt idx="35">
                  <c:v>237.58736325545578</c:v>
                </c:pt>
                <c:pt idx="36">
                  <c:v>253.08515331210583</c:v>
                </c:pt>
                <c:pt idx="37">
                  <c:v>266.3267987706804</c:v>
                </c:pt>
                <c:pt idx="38">
                  <c:v>278.20455425688488</c:v>
                </c:pt>
                <c:pt idx="39">
                  <c:v>289.1367652284589</c:v>
                </c:pt>
                <c:pt idx="40">
                  <c:v>299.23322312009805</c:v>
                </c:pt>
                <c:pt idx="41">
                  <c:v>308.44840190122159</c:v>
                </c:pt>
                <c:pt idx="42">
                  <c:v>316.74834343006296</c:v>
                </c:pt>
                <c:pt idx="43">
                  <c:v>324.26645012996414</c:v>
                </c:pt>
                <c:pt idx="44">
                  <c:v>331.32276631740206</c:v>
                </c:pt>
              </c:numCache>
            </c:numRef>
          </c:val>
          <c:smooth val="0"/>
          <c:extLst>
            <c:ext xmlns:c16="http://schemas.microsoft.com/office/drawing/2014/chart" uri="{C3380CC4-5D6E-409C-BE32-E72D297353CC}">
              <c16:uniqueId val="{00000004-5C2A-483D-BE16-7C84262F9E2B}"/>
            </c:ext>
          </c:extLst>
        </c:ser>
        <c:ser>
          <c:idx val="5"/>
          <c:order val="5"/>
          <c:tx>
            <c:strRef>
              <c:f>Triplex2_62C!$A$42</c:f>
              <c:strCache>
                <c:ptCount val="1"/>
                <c:pt idx="0">
                  <c:v>5,000 copies</c:v>
                </c:pt>
              </c:strCache>
            </c:strRef>
          </c:tx>
          <c:spPr>
            <a:ln w="28575" cap="rnd">
              <a:solidFill>
                <a:schemeClr val="accent6"/>
              </a:solidFill>
              <a:round/>
            </a:ln>
            <a:effectLst/>
          </c:spPr>
          <c:marker>
            <c:symbol val="none"/>
          </c:marker>
          <c:val>
            <c:numRef>
              <c:f>Triplex2_62C!$B$42:$AT$42</c:f>
              <c:numCache>
                <c:formatCode>General</c:formatCode>
                <c:ptCount val="45"/>
                <c:pt idx="0">
                  <c:v>-3.9829364649558556</c:v>
                </c:pt>
                <c:pt idx="1">
                  <c:v>-2.6904689855382458</c:v>
                </c:pt>
                <c:pt idx="2">
                  <c:v>-1.7057774895929469</c:v>
                </c:pt>
                <c:pt idx="3">
                  <c:v>-1.0974953113454831</c:v>
                </c:pt>
                <c:pt idx="4">
                  <c:v>-0.74893542765312304</c:v>
                </c:pt>
                <c:pt idx="5">
                  <c:v>-0.5012869968850282</c:v>
                </c:pt>
                <c:pt idx="6">
                  <c:v>-0.25708681757714658</c:v>
                </c:pt>
                <c:pt idx="7">
                  <c:v>-3.7572234039544128E-2</c:v>
                </c:pt>
                <c:pt idx="8">
                  <c:v>0.10172622532081732</c:v>
                </c:pt>
                <c:pt idx="9">
                  <c:v>0.17890977828392352</c:v>
                </c:pt>
                <c:pt idx="10">
                  <c:v>0.2384307410375186</c:v>
                </c:pt>
                <c:pt idx="11">
                  <c:v>0.27309194411100179</c:v>
                </c:pt>
                <c:pt idx="12">
                  <c:v>0.25830639155719837</c:v>
                </c:pt>
                <c:pt idx="13">
                  <c:v>0.20003165402704326</c:v>
                </c:pt>
                <c:pt idx="14">
                  <c:v>0.12535088579898002</c:v>
                </c:pt>
                <c:pt idx="15">
                  <c:v>5.6864781074182247E-2</c:v>
                </c:pt>
                <c:pt idx="16">
                  <c:v>-6.903137144036009E-3</c:v>
                </c:pt>
                <c:pt idx="17">
                  <c:v>-8.8054268368068733E-2</c:v>
                </c:pt>
                <c:pt idx="18">
                  <c:v>-0.19110500965507526</c:v>
                </c:pt>
                <c:pt idx="19">
                  <c:v>-0.25301428856801067</c:v>
                </c:pt>
                <c:pt idx="20">
                  <c:v>-9.7689649002859369E-2</c:v>
                </c:pt>
                <c:pt idx="21">
                  <c:v>0.63490147442098532</c:v>
                </c:pt>
                <c:pt idx="22">
                  <c:v>2.6408945957573451</c:v>
                </c:pt>
                <c:pt idx="23">
                  <c:v>7.101651602793936</c:v>
                </c:pt>
                <c:pt idx="24">
                  <c:v>15.506900720052727</c:v>
                </c:pt>
                <c:pt idx="25">
                  <c:v>28.963532489318823</c:v>
                </c:pt>
                <c:pt idx="26">
                  <c:v>47.324806610962696</c:v>
                </c:pt>
                <c:pt idx="27">
                  <c:v>68.881193493649334</c:v>
                </c:pt>
                <c:pt idx="28">
                  <c:v>91.028643965628362</c:v>
                </c:pt>
                <c:pt idx="29">
                  <c:v>111.36389746774876</c:v>
                </c:pt>
                <c:pt idx="30">
                  <c:v>128.43145623073906</c:v>
                </c:pt>
                <c:pt idx="31">
                  <c:v>141.96558546706365</c:v>
                </c:pt>
                <c:pt idx="32">
                  <c:v>152.63131138883728</c:v>
                </c:pt>
                <c:pt idx="33">
                  <c:v>161.38216831660611</c:v>
                </c:pt>
                <c:pt idx="34">
                  <c:v>168.96794262846561</c:v>
                </c:pt>
                <c:pt idx="35">
                  <c:v>175.83585658858465</c:v>
                </c:pt>
                <c:pt idx="36">
                  <c:v>182.20079458877444</c:v>
                </c:pt>
                <c:pt idx="37">
                  <c:v>188.17181290990811</c:v>
                </c:pt>
                <c:pt idx="38">
                  <c:v>193.85754180414369</c:v>
                </c:pt>
                <c:pt idx="39">
                  <c:v>199.32873961184123</c:v>
                </c:pt>
                <c:pt idx="40">
                  <c:v>204.56459384972186</c:v>
                </c:pt>
                <c:pt idx="41">
                  <c:v>209.54782062731647</c:v>
                </c:pt>
                <c:pt idx="42">
                  <c:v>214.34292732610811</c:v>
                </c:pt>
                <c:pt idx="43">
                  <c:v>219.03209252126544</c:v>
                </c:pt>
                <c:pt idx="44">
                  <c:v>223.66469826482898</c:v>
                </c:pt>
              </c:numCache>
            </c:numRef>
          </c:val>
          <c:smooth val="0"/>
          <c:extLst>
            <c:ext xmlns:c16="http://schemas.microsoft.com/office/drawing/2014/chart" uri="{C3380CC4-5D6E-409C-BE32-E72D297353CC}">
              <c16:uniqueId val="{00000005-5C2A-483D-BE16-7C84262F9E2B}"/>
            </c:ext>
          </c:extLst>
        </c:ser>
        <c:ser>
          <c:idx val="6"/>
          <c:order val="6"/>
          <c:tx>
            <c:strRef>
              <c:f>Triplex2_62C!$A$45</c:f>
              <c:strCache>
                <c:ptCount val="1"/>
                <c:pt idx="0">
                  <c:v>5,000 copies</c:v>
                </c:pt>
              </c:strCache>
            </c:strRef>
          </c:tx>
          <c:spPr>
            <a:ln w="28575" cap="rnd">
              <a:solidFill>
                <a:schemeClr val="accent1">
                  <a:lumMod val="60000"/>
                </a:schemeClr>
              </a:solidFill>
              <a:round/>
            </a:ln>
            <a:effectLst/>
          </c:spPr>
          <c:marker>
            <c:symbol val="none"/>
          </c:marker>
          <c:val>
            <c:numRef>
              <c:f>Triplex2_62C!$B$45:$AT$45</c:f>
              <c:numCache>
                <c:formatCode>General</c:formatCode>
                <c:ptCount val="45"/>
                <c:pt idx="0">
                  <c:v>1.292376926230645</c:v>
                </c:pt>
                <c:pt idx="1">
                  <c:v>0.79912955681538733</c:v>
                </c:pt>
                <c:pt idx="2">
                  <c:v>0.40517937917684321</c:v>
                </c:pt>
                <c:pt idx="3">
                  <c:v>0.13692831996195309</c:v>
                </c:pt>
                <c:pt idx="4">
                  <c:v>-2.5250844559195684E-2</c:v>
                </c:pt>
                <c:pt idx="5">
                  <c:v>-9.9250093689988717E-2</c:v>
                </c:pt>
                <c:pt idx="6">
                  <c:v>-9.5523030317053781E-2</c:v>
                </c:pt>
                <c:pt idx="7">
                  <c:v>-4.3673969341398333E-2</c:v>
                </c:pt>
                <c:pt idx="8">
                  <c:v>2.7535344584975974E-2</c:v>
                </c:pt>
                <c:pt idx="9">
                  <c:v>0.12563629857868364</c:v>
                </c:pt>
                <c:pt idx="10">
                  <c:v>0.21258628932082502</c:v>
                </c:pt>
                <c:pt idx="11">
                  <c:v>0.18189920592885755</c:v>
                </c:pt>
                <c:pt idx="12">
                  <c:v>1.8018737564489129E-2</c:v>
                </c:pt>
                <c:pt idx="13">
                  <c:v>-0.1475059971508017</c:v>
                </c:pt>
                <c:pt idx="14">
                  <c:v>-0.1848703009854944</c:v>
                </c:pt>
                <c:pt idx="15">
                  <c:v>-9.8261782755798777E-2</c:v>
                </c:pt>
                <c:pt idx="16">
                  <c:v>1.417561381640553E-2</c:v>
                </c:pt>
                <c:pt idx="17">
                  <c:v>7.8600373342851526E-2</c:v>
                </c:pt>
                <c:pt idx="18">
                  <c:v>6.7025637501501478E-2</c:v>
                </c:pt>
                <c:pt idx="19">
                  <c:v>-1.917578589382174E-2</c:v>
                </c:pt>
                <c:pt idx="20">
                  <c:v>-3.7216540496956441E-2</c:v>
                </c:pt>
                <c:pt idx="21">
                  <c:v>0.54138242948101833</c:v>
                </c:pt>
                <c:pt idx="22">
                  <c:v>2.8096841223959927</c:v>
                </c:pt>
                <c:pt idx="23">
                  <c:v>8.3635866227486986</c:v>
                </c:pt>
                <c:pt idx="24">
                  <c:v>18.992471360425043</c:v>
                </c:pt>
                <c:pt idx="25">
                  <c:v>35.992198718240616</c:v>
                </c:pt>
                <c:pt idx="26">
                  <c:v>59.194471953618631</c:v>
                </c:pt>
                <c:pt idx="27">
                  <c:v>86.558982741484215</c:v>
                </c:pt>
                <c:pt idx="28">
                  <c:v>114.91406092036596</c:v>
                </c:pt>
                <c:pt idx="29">
                  <c:v>141.21012830530344</c:v>
                </c:pt>
                <c:pt idx="30">
                  <c:v>163.47545825446286</c:v>
                </c:pt>
                <c:pt idx="31">
                  <c:v>181.29792371700751</c:v>
                </c:pt>
                <c:pt idx="32">
                  <c:v>195.56537376004781</c:v>
                </c:pt>
                <c:pt idx="33">
                  <c:v>207.54807853454986</c:v>
                </c:pt>
                <c:pt idx="34">
                  <c:v>218.18642984501639</c:v>
                </c:pt>
                <c:pt idx="35">
                  <c:v>227.92274760315922</c:v>
                </c:pt>
                <c:pt idx="36">
                  <c:v>236.86040782377859</c:v>
                </c:pt>
                <c:pt idx="37">
                  <c:v>245.12569594023989</c:v>
                </c:pt>
                <c:pt idx="38">
                  <c:v>253.01392832751844</c:v>
                </c:pt>
                <c:pt idx="39">
                  <c:v>260.7435990865888</c:v>
                </c:pt>
                <c:pt idx="40">
                  <c:v>268.33959146542838</c:v>
                </c:pt>
                <c:pt idx="41">
                  <c:v>275.69632259342325</c:v>
                </c:pt>
                <c:pt idx="42">
                  <c:v>282.58347628732008</c:v>
                </c:pt>
                <c:pt idx="43">
                  <c:v>288.84880810294271</c:v>
                </c:pt>
                <c:pt idx="44">
                  <c:v>294.66559514791697</c:v>
                </c:pt>
              </c:numCache>
            </c:numRef>
          </c:val>
          <c:smooth val="0"/>
          <c:extLst>
            <c:ext xmlns:c16="http://schemas.microsoft.com/office/drawing/2014/chart" uri="{C3380CC4-5D6E-409C-BE32-E72D297353CC}">
              <c16:uniqueId val="{00000006-5C2A-483D-BE16-7C84262F9E2B}"/>
            </c:ext>
          </c:extLst>
        </c:ser>
        <c:ser>
          <c:idx val="7"/>
          <c:order val="7"/>
          <c:tx>
            <c:strRef>
              <c:f>Triplex2_62C!$A$48</c:f>
              <c:strCache>
                <c:ptCount val="1"/>
                <c:pt idx="0">
                  <c:v>50,000 copies</c:v>
                </c:pt>
              </c:strCache>
            </c:strRef>
          </c:tx>
          <c:spPr>
            <a:ln w="28575" cap="rnd">
              <a:solidFill>
                <a:schemeClr val="accent2">
                  <a:lumMod val="60000"/>
                </a:schemeClr>
              </a:solidFill>
              <a:round/>
            </a:ln>
            <a:effectLst/>
          </c:spPr>
          <c:marker>
            <c:symbol val="none"/>
          </c:marker>
          <c:val>
            <c:numRef>
              <c:f>Triplex2_62C!$B$48:$AT$48</c:f>
              <c:numCache>
                <c:formatCode>General</c:formatCode>
                <c:ptCount val="45"/>
                <c:pt idx="0">
                  <c:v>0.3346007935833768</c:v>
                </c:pt>
                <c:pt idx="1">
                  <c:v>-0.56116682448919164</c:v>
                </c:pt>
                <c:pt idx="2">
                  <c:v>-1.2529020174642937</c:v>
                </c:pt>
                <c:pt idx="3">
                  <c:v>-1.3771082536641188</c:v>
                </c:pt>
                <c:pt idx="4">
                  <c:v>-0.8324086472093768</c:v>
                </c:pt>
                <c:pt idx="5">
                  <c:v>-7.2204938083814341E-2</c:v>
                </c:pt>
                <c:pt idx="6">
                  <c:v>0.34445162261363294</c:v>
                </c:pt>
                <c:pt idx="7">
                  <c:v>0.26344815607990313</c:v>
                </c:pt>
                <c:pt idx="8">
                  <c:v>-0.11005261819445877</c:v>
                </c:pt>
                <c:pt idx="9">
                  <c:v>-0.45802583209297154</c:v>
                </c:pt>
                <c:pt idx="10">
                  <c:v>-0.49463919876689033</c:v>
                </c:pt>
                <c:pt idx="11">
                  <c:v>-0.15783505870422232</c:v>
                </c:pt>
                <c:pt idx="12">
                  <c:v>0.27874853543107747</c:v>
                </c:pt>
                <c:pt idx="13">
                  <c:v>0.44435522030471475</c:v>
                </c:pt>
                <c:pt idx="14">
                  <c:v>0.23479333593240881</c:v>
                </c:pt>
                <c:pt idx="15">
                  <c:v>-9.5329529905939125E-2</c:v>
                </c:pt>
                <c:pt idx="16">
                  <c:v>-0.17770969460252672</c:v>
                </c:pt>
                <c:pt idx="17">
                  <c:v>0.19777916718339839</c:v>
                </c:pt>
                <c:pt idx="18">
                  <c:v>1.2885444531784742</c:v>
                </c:pt>
                <c:pt idx="19">
                  <c:v>4.0611097511136904</c:v>
                </c:pt>
                <c:pt idx="20">
                  <c:v>10.582231818310902</c:v>
                </c:pt>
                <c:pt idx="21">
                  <c:v>23.483091996127769</c:v>
                </c:pt>
                <c:pt idx="22">
                  <c:v>44.470638323558887</c:v>
                </c:pt>
                <c:pt idx="23">
                  <c:v>72.82669893833372</c:v>
                </c:pt>
                <c:pt idx="24">
                  <c:v>105.32466152992311</c:v>
                </c:pt>
                <c:pt idx="25">
                  <c:v>137.73854360623409</c:v>
                </c:pt>
                <c:pt idx="26">
                  <c:v>166.63559171167981</c:v>
                </c:pt>
                <c:pt idx="27">
                  <c:v>190.42566415538568</c:v>
                </c:pt>
                <c:pt idx="28">
                  <c:v>209.42404945567614</c:v>
                </c:pt>
                <c:pt idx="29">
                  <c:v>225.01123123163961</c:v>
                </c:pt>
                <c:pt idx="30">
                  <c:v>238.4888267631959</c:v>
                </c:pt>
                <c:pt idx="31">
                  <c:v>250.48515669090375</c:v>
                </c:pt>
                <c:pt idx="32">
                  <c:v>261.19643873843597</c:v>
                </c:pt>
                <c:pt idx="33">
                  <c:v>270.92661354751363</c:v>
                </c:pt>
                <c:pt idx="34">
                  <c:v>280.13470186456652</c:v>
                </c:pt>
                <c:pt idx="35">
                  <c:v>289.08233101930273</c:v>
                </c:pt>
                <c:pt idx="36">
                  <c:v>297.78951746580969</c:v>
                </c:pt>
                <c:pt idx="37">
                  <c:v>306.16931617093906</c:v>
                </c:pt>
                <c:pt idx="38">
                  <c:v>314.06588110398843</c:v>
                </c:pt>
                <c:pt idx="39">
                  <c:v>321.4178503162384</c:v>
                </c:pt>
                <c:pt idx="40">
                  <c:v>328.34176978531832</c:v>
                </c:pt>
                <c:pt idx="41">
                  <c:v>334.96264507055821</c:v>
                </c:pt>
                <c:pt idx="42">
                  <c:v>341.32538870760618</c:v>
                </c:pt>
                <c:pt idx="43">
                  <c:v>347.4783857959701</c:v>
                </c:pt>
                <c:pt idx="44">
                  <c:v>353.51073598589392</c:v>
                </c:pt>
              </c:numCache>
            </c:numRef>
          </c:val>
          <c:smooth val="0"/>
          <c:extLst>
            <c:ext xmlns:c16="http://schemas.microsoft.com/office/drawing/2014/chart" uri="{C3380CC4-5D6E-409C-BE32-E72D297353CC}">
              <c16:uniqueId val="{00000007-5C2A-483D-BE16-7C84262F9E2B}"/>
            </c:ext>
          </c:extLst>
        </c:ser>
        <c:ser>
          <c:idx val="8"/>
          <c:order val="8"/>
          <c:tx>
            <c:strRef>
              <c:f>Triplex2_62C!$A$51</c:f>
              <c:strCache>
                <c:ptCount val="1"/>
                <c:pt idx="0">
                  <c:v>50,000 copies</c:v>
                </c:pt>
              </c:strCache>
            </c:strRef>
          </c:tx>
          <c:spPr>
            <a:ln w="28575" cap="rnd">
              <a:solidFill>
                <a:schemeClr val="accent3">
                  <a:lumMod val="60000"/>
                </a:schemeClr>
              </a:solidFill>
              <a:round/>
            </a:ln>
            <a:effectLst/>
          </c:spPr>
          <c:marker>
            <c:symbol val="none"/>
          </c:marker>
          <c:val>
            <c:numRef>
              <c:f>Triplex2_62C!$B$51:$AT$51</c:f>
              <c:numCache>
                <c:formatCode>General</c:formatCode>
                <c:ptCount val="45"/>
                <c:pt idx="0">
                  <c:v>5.2377000738597417</c:v>
                </c:pt>
                <c:pt idx="1">
                  <c:v>8.5435796814217611</c:v>
                </c:pt>
                <c:pt idx="2">
                  <c:v>11.039604763320312</c:v>
                </c:pt>
                <c:pt idx="3">
                  <c:v>12.430813981074607</c:v>
                </c:pt>
                <c:pt idx="4">
                  <c:v>12.460732809106048</c:v>
                </c:pt>
                <c:pt idx="5">
                  <c:v>10.365627440201933</c:v>
                </c:pt>
                <c:pt idx="6">
                  <c:v>5.6452276410273043</c:v>
                </c:pt>
                <c:pt idx="7">
                  <c:v>-0.38451319652995153</c:v>
                </c:pt>
                <c:pt idx="8">
                  <c:v>-5.0407655193375831</c:v>
                </c:pt>
                <c:pt idx="9">
                  <c:v>-6.8557317198992678</c:v>
                </c:pt>
                <c:pt idx="10">
                  <c:v>-6.4499317780919228</c:v>
                </c:pt>
                <c:pt idx="11">
                  <c:v>-4.9602478863689612</c:v>
                </c:pt>
                <c:pt idx="12">
                  <c:v>-2.9866298712895514</c:v>
                </c:pt>
                <c:pt idx="13">
                  <c:v>-0.88795519866107497</c:v>
                </c:pt>
                <c:pt idx="14">
                  <c:v>0.94679898329923162</c:v>
                </c:pt>
                <c:pt idx="15">
                  <c:v>2.3346153715665423</c:v>
                </c:pt>
                <c:pt idx="16">
                  <c:v>3.4591942879287672</c:v>
                </c:pt>
                <c:pt idx="17">
                  <c:v>4.8143114461818186</c:v>
                </c:pt>
                <c:pt idx="18">
                  <c:v>7.253408162481719</c:v>
                </c:pt>
                <c:pt idx="19">
                  <c:v>12.213105476124838</c:v>
                </c:pt>
                <c:pt idx="20">
                  <c:v>21.917520259466983</c:v>
                </c:pt>
                <c:pt idx="21">
                  <c:v>39.063569485851986</c:v>
                </c:pt>
                <c:pt idx="22">
                  <c:v>65.590392578882529</c:v>
                </c:pt>
                <c:pt idx="23">
                  <c:v>101.09235064954919</c:v>
                </c:pt>
                <c:pt idx="24">
                  <c:v>142.19583312321811</c:v>
                </c:pt>
                <c:pt idx="25">
                  <c:v>183.77212953851085</c:v>
                </c:pt>
                <c:pt idx="26">
                  <c:v>221.25350641698242</c:v>
                </c:pt>
                <c:pt idx="27">
                  <c:v>252.32116159650468</c:v>
                </c:pt>
                <c:pt idx="28">
                  <c:v>277.12863841329272</c:v>
                </c:pt>
                <c:pt idx="29">
                  <c:v>297.32296222412515</c:v>
                </c:pt>
                <c:pt idx="30">
                  <c:v>314.66077334757756</c:v>
                </c:pt>
                <c:pt idx="31">
                  <c:v>330.27514106810122</c:v>
                </c:pt>
                <c:pt idx="32">
                  <c:v>344.76112347870912</c:v>
                </c:pt>
                <c:pt idx="33">
                  <c:v>358.43104592600503</c:v>
                </c:pt>
                <c:pt idx="34">
                  <c:v>371.46948881273238</c:v>
                </c:pt>
                <c:pt idx="35">
                  <c:v>383.98312567387438</c:v>
                </c:pt>
                <c:pt idx="36">
                  <c:v>395.99878603620164</c:v>
                </c:pt>
                <c:pt idx="37">
                  <c:v>407.56983245170886</c:v>
                </c:pt>
                <c:pt idx="38">
                  <c:v>418.78618583021489</c:v>
                </c:pt>
                <c:pt idx="39">
                  <c:v>429.58388330051093</c:v>
                </c:pt>
                <c:pt idx="40">
                  <c:v>439.81855493712828</c:v>
                </c:pt>
                <c:pt idx="41">
                  <c:v>449.54128090805898</c:v>
                </c:pt>
                <c:pt idx="42">
                  <c:v>458.97682354536119</c:v>
                </c:pt>
                <c:pt idx="43">
                  <c:v>468.33381796145295</c:v>
                </c:pt>
                <c:pt idx="44">
                  <c:v>477.69989496049129</c:v>
                </c:pt>
              </c:numCache>
            </c:numRef>
          </c:val>
          <c:smooth val="0"/>
          <c:extLst>
            <c:ext xmlns:c16="http://schemas.microsoft.com/office/drawing/2014/chart" uri="{C3380CC4-5D6E-409C-BE32-E72D297353CC}">
              <c16:uniqueId val="{00000008-5C2A-483D-BE16-7C84262F9E2B}"/>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5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r>
              <a:rPr lang="en-US" sz="1800">
                <a:latin typeface="Times New Roman" panose="02020603050405020304" pitchFamily="18" charset="0"/>
                <a:cs typeface="Times New Roman" panose="02020603050405020304" pitchFamily="18" charset="0"/>
              </a:rPr>
              <a:t>Average Ct Values of RADx Clinical</a:t>
            </a:r>
            <a:r>
              <a:rPr lang="en-US" sz="1800" baseline="0">
                <a:latin typeface="Times New Roman" panose="02020603050405020304" pitchFamily="18" charset="0"/>
                <a:cs typeface="Times New Roman" panose="02020603050405020304" pitchFamily="18" charset="0"/>
              </a:rPr>
              <a:t> Specimens</a:t>
            </a:r>
            <a:endParaRPr lang="en-US" sz="1800">
              <a:latin typeface="Times New Roman" panose="02020603050405020304" pitchFamily="18" charset="0"/>
              <a:cs typeface="Times New Roman" panose="02020603050405020304" pitchFamily="18" charset="0"/>
            </a:endParaRPr>
          </a:p>
        </c:rich>
      </c:tx>
      <c:layout/>
      <c:overlay val="0"/>
      <c:spPr>
        <a:noFill/>
        <a:ln>
          <a:noFill/>
        </a:ln>
        <a:effectLst/>
      </c:spPr>
      <c:txPr>
        <a:bodyPr rot="0" spcFirstLastPara="1" vertOverflow="ellipsis" vert="horz" wrap="square" anchor="ctr" anchorCtr="1"/>
        <a:lstStyle/>
        <a:p>
          <a:pPr>
            <a:defRPr sz="1800" b="0" i="0" u="none" strike="noStrike" kern="1200" spc="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lineChart>
        <c:grouping val="standard"/>
        <c:varyColors val="0"/>
        <c:ser>
          <c:idx val="0"/>
          <c:order val="0"/>
          <c:tx>
            <c:strRef>
              <c:f>'RADx Ct plots'!$M$4</c:f>
              <c:strCache>
                <c:ptCount val="1"/>
                <c:pt idx="0">
                  <c:v>Spike</c:v>
                </c:pt>
              </c:strCache>
            </c:strRef>
          </c:tx>
          <c:spPr>
            <a:ln w="19050" cap="rnd">
              <a:noFill/>
              <a:round/>
            </a:ln>
            <a:effectLst/>
          </c:spPr>
          <c:marker>
            <c:symbol val="x"/>
            <c:size val="4"/>
            <c:spPr>
              <a:noFill/>
              <a:ln w="19050">
                <a:solidFill>
                  <a:schemeClr val="tx1"/>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M$5:$M$24</c:f>
              <c:numCache>
                <c:formatCode>0.0</c:formatCode>
                <c:ptCount val="20"/>
                <c:pt idx="0">
                  <c:v>23.504999999999999</c:v>
                </c:pt>
                <c:pt idx="1">
                  <c:v>26.545000000000002</c:v>
                </c:pt>
                <c:pt idx="2">
                  <c:v>28.365000000000002</c:v>
                </c:pt>
                <c:pt idx="3">
                  <c:v>28.69</c:v>
                </c:pt>
                <c:pt idx="4">
                  <c:v>34.495000000000005</c:v>
                </c:pt>
                <c:pt idx="5">
                  <c:v>24.344999999999999</c:v>
                </c:pt>
                <c:pt idx="6">
                  <c:v>24.27</c:v>
                </c:pt>
                <c:pt idx="7">
                  <c:v>25.09</c:v>
                </c:pt>
                <c:pt idx="8">
                  <c:v>25.1</c:v>
                </c:pt>
                <c:pt idx="9">
                  <c:v>33.435000000000002</c:v>
                </c:pt>
                <c:pt idx="10">
                  <c:v>22.134999999999998</c:v>
                </c:pt>
                <c:pt idx="11">
                  <c:v>24.145000000000003</c:v>
                </c:pt>
                <c:pt idx="12">
                  <c:v>25.17</c:v>
                </c:pt>
                <c:pt idx="13">
                  <c:v>29.369999999999997</c:v>
                </c:pt>
                <c:pt idx="14">
                  <c:v>33.475000000000001</c:v>
                </c:pt>
                <c:pt idx="15">
                  <c:v>20.73</c:v>
                </c:pt>
                <c:pt idx="16">
                  <c:v>26.11</c:v>
                </c:pt>
                <c:pt idx="17">
                  <c:v>28.234999999999999</c:v>
                </c:pt>
                <c:pt idx="18">
                  <c:v>28.009999999999998</c:v>
                </c:pt>
                <c:pt idx="19">
                  <c:v>32.805</c:v>
                </c:pt>
              </c:numCache>
            </c:numRef>
          </c:val>
          <c:smooth val="0"/>
          <c:extLst>
            <c:ext xmlns:c16="http://schemas.microsoft.com/office/drawing/2014/chart" uri="{C3380CC4-5D6E-409C-BE32-E72D297353CC}">
              <c16:uniqueId val="{00000000-5068-4D33-BAE6-189EA21A6111}"/>
            </c:ext>
          </c:extLst>
        </c:ser>
        <c:ser>
          <c:idx val="1"/>
          <c:order val="1"/>
          <c:tx>
            <c:strRef>
              <c:f>'RADx Ct plots'!$N$4</c:f>
              <c:strCache>
                <c:ptCount val="1"/>
                <c:pt idx="0">
                  <c:v>Orf1ab</c:v>
                </c:pt>
              </c:strCache>
            </c:strRef>
          </c:tx>
          <c:spPr>
            <a:ln w="19050" cap="rnd">
              <a:noFill/>
              <a:round/>
            </a:ln>
            <a:effectLst/>
          </c:spPr>
          <c:marker>
            <c:symbol val="x"/>
            <c:size val="4"/>
            <c:spPr>
              <a:noFill/>
              <a:ln w="19050">
                <a:solidFill>
                  <a:schemeClr val="accent2"/>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N$5:$N$24</c:f>
              <c:numCache>
                <c:formatCode>0.0</c:formatCode>
                <c:ptCount val="20"/>
                <c:pt idx="0">
                  <c:v>24.274999999999999</c:v>
                </c:pt>
                <c:pt idx="1">
                  <c:v>28.064999999999998</c:v>
                </c:pt>
                <c:pt idx="2">
                  <c:v>29.59</c:v>
                </c:pt>
                <c:pt idx="3">
                  <c:v>30.215000000000003</c:v>
                </c:pt>
                <c:pt idx="4">
                  <c:v>36.6</c:v>
                </c:pt>
                <c:pt idx="5">
                  <c:v>26.115000000000002</c:v>
                </c:pt>
                <c:pt idx="6">
                  <c:v>25.299999999999997</c:v>
                </c:pt>
                <c:pt idx="7">
                  <c:v>26.02</c:v>
                </c:pt>
                <c:pt idx="8">
                  <c:v>26.36</c:v>
                </c:pt>
                <c:pt idx="9">
                  <c:v>36.034999999999997</c:v>
                </c:pt>
                <c:pt idx="10">
                  <c:v>22.87</c:v>
                </c:pt>
                <c:pt idx="11">
                  <c:v>25.03</c:v>
                </c:pt>
                <c:pt idx="12">
                  <c:v>26.125</c:v>
                </c:pt>
                <c:pt idx="13">
                  <c:v>30.630000000000003</c:v>
                </c:pt>
                <c:pt idx="14">
                  <c:v>36.53</c:v>
                </c:pt>
                <c:pt idx="15">
                  <c:v>24.43</c:v>
                </c:pt>
                <c:pt idx="16">
                  <c:v>29.439999999999998</c:v>
                </c:pt>
                <c:pt idx="17">
                  <c:v>31.75</c:v>
                </c:pt>
                <c:pt idx="18">
                  <c:v>31.195</c:v>
                </c:pt>
                <c:pt idx="19">
                  <c:v>39.515000000000001</c:v>
                </c:pt>
              </c:numCache>
            </c:numRef>
          </c:val>
          <c:smooth val="0"/>
          <c:extLst>
            <c:ext xmlns:c16="http://schemas.microsoft.com/office/drawing/2014/chart" uri="{C3380CC4-5D6E-409C-BE32-E72D297353CC}">
              <c16:uniqueId val="{00000001-5068-4D33-BAE6-189EA21A6111}"/>
            </c:ext>
          </c:extLst>
        </c:ser>
        <c:ser>
          <c:idx val="2"/>
          <c:order val="2"/>
          <c:tx>
            <c:strRef>
              <c:f>'RADx Ct plots'!$O$4</c:f>
              <c:strCache>
                <c:ptCount val="1"/>
                <c:pt idx="0">
                  <c:v>S:501Y</c:v>
                </c:pt>
              </c:strCache>
            </c:strRef>
          </c:tx>
          <c:spPr>
            <a:ln w="19050" cap="rnd">
              <a:noFill/>
              <a:round/>
            </a:ln>
            <a:effectLst/>
          </c:spPr>
          <c:marker>
            <c:symbol val="dash"/>
            <c:size val="5"/>
            <c:spPr>
              <a:solidFill>
                <a:schemeClr val="accent3"/>
              </a:solidFill>
              <a:ln w="19050">
                <a:solidFill>
                  <a:schemeClr val="accent3"/>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O$5:$O$24</c:f>
              <c:numCache>
                <c:formatCode>0.0</c:formatCode>
                <c:ptCount val="20"/>
                <c:pt idx="0">
                  <c:v>24.909999999999997</c:v>
                </c:pt>
                <c:pt idx="1">
                  <c:v>28.48</c:v>
                </c:pt>
                <c:pt idx="2">
                  <c:v>30.195</c:v>
                </c:pt>
                <c:pt idx="3">
                  <c:v>31.055</c:v>
                </c:pt>
                <c:pt idx="5">
                  <c:v>26.189999999999998</c:v>
                </c:pt>
                <c:pt idx="6">
                  <c:v>26.305</c:v>
                </c:pt>
                <c:pt idx="7">
                  <c:v>26.78</c:v>
                </c:pt>
                <c:pt idx="8">
                  <c:v>27.15</c:v>
                </c:pt>
                <c:pt idx="10">
                  <c:v>23.86</c:v>
                </c:pt>
                <c:pt idx="11">
                  <c:v>26.1</c:v>
                </c:pt>
                <c:pt idx="12">
                  <c:v>27.07</c:v>
                </c:pt>
                <c:pt idx="13">
                  <c:v>33.93</c:v>
                </c:pt>
              </c:numCache>
            </c:numRef>
          </c:val>
          <c:smooth val="0"/>
          <c:extLst>
            <c:ext xmlns:c16="http://schemas.microsoft.com/office/drawing/2014/chart" uri="{C3380CC4-5D6E-409C-BE32-E72D297353CC}">
              <c16:uniqueId val="{00000002-5068-4D33-BAE6-189EA21A6111}"/>
            </c:ext>
          </c:extLst>
        </c:ser>
        <c:ser>
          <c:idx val="3"/>
          <c:order val="3"/>
          <c:tx>
            <c:strRef>
              <c:f>'RADx Ct plots'!$P$4</c:f>
              <c:strCache>
                <c:ptCount val="1"/>
                <c:pt idx="0">
                  <c:v>S:P26S</c:v>
                </c:pt>
              </c:strCache>
            </c:strRef>
          </c:tx>
          <c:spPr>
            <a:ln w="19050" cap="rnd">
              <a:noFill/>
              <a:round/>
            </a:ln>
            <a:effectLst/>
          </c:spPr>
          <c:marker>
            <c:symbol val="dash"/>
            <c:size val="5"/>
            <c:spPr>
              <a:solidFill>
                <a:schemeClr val="accent4"/>
              </a:solidFill>
              <a:ln w="19050">
                <a:solidFill>
                  <a:schemeClr val="accent4"/>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P$5:$P$24</c:f>
              <c:numCache>
                <c:formatCode>General</c:formatCode>
                <c:ptCount val="20"/>
                <c:pt idx="10" formatCode="0.0">
                  <c:v>26.2</c:v>
                </c:pt>
                <c:pt idx="11" formatCode="0.0">
                  <c:v>28.715</c:v>
                </c:pt>
                <c:pt idx="12" formatCode="0.0">
                  <c:v>31.135000000000002</c:v>
                </c:pt>
                <c:pt idx="13" formatCode="0.0">
                  <c:v>43.335000000000001</c:v>
                </c:pt>
              </c:numCache>
            </c:numRef>
          </c:val>
          <c:smooth val="0"/>
          <c:extLst>
            <c:ext xmlns:c16="http://schemas.microsoft.com/office/drawing/2014/chart" uri="{C3380CC4-5D6E-409C-BE32-E72D297353CC}">
              <c16:uniqueId val="{00000003-5068-4D33-BAE6-189EA21A6111}"/>
            </c:ext>
          </c:extLst>
        </c:ser>
        <c:ser>
          <c:idx val="4"/>
          <c:order val="4"/>
          <c:tx>
            <c:strRef>
              <c:f>'RADx Ct plots'!$Q$4</c:f>
              <c:strCache>
                <c:ptCount val="1"/>
                <c:pt idx="0">
                  <c:v>S:144del</c:v>
                </c:pt>
              </c:strCache>
            </c:strRef>
          </c:tx>
          <c:spPr>
            <a:ln w="19050" cap="rnd">
              <a:noFill/>
              <a:round/>
            </a:ln>
            <a:effectLst/>
          </c:spPr>
          <c:marker>
            <c:symbol val="dash"/>
            <c:size val="5"/>
            <c:spPr>
              <a:solidFill>
                <a:schemeClr val="accent5"/>
              </a:solidFill>
              <a:ln w="19050">
                <a:solidFill>
                  <a:schemeClr val="accent5"/>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Q$5:$Q$24</c:f>
              <c:numCache>
                <c:formatCode>0.0</c:formatCode>
                <c:ptCount val="20"/>
                <c:pt idx="0">
                  <c:v>23.98</c:v>
                </c:pt>
                <c:pt idx="1">
                  <c:v>27.21</c:v>
                </c:pt>
                <c:pt idx="2">
                  <c:v>28.895</c:v>
                </c:pt>
                <c:pt idx="3">
                  <c:v>29.295000000000002</c:v>
                </c:pt>
              </c:numCache>
            </c:numRef>
          </c:val>
          <c:smooth val="0"/>
          <c:extLst>
            <c:ext xmlns:c16="http://schemas.microsoft.com/office/drawing/2014/chart" uri="{C3380CC4-5D6E-409C-BE32-E72D297353CC}">
              <c16:uniqueId val="{00000004-5068-4D33-BAE6-189EA21A6111}"/>
            </c:ext>
          </c:extLst>
        </c:ser>
        <c:ser>
          <c:idx val="5"/>
          <c:order val="5"/>
          <c:tx>
            <c:strRef>
              <c:f>'RADx Ct plots'!$R$4</c:f>
              <c:strCache>
                <c:ptCount val="1"/>
                <c:pt idx="0">
                  <c:v>S:69/70 del</c:v>
                </c:pt>
              </c:strCache>
            </c:strRef>
          </c:tx>
          <c:spPr>
            <a:ln w="19050" cap="rnd">
              <a:noFill/>
              <a:round/>
            </a:ln>
            <a:effectLst/>
          </c:spPr>
          <c:marker>
            <c:symbol val="dash"/>
            <c:size val="5"/>
            <c:spPr>
              <a:solidFill>
                <a:schemeClr val="accent6"/>
              </a:solidFill>
              <a:ln w="19050">
                <a:solidFill>
                  <a:schemeClr val="accent6"/>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R$5:$R$24</c:f>
              <c:numCache>
                <c:formatCode>0.0</c:formatCode>
                <c:ptCount val="20"/>
                <c:pt idx="0">
                  <c:v>24.145</c:v>
                </c:pt>
                <c:pt idx="1">
                  <c:v>27.134999999999998</c:v>
                </c:pt>
                <c:pt idx="2">
                  <c:v>29.324999999999999</c:v>
                </c:pt>
                <c:pt idx="3">
                  <c:v>29.515000000000001</c:v>
                </c:pt>
              </c:numCache>
            </c:numRef>
          </c:val>
          <c:smooth val="0"/>
          <c:extLst>
            <c:ext xmlns:c16="http://schemas.microsoft.com/office/drawing/2014/chart" uri="{C3380CC4-5D6E-409C-BE32-E72D297353CC}">
              <c16:uniqueId val="{00000005-5068-4D33-BAE6-189EA21A6111}"/>
            </c:ext>
          </c:extLst>
        </c:ser>
        <c:ser>
          <c:idx val="6"/>
          <c:order val="6"/>
          <c:tx>
            <c:strRef>
              <c:f>'RADx Ct plots'!$S$4</c:f>
              <c:strCache>
                <c:ptCount val="1"/>
                <c:pt idx="0">
                  <c:v>S:484K</c:v>
                </c:pt>
              </c:strCache>
            </c:strRef>
          </c:tx>
          <c:spPr>
            <a:ln w="19050" cap="rnd">
              <a:noFill/>
              <a:round/>
            </a:ln>
            <a:effectLst/>
          </c:spPr>
          <c:marker>
            <c:symbol val="dash"/>
            <c:size val="5"/>
            <c:spPr>
              <a:solidFill>
                <a:schemeClr val="accent1">
                  <a:lumMod val="60000"/>
                </a:schemeClr>
              </a:solidFill>
              <a:ln w="19050">
                <a:solidFill>
                  <a:schemeClr val="accent1">
                    <a:lumMod val="60000"/>
                  </a:schemeClr>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S$5:$S$24</c:f>
              <c:numCache>
                <c:formatCode>General</c:formatCode>
                <c:ptCount val="20"/>
                <c:pt idx="5" formatCode="0.0">
                  <c:v>27.48</c:v>
                </c:pt>
                <c:pt idx="6" formatCode="0.0">
                  <c:v>27.630000000000003</c:v>
                </c:pt>
                <c:pt idx="7" formatCode="0.0">
                  <c:v>28.075000000000003</c:v>
                </c:pt>
                <c:pt idx="8" formatCode="0.0">
                  <c:v>27.814999999999998</c:v>
                </c:pt>
                <c:pt idx="9" formatCode="0.0">
                  <c:v>36.47</c:v>
                </c:pt>
                <c:pt idx="10" formatCode="0.0">
                  <c:v>25.465</c:v>
                </c:pt>
                <c:pt idx="11" formatCode="0.0">
                  <c:v>27.895000000000003</c:v>
                </c:pt>
                <c:pt idx="12" formatCode="0.0">
                  <c:v>28.715</c:v>
                </c:pt>
                <c:pt idx="13" formatCode="0.0">
                  <c:v>32.65</c:v>
                </c:pt>
                <c:pt idx="14" formatCode="0.0">
                  <c:v>37.230000000000004</c:v>
                </c:pt>
              </c:numCache>
            </c:numRef>
          </c:val>
          <c:smooth val="0"/>
          <c:extLst>
            <c:ext xmlns:c16="http://schemas.microsoft.com/office/drawing/2014/chart" uri="{C3380CC4-5D6E-409C-BE32-E72D297353CC}">
              <c16:uniqueId val="{00000006-5068-4D33-BAE6-189EA21A6111}"/>
            </c:ext>
          </c:extLst>
        </c:ser>
        <c:ser>
          <c:idx val="7"/>
          <c:order val="7"/>
          <c:tx>
            <c:strRef>
              <c:f>'RADx Ct plots'!$T$4</c:f>
              <c:strCache>
                <c:ptCount val="1"/>
                <c:pt idx="0">
                  <c:v>S:215G</c:v>
                </c:pt>
              </c:strCache>
            </c:strRef>
          </c:tx>
          <c:spPr>
            <a:ln w="19050" cap="rnd">
              <a:noFill/>
              <a:round/>
            </a:ln>
            <a:effectLst/>
          </c:spPr>
          <c:marker>
            <c:symbol val="dash"/>
            <c:size val="5"/>
            <c:spPr>
              <a:solidFill>
                <a:schemeClr val="accent2">
                  <a:lumMod val="60000"/>
                </a:schemeClr>
              </a:solidFill>
              <a:ln w="19050">
                <a:solidFill>
                  <a:schemeClr val="accent2">
                    <a:lumMod val="60000"/>
                  </a:schemeClr>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T$5:$T$24</c:f>
              <c:numCache>
                <c:formatCode>General</c:formatCode>
                <c:ptCount val="20"/>
                <c:pt idx="5" formatCode="0.0">
                  <c:v>25.85</c:v>
                </c:pt>
                <c:pt idx="6" formatCode="0.0">
                  <c:v>25.935000000000002</c:v>
                </c:pt>
                <c:pt idx="7" formatCode="0.0">
                  <c:v>26.255000000000003</c:v>
                </c:pt>
                <c:pt idx="8" formatCode="0.0">
                  <c:v>26.035</c:v>
                </c:pt>
                <c:pt idx="9" formatCode="0.0">
                  <c:v>36.980000000000004</c:v>
                </c:pt>
              </c:numCache>
            </c:numRef>
          </c:val>
          <c:smooth val="0"/>
          <c:extLst>
            <c:ext xmlns:c16="http://schemas.microsoft.com/office/drawing/2014/chart" uri="{C3380CC4-5D6E-409C-BE32-E72D297353CC}">
              <c16:uniqueId val="{00000007-5068-4D33-BAE6-189EA21A6111}"/>
            </c:ext>
          </c:extLst>
        </c:ser>
        <c:ser>
          <c:idx val="8"/>
          <c:order val="8"/>
          <c:tx>
            <c:strRef>
              <c:f>'RADx Ct plots'!$U$4</c:f>
              <c:strCache>
                <c:ptCount val="1"/>
                <c:pt idx="0">
                  <c:v>S:681R</c:v>
                </c:pt>
              </c:strCache>
            </c:strRef>
          </c:tx>
          <c:spPr>
            <a:ln w="19050" cap="rnd">
              <a:noFill/>
              <a:round/>
            </a:ln>
            <a:effectLst/>
          </c:spPr>
          <c:marker>
            <c:symbol val="dash"/>
            <c:size val="5"/>
            <c:spPr>
              <a:solidFill>
                <a:schemeClr val="accent3">
                  <a:lumMod val="60000"/>
                </a:schemeClr>
              </a:solidFill>
              <a:ln w="19050">
                <a:solidFill>
                  <a:srgbClr val="00B0F0"/>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U$5:$U$24</c:f>
              <c:numCache>
                <c:formatCode>General</c:formatCode>
                <c:ptCount val="20"/>
                <c:pt idx="15" formatCode="0.0">
                  <c:v>24.895000000000003</c:v>
                </c:pt>
                <c:pt idx="16" formatCode="0.0">
                  <c:v>30.395</c:v>
                </c:pt>
                <c:pt idx="17" formatCode="0.0">
                  <c:v>31.66</c:v>
                </c:pt>
                <c:pt idx="18" formatCode="0.0">
                  <c:v>32.445</c:v>
                </c:pt>
                <c:pt idx="19" formatCode="0.0">
                  <c:v>37.614999999999995</c:v>
                </c:pt>
              </c:numCache>
            </c:numRef>
          </c:val>
          <c:smooth val="0"/>
          <c:extLst>
            <c:ext xmlns:c16="http://schemas.microsoft.com/office/drawing/2014/chart" uri="{C3380CC4-5D6E-409C-BE32-E72D297353CC}">
              <c16:uniqueId val="{00000008-5068-4D33-BAE6-189EA21A6111}"/>
            </c:ext>
          </c:extLst>
        </c:ser>
        <c:ser>
          <c:idx val="9"/>
          <c:order val="9"/>
          <c:tx>
            <c:strRef>
              <c:f>'RADx Ct plots'!$V$4</c:f>
              <c:strCache>
                <c:ptCount val="1"/>
                <c:pt idx="0">
                  <c:v>S:452R</c:v>
                </c:pt>
              </c:strCache>
            </c:strRef>
          </c:tx>
          <c:spPr>
            <a:ln w="19050" cap="rnd">
              <a:noFill/>
              <a:round/>
            </a:ln>
            <a:effectLst/>
          </c:spPr>
          <c:marker>
            <c:symbol val="dash"/>
            <c:size val="5"/>
            <c:spPr>
              <a:solidFill>
                <a:schemeClr val="accent4">
                  <a:lumMod val="60000"/>
                </a:schemeClr>
              </a:solidFill>
              <a:ln w="19050">
                <a:solidFill>
                  <a:srgbClr val="61FD23"/>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V$5:$V$24</c:f>
              <c:numCache>
                <c:formatCode>General</c:formatCode>
                <c:ptCount val="20"/>
                <c:pt idx="15" formatCode="0.0">
                  <c:v>23.414999999999999</c:v>
                </c:pt>
                <c:pt idx="16" formatCode="0.0">
                  <c:v>28.965000000000003</c:v>
                </c:pt>
                <c:pt idx="17" formatCode="0.0">
                  <c:v>30.234999999999999</c:v>
                </c:pt>
                <c:pt idx="18" formatCode="0.0">
                  <c:v>30.344999999999999</c:v>
                </c:pt>
                <c:pt idx="19" formatCode="0.0">
                  <c:v>35.715000000000003</c:v>
                </c:pt>
              </c:numCache>
            </c:numRef>
          </c:val>
          <c:smooth val="0"/>
          <c:extLst>
            <c:ext xmlns:c16="http://schemas.microsoft.com/office/drawing/2014/chart" uri="{C3380CC4-5D6E-409C-BE32-E72D297353CC}">
              <c16:uniqueId val="{00000009-5068-4D33-BAE6-189EA21A6111}"/>
            </c:ext>
          </c:extLst>
        </c:ser>
        <c:ser>
          <c:idx val="10"/>
          <c:order val="10"/>
          <c:tx>
            <c:strRef>
              <c:f>'RADx Ct plots'!$W$4</c:f>
              <c:strCache>
                <c:ptCount val="1"/>
                <c:pt idx="0">
                  <c:v>S:156/ 157 del</c:v>
                </c:pt>
              </c:strCache>
            </c:strRef>
          </c:tx>
          <c:spPr>
            <a:ln w="19050" cap="rnd">
              <a:noFill/>
              <a:round/>
            </a:ln>
            <a:effectLst/>
          </c:spPr>
          <c:marker>
            <c:symbol val="dash"/>
            <c:size val="5"/>
            <c:spPr>
              <a:solidFill>
                <a:schemeClr val="accent5">
                  <a:lumMod val="60000"/>
                </a:schemeClr>
              </a:solidFill>
              <a:ln w="19050">
                <a:solidFill>
                  <a:srgbClr val="FF0000"/>
                </a:solidFill>
              </a:ln>
              <a:effectLst/>
            </c:spPr>
          </c:marker>
          <c:cat>
            <c:strRef>
              <c:f>'RADx Ct plots'!$L$5:$L$24</c:f>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f>'RADx Ct plots'!$W$5:$W$24</c:f>
              <c:numCache>
                <c:formatCode>General</c:formatCode>
                <c:ptCount val="20"/>
                <c:pt idx="15" formatCode="0.0">
                  <c:v>24.115000000000002</c:v>
                </c:pt>
                <c:pt idx="16" formatCode="0.0">
                  <c:v>29.914999999999999</c:v>
                </c:pt>
                <c:pt idx="17" formatCode="0.0">
                  <c:v>31.515000000000001</c:v>
                </c:pt>
                <c:pt idx="18" formatCode="0.0">
                  <c:v>31.35</c:v>
                </c:pt>
                <c:pt idx="19" formatCode="0.0">
                  <c:v>37.325000000000003</c:v>
                </c:pt>
              </c:numCache>
            </c:numRef>
          </c:val>
          <c:smooth val="0"/>
          <c:extLst>
            <c:ext xmlns:c16="http://schemas.microsoft.com/office/drawing/2014/chart" uri="{C3380CC4-5D6E-409C-BE32-E72D297353CC}">
              <c16:uniqueId val="{0000000A-5068-4D33-BAE6-189EA21A6111}"/>
            </c:ext>
          </c:extLst>
        </c:ser>
        <c:dLbls>
          <c:showLegendKey val="0"/>
          <c:showVal val="0"/>
          <c:showCatName val="0"/>
          <c:showSerName val="0"/>
          <c:showPercent val="0"/>
          <c:showBubbleSize val="0"/>
        </c:dLbls>
        <c:marker val="1"/>
        <c:smooth val="0"/>
        <c:axId val="535968072"/>
        <c:axId val="535961840"/>
        <c:extLst>
          <c:ext xmlns:c15="http://schemas.microsoft.com/office/drawing/2012/chart" uri="{02D57815-91ED-43cb-92C2-25804820EDAC}">
            <c15:filteredLineSeries>
              <c15:ser>
                <c:idx val="11"/>
                <c:order val="11"/>
                <c:tx>
                  <c:strRef>
                    <c:extLst>
                      <c:ext uri="{02D57815-91ED-43cb-92C2-25804820EDAC}">
                        <c15:formulaRef>
                          <c15:sqref>'RADx Ct plots'!$X$4</c15:sqref>
                        </c15:formulaRef>
                      </c:ext>
                    </c:extLst>
                    <c:strCache>
                      <c:ptCount val="1"/>
                      <c:pt idx="0">
                        <c:v>S:371-375</c:v>
                      </c:pt>
                    </c:strCache>
                  </c:strRef>
                </c:tx>
                <c:spPr>
                  <a:ln w="19050" cap="rnd">
                    <a:solidFill>
                      <a:schemeClr val="accent6">
                        <a:lumMod val="60000"/>
                      </a:schemeClr>
                    </a:solidFill>
                    <a:round/>
                  </a:ln>
                  <a:effectLst/>
                </c:spPr>
                <c:marker>
                  <c:symbol val="circle"/>
                  <c:size val="5"/>
                  <c:spPr>
                    <a:solidFill>
                      <a:schemeClr val="accent6">
                        <a:lumMod val="60000"/>
                      </a:schemeClr>
                    </a:solidFill>
                    <a:ln w="9525">
                      <a:solidFill>
                        <a:schemeClr val="accent6">
                          <a:lumMod val="60000"/>
                        </a:schemeClr>
                      </a:solidFill>
                    </a:ln>
                    <a:effectLst/>
                  </c:spPr>
                </c:marker>
                <c:cat>
                  <c:strRef>
                    <c:extLst>
                      <c:ext uri="{02D57815-91ED-43cb-92C2-25804820EDAC}">
                        <c15:formulaRef>
                          <c15:sqref>'RADx Ct plots'!$L$5:$L$24</c15:sqref>
                        </c15:formulaRef>
                      </c:ext>
                    </c:extLst>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extLst>
                      <c:ext uri="{02D57815-91ED-43cb-92C2-25804820EDAC}">
                        <c15:formulaRef>
                          <c15:sqref>'RADx Ct plots'!$X$5:$X$24</c15:sqref>
                        </c15:formulaRef>
                      </c:ext>
                    </c:extLst>
                    <c:numCache>
                      <c:formatCode>General</c:formatCode>
                      <c:ptCount val="20"/>
                    </c:numCache>
                  </c:numRef>
                </c:val>
                <c:smooth val="0"/>
                <c:extLst>
                  <c:ext xmlns:c16="http://schemas.microsoft.com/office/drawing/2014/chart" uri="{C3380CC4-5D6E-409C-BE32-E72D297353CC}">
                    <c16:uniqueId val="{0000000B-5068-4D33-BAE6-189EA21A6111}"/>
                  </c:ext>
                </c:extLst>
              </c15:ser>
            </c15:filteredLineSeries>
            <c15:filteredLineSeries>
              <c15:ser>
                <c:idx val="12"/>
                <c:order val="12"/>
                <c:tx>
                  <c:strRef>
                    <c:extLst xmlns:c15="http://schemas.microsoft.com/office/drawing/2012/chart">
                      <c:ext xmlns:c15="http://schemas.microsoft.com/office/drawing/2012/chart" uri="{02D57815-91ED-43cb-92C2-25804820EDAC}">
                        <c15:formulaRef>
                          <c15:sqref>'RADx Ct plots'!$Y$4</c15:sqref>
                        </c15:formulaRef>
                      </c:ext>
                    </c:extLst>
                    <c:strCache>
                      <c:ptCount val="1"/>
                      <c:pt idx="0">
                        <c:v>S:142-144del</c:v>
                      </c:pt>
                    </c:strCache>
                  </c:strRef>
                </c:tx>
                <c:spPr>
                  <a:ln w="19050" cap="rnd">
                    <a:solidFill>
                      <a:schemeClr val="accent1">
                        <a:lumMod val="80000"/>
                        <a:lumOff val="20000"/>
                      </a:schemeClr>
                    </a:solidFill>
                    <a:round/>
                  </a:ln>
                  <a:effectLst/>
                </c:spPr>
                <c:marker>
                  <c:symbol val="circle"/>
                  <c:size val="5"/>
                  <c:spPr>
                    <a:solidFill>
                      <a:schemeClr val="accent1">
                        <a:lumMod val="80000"/>
                        <a:lumOff val="20000"/>
                      </a:schemeClr>
                    </a:solidFill>
                    <a:ln w="9525">
                      <a:solidFill>
                        <a:schemeClr val="accent1">
                          <a:lumMod val="80000"/>
                          <a:lumOff val="20000"/>
                        </a:schemeClr>
                      </a:solidFill>
                    </a:ln>
                    <a:effectLst/>
                  </c:spPr>
                </c:marker>
                <c:cat>
                  <c:strRef>
                    <c:extLst xmlns:c15="http://schemas.microsoft.com/office/drawing/2012/chart">
                      <c:ext xmlns:c15="http://schemas.microsoft.com/office/drawing/2012/chart" uri="{02D57815-91ED-43cb-92C2-25804820EDAC}">
                        <c15:formulaRef>
                          <c15:sqref>'RADx Ct plots'!$L$5:$L$24</c15:sqref>
                        </c15:formulaRef>
                      </c:ext>
                    </c:extLst>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extLst xmlns:c15="http://schemas.microsoft.com/office/drawing/2012/chart">
                      <c:ext xmlns:c15="http://schemas.microsoft.com/office/drawing/2012/chart" uri="{02D57815-91ED-43cb-92C2-25804820EDAC}">
                        <c15:formulaRef>
                          <c15:sqref>'RADx Ct plots'!$Y$5:$Y$24</c15:sqref>
                        </c15:formulaRef>
                      </c:ext>
                    </c:extLst>
                    <c:numCache>
                      <c:formatCode>General</c:formatCode>
                      <c:ptCount val="20"/>
                    </c:numCache>
                  </c:numRef>
                </c:val>
                <c:smooth val="0"/>
                <c:extLst xmlns:c15="http://schemas.microsoft.com/office/drawing/2012/chart">
                  <c:ext xmlns:c16="http://schemas.microsoft.com/office/drawing/2014/chart" uri="{C3380CC4-5D6E-409C-BE32-E72D297353CC}">
                    <c16:uniqueId val="{0000000C-5068-4D33-BAE6-189EA21A6111}"/>
                  </c:ext>
                </c:extLst>
              </c15:ser>
            </c15:filteredLineSeries>
            <c15:filteredLineSeries>
              <c15:ser>
                <c:idx val="13"/>
                <c:order val="13"/>
                <c:tx>
                  <c:strRef>
                    <c:extLst xmlns:c15="http://schemas.microsoft.com/office/drawing/2012/chart">
                      <c:ext xmlns:c15="http://schemas.microsoft.com/office/drawing/2012/chart" uri="{02D57815-91ED-43cb-92C2-25804820EDAC}">
                        <c15:formulaRef>
                          <c15:sqref>'RADx Ct plots'!$Z$4</c15:sqref>
                        </c15:formulaRef>
                      </c:ext>
                    </c:extLst>
                    <c:strCache>
                      <c:ptCount val="1"/>
                      <c:pt idx="0">
                        <c:v>S:ins214</c:v>
                      </c:pt>
                    </c:strCache>
                  </c:strRef>
                </c:tx>
                <c:spPr>
                  <a:ln w="19050" cap="rnd">
                    <a:solidFill>
                      <a:schemeClr val="accent2">
                        <a:lumMod val="80000"/>
                        <a:lumOff val="20000"/>
                      </a:schemeClr>
                    </a:solidFill>
                    <a:round/>
                  </a:ln>
                  <a:effectLst/>
                </c:spPr>
                <c:marker>
                  <c:symbol val="circle"/>
                  <c:size val="5"/>
                  <c:spPr>
                    <a:solidFill>
                      <a:schemeClr val="accent2">
                        <a:lumMod val="80000"/>
                        <a:lumOff val="20000"/>
                      </a:schemeClr>
                    </a:solidFill>
                    <a:ln w="9525">
                      <a:solidFill>
                        <a:schemeClr val="accent2">
                          <a:lumMod val="80000"/>
                          <a:lumOff val="20000"/>
                        </a:schemeClr>
                      </a:solidFill>
                    </a:ln>
                    <a:effectLst/>
                  </c:spPr>
                </c:marker>
                <c:cat>
                  <c:strRef>
                    <c:extLst xmlns:c15="http://schemas.microsoft.com/office/drawing/2012/chart">
                      <c:ext xmlns:c15="http://schemas.microsoft.com/office/drawing/2012/chart" uri="{02D57815-91ED-43cb-92C2-25804820EDAC}">
                        <c15:formulaRef>
                          <c15:sqref>'RADx Ct plots'!$L$5:$L$24</c15:sqref>
                        </c15:formulaRef>
                      </c:ext>
                    </c:extLst>
                    <c:strCache>
                      <c:ptCount val="20"/>
                      <c:pt idx="0">
                        <c:v>B.1.1.7_S1</c:v>
                      </c:pt>
                      <c:pt idx="1">
                        <c:v>B.1.1.7_S2</c:v>
                      </c:pt>
                      <c:pt idx="2">
                        <c:v>B.1.1.7_S3</c:v>
                      </c:pt>
                      <c:pt idx="3">
                        <c:v>B.1.1.7_S4</c:v>
                      </c:pt>
                      <c:pt idx="4">
                        <c:v>B.1.1.7_S5</c:v>
                      </c:pt>
                      <c:pt idx="5">
                        <c:v>B.1.351_S1</c:v>
                      </c:pt>
                      <c:pt idx="6">
                        <c:v>B.1.351_S2</c:v>
                      </c:pt>
                      <c:pt idx="7">
                        <c:v>B.1.351_S3</c:v>
                      </c:pt>
                      <c:pt idx="8">
                        <c:v>B.1.351_S4</c:v>
                      </c:pt>
                      <c:pt idx="9">
                        <c:v>B.1.351_S5</c:v>
                      </c:pt>
                      <c:pt idx="10">
                        <c:v>P.1_S1</c:v>
                      </c:pt>
                      <c:pt idx="11">
                        <c:v>P.1_S2</c:v>
                      </c:pt>
                      <c:pt idx="12">
                        <c:v>P.1_S3</c:v>
                      </c:pt>
                      <c:pt idx="13">
                        <c:v>P.1_S4</c:v>
                      </c:pt>
                      <c:pt idx="14">
                        <c:v>P.1_S5</c:v>
                      </c:pt>
                      <c:pt idx="15">
                        <c:v>B.1.617.2_S1</c:v>
                      </c:pt>
                      <c:pt idx="16">
                        <c:v>B.1.617.2_S2</c:v>
                      </c:pt>
                      <c:pt idx="17">
                        <c:v>B.1.617.2_S3</c:v>
                      </c:pt>
                      <c:pt idx="18">
                        <c:v>B.1.617.2_S4</c:v>
                      </c:pt>
                      <c:pt idx="19">
                        <c:v>B.1.617.2_S5</c:v>
                      </c:pt>
                    </c:strCache>
                  </c:strRef>
                </c:cat>
                <c:val>
                  <c:numRef>
                    <c:extLst xmlns:c15="http://schemas.microsoft.com/office/drawing/2012/chart">
                      <c:ext xmlns:c15="http://schemas.microsoft.com/office/drawing/2012/chart" uri="{02D57815-91ED-43cb-92C2-25804820EDAC}">
                        <c15:formulaRef>
                          <c15:sqref>'RADx Ct plots'!$Z$5:$Z$24</c15:sqref>
                        </c15:formulaRef>
                      </c:ext>
                    </c:extLst>
                    <c:numCache>
                      <c:formatCode>General</c:formatCode>
                      <c:ptCount val="20"/>
                    </c:numCache>
                  </c:numRef>
                </c:val>
                <c:smooth val="0"/>
                <c:extLst xmlns:c15="http://schemas.microsoft.com/office/drawing/2012/chart">
                  <c:ext xmlns:c16="http://schemas.microsoft.com/office/drawing/2014/chart" uri="{C3380CC4-5D6E-409C-BE32-E72D297353CC}">
                    <c16:uniqueId val="{0000000D-5068-4D33-BAE6-189EA21A6111}"/>
                  </c:ext>
                </c:extLst>
              </c15:ser>
            </c15:filteredLineSeries>
          </c:ext>
        </c:extLst>
      </c:lineChart>
      <c:catAx>
        <c:axId val="535968072"/>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35961840"/>
        <c:crosses val="max"/>
        <c:auto val="0"/>
        <c:lblAlgn val="ctr"/>
        <c:lblOffset val="100"/>
        <c:tickMarkSkip val="1"/>
        <c:noMultiLvlLbl val="0"/>
      </c:catAx>
      <c:valAx>
        <c:axId val="535961840"/>
        <c:scaling>
          <c:orientation val="maxMin"/>
          <c:max val="44"/>
          <c:min val="20"/>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Average</a:t>
                </a:r>
                <a:r>
                  <a:rPr lang="en-US" baseline="0"/>
                  <a:t> Ct Value (n=2)</a:t>
                </a:r>
                <a:endParaRPr lang="en-US"/>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35968072"/>
        <c:crossesAt val="1"/>
        <c:crossBetween val="midCat"/>
      </c:valAx>
      <c:spPr>
        <a:noFill/>
        <a:ln>
          <a:noFill/>
        </a:ln>
        <a:effectLst/>
      </c:spPr>
    </c:plotArea>
    <c:legend>
      <c:legendPos val="r"/>
      <c:layout/>
      <c:overlay val="0"/>
      <c:spPr>
        <a:noFill/>
        <a:ln>
          <a:noFill/>
        </a:ln>
        <a:effectLst/>
      </c:spPr>
      <c:txPr>
        <a:bodyPr rot="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0" i="0" u="none" strike="noStrike" kern="1200" spc="0" baseline="0">
                <a:solidFill>
                  <a:schemeClr val="tx1">
                    <a:lumMod val="65000"/>
                    <a:lumOff val="35000"/>
                  </a:schemeClr>
                </a:solidFill>
                <a:latin typeface="+mn-lt"/>
                <a:ea typeface="+mn-ea"/>
                <a:cs typeface="+mn-cs"/>
              </a:defRPr>
            </a:pPr>
            <a:r>
              <a:rPr lang="en-US" sz="1800"/>
              <a:t>Ct Values</a:t>
            </a:r>
            <a:r>
              <a:rPr lang="en-US" sz="1800" baseline="0"/>
              <a:t> of NHRC Residual </a:t>
            </a:r>
            <a:r>
              <a:rPr lang="en-US" sz="1800"/>
              <a:t>Clinical</a:t>
            </a:r>
            <a:r>
              <a:rPr lang="en-US" sz="1800" baseline="0"/>
              <a:t> Specimens</a:t>
            </a:r>
            <a:endParaRPr lang="en-US" sz="1800"/>
          </a:p>
        </c:rich>
      </c:tx>
      <c:layout/>
      <c:overlay val="0"/>
      <c:spPr>
        <a:noFill/>
        <a:ln>
          <a:noFill/>
        </a:ln>
        <a:effectLst/>
      </c:spPr>
      <c:txPr>
        <a:bodyPr rot="0" spcFirstLastPara="1" vertOverflow="ellipsis" vert="horz" wrap="square" anchor="ctr" anchorCtr="1"/>
        <a:lstStyle/>
        <a:p>
          <a:pPr>
            <a:defRPr sz="18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Ct plots'!$V$4</c:f>
              <c:strCache>
                <c:ptCount val="1"/>
                <c:pt idx="0">
                  <c:v>N1</c:v>
                </c:pt>
              </c:strCache>
            </c:strRef>
          </c:tx>
          <c:spPr>
            <a:ln w="19050" cap="rnd">
              <a:noFill/>
              <a:round/>
            </a:ln>
            <a:effectLst/>
          </c:spPr>
          <c:marker>
            <c:symbol val="x"/>
            <c:size val="4"/>
            <c:spPr>
              <a:noFill/>
              <a:ln w="19050">
                <a:solidFill>
                  <a:schemeClr val="tx1"/>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V$5:$V$68</c:f>
              <c:numCache>
                <c:formatCode>0.0</c:formatCode>
                <c:ptCount val="64"/>
                <c:pt idx="0">
                  <c:v>16.46</c:v>
                </c:pt>
                <c:pt idx="1">
                  <c:v>22.43</c:v>
                </c:pt>
                <c:pt idx="2">
                  <c:v>24.31</c:v>
                </c:pt>
                <c:pt idx="3">
                  <c:v>24.67</c:v>
                </c:pt>
                <c:pt idx="4">
                  <c:v>25.2</c:v>
                </c:pt>
                <c:pt idx="5">
                  <c:v>25.27</c:v>
                </c:pt>
                <c:pt idx="6">
                  <c:v>26.54</c:v>
                </c:pt>
                <c:pt idx="7">
                  <c:v>26.66</c:v>
                </c:pt>
                <c:pt idx="8">
                  <c:v>27.07</c:v>
                </c:pt>
                <c:pt idx="9">
                  <c:v>27.11</c:v>
                </c:pt>
                <c:pt idx="10">
                  <c:v>18.88</c:v>
                </c:pt>
                <c:pt idx="11">
                  <c:v>19.03</c:v>
                </c:pt>
                <c:pt idx="12">
                  <c:v>19.579999999999998</c:v>
                </c:pt>
                <c:pt idx="13">
                  <c:v>20.18</c:v>
                </c:pt>
                <c:pt idx="14">
                  <c:v>22.14</c:v>
                </c:pt>
                <c:pt idx="15">
                  <c:v>22.18</c:v>
                </c:pt>
                <c:pt idx="16">
                  <c:v>23.55</c:v>
                </c:pt>
                <c:pt idx="17">
                  <c:v>23.87</c:v>
                </c:pt>
                <c:pt idx="18">
                  <c:v>24.77</c:v>
                </c:pt>
                <c:pt idx="19">
                  <c:v>25.31</c:v>
                </c:pt>
                <c:pt idx="20">
                  <c:v>25.87</c:v>
                </c:pt>
                <c:pt idx="21">
                  <c:v>26.01</c:v>
                </c:pt>
                <c:pt idx="22">
                  <c:v>26.01</c:v>
                </c:pt>
                <c:pt idx="23">
                  <c:v>27</c:v>
                </c:pt>
                <c:pt idx="24">
                  <c:v>15.93</c:v>
                </c:pt>
                <c:pt idx="25">
                  <c:v>18.309999999999999</c:v>
                </c:pt>
                <c:pt idx="26">
                  <c:v>21.73</c:v>
                </c:pt>
                <c:pt idx="27">
                  <c:v>22.07</c:v>
                </c:pt>
                <c:pt idx="28">
                  <c:v>23</c:v>
                </c:pt>
                <c:pt idx="29">
                  <c:v>23.26</c:v>
                </c:pt>
                <c:pt idx="30">
                  <c:v>23.39</c:v>
                </c:pt>
                <c:pt idx="31">
                  <c:v>23.69</c:v>
                </c:pt>
                <c:pt idx="32">
                  <c:v>23.83</c:v>
                </c:pt>
                <c:pt idx="33">
                  <c:v>24.06</c:v>
                </c:pt>
                <c:pt idx="34">
                  <c:v>15.27</c:v>
                </c:pt>
                <c:pt idx="35">
                  <c:v>16.649999999999999</c:v>
                </c:pt>
                <c:pt idx="36">
                  <c:v>16.899999999999999</c:v>
                </c:pt>
                <c:pt idx="37">
                  <c:v>17.02</c:v>
                </c:pt>
                <c:pt idx="38">
                  <c:v>17.309999999999999</c:v>
                </c:pt>
                <c:pt idx="39">
                  <c:v>17.38</c:v>
                </c:pt>
                <c:pt idx="40">
                  <c:v>18.02</c:v>
                </c:pt>
                <c:pt idx="41">
                  <c:v>19.059999999999999</c:v>
                </c:pt>
                <c:pt idx="42">
                  <c:v>21.08</c:v>
                </c:pt>
                <c:pt idx="43">
                  <c:v>22.87</c:v>
                </c:pt>
                <c:pt idx="44">
                  <c:v>14.36</c:v>
                </c:pt>
                <c:pt idx="45">
                  <c:v>15.13</c:v>
                </c:pt>
                <c:pt idx="46">
                  <c:v>16.149999999999999</c:v>
                </c:pt>
                <c:pt idx="47">
                  <c:v>17.32</c:v>
                </c:pt>
                <c:pt idx="48">
                  <c:v>17.52</c:v>
                </c:pt>
                <c:pt idx="49">
                  <c:v>17.52</c:v>
                </c:pt>
                <c:pt idx="50">
                  <c:v>17.71</c:v>
                </c:pt>
                <c:pt idx="51">
                  <c:v>20.62</c:v>
                </c:pt>
                <c:pt idx="52">
                  <c:v>21.29</c:v>
                </c:pt>
                <c:pt idx="53">
                  <c:v>22.26</c:v>
                </c:pt>
                <c:pt idx="54">
                  <c:v>22.38</c:v>
                </c:pt>
                <c:pt idx="55">
                  <c:v>22.55</c:v>
                </c:pt>
                <c:pt idx="56">
                  <c:v>22.9</c:v>
                </c:pt>
                <c:pt idx="57">
                  <c:v>23.69</c:v>
                </c:pt>
                <c:pt idx="58">
                  <c:v>24.13</c:v>
                </c:pt>
                <c:pt idx="59">
                  <c:v>24.45</c:v>
                </c:pt>
                <c:pt idx="60">
                  <c:v>25.27</c:v>
                </c:pt>
                <c:pt idx="61">
                  <c:v>26.35</c:v>
                </c:pt>
                <c:pt idx="62">
                  <c:v>27.12</c:v>
                </c:pt>
                <c:pt idx="63">
                  <c:v>27.73</c:v>
                </c:pt>
              </c:numCache>
            </c:numRef>
          </c:val>
          <c:smooth val="0"/>
          <c:extLst>
            <c:ext xmlns:c16="http://schemas.microsoft.com/office/drawing/2014/chart" uri="{C3380CC4-5D6E-409C-BE32-E72D297353CC}">
              <c16:uniqueId val="{00000000-0ACB-47E7-9ABF-C0DE81FF880F}"/>
            </c:ext>
          </c:extLst>
        </c:ser>
        <c:ser>
          <c:idx val="1"/>
          <c:order val="1"/>
          <c:tx>
            <c:strRef>
              <c:f>'Ct plots'!$W$4</c:f>
              <c:strCache>
                <c:ptCount val="1"/>
                <c:pt idx="0">
                  <c:v>N2</c:v>
                </c:pt>
              </c:strCache>
            </c:strRef>
          </c:tx>
          <c:spPr>
            <a:ln w="19050" cap="rnd">
              <a:noFill/>
              <a:round/>
            </a:ln>
            <a:effectLst/>
          </c:spPr>
          <c:marker>
            <c:symbol val="x"/>
            <c:size val="4"/>
            <c:spPr>
              <a:noFill/>
              <a:ln w="19050">
                <a:solidFill>
                  <a:schemeClr val="accent2"/>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W$5:$W$68</c:f>
              <c:numCache>
                <c:formatCode>0.0</c:formatCode>
                <c:ptCount val="64"/>
                <c:pt idx="0">
                  <c:v>17.79</c:v>
                </c:pt>
                <c:pt idx="1">
                  <c:v>24.13</c:v>
                </c:pt>
                <c:pt idx="2">
                  <c:v>24.95</c:v>
                </c:pt>
                <c:pt idx="3">
                  <c:v>25.59</c:v>
                </c:pt>
                <c:pt idx="4">
                  <c:v>27.56</c:v>
                </c:pt>
                <c:pt idx="5">
                  <c:v>27.55</c:v>
                </c:pt>
                <c:pt idx="6">
                  <c:v>28.73</c:v>
                </c:pt>
                <c:pt idx="7">
                  <c:v>28.97</c:v>
                </c:pt>
                <c:pt idx="8">
                  <c:v>28.61</c:v>
                </c:pt>
                <c:pt idx="9">
                  <c:v>29.46</c:v>
                </c:pt>
                <c:pt idx="10">
                  <c:v>20.75</c:v>
                </c:pt>
                <c:pt idx="11">
                  <c:v>21.12</c:v>
                </c:pt>
                <c:pt idx="12">
                  <c:v>21.68</c:v>
                </c:pt>
                <c:pt idx="13">
                  <c:v>22.83</c:v>
                </c:pt>
                <c:pt idx="14">
                  <c:v>24.12</c:v>
                </c:pt>
                <c:pt idx="15">
                  <c:v>23.67</c:v>
                </c:pt>
                <c:pt idx="16">
                  <c:v>25.25</c:v>
                </c:pt>
                <c:pt idx="17">
                  <c:v>25.45</c:v>
                </c:pt>
                <c:pt idx="18">
                  <c:v>26.61</c:v>
                </c:pt>
                <c:pt idx="19">
                  <c:v>27.11</c:v>
                </c:pt>
                <c:pt idx="20">
                  <c:v>27.52</c:v>
                </c:pt>
                <c:pt idx="21">
                  <c:v>28.17</c:v>
                </c:pt>
                <c:pt idx="22">
                  <c:v>28.02</c:v>
                </c:pt>
                <c:pt idx="23">
                  <c:v>29.18</c:v>
                </c:pt>
                <c:pt idx="24">
                  <c:v>16.71</c:v>
                </c:pt>
                <c:pt idx="25">
                  <c:v>19.16</c:v>
                </c:pt>
                <c:pt idx="26">
                  <c:v>22.97</c:v>
                </c:pt>
                <c:pt idx="27">
                  <c:v>23.98</c:v>
                </c:pt>
                <c:pt idx="28">
                  <c:v>24.12</c:v>
                </c:pt>
                <c:pt idx="29">
                  <c:v>24.35</c:v>
                </c:pt>
                <c:pt idx="30">
                  <c:v>24.97</c:v>
                </c:pt>
                <c:pt idx="31">
                  <c:v>24.18</c:v>
                </c:pt>
                <c:pt idx="32">
                  <c:v>25.07</c:v>
                </c:pt>
                <c:pt idx="33">
                  <c:v>25.66</c:v>
                </c:pt>
                <c:pt idx="34">
                  <c:v>15.56</c:v>
                </c:pt>
                <c:pt idx="35">
                  <c:v>17.04</c:v>
                </c:pt>
                <c:pt idx="36">
                  <c:v>16.95</c:v>
                </c:pt>
                <c:pt idx="37">
                  <c:v>17.18</c:v>
                </c:pt>
                <c:pt idx="38">
                  <c:v>17.66</c:v>
                </c:pt>
                <c:pt idx="39">
                  <c:v>18.2</c:v>
                </c:pt>
                <c:pt idx="40">
                  <c:v>18.489999999999998</c:v>
                </c:pt>
                <c:pt idx="41">
                  <c:v>19.14</c:v>
                </c:pt>
                <c:pt idx="42">
                  <c:v>21.16</c:v>
                </c:pt>
                <c:pt idx="43">
                  <c:v>23.38</c:v>
                </c:pt>
                <c:pt idx="44">
                  <c:v>15.04</c:v>
                </c:pt>
                <c:pt idx="45">
                  <c:v>15.63</c:v>
                </c:pt>
                <c:pt idx="46">
                  <c:v>16.87</c:v>
                </c:pt>
                <c:pt idx="47">
                  <c:v>18.739999999999998</c:v>
                </c:pt>
                <c:pt idx="48">
                  <c:v>18</c:v>
                </c:pt>
                <c:pt idx="49">
                  <c:v>18.59</c:v>
                </c:pt>
                <c:pt idx="50">
                  <c:v>18.66</c:v>
                </c:pt>
                <c:pt idx="51">
                  <c:v>21.66</c:v>
                </c:pt>
                <c:pt idx="52">
                  <c:v>22.74</c:v>
                </c:pt>
                <c:pt idx="53">
                  <c:v>24.04</c:v>
                </c:pt>
                <c:pt idx="54">
                  <c:v>23.69</c:v>
                </c:pt>
                <c:pt idx="55">
                  <c:v>24.57</c:v>
                </c:pt>
                <c:pt idx="56">
                  <c:v>24.98</c:v>
                </c:pt>
                <c:pt idx="57">
                  <c:v>25.47</c:v>
                </c:pt>
                <c:pt idx="58">
                  <c:v>25.01</c:v>
                </c:pt>
                <c:pt idx="59">
                  <c:v>26.14</c:v>
                </c:pt>
                <c:pt idx="60">
                  <c:v>28.05</c:v>
                </c:pt>
                <c:pt idx="61">
                  <c:v>27.76</c:v>
                </c:pt>
                <c:pt idx="62">
                  <c:v>29.27</c:v>
                </c:pt>
                <c:pt idx="63">
                  <c:v>29.2</c:v>
                </c:pt>
              </c:numCache>
            </c:numRef>
          </c:val>
          <c:smooth val="0"/>
          <c:extLst>
            <c:ext xmlns:c16="http://schemas.microsoft.com/office/drawing/2014/chart" uri="{C3380CC4-5D6E-409C-BE32-E72D297353CC}">
              <c16:uniqueId val="{00000001-0ACB-47E7-9ABF-C0DE81FF880F}"/>
            </c:ext>
          </c:extLst>
        </c:ser>
        <c:ser>
          <c:idx val="2"/>
          <c:order val="2"/>
          <c:tx>
            <c:strRef>
              <c:f>'Ct plots'!$X$4</c:f>
              <c:strCache>
                <c:ptCount val="1"/>
                <c:pt idx="0">
                  <c:v>S:501Y</c:v>
                </c:pt>
              </c:strCache>
            </c:strRef>
          </c:tx>
          <c:spPr>
            <a:ln w="19050" cap="rnd">
              <a:noFill/>
              <a:round/>
            </a:ln>
            <a:effectLst/>
          </c:spPr>
          <c:marker>
            <c:symbol val="dash"/>
            <c:size val="5"/>
            <c:spPr>
              <a:solidFill>
                <a:schemeClr val="accent3"/>
              </a:solidFill>
              <a:ln w="19050">
                <a:solidFill>
                  <a:schemeClr val="accent3"/>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X$5:$X$68</c:f>
              <c:numCache>
                <c:formatCode>0.0</c:formatCode>
                <c:ptCount val="64"/>
                <c:pt idx="0">
                  <c:v>22.3</c:v>
                </c:pt>
                <c:pt idx="1">
                  <c:v>28.17</c:v>
                </c:pt>
                <c:pt idx="2">
                  <c:v>28.6</c:v>
                </c:pt>
                <c:pt idx="3">
                  <c:v>30.37</c:v>
                </c:pt>
                <c:pt idx="4">
                  <c:v>31.75</c:v>
                </c:pt>
                <c:pt idx="5">
                  <c:v>31.68</c:v>
                </c:pt>
                <c:pt idx="6">
                  <c:v>31.72</c:v>
                </c:pt>
                <c:pt idx="7">
                  <c:v>31.6</c:v>
                </c:pt>
                <c:pt idx="8">
                  <c:v>32.54</c:v>
                </c:pt>
                <c:pt idx="9">
                  <c:v>33.619999999999997</c:v>
                </c:pt>
                <c:pt idx="10">
                  <c:v>23.22</c:v>
                </c:pt>
                <c:pt idx="11">
                  <c:v>25.43</c:v>
                </c:pt>
                <c:pt idx="12">
                  <c:v>24.99</c:v>
                </c:pt>
                <c:pt idx="13">
                  <c:v>26.12</c:v>
                </c:pt>
                <c:pt idx="14">
                  <c:v>28.81</c:v>
                </c:pt>
                <c:pt idx="15">
                  <c:v>29.04</c:v>
                </c:pt>
                <c:pt idx="16">
                  <c:v>29.84</c:v>
                </c:pt>
                <c:pt idx="17">
                  <c:v>30.09</c:v>
                </c:pt>
                <c:pt idx="18">
                  <c:v>31.16</c:v>
                </c:pt>
                <c:pt idx="19">
                  <c:v>31.26</c:v>
                </c:pt>
                <c:pt idx="20">
                  <c:v>31.58</c:v>
                </c:pt>
                <c:pt idx="21">
                  <c:v>33.49</c:v>
                </c:pt>
                <c:pt idx="22">
                  <c:v>32.33</c:v>
                </c:pt>
                <c:pt idx="23">
                  <c:v>33.729999999999997</c:v>
                </c:pt>
                <c:pt idx="50">
                  <c:v>22.38</c:v>
                </c:pt>
              </c:numCache>
            </c:numRef>
          </c:val>
          <c:smooth val="0"/>
          <c:extLst>
            <c:ext xmlns:c16="http://schemas.microsoft.com/office/drawing/2014/chart" uri="{C3380CC4-5D6E-409C-BE32-E72D297353CC}">
              <c16:uniqueId val="{00000002-0ACB-47E7-9ABF-C0DE81FF880F}"/>
            </c:ext>
          </c:extLst>
        </c:ser>
        <c:ser>
          <c:idx val="3"/>
          <c:order val="3"/>
          <c:tx>
            <c:strRef>
              <c:f>'Ct plots'!$Y$4</c:f>
              <c:strCache>
                <c:ptCount val="1"/>
                <c:pt idx="0">
                  <c:v>S:P26S</c:v>
                </c:pt>
              </c:strCache>
            </c:strRef>
          </c:tx>
          <c:spPr>
            <a:ln w="19050" cap="rnd">
              <a:noFill/>
              <a:round/>
            </a:ln>
            <a:effectLst/>
          </c:spPr>
          <c:marker>
            <c:symbol val="dash"/>
            <c:size val="5"/>
            <c:spPr>
              <a:solidFill>
                <a:schemeClr val="accent4"/>
              </a:solidFill>
              <a:ln w="19050">
                <a:solidFill>
                  <a:schemeClr val="accent4"/>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Y$5:$Y$68</c:f>
              <c:numCache>
                <c:formatCode>0.0</c:formatCode>
                <c:ptCount val="64"/>
                <c:pt idx="0">
                  <c:v>26.8</c:v>
                </c:pt>
                <c:pt idx="1">
                  <c:v>31.64</c:v>
                </c:pt>
                <c:pt idx="2">
                  <c:v>33.840000000000003</c:v>
                </c:pt>
                <c:pt idx="3">
                  <c:v>34</c:v>
                </c:pt>
                <c:pt idx="4">
                  <c:v>34.159999999999997</c:v>
                </c:pt>
                <c:pt idx="5">
                  <c:v>37.78</c:v>
                </c:pt>
                <c:pt idx="6">
                  <c:v>34.58</c:v>
                </c:pt>
                <c:pt idx="7">
                  <c:v>34.42</c:v>
                </c:pt>
                <c:pt idx="8">
                  <c:v>38.76</c:v>
                </c:pt>
                <c:pt idx="9">
                  <c:v>37.369999999999997</c:v>
                </c:pt>
                <c:pt idx="10">
                  <c:v>26.71</c:v>
                </c:pt>
                <c:pt idx="11">
                  <c:v>28.81</c:v>
                </c:pt>
                <c:pt idx="12">
                  <c:v>28.13</c:v>
                </c:pt>
                <c:pt idx="13">
                  <c:v>30.4</c:v>
                </c:pt>
                <c:pt idx="14">
                  <c:v>35.57</c:v>
                </c:pt>
                <c:pt idx="15">
                  <c:v>33.11</c:v>
                </c:pt>
                <c:pt idx="16">
                  <c:v>34.92</c:v>
                </c:pt>
                <c:pt idx="17">
                  <c:v>37.1</c:v>
                </c:pt>
                <c:pt idx="18">
                  <c:v>39.299999999999997</c:v>
                </c:pt>
                <c:pt idx="19">
                  <c:v>43.46</c:v>
                </c:pt>
                <c:pt idx="20">
                  <c:v>37.58</c:v>
                </c:pt>
                <c:pt idx="22">
                  <c:v>41.43</c:v>
                </c:pt>
                <c:pt idx="24">
                  <c:v>24.95</c:v>
                </c:pt>
                <c:pt idx="25">
                  <c:v>27.45</c:v>
                </c:pt>
                <c:pt idx="26">
                  <c:v>30.85</c:v>
                </c:pt>
                <c:pt idx="27">
                  <c:v>32.08</c:v>
                </c:pt>
                <c:pt idx="28">
                  <c:v>31.3</c:v>
                </c:pt>
                <c:pt idx="29">
                  <c:v>31.56</c:v>
                </c:pt>
                <c:pt idx="30">
                  <c:v>32.9</c:v>
                </c:pt>
                <c:pt idx="31">
                  <c:v>32.35</c:v>
                </c:pt>
                <c:pt idx="32">
                  <c:v>33.29</c:v>
                </c:pt>
                <c:pt idx="33">
                  <c:v>32.869999999999997</c:v>
                </c:pt>
                <c:pt idx="34">
                  <c:v>23.29</c:v>
                </c:pt>
                <c:pt idx="35">
                  <c:v>24.75</c:v>
                </c:pt>
                <c:pt idx="36">
                  <c:v>24.09</c:v>
                </c:pt>
                <c:pt idx="37">
                  <c:v>24.33</c:v>
                </c:pt>
                <c:pt idx="38">
                  <c:v>25.97</c:v>
                </c:pt>
                <c:pt idx="39">
                  <c:v>25.43</c:v>
                </c:pt>
                <c:pt idx="40">
                  <c:v>25.2</c:v>
                </c:pt>
                <c:pt idx="41">
                  <c:v>26.28</c:v>
                </c:pt>
                <c:pt idx="42">
                  <c:v>28.73</c:v>
                </c:pt>
                <c:pt idx="43">
                  <c:v>30.7</c:v>
                </c:pt>
                <c:pt idx="44">
                  <c:v>21.52</c:v>
                </c:pt>
                <c:pt idx="45">
                  <c:v>21.56</c:v>
                </c:pt>
                <c:pt idx="46">
                  <c:v>24.61</c:v>
                </c:pt>
                <c:pt idx="47">
                  <c:v>25.48</c:v>
                </c:pt>
                <c:pt idx="48">
                  <c:v>25.77</c:v>
                </c:pt>
                <c:pt idx="49">
                  <c:v>25.18</c:v>
                </c:pt>
                <c:pt idx="50">
                  <c:v>25.78</c:v>
                </c:pt>
                <c:pt idx="51">
                  <c:v>29.67</c:v>
                </c:pt>
                <c:pt idx="52">
                  <c:v>33.65</c:v>
                </c:pt>
                <c:pt idx="53">
                  <c:v>31.48</c:v>
                </c:pt>
                <c:pt idx="54">
                  <c:v>30.58</c:v>
                </c:pt>
                <c:pt idx="55">
                  <c:v>30.15</c:v>
                </c:pt>
                <c:pt idx="56">
                  <c:v>30.54</c:v>
                </c:pt>
                <c:pt idx="57">
                  <c:v>33.06</c:v>
                </c:pt>
                <c:pt idx="58">
                  <c:v>30.72</c:v>
                </c:pt>
                <c:pt idx="59">
                  <c:v>31.59</c:v>
                </c:pt>
                <c:pt idx="60">
                  <c:v>33.79</c:v>
                </c:pt>
                <c:pt idx="61">
                  <c:v>31.67</c:v>
                </c:pt>
                <c:pt idx="62">
                  <c:v>34.53</c:v>
                </c:pt>
                <c:pt idx="63">
                  <c:v>36.71</c:v>
                </c:pt>
              </c:numCache>
            </c:numRef>
          </c:val>
          <c:smooth val="0"/>
          <c:extLst>
            <c:ext xmlns:c16="http://schemas.microsoft.com/office/drawing/2014/chart" uri="{C3380CC4-5D6E-409C-BE32-E72D297353CC}">
              <c16:uniqueId val="{00000003-0ACB-47E7-9ABF-C0DE81FF880F}"/>
            </c:ext>
          </c:extLst>
        </c:ser>
        <c:ser>
          <c:idx val="4"/>
          <c:order val="4"/>
          <c:tx>
            <c:strRef>
              <c:f>'Ct plots'!$Z$4</c:f>
              <c:strCache>
                <c:ptCount val="1"/>
                <c:pt idx="0">
                  <c:v>S:144del</c:v>
                </c:pt>
              </c:strCache>
            </c:strRef>
          </c:tx>
          <c:spPr>
            <a:ln w="19050" cap="rnd">
              <a:noFill/>
              <a:round/>
            </a:ln>
            <a:effectLst/>
          </c:spPr>
          <c:marker>
            <c:symbol val="dash"/>
            <c:size val="5"/>
            <c:spPr>
              <a:solidFill>
                <a:schemeClr val="accent5"/>
              </a:solidFill>
              <a:ln w="19050">
                <a:solidFill>
                  <a:schemeClr val="accent5"/>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Z$5:$Z$68</c:f>
              <c:numCache>
                <c:formatCode>0.0</c:formatCode>
                <c:ptCount val="64"/>
                <c:pt idx="0">
                  <c:v>22.59</c:v>
                </c:pt>
                <c:pt idx="1">
                  <c:v>28.32</c:v>
                </c:pt>
                <c:pt idx="2">
                  <c:v>29.04</c:v>
                </c:pt>
                <c:pt idx="3">
                  <c:v>30.38</c:v>
                </c:pt>
                <c:pt idx="4">
                  <c:v>31.86</c:v>
                </c:pt>
                <c:pt idx="5">
                  <c:v>31.88</c:v>
                </c:pt>
                <c:pt idx="6">
                  <c:v>31.79</c:v>
                </c:pt>
                <c:pt idx="7">
                  <c:v>31.7</c:v>
                </c:pt>
                <c:pt idx="8">
                  <c:v>32.520000000000003</c:v>
                </c:pt>
                <c:pt idx="9">
                  <c:v>33.08</c:v>
                </c:pt>
                <c:pt idx="47">
                  <c:v>22.22</c:v>
                </c:pt>
                <c:pt idx="49">
                  <c:v>21.83</c:v>
                </c:pt>
              </c:numCache>
            </c:numRef>
          </c:val>
          <c:smooth val="0"/>
          <c:extLst>
            <c:ext xmlns:c16="http://schemas.microsoft.com/office/drawing/2014/chart" uri="{C3380CC4-5D6E-409C-BE32-E72D297353CC}">
              <c16:uniqueId val="{00000004-0ACB-47E7-9ABF-C0DE81FF880F}"/>
            </c:ext>
          </c:extLst>
        </c:ser>
        <c:ser>
          <c:idx val="5"/>
          <c:order val="5"/>
          <c:tx>
            <c:strRef>
              <c:f>'Ct plots'!$AA$4</c:f>
              <c:strCache>
                <c:ptCount val="1"/>
                <c:pt idx="0">
                  <c:v>S:69/70 del</c:v>
                </c:pt>
              </c:strCache>
            </c:strRef>
          </c:tx>
          <c:spPr>
            <a:ln w="19050" cap="rnd">
              <a:noFill/>
              <a:round/>
            </a:ln>
            <a:effectLst/>
          </c:spPr>
          <c:marker>
            <c:symbol val="dash"/>
            <c:size val="5"/>
            <c:spPr>
              <a:solidFill>
                <a:schemeClr val="accent6"/>
              </a:solidFill>
              <a:ln w="19050">
                <a:solidFill>
                  <a:schemeClr val="accent6"/>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A$5:$AA$68</c:f>
              <c:numCache>
                <c:formatCode>0.0</c:formatCode>
                <c:ptCount val="64"/>
                <c:pt idx="0">
                  <c:v>20.149999999999999</c:v>
                </c:pt>
                <c:pt idx="1">
                  <c:v>25.67</c:v>
                </c:pt>
                <c:pt idx="2">
                  <c:v>26.16</c:v>
                </c:pt>
                <c:pt idx="3">
                  <c:v>27.11</c:v>
                </c:pt>
                <c:pt idx="4">
                  <c:v>29.14</c:v>
                </c:pt>
                <c:pt idx="5">
                  <c:v>29.01</c:v>
                </c:pt>
                <c:pt idx="6">
                  <c:v>28.97</c:v>
                </c:pt>
                <c:pt idx="7">
                  <c:v>28.99</c:v>
                </c:pt>
                <c:pt idx="8">
                  <c:v>29.61</c:v>
                </c:pt>
                <c:pt idx="9">
                  <c:v>30.17</c:v>
                </c:pt>
                <c:pt idx="34">
                  <c:v>20.03</c:v>
                </c:pt>
                <c:pt idx="35">
                  <c:v>21.65</c:v>
                </c:pt>
                <c:pt idx="36">
                  <c:v>21.52</c:v>
                </c:pt>
                <c:pt idx="37">
                  <c:v>21.17</c:v>
                </c:pt>
                <c:pt idx="38">
                  <c:v>22.28</c:v>
                </c:pt>
                <c:pt idx="39">
                  <c:v>22.25</c:v>
                </c:pt>
                <c:pt idx="40">
                  <c:v>22.47</c:v>
                </c:pt>
                <c:pt idx="41">
                  <c:v>23.68</c:v>
                </c:pt>
                <c:pt idx="42">
                  <c:v>26.43</c:v>
                </c:pt>
                <c:pt idx="43">
                  <c:v>27.57</c:v>
                </c:pt>
              </c:numCache>
            </c:numRef>
          </c:val>
          <c:smooth val="0"/>
          <c:extLst>
            <c:ext xmlns:c16="http://schemas.microsoft.com/office/drawing/2014/chart" uri="{C3380CC4-5D6E-409C-BE32-E72D297353CC}">
              <c16:uniqueId val="{00000005-0ACB-47E7-9ABF-C0DE81FF880F}"/>
            </c:ext>
          </c:extLst>
        </c:ser>
        <c:ser>
          <c:idx val="6"/>
          <c:order val="6"/>
          <c:tx>
            <c:strRef>
              <c:f>'Ct plots'!$AB$4</c:f>
              <c:strCache>
                <c:ptCount val="1"/>
                <c:pt idx="0">
                  <c:v>S:484K</c:v>
                </c:pt>
              </c:strCache>
            </c:strRef>
          </c:tx>
          <c:spPr>
            <a:ln w="19050" cap="rnd">
              <a:noFill/>
              <a:round/>
            </a:ln>
            <a:effectLst/>
          </c:spPr>
          <c:marker>
            <c:symbol val="dash"/>
            <c:size val="5"/>
            <c:spPr>
              <a:solidFill>
                <a:schemeClr val="accent1">
                  <a:lumMod val="60000"/>
                </a:schemeClr>
              </a:solidFill>
              <a:ln w="19050">
                <a:solidFill>
                  <a:schemeClr val="accent1">
                    <a:lumMod val="60000"/>
                  </a:schemeClr>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B$5:$AB$68</c:f>
              <c:numCache>
                <c:formatCode>General</c:formatCode>
                <c:ptCount val="64"/>
                <c:pt idx="10" formatCode="0.0">
                  <c:v>23.18</c:v>
                </c:pt>
                <c:pt idx="11" formatCode="0.0">
                  <c:v>24.11</c:v>
                </c:pt>
                <c:pt idx="12" formatCode="0.0">
                  <c:v>24.09</c:v>
                </c:pt>
                <c:pt idx="13" formatCode="0.0">
                  <c:v>25.25</c:v>
                </c:pt>
                <c:pt idx="14" formatCode="0.0">
                  <c:v>27.95</c:v>
                </c:pt>
                <c:pt idx="15" formatCode="0.0">
                  <c:v>28.21</c:v>
                </c:pt>
                <c:pt idx="16" formatCode="0.0">
                  <c:v>29.72</c:v>
                </c:pt>
                <c:pt idx="17" formatCode="0.0">
                  <c:v>29.56</c:v>
                </c:pt>
                <c:pt idx="18" formatCode="0.0">
                  <c:v>30.58</c:v>
                </c:pt>
                <c:pt idx="19" formatCode="0.0">
                  <c:v>30.36</c:v>
                </c:pt>
                <c:pt idx="20" formatCode="0.0">
                  <c:v>31.01</c:v>
                </c:pt>
                <c:pt idx="21" formatCode="0.0">
                  <c:v>32.229999999999997</c:v>
                </c:pt>
                <c:pt idx="22" formatCode="0.0">
                  <c:v>31.31</c:v>
                </c:pt>
                <c:pt idx="23" formatCode="0.0">
                  <c:v>32.950000000000003</c:v>
                </c:pt>
                <c:pt idx="47" formatCode="0.0">
                  <c:v>22.26</c:v>
                </c:pt>
                <c:pt idx="50" formatCode="0.0">
                  <c:v>21.97</c:v>
                </c:pt>
                <c:pt idx="62" formatCode="0.0">
                  <c:v>32.44</c:v>
                </c:pt>
              </c:numCache>
            </c:numRef>
          </c:val>
          <c:smooth val="0"/>
          <c:extLst>
            <c:ext xmlns:c16="http://schemas.microsoft.com/office/drawing/2014/chart" uri="{C3380CC4-5D6E-409C-BE32-E72D297353CC}">
              <c16:uniqueId val="{00000006-0ACB-47E7-9ABF-C0DE81FF880F}"/>
            </c:ext>
          </c:extLst>
        </c:ser>
        <c:ser>
          <c:idx val="7"/>
          <c:order val="7"/>
          <c:tx>
            <c:strRef>
              <c:f>'Ct plots'!$AC$4</c:f>
              <c:strCache>
                <c:ptCount val="1"/>
                <c:pt idx="0">
                  <c:v>S:215G</c:v>
                </c:pt>
              </c:strCache>
            </c:strRef>
          </c:tx>
          <c:spPr>
            <a:ln w="19050" cap="rnd">
              <a:noFill/>
              <a:round/>
            </a:ln>
            <a:effectLst/>
          </c:spPr>
          <c:marker>
            <c:symbol val="dash"/>
            <c:size val="5"/>
            <c:spPr>
              <a:solidFill>
                <a:schemeClr val="accent2">
                  <a:lumMod val="60000"/>
                </a:schemeClr>
              </a:solidFill>
              <a:ln w="19050">
                <a:solidFill>
                  <a:schemeClr val="accent2">
                    <a:lumMod val="60000"/>
                  </a:schemeClr>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C$5:$AC$68</c:f>
              <c:numCache>
                <c:formatCode>General</c:formatCode>
                <c:ptCount val="64"/>
                <c:pt idx="10" formatCode="0.0">
                  <c:v>23.04</c:v>
                </c:pt>
                <c:pt idx="11" formatCode="0.0">
                  <c:v>23.72</c:v>
                </c:pt>
                <c:pt idx="12" formatCode="0.0">
                  <c:v>23.88</c:v>
                </c:pt>
                <c:pt idx="13" formatCode="0.0">
                  <c:v>24.63</c:v>
                </c:pt>
              </c:numCache>
            </c:numRef>
          </c:val>
          <c:smooth val="0"/>
          <c:extLst>
            <c:ext xmlns:c16="http://schemas.microsoft.com/office/drawing/2014/chart" uri="{C3380CC4-5D6E-409C-BE32-E72D297353CC}">
              <c16:uniqueId val="{00000007-0ACB-47E7-9ABF-C0DE81FF880F}"/>
            </c:ext>
          </c:extLst>
        </c:ser>
        <c:ser>
          <c:idx val="8"/>
          <c:order val="8"/>
          <c:tx>
            <c:strRef>
              <c:f>'Ct plots'!$AD$4</c:f>
              <c:strCache>
                <c:ptCount val="1"/>
                <c:pt idx="0">
                  <c:v>S:681R</c:v>
                </c:pt>
              </c:strCache>
            </c:strRef>
          </c:tx>
          <c:spPr>
            <a:ln w="19050" cap="rnd">
              <a:noFill/>
              <a:round/>
            </a:ln>
            <a:effectLst/>
          </c:spPr>
          <c:marker>
            <c:symbol val="dash"/>
            <c:size val="5"/>
            <c:spPr>
              <a:solidFill>
                <a:schemeClr val="accent3">
                  <a:lumMod val="60000"/>
                </a:schemeClr>
              </a:solidFill>
              <a:ln w="19050">
                <a:solidFill>
                  <a:srgbClr val="00B0F0"/>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D$5:$AD$68</c:f>
              <c:numCache>
                <c:formatCode>General</c:formatCode>
                <c:ptCount val="64"/>
                <c:pt idx="24" formatCode="0.0">
                  <c:v>21.47</c:v>
                </c:pt>
                <c:pt idx="25" formatCode="0.0">
                  <c:v>24.58</c:v>
                </c:pt>
                <c:pt idx="26" formatCode="0.0">
                  <c:v>27.19</c:v>
                </c:pt>
                <c:pt idx="27" formatCode="0.0">
                  <c:v>28.79</c:v>
                </c:pt>
                <c:pt idx="28" formatCode="0.0">
                  <c:v>28.09</c:v>
                </c:pt>
                <c:pt idx="29" formatCode="0.0">
                  <c:v>28.65</c:v>
                </c:pt>
                <c:pt idx="30" formatCode="0.0">
                  <c:v>29.53</c:v>
                </c:pt>
                <c:pt idx="31" formatCode="0.0">
                  <c:v>29.6</c:v>
                </c:pt>
                <c:pt idx="32" formatCode="0.0">
                  <c:v>29.81</c:v>
                </c:pt>
                <c:pt idx="33" formatCode="0.0">
                  <c:v>30.16</c:v>
                </c:pt>
              </c:numCache>
            </c:numRef>
          </c:val>
          <c:smooth val="0"/>
          <c:extLst>
            <c:ext xmlns:c16="http://schemas.microsoft.com/office/drawing/2014/chart" uri="{C3380CC4-5D6E-409C-BE32-E72D297353CC}">
              <c16:uniqueId val="{00000008-0ACB-47E7-9ABF-C0DE81FF880F}"/>
            </c:ext>
          </c:extLst>
        </c:ser>
        <c:ser>
          <c:idx val="9"/>
          <c:order val="9"/>
          <c:tx>
            <c:strRef>
              <c:f>'Ct plots'!$AE$4</c:f>
              <c:strCache>
                <c:ptCount val="1"/>
                <c:pt idx="0">
                  <c:v>S:452R</c:v>
                </c:pt>
              </c:strCache>
            </c:strRef>
          </c:tx>
          <c:spPr>
            <a:ln w="19050" cap="rnd">
              <a:noFill/>
              <a:round/>
            </a:ln>
            <a:effectLst/>
          </c:spPr>
          <c:marker>
            <c:symbol val="dash"/>
            <c:size val="5"/>
            <c:spPr>
              <a:solidFill>
                <a:schemeClr val="accent4">
                  <a:lumMod val="60000"/>
                </a:schemeClr>
              </a:solidFill>
              <a:ln w="19050">
                <a:solidFill>
                  <a:srgbClr val="61FD23"/>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E$5:$AE$68</c:f>
              <c:numCache>
                <c:formatCode>General</c:formatCode>
                <c:ptCount val="64"/>
                <c:pt idx="24" formatCode="0.0">
                  <c:v>20.170000000000002</c:v>
                </c:pt>
                <c:pt idx="25" formatCode="0.0">
                  <c:v>23.02</c:v>
                </c:pt>
                <c:pt idx="26" formatCode="0.0">
                  <c:v>25.98</c:v>
                </c:pt>
                <c:pt idx="27" formatCode="0.0">
                  <c:v>27.36</c:v>
                </c:pt>
                <c:pt idx="28" formatCode="0.0">
                  <c:v>26.86</c:v>
                </c:pt>
                <c:pt idx="29" formatCode="0.0">
                  <c:v>27.44</c:v>
                </c:pt>
                <c:pt idx="30" formatCode="0.0">
                  <c:v>27.85</c:v>
                </c:pt>
                <c:pt idx="31" formatCode="0.0">
                  <c:v>28.27</c:v>
                </c:pt>
                <c:pt idx="32" formatCode="0.0">
                  <c:v>28.49</c:v>
                </c:pt>
                <c:pt idx="33" formatCode="0.0">
                  <c:v>28.97</c:v>
                </c:pt>
                <c:pt idx="49" formatCode="0.0">
                  <c:v>21.42</c:v>
                </c:pt>
                <c:pt idx="52" formatCode="0.0">
                  <c:v>26.55</c:v>
                </c:pt>
                <c:pt idx="58" formatCode="0.0">
                  <c:v>28.22</c:v>
                </c:pt>
                <c:pt idx="63" formatCode="0.0">
                  <c:v>32.33</c:v>
                </c:pt>
              </c:numCache>
            </c:numRef>
          </c:val>
          <c:smooth val="0"/>
          <c:extLst>
            <c:ext xmlns:c16="http://schemas.microsoft.com/office/drawing/2014/chart" uri="{C3380CC4-5D6E-409C-BE32-E72D297353CC}">
              <c16:uniqueId val="{00000009-0ACB-47E7-9ABF-C0DE81FF880F}"/>
            </c:ext>
          </c:extLst>
        </c:ser>
        <c:ser>
          <c:idx val="10"/>
          <c:order val="10"/>
          <c:tx>
            <c:strRef>
              <c:f>'Ct plots'!$AF$4</c:f>
              <c:strCache>
                <c:ptCount val="1"/>
                <c:pt idx="0">
                  <c:v>S:156/ 157 del</c:v>
                </c:pt>
              </c:strCache>
            </c:strRef>
          </c:tx>
          <c:spPr>
            <a:ln w="19050" cap="rnd">
              <a:noFill/>
              <a:round/>
            </a:ln>
            <a:effectLst/>
          </c:spPr>
          <c:marker>
            <c:symbol val="dash"/>
            <c:size val="5"/>
            <c:spPr>
              <a:solidFill>
                <a:schemeClr val="accent5">
                  <a:lumMod val="60000"/>
                </a:schemeClr>
              </a:solidFill>
              <a:ln w="19050">
                <a:solidFill>
                  <a:srgbClr val="FF0000"/>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F$5:$AF$68</c:f>
              <c:numCache>
                <c:formatCode>General</c:formatCode>
                <c:ptCount val="64"/>
                <c:pt idx="24" formatCode="0.0">
                  <c:v>20.59</c:v>
                </c:pt>
                <c:pt idx="25" formatCode="0.0">
                  <c:v>23.25</c:v>
                </c:pt>
                <c:pt idx="26" formatCode="0.0">
                  <c:v>26.43</c:v>
                </c:pt>
                <c:pt idx="27" formatCode="0.0">
                  <c:v>28.37</c:v>
                </c:pt>
                <c:pt idx="28" formatCode="0.0">
                  <c:v>27.34</c:v>
                </c:pt>
                <c:pt idx="29" formatCode="0.0">
                  <c:v>28.12</c:v>
                </c:pt>
                <c:pt idx="30" formatCode="0.0">
                  <c:v>28.38</c:v>
                </c:pt>
                <c:pt idx="31" formatCode="0.0">
                  <c:v>28.94</c:v>
                </c:pt>
                <c:pt idx="32" formatCode="0.0">
                  <c:v>29.04</c:v>
                </c:pt>
                <c:pt idx="33" formatCode="0.0">
                  <c:v>29.68</c:v>
                </c:pt>
              </c:numCache>
            </c:numRef>
          </c:val>
          <c:smooth val="0"/>
          <c:extLst>
            <c:ext xmlns:c16="http://schemas.microsoft.com/office/drawing/2014/chart" uri="{C3380CC4-5D6E-409C-BE32-E72D297353CC}">
              <c16:uniqueId val="{0000000A-0ACB-47E7-9ABF-C0DE81FF880F}"/>
            </c:ext>
          </c:extLst>
        </c:ser>
        <c:ser>
          <c:idx val="11"/>
          <c:order val="11"/>
          <c:tx>
            <c:strRef>
              <c:f>'Ct plots'!$AG$4</c:f>
              <c:strCache>
                <c:ptCount val="1"/>
                <c:pt idx="0">
                  <c:v>S:371-375</c:v>
                </c:pt>
              </c:strCache>
            </c:strRef>
          </c:tx>
          <c:spPr>
            <a:ln w="19050" cap="rnd">
              <a:noFill/>
              <a:round/>
            </a:ln>
            <a:effectLst/>
          </c:spPr>
          <c:marker>
            <c:symbol val="dash"/>
            <c:size val="5"/>
            <c:spPr>
              <a:solidFill>
                <a:schemeClr val="accent6">
                  <a:lumMod val="60000"/>
                </a:schemeClr>
              </a:solidFill>
              <a:ln w="19050">
                <a:solidFill>
                  <a:schemeClr val="accent6">
                    <a:lumMod val="60000"/>
                  </a:schemeClr>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G$5:$AG$68</c:f>
              <c:numCache>
                <c:formatCode>General</c:formatCode>
                <c:ptCount val="64"/>
                <c:pt idx="34" formatCode="0.0">
                  <c:v>21.73</c:v>
                </c:pt>
                <c:pt idx="35" formatCode="0.0">
                  <c:v>23.51</c:v>
                </c:pt>
                <c:pt idx="36" formatCode="0.0">
                  <c:v>23.11</c:v>
                </c:pt>
                <c:pt idx="37" formatCode="0.0">
                  <c:v>22.97</c:v>
                </c:pt>
                <c:pt idx="38" formatCode="0.0">
                  <c:v>24.12</c:v>
                </c:pt>
                <c:pt idx="39" formatCode="0.0">
                  <c:v>24.38</c:v>
                </c:pt>
                <c:pt idx="40" formatCode="0.0">
                  <c:v>24.26</c:v>
                </c:pt>
                <c:pt idx="41" formatCode="0.0">
                  <c:v>25.56</c:v>
                </c:pt>
                <c:pt idx="42" formatCode="0.0">
                  <c:v>28.36</c:v>
                </c:pt>
                <c:pt idx="43" formatCode="0.0">
                  <c:v>29.45</c:v>
                </c:pt>
              </c:numCache>
            </c:numRef>
          </c:val>
          <c:smooth val="0"/>
          <c:extLst xmlns:c15="http://schemas.microsoft.com/office/drawing/2012/chart">
            <c:ext xmlns:c16="http://schemas.microsoft.com/office/drawing/2014/chart" uri="{C3380CC4-5D6E-409C-BE32-E72D297353CC}">
              <c16:uniqueId val="{0000000B-0ACB-47E7-9ABF-C0DE81FF880F}"/>
            </c:ext>
          </c:extLst>
        </c:ser>
        <c:ser>
          <c:idx val="12"/>
          <c:order val="12"/>
          <c:tx>
            <c:strRef>
              <c:f>'Ct plots'!$AH$4</c:f>
              <c:strCache>
                <c:ptCount val="1"/>
                <c:pt idx="0">
                  <c:v>S:142-144del</c:v>
                </c:pt>
              </c:strCache>
            </c:strRef>
          </c:tx>
          <c:spPr>
            <a:ln w="19050" cap="rnd">
              <a:noFill/>
              <a:round/>
            </a:ln>
            <a:effectLst/>
          </c:spPr>
          <c:marker>
            <c:symbol val="dash"/>
            <c:size val="5"/>
            <c:spPr>
              <a:solidFill>
                <a:schemeClr val="accent1">
                  <a:lumMod val="80000"/>
                  <a:lumOff val="20000"/>
                </a:schemeClr>
              </a:solidFill>
              <a:ln w="19050">
                <a:solidFill>
                  <a:srgbClr val="9F5FCF"/>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H$5:$AH$68</c:f>
              <c:numCache>
                <c:formatCode>General</c:formatCode>
                <c:ptCount val="64"/>
                <c:pt idx="34" formatCode="0.0">
                  <c:v>18.7</c:v>
                </c:pt>
                <c:pt idx="35" formatCode="0.0">
                  <c:v>20.52</c:v>
                </c:pt>
                <c:pt idx="36" formatCode="0.0">
                  <c:v>20.309999999999999</c:v>
                </c:pt>
                <c:pt idx="37" formatCode="0.0">
                  <c:v>20.100000000000001</c:v>
                </c:pt>
                <c:pt idx="38" formatCode="0.0">
                  <c:v>21.19</c:v>
                </c:pt>
                <c:pt idx="39" formatCode="0.0">
                  <c:v>21.28</c:v>
                </c:pt>
                <c:pt idx="40" formatCode="0.0">
                  <c:v>21.24</c:v>
                </c:pt>
                <c:pt idx="41" formatCode="0.0">
                  <c:v>22.76</c:v>
                </c:pt>
                <c:pt idx="42" formatCode="0.0">
                  <c:v>25.28</c:v>
                </c:pt>
                <c:pt idx="43" formatCode="0.0">
                  <c:v>26.49</c:v>
                </c:pt>
              </c:numCache>
            </c:numRef>
          </c:val>
          <c:smooth val="0"/>
          <c:extLst xmlns:c15="http://schemas.microsoft.com/office/drawing/2012/chart">
            <c:ext xmlns:c16="http://schemas.microsoft.com/office/drawing/2014/chart" uri="{C3380CC4-5D6E-409C-BE32-E72D297353CC}">
              <c16:uniqueId val="{0000000C-0ACB-47E7-9ABF-C0DE81FF880F}"/>
            </c:ext>
          </c:extLst>
        </c:ser>
        <c:ser>
          <c:idx val="13"/>
          <c:order val="13"/>
          <c:tx>
            <c:strRef>
              <c:f>'Ct plots'!$AI$4</c:f>
              <c:strCache>
                <c:ptCount val="1"/>
                <c:pt idx="0">
                  <c:v>S:ins214</c:v>
                </c:pt>
              </c:strCache>
            </c:strRef>
          </c:tx>
          <c:spPr>
            <a:ln w="19050" cap="rnd">
              <a:noFill/>
              <a:round/>
            </a:ln>
            <a:effectLst/>
          </c:spPr>
          <c:marker>
            <c:symbol val="dash"/>
            <c:size val="5"/>
            <c:spPr>
              <a:solidFill>
                <a:schemeClr val="accent2">
                  <a:lumMod val="80000"/>
                  <a:lumOff val="20000"/>
                </a:schemeClr>
              </a:solidFill>
              <a:ln w="19050">
                <a:solidFill>
                  <a:srgbClr val="EBE600"/>
                </a:solidFill>
              </a:ln>
              <a:effectLst/>
            </c:spPr>
          </c:marker>
          <c:cat>
            <c:strRef>
              <c:f>'Ct plots'!$U$5:$U$68</c:f>
              <c:strCache>
                <c:ptCount val="64"/>
                <c:pt idx="0">
                  <c:v>B.1.1.7_S1</c:v>
                </c:pt>
                <c:pt idx="1">
                  <c:v>B.1.1.7_S2</c:v>
                </c:pt>
                <c:pt idx="2">
                  <c:v>B.1.1.7_S3</c:v>
                </c:pt>
                <c:pt idx="3">
                  <c:v>B.1.1.7_S4</c:v>
                </c:pt>
                <c:pt idx="4">
                  <c:v>B.1.1.7_S5</c:v>
                </c:pt>
                <c:pt idx="5">
                  <c:v>B.1.1.7_S6</c:v>
                </c:pt>
                <c:pt idx="6">
                  <c:v>B.1.1.7_S7</c:v>
                </c:pt>
                <c:pt idx="7">
                  <c:v>B.1.1.7_S8</c:v>
                </c:pt>
                <c:pt idx="8">
                  <c:v>B.1.1.7_S9</c:v>
                </c:pt>
                <c:pt idx="9">
                  <c:v>B.1.1.7_S10</c:v>
                </c:pt>
                <c:pt idx="10">
                  <c:v>B.1.351_S11</c:v>
                </c:pt>
                <c:pt idx="11">
                  <c:v>B.1.351_S12</c:v>
                </c:pt>
                <c:pt idx="12">
                  <c:v>B.1.351_S13</c:v>
                </c:pt>
                <c:pt idx="13">
                  <c:v>B.1.351_S14</c:v>
                </c:pt>
                <c:pt idx="14">
                  <c:v>P.1_S15</c:v>
                </c:pt>
                <c:pt idx="15">
                  <c:v>P.1_S16</c:v>
                </c:pt>
                <c:pt idx="16">
                  <c:v>P.1_S17</c:v>
                </c:pt>
                <c:pt idx="17">
                  <c:v>P.1_S18</c:v>
                </c:pt>
                <c:pt idx="18">
                  <c:v>P.1_S19</c:v>
                </c:pt>
                <c:pt idx="19">
                  <c:v>P.1_S20</c:v>
                </c:pt>
                <c:pt idx="20">
                  <c:v>P.1_S21</c:v>
                </c:pt>
                <c:pt idx="21">
                  <c:v>P.1_S22</c:v>
                </c:pt>
                <c:pt idx="22">
                  <c:v>P.1_S23</c:v>
                </c:pt>
                <c:pt idx="23">
                  <c:v>P.1_S24</c:v>
                </c:pt>
                <c:pt idx="24">
                  <c:v>AY.3_S25</c:v>
                </c:pt>
                <c:pt idx="25">
                  <c:v>AY.44_S26</c:v>
                </c:pt>
                <c:pt idx="26">
                  <c:v>B.1.617.2_S27</c:v>
                </c:pt>
                <c:pt idx="27">
                  <c:v>B.1.617.2_S28</c:v>
                </c:pt>
                <c:pt idx="28">
                  <c:v>B.1.617.2_S29</c:v>
                </c:pt>
                <c:pt idx="29">
                  <c:v>AY.103_S30</c:v>
                </c:pt>
                <c:pt idx="30">
                  <c:v>AY.26_S31</c:v>
                </c:pt>
                <c:pt idx="31">
                  <c:v>B.1.617.2_S32</c:v>
                </c:pt>
                <c:pt idx="32">
                  <c:v>B.1.617.2_S33</c:v>
                </c:pt>
                <c:pt idx="33">
                  <c:v>B.1.617.2_S34</c:v>
                </c:pt>
                <c:pt idx="34">
                  <c:v>BA.1_S35</c:v>
                </c:pt>
                <c:pt idx="35">
                  <c:v>BA.1_S36</c:v>
                </c:pt>
                <c:pt idx="36">
                  <c:v>BA.1_S37</c:v>
                </c:pt>
                <c:pt idx="37">
                  <c:v>BA.1_S38</c:v>
                </c:pt>
                <c:pt idx="38">
                  <c:v>BA.1_S39</c:v>
                </c:pt>
                <c:pt idx="39">
                  <c:v>BA.1_S40</c:v>
                </c:pt>
                <c:pt idx="40">
                  <c:v>BA.1_S41</c:v>
                </c:pt>
                <c:pt idx="41">
                  <c:v>BA.1_S42</c:v>
                </c:pt>
                <c:pt idx="42">
                  <c:v>BA.1.1_S43</c:v>
                </c:pt>
                <c:pt idx="43">
                  <c:v>BA.1.1_S44</c:v>
                </c:pt>
                <c:pt idx="44">
                  <c:v>B.1.1.29_S52</c:v>
                </c:pt>
                <c:pt idx="45">
                  <c:v>B.1.1.139_S47</c:v>
                </c:pt>
                <c:pt idx="46">
                  <c:v>B.1.189_S55</c:v>
                </c:pt>
                <c:pt idx="47">
                  <c:v>B.1.1.318_S53</c:v>
                </c:pt>
                <c:pt idx="48">
                  <c:v>B.1.404_S57</c:v>
                </c:pt>
                <c:pt idx="49">
                  <c:v>B.1.526.1_S60</c:v>
                </c:pt>
                <c:pt idx="50">
                  <c:v>B.1.621_S62</c:v>
                </c:pt>
                <c:pt idx="51">
                  <c:v>B.1.1.162_S48</c:v>
                </c:pt>
                <c:pt idx="52">
                  <c:v>B.1.427_S58</c:v>
                </c:pt>
                <c:pt idx="53">
                  <c:v>B.1.1.244_S51</c:v>
                </c:pt>
                <c:pt idx="54">
                  <c:v>B.1.243_S56</c:v>
                </c:pt>
                <c:pt idx="55">
                  <c:v>B.1_S46</c:v>
                </c:pt>
                <c:pt idx="56">
                  <c:v>B.1.1.174_S49</c:v>
                </c:pt>
                <c:pt idx="57">
                  <c:v>B.1.628_S63</c:v>
                </c:pt>
                <c:pt idx="58">
                  <c:v>A.2.5_S45</c:v>
                </c:pt>
                <c:pt idx="59">
                  <c:v>R.1_S64</c:v>
                </c:pt>
                <c:pt idx="60">
                  <c:v>B.1.1.519_S54</c:v>
                </c:pt>
                <c:pt idx="61">
                  <c:v>B.1.1.214_S50</c:v>
                </c:pt>
                <c:pt idx="62">
                  <c:v>B.1.582_S61</c:v>
                </c:pt>
                <c:pt idx="63">
                  <c:v>B.1.429_S59</c:v>
                </c:pt>
              </c:strCache>
            </c:strRef>
          </c:cat>
          <c:val>
            <c:numRef>
              <c:f>'Ct plots'!$AI$5:$AI$68</c:f>
              <c:numCache>
                <c:formatCode>General</c:formatCode>
                <c:ptCount val="64"/>
                <c:pt idx="34" formatCode="0.0">
                  <c:v>19.21</c:v>
                </c:pt>
                <c:pt idx="35" formatCode="0.0">
                  <c:v>21.03</c:v>
                </c:pt>
                <c:pt idx="36" formatCode="0.0">
                  <c:v>20.63</c:v>
                </c:pt>
                <c:pt idx="37" formatCode="0.0">
                  <c:v>20.45</c:v>
                </c:pt>
                <c:pt idx="38" formatCode="0.0">
                  <c:v>21.54</c:v>
                </c:pt>
                <c:pt idx="39" formatCode="0.0">
                  <c:v>22.1</c:v>
                </c:pt>
                <c:pt idx="40" formatCode="0.0">
                  <c:v>21.72</c:v>
                </c:pt>
                <c:pt idx="41" formatCode="0.0">
                  <c:v>23.19</c:v>
                </c:pt>
                <c:pt idx="42" formatCode="0.0">
                  <c:v>25.91</c:v>
                </c:pt>
                <c:pt idx="43" formatCode="0.0">
                  <c:v>27.04</c:v>
                </c:pt>
              </c:numCache>
            </c:numRef>
          </c:val>
          <c:smooth val="0"/>
          <c:extLst xmlns:c15="http://schemas.microsoft.com/office/drawing/2012/chart">
            <c:ext xmlns:c16="http://schemas.microsoft.com/office/drawing/2014/chart" uri="{C3380CC4-5D6E-409C-BE32-E72D297353CC}">
              <c16:uniqueId val="{0000000D-0ACB-47E7-9ABF-C0DE81FF880F}"/>
            </c:ext>
          </c:extLst>
        </c:ser>
        <c:dLbls>
          <c:showLegendKey val="0"/>
          <c:showVal val="0"/>
          <c:showCatName val="0"/>
          <c:showSerName val="0"/>
          <c:showPercent val="0"/>
          <c:showBubbleSize val="0"/>
        </c:dLbls>
        <c:marker val="1"/>
        <c:smooth val="0"/>
        <c:axId val="535968072"/>
        <c:axId val="535961840"/>
        <c:extLst/>
      </c:lineChart>
      <c:catAx>
        <c:axId val="535968072"/>
        <c:scaling>
          <c:orientation val="minMax"/>
        </c:scaling>
        <c:delete val="0"/>
        <c:axPos val="b"/>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35961840"/>
        <c:crosses val="max"/>
        <c:auto val="0"/>
        <c:lblAlgn val="ctr"/>
        <c:lblOffset val="100"/>
        <c:tickMarkSkip val="1"/>
        <c:noMultiLvlLbl val="0"/>
      </c:catAx>
      <c:valAx>
        <c:axId val="535961840"/>
        <c:scaling>
          <c:orientation val="maxMin"/>
          <c:max val="44"/>
          <c:min val="14"/>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baseline="0"/>
                  <a:t>Ct Value</a:t>
                </a:r>
                <a:endParaRPr lang="en-US"/>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0" sourceLinked="0"/>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535968072"/>
        <c:crossesAt val="1"/>
        <c:crossBetween val="midCat"/>
      </c:valAx>
      <c:spPr>
        <a:noFill/>
        <a:ln>
          <a:noFill/>
        </a:ln>
        <a:effectLst/>
      </c:spPr>
    </c:plotArea>
    <c:legend>
      <c:legendPos val="r"/>
      <c:layout/>
      <c:overlay val="0"/>
      <c:spPr>
        <a:noFill/>
        <a:ln>
          <a:noFill/>
        </a:ln>
        <a:effectLst/>
      </c:spPr>
      <c:txPr>
        <a:bodyPr rot="0" spcFirstLastPara="1" vertOverflow="ellipsis" vert="horz" wrap="square" anchor="ctr" anchorCtr="1"/>
        <a:lstStyle/>
        <a:p>
          <a:pPr>
            <a:defRPr sz="1100" b="0"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a:t>
            </a:r>
            <a:r>
              <a:rPr lang="en-US" baseline="0"/>
              <a:t> S:69/70del</a:t>
            </a:r>
            <a:endParaRPr lang="en-US"/>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62C!$A$27</c:f>
              <c:strCache>
                <c:ptCount val="1"/>
                <c:pt idx="0">
                  <c:v>NTC</c:v>
                </c:pt>
              </c:strCache>
            </c:strRef>
          </c:tx>
          <c:spPr>
            <a:ln w="28575" cap="rnd">
              <a:solidFill>
                <a:schemeClr val="accent1"/>
              </a:solidFill>
              <a:round/>
            </a:ln>
            <a:effectLst/>
          </c:spPr>
          <c:marker>
            <c:symbol val="none"/>
          </c:marker>
          <c:val>
            <c:numRef>
              <c:f>Triplex2_62C!$B$27:$AT$27</c:f>
              <c:numCache>
                <c:formatCode>General</c:formatCode>
                <c:ptCount val="45"/>
                <c:pt idx="0">
                  <c:v>-24.93955350093529</c:v>
                </c:pt>
                <c:pt idx="1">
                  <c:v>-20.858463048787598</c:v>
                </c:pt>
                <c:pt idx="2">
                  <c:v>-17.222629154182869</c:v>
                </c:pt>
                <c:pt idx="3">
                  <c:v>-14.350325495870493</c:v>
                </c:pt>
                <c:pt idx="4">
                  <c:v>-12.342207587933444</c:v>
                </c:pt>
                <c:pt idx="5">
                  <c:v>-10.973322864405418</c:v>
                </c:pt>
                <c:pt idx="6">
                  <c:v>-9.7072513928906119</c:v>
                </c:pt>
                <c:pt idx="7">
                  <c:v>-8.0483133201269084</c:v>
                </c:pt>
                <c:pt idx="8">
                  <c:v>-6.014377842147951</c:v>
                </c:pt>
                <c:pt idx="9">
                  <c:v>-4.0560306246024993</c:v>
                </c:pt>
                <c:pt idx="10">
                  <c:v>-2.433224687092661</c:v>
                </c:pt>
                <c:pt idx="11">
                  <c:v>-0.96137794203423255</c:v>
                </c:pt>
                <c:pt idx="12">
                  <c:v>0.61311077382742951</c:v>
                </c:pt>
                <c:pt idx="13">
                  <c:v>2.2754489306025789</c:v>
                </c:pt>
                <c:pt idx="14">
                  <c:v>3.763308741068613</c:v>
                </c:pt>
                <c:pt idx="15">
                  <c:v>4.7241175811941503</c:v>
                </c:pt>
                <c:pt idx="16">
                  <c:v>4.9642866099675302</c:v>
                </c:pt>
                <c:pt idx="17">
                  <c:v>4.6374412260411191</c:v>
                </c:pt>
                <c:pt idx="18">
                  <c:v>4.0931620531355293</c:v>
                </c:pt>
                <c:pt idx="19">
                  <c:v>3.6116894570495788</c:v>
                </c:pt>
                <c:pt idx="20">
                  <c:v>3.321307719385004</c:v>
                </c:pt>
                <c:pt idx="21">
                  <c:v>3.2815948158859101</c:v>
                </c:pt>
                <c:pt idx="22">
                  <c:v>3.5306606317899423</c:v>
                </c:pt>
                <c:pt idx="23">
                  <c:v>3.9352377036120743</c:v>
                </c:pt>
                <c:pt idx="24">
                  <c:v>4.168823050962601</c:v>
                </c:pt>
                <c:pt idx="25">
                  <c:v>4.0313858853260172</c:v>
                </c:pt>
                <c:pt idx="26">
                  <c:v>3.6205540945520625</c:v>
                </c:pt>
                <c:pt idx="27">
                  <c:v>3.1868566226912662</c:v>
                </c:pt>
                <c:pt idx="28">
                  <c:v>3.017623382522288</c:v>
                </c:pt>
                <c:pt idx="29">
                  <c:v>3.2460956999821065</c:v>
                </c:pt>
                <c:pt idx="30">
                  <c:v>3.6027762218927819</c:v>
                </c:pt>
                <c:pt idx="31">
                  <c:v>3.5823507966288162</c:v>
                </c:pt>
                <c:pt idx="32">
                  <c:v>2.9156805780112336</c:v>
                </c:pt>
                <c:pt idx="33">
                  <c:v>1.8079467849711364</c:v>
                </c:pt>
                <c:pt idx="34">
                  <c:v>0.72346451554585656</c:v>
                </c:pt>
                <c:pt idx="35">
                  <c:v>-9.0371908492670627E-2</c:v>
                </c:pt>
                <c:pt idx="36">
                  <c:v>-0.79856569923504139</c:v>
                </c:pt>
                <c:pt idx="37">
                  <c:v>-1.573128084100972</c:v>
                </c:pt>
                <c:pt idx="38">
                  <c:v>-2.2432757058049901</c:v>
                </c:pt>
                <c:pt idx="39">
                  <c:v>-2.6622197647193389</c:v>
                </c:pt>
                <c:pt idx="40">
                  <c:v>-3.0328352157448535</c:v>
                </c:pt>
                <c:pt idx="41">
                  <c:v>-3.6605440825132973</c:v>
                </c:pt>
                <c:pt idx="42">
                  <c:v>-4.8061417427798006</c:v>
                </c:pt>
                <c:pt idx="43">
                  <c:v>-6.6312042071240285</c:v>
                </c:pt>
                <c:pt idx="44">
                  <c:v>-8.9627387928303506</c:v>
                </c:pt>
              </c:numCache>
            </c:numRef>
          </c:val>
          <c:smooth val="0"/>
          <c:extLst>
            <c:ext xmlns:c16="http://schemas.microsoft.com/office/drawing/2014/chart" uri="{C3380CC4-5D6E-409C-BE32-E72D297353CC}">
              <c16:uniqueId val="{00000000-250E-4964-B6F7-5892B0C3FB06}"/>
            </c:ext>
          </c:extLst>
        </c:ser>
        <c:ser>
          <c:idx val="1"/>
          <c:order val="1"/>
          <c:tx>
            <c:strRef>
              <c:f>Triplex2_62C!$A$30</c:f>
              <c:strCache>
                <c:ptCount val="1"/>
                <c:pt idx="0">
                  <c:v>50 copies</c:v>
                </c:pt>
              </c:strCache>
            </c:strRef>
          </c:tx>
          <c:spPr>
            <a:ln w="28575" cap="rnd">
              <a:solidFill>
                <a:schemeClr val="accent2"/>
              </a:solidFill>
              <a:round/>
            </a:ln>
            <a:effectLst/>
          </c:spPr>
          <c:marker>
            <c:symbol val="none"/>
          </c:marker>
          <c:val>
            <c:numRef>
              <c:f>Triplex2_62C!$B$30:$AT$30</c:f>
              <c:numCache>
                <c:formatCode>General</c:formatCode>
                <c:ptCount val="45"/>
                <c:pt idx="0">
                  <c:v>-6.9352301711642212</c:v>
                </c:pt>
                <c:pt idx="1">
                  <c:v>-3.8418768625633675</c:v>
                </c:pt>
                <c:pt idx="2">
                  <c:v>-1.8189310751295125</c:v>
                </c:pt>
                <c:pt idx="3">
                  <c:v>-1.1752771473074972</c:v>
                </c:pt>
                <c:pt idx="4">
                  <c:v>-1.3624682048957766</c:v>
                </c:pt>
                <c:pt idx="5">
                  <c:v>-1.5657697463811928</c:v>
                </c:pt>
                <c:pt idx="6">
                  <c:v>-1.3248555296322593</c:v>
                </c:pt>
                <c:pt idx="7">
                  <c:v>-0.69070732514956035</c:v>
                </c:pt>
                <c:pt idx="8">
                  <c:v>-2.9015741514740512E-2</c:v>
                </c:pt>
                <c:pt idx="9">
                  <c:v>0.29748815031780396</c:v>
                </c:pt>
                <c:pt idx="10">
                  <c:v>0.25314420597351273</c:v>
                </c:pt>
                <c:pt idx="11">
                  <c:v>0.1845150644385285</c:v>
                </c:pt>
                <c:pt idx="12">
                  <c:v>0.42568230430333642</c:v>
                </c:pt>
                <c:pt idx="13">
                  <c:v>0.91909032038893201</c:v>
                </c:pt>
                <c:pt idx="14">
                  <c:v>1.3465162827596941</c:v>
                </c:pt>
                <c:pt idx="15">
                  <c:v>1.4852808312007255</c:v>
                </c:pt>
                <c:pt idx="16">
                  <c:v>1.2934031181321188</c:v>
                </c:pt>
                <c:pt idx="17">
                  <c:v>0.82253556343857781</c:v>
                </c:pt>
                <c:pt idx="18">
                  <c:v>0.2290809788628394</c:v>
                </c:pt>
                <c:pt idx="19">
                  <c:v>-0.27223238976512221</c:v>
                </c:pt>
                <c:pt idx="20">
                  <c:v>-0.54118869161175098</c:v>
                </c:pt>
                <c:pt idx="21">
                  <c:v>-0.54103195786046854</c:v>
                </c:pt>
                <c:pt idx="22">
                  <c:v>-0.36626630768660107</c:v>
                </c:pt>
                <c:pt idx="23">
                  <c:v>-0.25601832642860245</c:v>
                </c:pt>
                <c:pt idx="24">
                  <c:v>-0.37011673250708554</c:v>
                </c:pt>
                <c:pt idx="25">
                  <c:v>-0.5935717296488292</c:v>
                </c:pt>
                <c:pt idx="26">
                  <c:v>-0.70596234165350324</c:v>
                </c:pt>
                <c:pt idx="27">
                  <c:v>-0.5130846128322446</c:v>
                </c:pt>
                <c:pt idx="28">
                  <c:v>0.40132159302993387</c:v>
                </c:pt>
                <c:pt idx="29">
                  <c:v>3.0274053306675341</c:v>
                </c:pt>
                <c:pt idx="30">
                  <c:v>9.0798366828057624</c:v>
                </c:pt>
                <c:pt idx="31">
                  <c:v>20.537872631359278</c:v>
                </c:pt>
                <c:pt idx="32">
                  <c:v>38.412470638073501</c:v>
                </c:pt>
                <c:pt idx="33">
                  <c:v>61.702520493814518</c:v>
                </c:pt>
                <c:pt idx="34">
                  <c:v>87.582143045621706</c:v>
                </c:pt>
                <c:pt idx="35">
                  <c:v>112.68091706822634</c:v>
                </c:pt>
                <c:pt idx="36">
                  <c:v>134.48172091234665</c:v>
                </c:pt>
                <c:pt idx="37">
                  <c:v>151.88161196301735</c:v>
                </c:pt>
                <c:pt idx="38">
                  <c:v>164.92818761963645</c:v>
                </c:pt>
                <c:pt idx="39">
                  <c:v>174.33255575315161</c:v>
                </c:pt>
                <c:pt idx="40">
                  <c:v>180.99977115413276</c:v>
                </c:pt>
                <c:pt idx="41">
                  <c:v>185.75913413566013</c:v>
                </c:pt>
                <c:pt idx="42">
                  <c:v>189.37136894519972</c:v>
                </c:pt>
                <c:pt idx="43">
                  <c:v>192.49781856236768</c:v>
                </c:pt>
                <c:pt idx="44">
                  <c:v>195.50750340618288</c:v>
                </c:pt>
              </c:numCache>
            </c:numRef>
          </c:val>
          <c:smooth val="0"/>
          <c:extLst>
            <c:ext xmlns:c16="http://schemas.microsoft.com/office/drawing/2014/chart" uri="{C3380CC4-5D6E-409C-BE32-E72D297353CC}">
              <c16:uniqueId val="{00000001-250E-4964-B6F7-5892B0C3FB06}"/>
            </c:ext>
          </c:extLst>
        </c:ser>
        <c:ser>
          <c:idx val="2"/>
          <c:order val="2"/>
          <c:tx>
            <c:strRef>
              <c:f>Triplex2_62C!$A$33</c:f>
              <c:strCache>
                <c:ptCount val="1"/>
                <c:pt idx="0">
                  <c:v>50 copies</c:v>
                </c:pt>
              </c:strCache>
            </c:strRef>
          </c:tx>
          <c:spPr>
            <a:ln w="28575" cap="rnd">
              <a:solidFill>
                <a:schemeClr val="accent3"/>
              </a:solidFill>
              <a:round/>
            </a:ln>
            <a:effectLst/>
          </c:spPr>
          <c:marker>
            <c:symbol val="none"/>
          </c:marker>
          <c:val>
            <c:numRef>
              <c:f>Triplex2_62C!$B$33:$AT$33</c:f>
              <c:numCache>
                <c:formatCode>General</c:formatCode>
                <c:ptCount val="45"/>
                <c:pt idx="0">
                  <c:v>-6.6416443868256465</c:v>
                </c:pt>
                <c:pt idx="1">
                  <c:v>-3.0744477189891768</c:v>
                </c:pt>
                <c:pt idx="2">
                  <c:v>-0.53467208209622186</c:v>
                </c:pt>
                <c:pt idx="3">
                  <c:v>0.61397325222424115</c:v>
                </c:pt>
                <c:pt idx="4">
                  <c:v>0.7349098978429538</c:v>
                </c:pt>
                <c:pt idx="5">
                  <c:v>0.49186335542617599</c:v>
                </c:pt>
                <c:pt idx="6">
                  <c:v>0.33027224165562075</c:v>
                </c:pt>
                <c:pt idx="7">
                  <c:v>0.25331304091014317</c:v>
                </c:pt>
                <c:pt idx="8">
                  <c:v>0.13135139805126528</c:v>
                </c:pt>
                <c:pt idx="9">
                  <c:v>3.1950989297911292E-2</c:v>
                </c:pt>
                <c:pt idx="10">
                  <c:v>6.2354032301300322E-2</c:v>
                </c:pt>
                <c:pt idx="11">
                  <c:v>0.1624642212937033</c:v>
                </c:pt>
                <c:pt idx="12">
                  <c:v>0.1951849888828292</c:v>
                </c:pt>
                <c:pt idx="13">
                  <c:v>0.11092208276568272</c:v>
                </c:pt>
                <c:pt idx="14">
                  <c:v>-5.2438103539316216E-3</c:v>
                </c:pt>
                <c:pt idx="15">
                  <c:v>-8.7077939600931131E-2</c:v>
                </c:pt>
                <c:pt idx="16">
                  <c:v>-0.21770624997225241</c:v>
                </c:pt>
                <c:pt idx="17">
                  <c:v>-0.48047664893056208</c:v>
                </c:pt>
                <c:pt idx="18">
                  <c:v>-0.78803649089786632</c:v>
                </c:pt>
                <c:pt idx="19">
                  <c:v>-0.96641569336679822</c:v>
                </c:pt>
                <c:pt idx="20">
                  <c:v>-0.93553729176346678</c:v>
                </c:pt>
                <c:pt idx="21">
                  <c:v>-0.74008786266495008</c:v>
                </c:pt>
                <c:pt idx="22">
                  <c:v>-0.45202769265415554</c:v>
                </c:pt>
                <c:pt idx="23">
                  <c:v>-0.11064887917746091</c:v>
                </c:pt>
                <c:pt idx="24">
                  <c:v>0.24814079561292601</c:v>
                </c:pt>
                <c:pt idx="25">
                  <c:v>0.58120006205535901</c:v>
                </c:pt>
                <c:pt idx="26">
                  <c:v>0.88759753702106536</c:v>
                </c:pt>
                <c:pt idx="27">
                  <c:v>1.2966438141320396</c:v>
                </c:pt>
                <c:pt idx="28">
                  <c:v>2.3316606319949642</c:v>
                </c:pt>
                <c:pt idx="29">
                  <c:v>5.2067074893457175</c:v>
                </c:pt>
                <c:pt idx="30">
                  <c:v>11.834938232515924</c:v>
                </c:pt>
                <c:pt idx="31">
                  <c:v>24.552928312388758</c:v>
                </c:pt>
                <c:pt idx="32">
                  <c:v>45.213751412127749</c:v>
                </c:pt>
                <c:pt idx="33">
                  <c:v>73.635921489083557</c:v>
                </c:pt>
                <c:pt idx="34">
                  <c:v>106.90995029547776</c:v>
                </c:pt>
                <c:pt idx="35">
                  <c:v>140.62661438870055</c:v>
                </c:pt>
                <c:pt idx="36">
                  <c:v>170.98375674324234</c:v>
                </c:pt>
                <c:pt idx="37">
                  <c:v>196.06362355564488</c:v>
                </c:pt>
                <c:pt idx="38">
                  <c:v>215.74429080102345</c:v>
                </c:pt>
                <c:pt idx="39">
                  <c:v>230.91597283798546</c:v>
                </c:pt>
                <c:pt idx="40">
                  <c:v>242.79457910118981</c:v>
                </c:pt>
                <c:pt idx="41">
                  <c:v>252.51246068612454</c:v>
                </c:pt>
                <c:pt idx="42">
                  <c:v>260.82127947550725</c:v>
                </c:pt>
                <c:pt idx="43">
                  <c:v>268.10430540046218</c:v>
                </c:pt>
                <c:pt idx="44">
                  <c:v>274.74044578077337</c:v>
                </c:pt>
              </c:numCache>
            </c:numRef>
          </c:val>
          <c:smooth val="0"/>
          <c:extLst>
            <c:ext xmlns:c16="http://schemas.microsoft.com/office/drawing/2014/chart" uri="{C3380CC4-5D6E-409C-BE32-E72D297353CC}">
              <c16:uniqueId val="{00000002-250E-4964-B6F7-5892B0C3FB06}"/>
            </c:ext>
          </c:extLst>
        </c:ser>
        <c:ser>
          <c:idx val="3"/>
          <c:order val="3"/>
          <c:tx>
            <c:strRef>
              <c:f>Triplex2_62C!$A$36</c:f>
              <c:strCache>
                <c:ptCount val="1"/>
                <c:pt idx="0">
                  <c:v>500 copies</c:v>
                </c:pt>
              </c:strCache>
            </c:strRef>
          </c:tx>
          <c:spPr>
            <a:ln w="28575" cap="rnd">
              <a:solidFill>
                <a:schemeClr val="accent4"/>
              </a:solidFill>
              <a:round/>
            </a:ln>
            <a:effectLst/>
          </c:spPr>
          <c:marker>
            <c:symbol val="none"/>
          </c:marker>
          <c:val>
            <c:numRef>
              <c:f>Triplex2_62C!$B$36:$AT$36</c:f>
              <c:numCache>
                <c:formatCode>General</c:formatCode>
                <c:ptCount val="45"/>
                <c:pt idx="0">
                  <c:v>-0.46230272792854521</c:v>
                </c:pt>
                <c:pt idx="1">
                  <c:v>-0.74629961212667695</c:v>
                </c:pt>
                <c:pt idx="2">
                  <c:v>-0.88882664150150958</c:v>
                </c:pt>
                <c:pt idx="3">
                  <c:v>-0.87370701053077937</c:v>
                </c:pt>
                <c:pt idx="4">
                  <c:v>-0.73274635097550345</c:v>
                </c:pt>
                <c:pt idx="5">
                  <c:v>-0.46698624263081001</c:v>
                </c:pt>
                <c:pt idx="6">
                  <c:v>-9.7811013763930532E-2</c:v>
                </c:pt>
                <c:pt idx="7">
                  <c:v>0.27343164645026263</c:v>
                </c:pt>
                <c:pt idx="8">
                  <c:v>0.51906990568022593</c:v>
                </c:pt>
                <c:pt idx="9">
                  <c:v>0.57696517750628118</c:v>
                </c:pt>
                <c:pt idx="10">
                  <c:v>0.4579539697006112</c:v>
                </c:pt>
                <c:pt idx="11">
                  <c:v>0.21728801745121018</c:v>
                </c:pt>
                <c:pt idx="12">
                  <c:v>-5.6006691378570395E-2</c:v>
                </c:pt>
                <c:pt idx="13">
                  <c:v>-0.26848532617805176</c:v>
                </c:pt>
                <c:pt idx="14">
                  <c:v>-0.38281785385152034</c:v>
                </c:pt>
                <c:pt idx="15">
                  <c:v>-0.43532504998802324</c:v>
                </c:pt>
                <c:pt idx="16">
                  <c:v>-0.45563290850986959</c:v>
                </c:pt>
                <c:pt idx="17">
                  <c:v>-0.41591311755291827</c:v>
                </c:pt>
                <c:pt idx="18">
                  <c:v>-0.31481263291243522</c:v>
                </c:pt>
                <c:pt idx="19">
                  <c:v>-0.22540857522290025</c:v>
                </c:pt>
                <c:pt idx="20">
                  <c:v>-0.17900752363129868</c:v>
                </c:pt>
                <c:pt idx="21">
                  <c:v>-5.8351749979919987E-2</c:v>
                </c:pt>
                <c:pt idx="22">
                  <c:v>0.31243492505200265</c:v>
                </c:pt>
                <c:pt idx="23">
                  <c:v>0.99941504379421531</c:v>
                </c:pt>
                <c:pt idx="24">
                  <c:v>2.03283675338389</c:v>
                </c:pt>
                <c:pt idx="25">
                  <c:v>3.766324452994013</c:v>
                </c:pt>
                <c:pt idx="26">
                  <c:v>7.2297058188069059</c:v>
                </c:pt>
                <c:pt idx="27">
                  <c:v>14.125951372921918</c:v>
                </c:pt>
                <c:pt idx="28">
                  <c:v>26.205488488858464</c:v>
                </c:pt>
                <c:pt idx="29">
                  <c:v>44.192903345925515</c:v>
                </c:pt>
                <c:pt idx="30">
                  <c:v>67.067514133632358</c:v>
                </c:pt>
                <c:pt idx="31">
                  <c:v>92.390057991824506</c:v>
                </c:pt>
                <c:pt idx="32">
                  <c:v>117.35216129331457</c:v>
                </c:pt>
                <c:pt idx="33">
                  <c:v>139.72275722653285</c:v>
                </c:pt>
                <c:pt idx="34">
                  <c:v>158.35102125628509</c:v>
                </c:pt>
                <c:pt idx="35">
                  <c:v>173.21927267850515</c:v>
                </c:pt>
                <c:pt idx="36">
                  <c:v>185.05593921407853</c:v>
                </c:pt>
                <c:pt idx="37">
                  <c:v>194.79028561682389</c:v>
                </c:pt>
                <c:pt idx="38">
                  <c:v>203.22544924733484</c:v>
                </c:pt>
                <c:pt idx="39">
                  <c:v>210.91346731374142</c:v>
                </c:pt>
                <c:pt idx="40">
                  <c:v>218.11397210182076</c:v>
                </c:pt>
                <c:pt idx="41">
                  <c:v>224.82211178634861</c:v>
                </c:pt>
                <c:pt idx="42">
                  <c:v>230.86208681231983</c:v>
                </c:pt>
                <c:pt idx="43">
                  <c:v>236.13209228766209</c:v>
                </c:pt>
                <c:pt idx="44">
                  <c:v>240.85425801598831</c:v>
                </c:pt>
              </c:numCache>
            </c:numRef>
          </c:val>
          <c:smooth val="0"/>
          <c:extLst>
            <c:ext xmlns:c16="http://schemas.microsoft.com/office/drawing/2014/chart" uri="{C3380CC4-5D6E-409C-BE32-E72D297353CC}">
              <c16:uniqueId val="{00000003-250E-4964-B6F7-5892B0C3FB06}"/>
            </c:ext>
          </c:extLst>
        </c:ser>
        <c:ser>
          <c:idx val="4"/>
          <c:order val="4"/>
          <c:tx>
            <c:strRef>
              <c:f>Triplex2_62C!$A$39</c:f>
              <c:strCache>
                <c:ptCount val="1"/>
                <c:pt idx="0">
                  <c:v>500 copies</c:v>
                </c:pt>
              </c:strCache>
            </c:strRef>
          </c:tx>
          <c:spPr>
            <a:ln w="28575" cap="rnd">
              <a:solidFill>
                <a:schemeClr val="accent5"/>
              </a:solidFill>
              <a:round/>
            </a:ln>
            <a:effectLst/>
          </c:spPr>
          <c:marker>
            <c:symbol val="none"/>
          </c:marker>
          <c:val>
            <c:numRef>
              <c:f>Triplex2_62C!$B$39:$AT$39</c:f>
              <c:numCache>
                <c:formatCode>General</c:formatCode>
                <c:ptCount val="45"/>
                <c:pt idx="0">
                  <c:v>4.2240366652276862</c:v>
                </c:pt>
                <c:pt idx="1">
                  <c:v>3.0191624928374949</c:v>
                </c:pt>
                <c:pt idx="2">
                  <c:v>2.0309912319880823</c:v>
                </c:pt>
                <c:pt idx="3">
                  <c:v>1.3430812841779698</c:v>
                </c:pt>
                <c:pt idx="4">
                  <c:v>0.96567707119356783</c:v>
                </c:pt>
                <c:pt idx="5">
                  <c:v>0.90678057175864524</c:v>
                </c:pt>
                <c:pt idx="6">
                  <c:v>1.1431438831514242</c:v>
                </c:pt>
                <c:pt idx="7">
                  <c:v>1.5696525628281961</c:v>
                </c:pt>
                <c:pt idx="8">
                  <c:v>1.9317582233543362</c:v>
                </c:pt>
                <c:pt idx="9">
                  <c:v>1.7550018617093883</c:v>
                </c:pt>
                <c:pt idx="10">
                  <c:v>0.62939783004912897</c:v>
                </c:pt>
                <c:pt idx="11">
                  <c:v>-1.1397370607628545</c:v>
                </c:pt>
                <c:pt idx="12">
                  <c:v>-2.6169734571121808</c:v>
                </c:pt>
                <c:pt idx="13">
                  <c:v>-3.186267645265616</c:v>
                </c:pt>
                <c:pt idx="14">
                  <c:v>-2.9118127262081543</c:v>
                </c:pt>
                <c:pt idx="15">
                  <c:v>-2.1562765199287242</c:v>
                </c:pt>
                <c:pt idx="16">
                  <c:v>-1.2966472105072171</c:v>
                </c:pt>
                <c:pt idx="17">
                  <c:v>-0.57763572637668403</c:v>
                </c:pt>
                <c:pt idx="18">
                  <c:v>-3.9758717524819076E-2</c:v>
                </c:pt>
                <c:pt idx="19">
                  <c:v>0.39527957275095105</c:v>
                </c:pt>
                <c:pt idx="20">
                  <c:v>0.80001115024606406</c:v>
                </c:pt>
                <c:pt idx="21">
                  <c:v>1.1885368551684223</c:v>
                </c:pt>
                <c:pt idx="22">
                  <c:v>1.5671603573537141</c:v>
                </c:pt>
                <c:pt idx="23">
                  <c:v>2.0383861952996085</c:v>
                </c:pt>
                <c:pt idx="24">
                  <c:v>2.9320601300078124</c:v>
                </c:pt>
                <c:pt idx="25">
                  <c:v>5.0377889714072808</c:v>
                </c:pt>
                <c:pt idx="26">
                  <c:v>9.8786909925674991</c:v>
                </c:pt>
                <c:pt idx="27">
                  <c:v>19.718925732122443</c:v>
                </c:pt>
                <c:pt idx="28">
                  <c:v>36.905758370730837</c:v>
                </c:pt>
                <c:pt idx="29">
                  <c:v>62.491882629121392</c:v>
                </c:pt>
                <c:pt idx="30">
                  <c:v>94.990721557927827</c:v>
                </c:pt>
                <c:pt idx="31">
                  <c:v>130.55665683269581</c:v>
                </c:pt>
                <c:pt idx="32">
                  <c:v>164.73667941723579</c:v>
                </c:pt>
                <c:pt idx="33">
                  <c:v>194.39707147064109</c:v>
                </c:pt>
                <c:pt idx="34">
                  <c:v>218.48210834230304</c:v>
                </c:pt>
                <c:pt idx="35">
                  <c:v>237.58736325545578</c:v>
                </c:pt>
                <c:pt idx="36">
                  <c:v>253.08515331210583</c:v>
                </c:pt>
                <c:pt idx="37">
                  <c:v>266.3267987706804</c:v>
                </c:pt>
                <c:pt idx="38">
                  <c:v>278.20455425688488</c:v>
                </c:pt>
                <c:pt idx="39">
                  <c:v>289.1367652284589</c:v>
                </c:pt>
                <c:pt idx="40">
                  <c:v>299.23322312009805</c:v>
                </c:pt>
                <c:pt idx="41">
                  <c:v>308.44840190122159</c:v>
                </c:pt>
                <c:pt idx="42">
                  <c:v>316.74834343006296</c:v>
                </c:pt>
                <c:pt idx="43">
                  <c:v>324.26645012996414</c:v>
                </c:pt>
                <c:pt idx="44">
                  <c:v>331.32276631740206</c:v>
                </c:pt>
              </c:numCache>
            </c:numRef>
          </c:val>
          <c:smooth val="0"/>
          <c:extLst>
            <c:ext xmlns:c16="http://schemas.microsoft.com/office/drawing/2014/chart" uri="{C3380CC4-5D6E-409C-BE32-E72D297353CC}">
              <c16:uniqueId val="{00000004-250E-4964-B6F7-5892B0C3FB06}"/>
            </c:ext>
          </c:extLst>
        </c:ser>
        <c:ser>
          <c:idx val="5"/>
          <c:order val="5"/>
          <c:tx>
            <c:strRef>
              <c:f>Triplex2_62C!$A$42</c:f>
              <c:strCache>
                <c:ptCount val="1"/>
                <c:pt idx="0">
                  <c:v>5,000 copies</c:v>
                </c:pt>
              </c:strCache>
            </c:strRef>
          </c:tx>
          <c:spPr>
            <a:ln w="28575" cap="rnd">
              <a:solidFill>
                <a:schemeClr val="accent6"/>
              </a:solidFill>
              <a:round/>
            </a:ln>
            <a:effectLst/>
          </c:spPr>
          <c:marker>
            <c:symbol val="none"/>
          </c:marker>
          <c:val>
            <c:numRef>
              <c:f>Triplex2_62C!$B$42:$AT$42</c:f>
              <c:numCache>
                <c:formatCode>General</c:formatCode>
                <c:ptCount val="45"/>
                <c:pt idx="0">
                  <c:v>-3.9829364649558556</c:v>
                </c:pt>
                <c:pt idx="1">
                  <c:v>-2.6904689855382458</c:v>
                </c:pt>
                <c:pt idx="2">
                  <c:v>-1.7057774895929469</c:v>
                </c:pt>
                <c:pt idx="3">
                  <c:v>-1.0974953113454831</c:v>
                </c:pt>
                <c:pt idx="4">
                  <c:v>-0.74893542765312304</c:v>
                </c:pt>
                <c:pt idx="5">
                  <c:v>-0.5012869968850282</c:v>
                </c:pt>
                <c:pt idx="6">
                  <c:v>-0.25708681757714658</c:v>
                </c:pt>
                <c:pt idx="7">
                  <c:v>-3.7572234039544128E-2</c:v>
                </c:pt>
                <c:pt idx="8">
                  <c:v>0.10172622532081732</c:v>
                </c:pt>
                <c:pt idx="9">
                  <c:v>0.17890977828392352</c:v>
                </c:pt>
                <c:pt idx="10">
                  <c:v>0.2384307410375186</c:v>
                </c:pt>
                <c:pt idx="11">
                  <c:v>0.27309194411100179</c:v>
                </c:pt>
                <c:pt idx="12">
                  <c:v>0.25830639155719837</c:v>
                </c:pt>
                <c:pt idx="13">
                  <c:v>0.20003165402704326</c:v>
                </c:pt>
                <c:pt idx="14">
                  <c:v>0.12535088579898002</c:v>
                </c:pt>
                <c:pt idx="15">
                  <c:v>5.6864781074182247E-2</c:v>
                </c:pt>
                <c:pt idx="16">
                  <c:v>-6.903137144036009E-3</c:v>
                </c:pt>
                <c:pt idx="17">
                  <c:v>-8.8054268368068733E-2</c:v>
                </c:pt>
                <c:pt idx="18">
                  <c:v>-0.19110500965507526</c:v>
                </c:pt>
                <c:pt idx="19">
                  <c:v>-0.25301428856801067</c:v>
                </c:pt>
                <c:pt idx="20">
                  <c:v>-9.7689649002859369E-2</c:v>
                </c:pt>
                <c:pt idx="21">
                  <c:v>0.63490147442098532</c:v>
                </c:pt>
                <c:pt idx="22">
                  <c:v>2.6408945957573451</c:v>
                </c:pt>
                <c:pt idx="23">
                  <c:v>7.101651602793936</c:v>
                </c:pt>
                <c:pt idx="24">
                  <c:v>15.506900720052727</c:v>
                </c:pt>
                <c:pt idx="25">
                  <c:v>28.963532489318823</c:v>
                </c:pt>
                <c:pt idx="26">
                  <c:v>47.324806610962696</c:v>
                </c:pt>
                <c:pt idx="27">
                  <c:v>68.881193493649334</c:v>
                </c:pt>
                <c:pt idx="28">
                  <c:v>91.028643965628362</c:v>
                </c:pt>
                <c:pt idx="29">
                  <c:v>111.36389746774876</c:v>
                </c:pt>
                <c:pt idx="30">
                  <c:v>128.43145623073906</c:v>
                </c:pt>
                <c:pt idx="31">
                  <c:v>141.96558546706365</c:v>
                </c:pt>
                <c:pt idx="32">
                  <c:v>152.63131138883728</c:v>
                </c:pt>
                <c:pt idx="33">
                  <c:v>161.38216831660611</c:v>
                </c:pt>
                <c:pt idx="34">
                  <c:v>168.96794262846561</c:v>
                </c:pt>
                <c:pt idx="35">
                  <c:v>175.83585658858465</c:v>
                </c:pt>
                <c:pt idx="36">
                  <c:v>182.20079458877444</c:v>
                </c:pt>
                <c:pt idx="37">
                  <c:v>188.17181290990811</c:v>
                </c:pt>
                <c:pt idx="38">
                  <c:v>193.85754180414369</c:v>
                </c:pt>
                <c:pt idx="39">
                  <c:v>199.32873961184123</c:v>
                </c:pt>
                <c:pt idx="40">
                  <c:v>204.56459384972186</c:v>
                </c:pt>
                <c:pt idx="41">
                  <c:v>209.54782062731647</c:v>
                </c:pt>
                <c:pt idx="42">
                  <c:v>214.34292732610811</c:v>
                </c:pt>
                <c:pt idx="43">
                  <c:v>219.03209252126544</c:v>
                </c:pt>
                <c:pt idx="44">
                  <c:v>223.66469826482898</c:v>
                </c:pt>
              </c:numCache>
            </c:numRef>
          </c:val>
          <c:smooth val="0"/>
          <c:extLst>
            <c:ext xmlns:c16="http://schemas.microsoft.com/office/drawing/2014/chart" uri="{C3380CC4-5D6E-409C-BE32-E72D297353CC}">
              <c16:uniqueId val="{00000005-250E-4964-B6F7-5892B0C3FB06}"/>
            </c:ext>
          </c:extLst>
        </c:ser>
        <c:ser>
          <c:idx val="6"/>
          <c:order val="6"/>
          <c:tx>
            <c:strRef>
              <c:f>Triplex2_62C!$A$45</c:f>
              <c:strCache>
                <c:ptCount val="1"/>
                <c:pt idx="0">
                  <c:v>5,000 copies</c:v>
                </c:pt>
              </c:strCache>
            </c:strRef>
          </c:tx>
          <c:spPr>
            <a:ln w="28575" cap="rnd">
              <a:solidFill>
                <a:schemeClr val="accent1">
                  <a:lumMod val="60000"/>
                </a:schemeClr>
              </a:solidFill>
              <a:round/>
            </a:ln>
            <a:effectLst/>
          </c:spPr>
          <c:marker>
            <c:symbol val="none"/>
          </c:marker>
          <c:val>
            <c:numRef>
              <c:f>Triplex2_62C!$B$45:$AT$45</c:f>
              <c:numCache>
                <c:formatCode>General</c:formatCode>
                <c:ptCount val="45"/>
                <c:pt idx="0">
                  <c:v>1.292376926230645</c:v>
                </c:pt>
                <c:pt idx="1">
                  <c:v>0.79912955681538733</c:v>
                </c:pt>
                <c:pt idx="2">
                  <c:v>0.40517937917684321</c:v>
                </c:pt>
                <c:pt idx="3">
                  <c:v>0.13692831996195309</c:v>
                </c:pt>
                <c:pt idx="4">
                  <c:v>-2.5250844559195684E-2</c:v>
                </c:pt>
                <c:pt idx="5">
                  <c:v>-9.9250093689988717E-2</c:v>
                </c:pt>
                <c:pt idx="6">
                  <c:v>-9.5523030317053781E-2</c:v>
                </c:pt>
                <c:pt idx="7">
                  <c:v>-4.3673969341398333E-2</c:v>
                </c:pt>
                <c:pt idx="8">
                  <c:v>2.7535344584975974E-2</c:v>
                </c:pt>
                <c:pt idx="9">
                  <c:v>0.12563629857868364</c:v>
                </c:pt>
                <c:pt idx="10">
                  <c:v>0.21258628932082502</c:v>
                </c:pt>
                <c:pt idx="11">
                  <c:v>0.18189920592885755</c:v>
                </c:pt>
                <c:pt idx="12">
                  <c:v>1.8018737564489129E-2</c:v>
                </c:pt>
                <c:pt idx="13">
                  <c:v>-0.1475059971508017</c:v>
                </c:pt>
                <c:pt idx="14">
                  <c:v>-0.1848703009854944</c:v>
                </c:pt>
                <c:pt idx="15">
                  <c:v>-9.8261782755798777E-2</c:v>
                </c:pt>
                <c:pt idx="16">
                  <c:v>1.417561381640553E-2</c:v>
                </c:pt>
                <c:pt idx="17">
                  <c:v>7.8600373342851526E-2</c:v>
                </c:pt>
                <c:pt idx="18">
                  <c:v>6.7025637501501478E-2</c:v>
                </c:pt>
                <c:pt idx="19">
                  <c:v>-1.917578589382174E-2</c:v>
                </c:pt>
                <c:pt idx="20">
                  <c:v>-3.7216540496956441E-2</c:v>
                </c:pt>
                <c:pt idx="21">
                  <c:v>0.54138242948101833</c:v>
                </c:pt>
                <c:pt idx="22">
                  <c:v>2.8096841223959927</c:v>
                </c:pt>
                <c:pt idx="23">
                  <c:v>8.3635866227486986</c:v>
                </c:pt>
                <c:pt idx="24">
                  <c:v>18.992471360425043</c:v>
                </c:pt>
                <c:pt idx="25">
                  <c:v>35.992198718240616</c:v>
                </c:pt>
                <c:pt idx="26">
                  <c:v>59.194471953618631</c:v>
                </c:pt>
                <c:pt idx="27">
                  <c:v>86.558982741484215</c:v>
                </c:pt>
                <c:pt idx="28">
                  <c:v>114.91406092036596</c:v>
                </c:pt>
                <c:pt idx="29">
                  <c:v>141.21012830530344</c:v>
                </c:pt>
                <c:pt idx="30">
                  <c:v>163.47545825446286</c:v>
                </c:pt>
                <c:pt idx="31">
                  <c:v>181.29792371700751</c:v>
                </c:pt>
                <c:pt idx="32">
                  <c:v>195.56537376004781</c:v>
                </c:pt>
                <c:pt idx="33">
                  <c:v>207.54807853454986</c:v>
                </c:pt>
                <c:pt idx="34">
                  <c:v>218.18642984501639</c:v>
                </c:pt>
                <c:pt idx="35">
                  <c:v>227.92274760315922</c:v>
                </c:pt>
                <c:pt idx="36">
                  <c:v>236.86040782377859</c:v>
                </c:pt>
                <c:pt idx="37">
                  <c:v>245.12569594023989</c:v>
                </c:pt>
                <c:pt idx="38">
                  <c:v>253.01392832751844</c:v>
                </c:pt>
                <c:pt idx="39">
                  <c:v>260.7435990865888</c:v>
                </c:pt>
                <c:pt idx="40">
                  <c:v>268.33959146542838</c:v>
                </c:pt>
                <c:pt idx="41">
                  <c:v>275.69632259342325</c:v>
                </c:pt>
                <c:pt idx="42">
                  <c:v>282.58347628732008</c:v>
                </c:pt>
                <c:pt idx="43">
                  <c:v>288.84880810294271</c:v>
                </c:pt>
                <c:pt idx="44">
                  <c:v>294.66559514791697</c:v>
                </c:pt>
              </c:numCache>
            </c:numRef>
          </c:val>
          <c:smooth val="0"/>
          <c:extLst>
            <c:ext xmlns:c16="http://schemas.microsoft.com/office/drawing/2014/chart" uri="{C3380CC4-5D6E-409C-BE32-E72D297353CC}">
              <c16:uniqueId val="{00000006-250E-4964-B6F7-5892B0C3FB06}"/>
            </c:ext>
          </c:extLst>
        </c:ser>
        <c:ser>
          <c:idx val="7"/>
          <c:order val="7"/>
          <c:tx>
            <c:strRef>
              <c:f>Triplex2_62C!$A$48</c:f>
              <c:strCache>
                <c:ptCount val="1"/>
                <c:pt idx="0">
                  <c:v>50,000 copies</c:v>
                </c:pt>
              </c:strCache>
            </c:strRef>
          </c:tx>
          <c:spPr>
            <a:ln w="28575" cap="rnd">
              <a:solidFill>
                <a:schemeClr val="accent2">
                  <a:lumMod val="60000"/>
                </a:schemeClr>
              </a:solidFill>
              <a:round/>
            </a:ln>
            <a:effectLst/>
          </c:spPr>
          <c:marker>
            <c:symbol val="none"/>
          </c:marker>
          <c:val>
            <c:numRef>
              <c:f>Triplex2_62C!$B$48:$AT$48</c:f>
              <c:numCache>
                <c:formatCode>General</c:formatCode>
                <c:ptCount val="45"/>
                <c:pt idx="0">
                  <c:v>0.3346007935833768</c:v>
                </c:pt>
                <c:pt idx="1">
                  <c:v>-0.56116682448919164</c:v>
                </c:pt>
                <c:pt idx="2">
                  <c:v>-1.2529020174642937</c:v>
                </c:pt>
                <c:pt idx="3">
                  <c:v>-1.3771082536641188</c:v>
                </c:pt>
                <c:pt idx="4">
                  <c:v>-0.8324086472093768</c:v>
                </c:pt>
                <c:pt idx="5">
                  <c:v>-7.2204938083814341E-2</c:v>
                </c:pt>
                <c:pt idx="6">
                  <c:v>0.34445162261363294</c:v>
                </c:pt>
                <c:pt idx="7">
                  <c:v>0.26344815607990313</c:v>
                </c:pt>
                <c:pt idx="8">
                  <c:v>-0.11005261819445877</c:v>
                </c:pt>
                <c:pt idx="9">
                  <c:v>-0.45802583209297154</c:v>
                </c:pt>
                <c:pt idx="10">
                  <c:v>-0.49463919876689033</c:v>
                </c:pt>
                <c:pt idx="11">
                  <c:v>-0.15783505870422232</c:v>
                </c:pt>
                <c:pt idx="12">
                  <c:v>0.27874853543107747</c:v>
                </c:pt>
                <c:pt idx="13">
                  <c:v>0.44435522030471475</c:v>
                </c:pt>
                <c:pt idx="14">
                  <c:v>0.23479333593240881</c:v>
                </c:pt>
                <c:pt idx="15">
                  <c:v>-9.5329529905939125E-2</c:v>
                </c:pt>
                <c:pt idx="16">
                  <c:v>-0.17770969460252672</c:v>
                </c:pt>
                <c:pt idx="17">
                  <c:v>0.19777916718339839</c:v>
                </c:pt>
                <c:pt idx="18">
                  <c:v>1.2885444531784742</c:v>
                </c:pt>
                <c:pt idx="19">
                  <c:v>4.0611097511136904</c:v>
                </c:pt>
                <c:pt idx="20">
                  <c:v>10.582231818310902</c:v>
                </c:pt>
                <c:pt idx="21">
                  <c:v>23.483091996127769</c:v>
                </c:pt>
                <c:pt idx="22">
                  <c:v>44.470638323558887</c:v>
                </c:pt>
                <c:pt idx="23">
                  <c:v>72.82669893833372</c:v>
                </c:pt>
                <c:pt idx="24">
                  <c:v>105.32466152992311</c:v>
                </c:pt>
                <c:pt idx="25">
                  <c:v>137.73854360623409</c:v>
                </c:pt>
                <c:pt idx="26">
                  <c:v>166.63559171167981</c:v>
                </c:pt>
                <c:pt idx="27">
                  <c:v>190.42566415538568</c:v>
                </c:pt>
                <c:pt idx="28">
                  <c:v>209.42404945567614</c:v>
                </c:pt>
                <c:pt idx="29">
                  <c:v>225.01123123163961</c:v>
                </c:pt>
                <c:pt idx="30">
                  <c:v>238.4888267631959</c:v>
                </c:pt>
                <c:pt idx="31">
                  <c:v>250.48515669090375</c:v>
                </c:pt>
                <c:pt idx="32">
                  <c:v>261.19643873843597</c:v>
                </c:pt>
                <c:pt idx="33">
                  <c:v>270.92661354751363</c:v>
                </c:pt>
                <c:pt idx="34">
                  <c:v>280.13470186456652</c:v>
                </c:pt>
                <c:pt idx="35">
                  <c:v>289.08233101930273</c:v>
                </c:pt>
                <c:pt idx="36">
                  <c:v>297.78951746580969</c:v>
                </c:pt>
                <c:pt idx="37">
                  <c:v>306.16931617093906</c:v>
                </c:pt>
                <c:pt idx="38">
                  <c:v>314.06588110398843</c:v>
                </c:pt>
                <c:pt idx="39">
                  <c:v>321.4178503162384</c:v>
                </c:pt>
                <c:pt idx="40">
                  <c:v>328.34176978531832</c:v>
                </c:pt>
                <c:pt idx="41">
                  <c:v>334.96264507055821</c:v>
                </c:pt>
                <c:pt idx="42">
                  <c:v>341.32538870760618</c:v>
                </c:pt>
                <c:pt idx="43">
                  <c:v>347.4783857959701</c:v>
                </c:pt>
                <c:pt idx="44">
                  <c:v>353.51073598589392</c:v>
                </c:pt>
              </c:numCache>
            </c:numRef>
          </c:val>
          <c:smooth val="0"/>
          <c:extLst>
            <c:ext xmlns:c16="http://schemas.microsoft.com/office/drawing/2014/chart" uri="{C3380CC4-5D6E-409C-BE32-E72D297353CC}">
              <c16:uniqueId val="{00000007-250E-4964-B6F7-5892B0C3FB06}"/>
            </c:ext>
          </c:extLst>
        </c:ser>
        <c:ser>
          <c:idx val="8"/>
          <c:order val="8"/>
          <c:tx>
            <c:strRef>
              <c:f>Triplex2_62C!$A$51</c:f>
              <c:strCache>
                <c:ptCount val="1"/>
                <c:pt idx="0">
                  <c:v>50,000 copies</c:v>
                </c:pt>
              </c:strCache>
            </c:strRef>
          </c:tx>
          <c:spPr>
            <a:ln w="28575" cap="rnd">
              <a:solidFill>
                <a:schemeClr val="accent3">
                  <a:lumMod val="60000"/>
                </a:schemeClr>
              </a:solidFill>
              <a:round/>
            </a:ln>
            <a:effectLst/>
          </c:spPr>
          <c:marker>
            <c:symbol val="none"/>
          </c:marker>
          <c:val>
            <c:numRef>
              <c:f>Triplex2_62C!$B$51:$AT$51</c:f>
              <c:numCache>
                <c:formatCode>General</c:formatCode>
                <c:ptCount val="45"/>
                <c:pt idx="0">
                  <c:v>5.2377000738597417</c:v>
                </c:pt>
                <c:pt idx="1">
                  <c:v>8.5435796814217611</c:v>
                </c:pt>
                <c:pt idx="2">
                  <c:v>11.039604763320312</c:v>
                </c:pt>
                <c:pt idx="3">
                  <c:v>12.430813981074607</c:v>
                </c:pt>
                <c:pt idx="4">
                  <c:v>12.460732809106048</c:v>
                </c:pt>
                <c:pt idx="5">
                  <c:v>10.365627440201933</c:v>
                </c:pt>
                <c:pt idx="6">
                  <c:v>5.6452276410273043</c:v>
                </c:pt>
                <c:pt idx="7">
                  <c:v>-0.38451319652995153</c:v>
                </c:pt>
                <c:pt idx="8">
                  <c:v>-5.0407655193375831</c:v>
                </c:pt>
                <c:pt idx="9">
                  <c:v>-6.8557317198992678</c:v>
                </c:pt>
                <c:pt idx="10">
                  <c:v>-6.4499317780919228</c:v>
                </c:pt>
                <c:pt idx="11">
                  <c:v>-4.9602478863689612</c:v>
                </c:pt>
                <c:pt idx="12">
                  <c:v>-2.9866298712895514</c:v>
                </c:pt>
                <c:pt idx="13">
                  <c:v>-0.88795519866107497</c:v>
                </c:pt>
                <c:pt idx="14">
                  <c:v>0.94679898329923162</c:v>
                </c:pt>
                <c:pt idx="15">
                  <c:v>2.3346153715665423</c:v>
                </c:pt>
                <c:pt idx="16">
                  <c:v>3.4591942879287672</c:v>
                </c:pt>
                <c:pt idx="17">
                  <c:v>4.8143114461818186</c:v>
                </c:pt>
                <c:pt idx="18">
                  <c:v>7.253408162481719</c:v>
                </c:pt>
                <c:pt idx="19">
                  <c:v>12.213105476124838</c:v>
                </c:pt>
                <c:pt idx="20">
                  <c:v>21.917520259466983</c:v>
                </c:pt>
                <c:pt idx="21">
                  <c:v>39.063569485851986</c:v>
                </c:pt>
                <c:pt idx="22">
                  <c:v>65.590392578882529</c:v>
                </c:pt>
                <c:pt idx="23">
                  <c:v>101.09235064954919</c:v>
                </c:pt>
                <c:pt idx="24">
                  <c:v>142.19583312321811</c:v>
                </c:pt>
                <c:pt idx="25">
                  <c:v>183.77212953851085</c:v>
                </c:pt>
                <c:pt idx="26">
                  <c:v>221.25350641698242</c:v>
                </c:pt>
                <c:pt idx="27">
                  <c:v>252.32116159650468</c:v>
                </c:pt>
                <c:pt idx="28">
                  <c:v>277.12863841329272</c:v>
                </c:pt>
                <c:pt idx="29">
                  <c:v>297.32296222412515</c:v>
                </c:pt>
                <c:pt idx="30">
                  <c:v>314.66077334757756</c:v>
                </c:pt>
                <c:pt idx="31">
                  <c:v>330.27514106810122</c:v>
                </c:pt>
                <c:pt idx="32">
                  <c:v>344.76112347870912</c:v>
                </c:pt>
                <c:pt idx="33">
                  <c:v>358.43104592600503</c:v>
                </c:pt>
                <c:pt idx="34">
                  <c:v>371.46948881273238</c:v>
                </c:pt>
                <c:pt idx="35">
                  <c:v>383.98312567387438</c:v>
                </c:pt>
                <c:pt idx="36">
                  <c:v>395.99878603620164</c:v>
                </c:pt>
                <c:pt idx="37">
                  <c:v>407.56983245170886</c:v>
                </c:pt>
                <c:pt idx="38">
                  <c:v>418.78618583021489</c:v>
                </c:pt>
                <c:pt idx="39">
                  <c:v>429.58388330051093</c:v>
                </c:pt>
                <c:pt idx="40">
                  <c:v>439.81855493712828</c:v>
                </c:pt>
                <c:pt idx="41">
                  <c:v>449.54128090805898</c:v>
                </c:pt>
                <c:pt idx="42">
                  <c:v>458.97682354536119</c:v>
                </c:pt>
                <c:pt idx="43">
                  <c:v>468.33381796145295</c:v>
                </c:pt>
                <c:pt idx="44">
                  <c:v>477.69989496049129</c:v>
                </c:pt>
              </c:numCache>
            </c:numRef>
          </c:val>
          <c:smooth val="0"/>
          <c:extLst>
            <c:ext xmlns:c16="http://schemas.microsoft.com/office/drawing/2014/chart" uri="{C3380CC4-5D6E-409C-BE32-E72D297353CC}">
              <c16:uniqueId val="{00000008-250E-4964-B6F7-5892B0C3FB06}"/>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1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a:t>
            </a:r>
            <a:r>
              <a:rPr lang="en-US" baseline="0"/>
              <a:t> S:69/70del</a:t>
            </a:r>
            <a:endParaRPr lang="en-US"/>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54C!$A$27</c:f>
              <c:strCache>
                <c:ptCount val="1"/>
                <c:pt idx="0">
                  <c:v>Well 1 green</c:v>
                </c:pt>
              </c:strCache>
            </c:strRef>
          </c:tx>
          <c:spPr>
            <a:ln w="28575" cap="rnd">
              <a:solidFill>
                <a:schemeClr val="accent1"/>
              </a:solidFill>
              <a:round/>
            </a:ln>
            <a:effectLst/>
          </c:spPr>
          <c:marker>
            <c:symbol val="none"/>
          </c:marker>
          <c:val>
            <c:numRef>
              <c:f>Triplex2_54C!$B$27:$AT$27</c:f>
              <c:numCache>
                <c:formatCode>General</c:formatCode>
                <c:ptCount val="45"/>
                <c:pt idx="0">
                  <c:v>-85.110601475354997</c:v>
                </c:pt>
                <c:pt idx="1">
                  <c:v>-69.924829481176857</c:v>
                </c:pt>
                <c:pt idx="2">
                  <c:v>-56.904009204527028</c:v>
                </c:pt>
                <c:pt idx="3">
                  <c:v>-46.844100269814589</c:v>
                </c:pt>
                <c:pt idx="4">
                  <c:v>-39.188977449390222</c:v>
                </c:pt>
                <c:pt idx="5">
                  <c:v>-32.836741381477623</c:v>
                </c:pt>
                <c:pt idx="6">
                  <c:v>-26.9151332118563</c:v>
                </c:pt>
                <c:pt idx="7">
                  <c:v>-21.132961015489855</c:v>
                </c:pt>
                <c:pt idx="8">
                  <c:v>-15.586687889317545</c:v>
                </c:pt>
                <c:pt idx="9">
                  <c:v>-10.424069779717684</c:v>
                </c:pt>
                <c:pt idx="10">
                  <c:v>-5.7548735355376266</c:v>
                </c:pt>
                <c:pt idx="11">
                  <c:v>-1.7390289497325284</c:v>
                </c:pt>
                <c:pt idx="12">
                  <c:v>1.5285372733615077</c:v>
                </c:pt>
                <c:pt idx="13">
                  <c:v>4.2464076529395243</c:v>
                </c:pt>
                <c:pt idx="14">
                  <c:v>6.7581233622950094</c:v>
                </c:pt>
                <c:pt idx="15">
                  <c:v>9.1736686999283847</c:v>
                </c:pt>
                <c:pt idx="16">
                  <c:v>11.282193669847402</c:v>
                </c:pt>
                <c:pt idx="17">
                  <c:v>12.800434492548447</c:v>
                </c:pt>
                <c:pt idx="18">
                  <c:v>13.634295532419856</c:v>
                </c:pt>
                <c:pt idx="19">
                  <c:v>13.919644098114077</c:v>
                </c:pt>
                <c:pt idx="20">
                  <c:v>13.891617255176243</c:v>
                </c:pt>
                <c:pt idx="21">
                  <c:v>13.731582025511671</c:v>
                </c:pt>
                <c:pt idx="22">
                  <c:v>13.467301489055899</c:v>
                </c:pt>
                <c:pt idx="23">
                  <c:v>13.016357005808459</c:v>
                </c:pt>
                <c:pt idx="24">
                  <c:v>12.336655001618055</c:v>
                </c:pt>
                <c:pt idx="25">
                  <c:v>11.490230764273292</c:v>
                </c:pt>
                <c:pt idx="26">
                  <c:v>10.577367794614474</c:v>
                </c:pt>
                <c:pt idx="27">
                  <c:v>9.6514930674184143</c:v>
                </c:pt>
                <c:pt idx="28">
                  <c:v>8.7022968595792918</c:v>
                </c:pt>
                <c:pt idx="29">
                  <c:v>7.6901153522085224</c:v>
                </c:pt>
                <c:pt idx="30">
                  <c:v>6.5645621059520636</c:v>
                </c:pt>
                <c:pt idx="31">
                  <c:v>5.2678538108593784</c:v>
                </c:pt>
                <c:pt idx="32">
                  <c:v>3.7540503045693185</c:v>
                </c:pt>
                <c:pt idx="33">
                  <c:v>2.0241538243972172</c:v>
                </c:pt>
                <c:pt idx="34">
                  <c:v>0.1461827965122211</c:v>
                </c:pt>
                <c:pt idx="35">
                  <c:v>-1.7590725511254277</c:v>
                </c:pt>
                <c:pt idx="36">
                  <c:v>-3.5831218461407843</c:v>
                </c:pt>
                <c:pt idx="37">
                  <c:v>-5.2842530648795218</c:v>
                </c:pt>
                <c:pt idx="38">
                  <c:v>-6.8244431963703391</c:v>
                </c:pt>
                <c:pt idx="39">
                  <c:v>-8.1316543461889523</c:v>
                </c:pt>
                <c:pt idx="40">
                  <c:v>-9.2449968407872802</c:v>
                </c:pt>
                <c:pt idx="41">
                  <c:v>-10.463012649137454</c:v>
                </c:pt>
                <c:pt idx="42">
                  <c:v>-12.283968938181715</c:v>
                </c:pt>
                <c:pt idx="43">
                  <c:v>-15.070565213665759</c:v>
                </c:pt>
                <c:pt idx="44">
                  <c:v>-18.620539829387781</c:v>
                </c:pt>
              </c:numCache>
            </c:numRef>
          </c:val>
          <c:smooth val="0"/>
          <c:extLst>
            <c:ext xmlns:c16="http://schemas.microsoft.com/office/drawing/2014/chart" uri="{C3380CC4-5D6E-409C-BE32-E72D297353CC}">
              <c16:uniqueId val="{00000000-F2BD-4186-BCDF-7B5297BCA73B}"/>
            </c:ext>
          </c:extLst>
        </c:ser>
        <c:ser>
          <c:idx val="1"/>
          <c:order val="1"/>
          <c:tx>
            <c:strRef>
              <c:f>Triplex2_54C!$A$30</c:f>
              <c:strCache>
                <c:ptCount val="1"/>
                <c:pt idx="0">
                  <c:v>Well 2 green</c:v>
                </c:pt>
              </c:strCache>
            </c:strRef>
          </c:tx>
          <c:spPr>
            <a:ln w="28575" cap="rnd">
              <a:solidFill>
                <a:schemeClr val="accent2"/>
              </a:solidFill>
              <a:round/>
            </a:ln>
            <a:effectLst/>
          </c:spPr>
          <c:marker>
            <c:symbol val="none"/>
          </c:marker>
          <c:val>
            <c:numRef>
              <c:f>Triplex2_54C!$B$30:$AT$30</c:f>
              <c:numCache>
                <c:formatCode>General</c:formatCode>
                <c:ptCount val="45"/>
                <c:pt idx="0">
                  <c:v>-25.297728576926602</c:v>
                </c:pt>
                <c:pt idx="1">
                  <c:v>-16.632885484981671</c:v>
                </c:pt>
                <c:pt idx="2">
                  <c:v>-10.067359749491516</c:v>
                </c:pt>
                <c:pt idx="3">
                  <c:v>-6.3248872271342407</c:v>
                </c:pt>
                <c:pt idx="4">
                  <c:v>-4.8037796835160407</c:v>
                </c:pt>
                <c:pt idx="5">
                  <c:v>-4.4794634894387855</c:v>
                </c:pt>
                <c:pt idx="6">
                  <c:v>-4.3684245167514746</c:v>
                </c:pt>
                <c:pt idx="7">
                  <c:v>-3.678737063497465</c:v>
                </c:pt>
                <c:pt idx="8">
                  <c:v>-2.2123185100117553</c:v>
                </c:pt>
                <c:pt idx="9">
                  <c:v>-0.46452250589209143</c:v>
                </c:pt>
                <c:pt idx="10">
                  <c:v>0.99038543886490515</c:v>
                </c:pt>
                <c:pt idx="11">
                  <c:v>2.0082045781309716</c:v>
                </c:pt>
                <c:pt idx="12">
                  <c:v>2.7090157167640427</c:v>
                </c:pt>
                <c:pt idx="13">
                  <c:v>3.1641594166194409</c:v>
                </c:pt>
                <c:pt idx="14">
                  <c:v>3.344372496858341</c:v>
                </c:pt>
                <c:pt idx="15">
                  <c:v>3.197368534260022</c:v>
                </c:pt>
                <c:pt idx="16">
                  <c:v>2.7836957364725095</c:v>
                </c:pt>
                <c:pt idx="17">
                  <c:v>2.3439486830066016</c:v>
                </c:pt>
                <c:pt idx="18">
                  <c:v>2.1078619289073686</c:v>
                </c:pt>
                <c:pt idx="19">
                  <c:v>2.0396526114382141</c:v>
                </c:pt>
                <c:pt idx="20">
                  <c:v>1.8841846085069847</c:v>
                </c:pt>
                <c:pt idx="21">
                  <c:v>1.4300958777585038</c:v>
                </c:pt>
                <c:pt idx="22">
                  <c:v>0.63905490526303765</c:v>
                </c:pt>
                <c:pt idx="23">
                  <c:v>-0.40522018183219188</c:v>
                </c:pt>
                <c:pt idx="24">
                  <c:v>-1.5848922661207325</c:v>
                </c:pt>
                <c:pt idx="25">
                  <c:v>-2.780099494229944</c:v>
                </c:pt>
                <c:pt idx="26">
                  <c:v>-3.8687522016498406</c:v>
                </c:pt>
                <c:pt idx="27">
                  <c:v>-4.7995703034430335</c:v>
                </c:pt>
                <c:pt idx="28">
                  <c:v>-5.5081050943790615</c:v>
                </c:pt>
                <c:pt idx="29">
                  <c:v>-5.320318066940672</c:v>
                </c:pt>
                <c:pt idx="30">
                  <c:v>-2.1573313399931067</c:v>
                </c:pt>
                <c:pt idx="31">
                  <c:v>7.7256963919335249</c:v>
                </c:pt>
                <c:pt idx="32">
                  <c:v>28.807406567901126</c:v>
                </c:pt>
                <c:pt idx="33">
                  <c:v>63.922384566178152</c:v>
                </c:pt>
                <c:pt idx="34">
                  <c:v>111.6112942901691</c:v>
                </c:pt>
                <c:pt idx="35">
                  <c:v>165.51869442371208</c:v>
                </c:pt>
                <c:pt idx="36">
                  <c:v>216.77145142636982</c:v>
                </c:pt>
                <c:pt idx="37">
                  <c:v>257.80079479426058</c:v>
                </c:pt>
                <c:pt idx="38">
                  <c:v>285.32501377459994</c:v>
                </c:pt>
                <c:pt idx="39">
                  <c:v>300.80370782729915</c:v>
                </c:pt>
                <c:pt idx="40">
                  <c:v>308.25471139425463</c:v>
                </c:pt>
                <c:pt idx="41">
                  <c:v>311.46823576382849</c:v>
                </c:pt>
                <c:pt idx="42">
                  <c:v>312.6822388413002</c:v>
                </c:pt>
                <c:pt idx="43">
                  <c:v>312.81932337532999</c:v>
                </c:pt>
                <c:pt idx="44">
                  <c:v>312.31435437444634</c:v>
                </c:pt>
              </c:numCache>
            </c:numRef>
          </c:val>
          <c:smooth val="0"/>
          <c:extLst>
            <c:ext xmlns:c16="http://schemas.microsoft.com/office/drawing/2014/chart" uri="{C3380CC4-5D6E-409C-BE32-E72D297353CC}">
              <c16:uniqueId val="{00000001-F2BD-4186-BCDF-7B5297BCA73B}"/>
            </c:ext>
          </c:extLst>
        </c:ser>
        <c:ser>
          <c:idx val="2"/>
          <c:order val="2"/>
          <c:tx>
            <c:strRef>
              <c:f>Triplex2_54C!$A$33</c:f>
              <c:strCache>
                <c:ptCount val="1"/>
                <c:pt idx="0">
                  <c:v>Well 3 green</c:v>
                </c:pt>
              </c:strCache>
            </c:strRef>
          </c:tx>
          <c:spPr>
            <a:ln w="28575" cap="rnd">
              <a:solidFill>
                <a:schemeClr val="accent3"/>
              </a:solidFill>
              <a:round/>
            </a:ln>
            <a:effectLst/>
          </c:spPr>
          <c:marker>
            <c:symbol val="none"/>
          </c:marker>
          <c:val>
            <c:numRef>
              <c:f>Triplex2_54C!$B$33:$AT$33</c:f>
              <c:numCache>
                <c:formatCode>General</c:formatCode>
                <c:ptCount val="45"/>
                <c:pt idx="0">
                  <c:v>-20.892893422646011</c:v>
                </c:pt>
                <c:pt idx="1">
                  <c:v>-14.38952202866858</c:v>
                </c:pt>
                <c:pt idx="2">
                  <c:v>-9.6275437440326641</c:v>
                </c:pt>
                <c:pt idx="3">
                  <c:v>-7.1390524216112681</c:v>
                </c:pt>
                <c:pt idx="4">
                  <c:v>-6.1894827106989396</c:v>
                </c:pt>
                <c:pt idx="5">
                  <c:v>-5.6201276676893031</c:v>
                </c:pt>
                <c:pt idx="6">
                  <c:v>-4.7114297162606817</c:v>
                </c:pt>
                <c:pt idx="7">
                  <c:v>-3.4795151426278608</c:v>
                </c:pt>
                <c:pt idx="8">
                  <c:v>-2.2620481557005405</c:v>
                </c:pt>
                <c:pt idx="9">
                  <c:v>-1.1576648994941934</c:v>
                </c:pt>
                <c:pt idx="10">
                  <c:v>-5.3065115025674459E-3</c:v>
                </c:pt>
                <c:pt idx="11">
                  <c:v>1.2815889768480702</c:v>
                </c:pt>
                <c:pt idx="12">
                  <c:v>2.5660276253911434</c:v>
                </c:pt>
                <c:pt idx="13">
                  <c:v>3.5741514949822886</c:v>
                </c:pt>
                <c:pt idx="14">
                  <c:v>4.0909192623075796</c:v>
                </c:pt>
                <c:pt idx="15">
                  <c:v>4.1588278643121157</c:v>
                </c:pt>
                <c:pt idx="16">
                  <c:v>4.0290275208062667</c:v>
                </c:pt>
                <c:pt idx="17">
                  <c:v>3.8552225340808945</c:v>
                </c:pt>
                <c:pt idx="18">
                  <c:v>3.5468851497280411</c:v>
                </c:pt>
                <c:pt idx="19">
                  <c:v>2.9745572627780348</c:v>
                </c:pt>
                <c:pt idx="20">
                  <c:v>2.1748497349544778</c:v>
                </c:pt>
                <c:pt idx="21">
                  <c:v>1.2648029493229842</c:v>
                </c:pt>
                <c:pt idx="22">
                  <c:v>0.30398716939635051</c:v>
                </c:pt>
                <c:pt idx="23">
                  <c:v>-0.69573536913776479</c:v>
                </c:pt>
                <c:pt idx="24">
                  <c:v>-1.7834724991316762</c:v>
                </c:pt>
                <c:pt idx="25">
                  <c:v>-3.0817677556860872</c:v>
                </c:pt>
                <c:pt idx="26">
                  <c:v>-4.667374015734822</c:v>
                </c:pt>
                <c:pt idx="27">
                  <c:v>-6.356405811940931</c:v>
                </c:pt>
                <c:pt idx="28">
                  <c:v>-7.4283108258223365</c:v>
                </c:pt>
                <c:pt idx="29">
                  <c:v>-6.3032137229984073</c:v>
                </c:pt>
                <c:pt idx="30">
                  <c:v>-0.20486618996801553</c:v>
                </c:pt>
                <c:pt idx="31">
                  <c:v>14.864603829708358</c:v>
                </c:pt>
                <c:pt idx="32">
                  <c:v>43.009931794966178</c:v>
                </c:pt>
                <c:pt idx="33">
                  <c:v>85.741800339641486</c:v>
                </c:pt>
                <c:pt idx="34">
                  <c:v>139.34989742654216</c:v>
                </c:pt>
                <c:pt idx="35">
                  <c:v>195.31829204482528</c:v>
                </c:pt>
                <c:pt idx="36">
                  <c:v>244.30141835004906</c:v>
                </c:pt>
                <c:pt idx="37">
                  <c:v>280.56595174422546</c:v>
                </c:pt>
                <c:pt idx="38">
                  <c:v>303.56177432149343</c:v>
                </c:pt>
                <c:pt idx="39">
                  <c:v>316.38014654240214</c:v>
                </c:pt>
                <c:pt idx="40">
                  <c:v>323.0861532295803</c:v>
                </c:pt>
                <c:pt idx="41">
                  <c:v>326.65409260551496</c:v>
                </c:pt>
                <c:pt idx="42">
                  <c:v>328.44156565385492</c:v>
                </c:pt>
                <c:pt idx="43">
                  <c:v>328.91844557465265</c:v>
                </c:pt>
                <c:pt idx="44">
                  <c:v>328.52296433320771</c:v>
                </c:pt>
              </c:numCache>
            </c:numRef>
          </c:val>
          <c:smooth val="0"/>
          <c:extLst>
            <c:ext xmlns:c16="http://schemas.microsoft.com/office/drawing/2014/chart" uri="{C3380CC4-5D6E-409C-BE32-E72D297353CC}">
              <c16:uniqueId val="{00000002-F2BD-4186-BCDF-7B5297BCA73B}"/>
            </c:ext>
          </c:extLst>
        </c:ser>
        <c:ser>
          <c:idx val="3"/>
          <c:order val="3"/>
          <c:tx>
            <c:strRef>
              <c:f>Triplex2_54C!$A$36</c:f>
              <c:strCache>
                <c:ptCount val="1"/>
                <c:pt idx="0">
                  <c:v>Well 4 green</c:v>
                </c:pt>
              </c:strCache>
            </c:strRef>
          </c:tx>
          <c:spPr>
            <a:ln w="28575" cap="rnd">
              <a:solidFill>
                <a:schemeClr val="accent4"/>
              </a:solidFill>
              <a:round/>
            </a:ln>
            <a:effectLst/>
          </c:spPr>
          <c:marker>
            <c:symbol val="none"/>
          </c:marker>
          <c:val>
            <c:numRef>
              <c:f>Triplex2_54C!$B$36:$AT$36</c:f>
              <c:numCache>
                <c:formatCode>General</c:formatCode>
                <c:ptCount val="45"/>
                <c:pt idx="0">
                  <c:v>-7.5203321724984562</c:v>
                </c:pt>
                <c:pt idx="1">
                  <c:v>-4.0297095111054659</c:v>
                </c:pt>
                <c:pt idx="2">
                  <c:v>-1.8772287603460427</c:v>
                </c:pt>
                <c:pt idx="3">
                  <c:v>-1.1245940925509785</c:v>
                </c:pt>
                <c:pt idx="4">
                  <c:v>-1.0274402813211054</c:v>
                </c:pt>
                <c:pt idx="5">
                  <c:v>-1.0273046029487887</c:v>
                </c:pt>
                <c:pt idx="6">
                  <c:v>-0.92245328952958516</c:v>
                </c:pt>
                <c:pt idx="7">
                  <c:v>-0.65158552376487933</c:v>
                </c:pt>
                <c:pt idx="8">
                  <c:v>-0.23991485183614714</c:v>
                </c:pt>
                <c:pt idx="9">
                  <c:v>0.19769186717530829</c:v>
                </c:pt>
                <c:pt idx="10">
                  <c:v>0.54135666380534531</c:v>
                </c:pt>
                <c:pt idx="11">
                  <c:v>0.73098372983258741</c:v>
                </c:pt>
                <c:pt idx="12">
                  <c:v>0.76589839494226908</c:v>
                </c:pt>
                <c:pt idx="13">
                  <c:v>0.72945881246050703</c:v>
                </c:pt>
                <c:pt idx="14">
                  <c:v>0.73254233973602823</c:v>
                </c:pt>
                <c:pt idx="15">
                  <c:v>0.73898303985879465</c:v>
                </c:pt>
                <c:pt idx="16">
                  <c:v>0.58630304615326168</c:v>
                </c:pt>
                <c:pt idx="17">
                  <c:v>0.23212065455845732</c:v>
                </c:pt>
                <c:pt idx="18">
                  <c:v>-0.15550208235799801</c:v>
                </c:pt>
                <c:pt idx="19">
                  <c:v>-0.37746615551986906</c:v>
                </c:pt>
                <c:pt idx="20">
                  <c:v>-0.4036610868988646</c:v>
                </c:pt>
                <c:pt idx="21">
                  <c:v>-0.35579509864328429</c:v>
                </c:pt>
                <c:pt idx="22">
                  <c:v>-0.33074715382463182</c:v>
                </c:pt>
                <c:pt idx="23">
                  <c:v>-0.35112174808455165</c:v>
                </c:pt>
                <c:pt idx="24">
                  <c:v>-0.43978695509576937</c:v>
                </c:pt>
                <c:pt idx="25">
                  <c:v>-0.3950700222994783</c:v>
                </c:pt>
                <c:pt idx="26">
                  <c:v>1.0009568098266755</c:v>
                </c:pt>
                <c:pt idx="27">
                  <c:v>7.1029558404388808</c:v>
                </c:pt>
                <c:pt idx="28">
                  <c:v>24.050699594952675</c:v>
                </c:pt>
                <c:pt idx="29">
                  <c:v>59.514705908486576</c:v>
                </c:pt>
                <c:pt idx="30">
                  <c:v>118.72847216476293</c:v>
                </c:pt>
                <c:pt idx="31">
                  <c:v>199.76134818871287</c:v>
                </c:pt>
                <c:pt idx="32">
                  <c:v>292.22740123670701</c:v>
                </c:pt>
                <c:pt idx="33">
                  <c:v>381.7364532425272</c:v>
                </c:pt>
                <c:pt idx="34">
                  <c:v>457.16945716761438</c:v>
                </c:pt>
                <c:pt idx="35">
                  <c:v>515.01890820789231</c:v>
                </c:pt>
                <c:pt idx="36">
                  <c:v>558.20448745409158</c:v>
                </c:pt>
                <c:pt idx="37">
                  <c:v>591.93222092721953</c:v>
                </c:pt>
                <c:pt idx="38">
                  <c:v>620.42650996755765</c:v>
                </c:pt>
                <c:pt idx="39">
                  <c:v>645.96612580539659</c:v>
                </c:pt>
                <c:pt idx="40">
                  <c:v>669.37618965956062</c:v>
                </c:pt>
                <c:pt idx="41">
                  <c:v>690.69908303961529</c:v>
                </c:pt>
                <c:pt idx="42">
                  <c:v>709.69977515646497</c:v>
                </c:pt>
                <c:pt idx="43">
                  <c:v>726.43976842827033</c:v>
                </c:pt>
                <c:pt idx="44">
                  <c:v>741.69267351727831</c:v>
                </c:pt>
              </c:numCache>
            </c:numRef>
          </c:val>
          <c:smooth val="0"/>
          <c:extLst>
            <c:ext xmlns:c16="http://schemas.microsoft.com/office/drawing/2014/chart" uri="{C3380CC4-5D6E-409C-BE32-E72D297353CC}">
              <c16:uniqueId val="{00000003-F2BD-4186-BCDF-7B5297BCA73B}"/>
            </c:ext>
          </c:extLst>
        </c:ser>
        <c:ser>
          <c:idx val="4"/>
          <c:order val="4"/>
          <c:tx>
            <c:strRef>
              <c:f>Triplex2_54C!$A$39</c:f>
              <c:strCache>
                <c:ptCount val="1"/>
                <c:pt idx="0">
                  <c:v>Well 5 green</c:v>
                </c:pt>
              </c:strCache>
            </c:strRef>
          </c:tx>
          <c:spPr>
            <a:ln w="28575" cap="rnd">
              <a:solidFill>
                <a:schemeClr val="accent5"/>
              </a:solidFill>
              <a:round/>
            </a:ln>
            <a:effectLst/>
          </c:spPr>
          <c:marker>
            <c:symbol val="none"/>
          </c:marker>
          <c:val>
            <c:numRef>
              <c:f>Triplex2_54C!$B$39:$AT$39</c:f>
              <c:numCache>
                <c:formatCode>General</c:formatCode>
                <c:ptCount val="45"/>
                <c:pt idx="0">
                  <c:v>-7.7233546556508372</c:v>
                </c:pt>
                <c:pt idx="1">
                  <c:v>-6.0703144550789148</c:v>
                </c:pt>
                <c:pt idx="2">
                  <c:v>-4.8471092954514461</c:v>
                </c:pt>
                <c:pt idx="3">
                  <c:v>-3.9321507505901536</c:v>
                </c:pt>
                <c:pt idx="4">
                  <c:v>-2.9733184790602536</c:v>
                </c:pt>
                <c:pt idx="5">
                  <c:v>-2.0226132796469756</c:v>
                </c:pt>
                <c:pt idx="6">
                  <c:v>-1.3617866338645399</c:v>
                </c:pt>
                <c:pt idx="7">
                  <c:v>-0.93348485758724564</c:v>
                </c:pt>
                <c:pt idx="8">
                  <c:v>-0.45752302818982571</c:v>
                </c:pt>
                <c:pt idx="9">
                  <c:v>0.15859312793145364</c:v>
                </c:pt>
                <c:pt idx="10">
                  <c:v>0.82036824280476139</c:v>
                </c:pt>
                <c:pt idx="11">
                  <c:v>1.3630422084170277</c:v>
                </c:pt>
                <c:pt idx="12">
                  <c:v>1.6172279273177992</c:v>
                </c:pt>
                <c:pt idx="13">
                  <c:v>1.5513374094825849</c:v>
                </c:pt>
                <c:pt idx="14">
                  <c:v>1.2761097914826678</c:v>
                </c:pt>
                <c:pt idx="15">
                  <c:v>0.88808276161034883</c:v>
                </c:pt>
                <c:pt idx="16">
                  <c:v>0.44602016413773526</c:v>
                </c:pt>
                <c:pt idx="17">
                  <c:v>4.9798403491877252E-2</c:v>
                </c:pt>
                <c:pt idx="18">
                  <c:v>-0.20203079376187816</c:v>
                </c:pt>
                <c:pt idx="19">
                  <c:v>-0.3016786769949249</c:v>
                </c:pt>
                <c:pt idx="20">
                  <c:v>-0.31711006048317358</c:v>
                </c:pt>
                <c:pt idx="21">
                  <c:v>-0.33909570038849779</c:v>
                </c:pt>
                <c:pt idx="22">
                  <c:v>-0.44694762786275533</c:v>
                </c:pt>
                <c:pt idx="23">
                  <c:v>-0.69401706767530413</c:v>
                </c:pt>
                <c:pt idx="24">
                  <c:v>-1.0942923102265922</c:v>
                </c:pt>
                <c:pt idx="25">
                  <c:v>-1.387221058976138</c:v>
                </c:pt>
                <c:pt idx="26">
                  <c:v>-0.35626045280696417</c:v>
                </c:pt>
                <c:pt idx="27">
                  <c:v>5.1105629503890668</c:v>
                </c:pt>
                <c:pt idx="28">
                  <c:v>20.571361172991601</c:v>
                </c:pt>
                <c:pt idx="29">
                  <c:v>53.127044306651442</c:v>
                </c:pt>
                <c:pt idx="30">
                  <c:v>108.09333377681469</c:v>
                </c:pt>
                <c:pt idx="31">
                  <c:v>184.43637947288153</c:v>
                </c:pt>
                <c:pt idx="32">
                  <c:v>272.89228776441087</c:v>
                </c:pt>
                <c:pt idx="33">
                  <c:v>359.59168193243931</c:v>
                </c:pt>
                <c:pt idx="34">
                  <c:v>433.09524024327038</c:v>
                </c:pt>
                <c:pt idx="35">
                  <c:v>489.26898120561964</c:v>
                </c:pt>
                <c:pt idx="36">
                  <c:v>530.61942738301514</c:v>
                </c:pt>
                <c:pt idx="37">
                  <c:v>562.14217191300304</c:v>
                </c:pt>
                <c:pt idx="38">
                  <c:v>587.84113395157874</c:v>
                </c:pt>
                <c:pt idx="39">
                  <c:v>609.77019704521263</c:v>
                </c:pt>
                <c:pt idx="40">
                  <c:v>628.78897280742603</c:v>
                </c:pt>
                <c:pt idx="41">
                  <c:v>645.37773180839395</c:v>
                </c:pt>
                <c:pt idx="42">
                  <c:v>659.84960644266539</c:v>
                </c:pt>
                <c:pt idx="43">
                  <c:v>672.47403314392614</c:v>
                </c:pt>
                <c:pt idx="44">
                  <c:v>683.85900048844087</c:v>
                </c:pt>
              </c:numCache>
            </c:numRef>
          </c:val>
          <c:smooth val="0"/>
          <c:extLst>
            <c:ext xmlns:c16="http://schemas.microsoft.com/office/drawing/2014/chart" uri="{C3380CC4-5D6E-409C-BE32-E72D297353CC}">
              <c16:uniqueId val="{00000004-F2BD-4186-BCDF-7B5297BCA73B}"/>
            </c:ext>
          </c:extLst>
        </c:ser>
        <c:ser>
          <c:idx val="5"/>
          <c:order val="5"/>
          <c:tx>
            <c:strRef>
              <c:f>Triplex2_54C!$A$42</c:f>
              <c:strCache>
                <c:ptCount val="1"/>
                <c:pt idx="0">
                  <c:v>Well 6 green</c:v>
                </c:pt>
              </c:strCache>
            </c:strRef>
          </c:tx>
          <c:spPr>
            <a:ln w="28575" cap="rnd">
              <a:solidFill>
                <a:schemeClr val="accent6"/>
              </a:solidFill>
              <a:round/>
            </a:ln>
            <a:effectLst/>
          </c:spPr>
          <c:marker>
            <c:symbol val="none"/>
          </c:marker>
          <c:val>
            <c:numRef>
              <c:f>Triplex2_54C!$B$42:$AT$42</c:f>
              <c:numCache>
                <c:formatCode>General</c:formatCode>
                <c:ptCount val="45"/>
                <c:pt idx="0">
                  <c:v>3.6299043393537431</c:v>
                </c:pt>
                <c:pt idx="1">
                  <c:v>5.6403147861128673</c:v>
                </c:pt>
                <c:pt idx="2">
                  <c:v>6.5815604716008238</c:v>
                </c:pt>
                <c:pt idx="3">
                  <c:v>6.1066007576173433</c:v>
                </c:pt>
                <c:pt idx="4">
                  <c:v>4.6784638784665731</c:v>
                </c:pt>
                <c:pt idx="5">
                  <c:v>2.9847132128907106</c:v>
                </c:pt>
                <c:pt idx="6">
                  <c:v>1.3913457919734356</c:v>
                </c:pt>
                <c:pt idx="7">
                  <c:v>-2.0696342615337926E-2</c:v>
                </c:pt>
                <c:pt idx="8">
                  <c:v>-1.1297773581136425</c:v>
                </c:pt>
                <c:pt idx="9">
                  <c:v>-1.6935028908428649</c:v>
                </c:pt>
                <c:pt idx="10">
                  <c:v>-1.5779015120460826</c:v>
                </c:pt>
                <c:pt idx="11">
                  <c:v>-0.98703189841580752</c:v>
                </c:pt>
                <c:pt idx="12">
                  <c:v>-0.37741895771978307</c:v>
                </c:pt>
                <c:pt idx="13">
                  <c:v>-9.0225740543246502E-2</c:v>
                </c:pt>
                <c:pt idx="14">
                  <c:v>-0.11477934168033244</c:v>
                </c:pt>
                <c:pt idx="15">
                  <c:v>-0.19135805307450937</c:v>
                </c:pt>
                <c:pt idx="16">
                  <c:v>-9.8882868724103901E-2</c:v>
                </c:pt>
                <c:pt idx="17">
                  <c:v>0.11615373013592034</c:v>
                </c:pt>
                <c:pt idx="18">
                  <c:v>0.23117868705594447</c:v>
                </c:pt>
                <c:pt idx="19">
                  <c:v>0.16043033571804699</c:v>
                </c:pt>
                <c:pt idx="20">
                  <c:v>7.1129821561044082E-2</c:v>
                </c:pt>
                <c:pt idx="21">
                  <c:v>0.2416029800697288</c:v>
                </c:pt>
                <c:pt idx="22">
                  <c:v>1.0850204043490521</c:v>
                </c:pt>
                <c:pt idx="23">
                  <c:v>3.7651931972613966</c:v>
                </c:pt>
                <c:pt idx="24">
                  <c:v>11.378402809399631</c:v>
                </c:pt>
                <c:pt idx="25">
                  <c:v>30.00029651290788</c:v>
                </c:pt>
                <c:pt idx="26">
                  <c:v>68.101146594421152</c:v>
                </c:pt>
                <c:pt idx="27">
                  <c:v>133.00052595878515</c:v>
                </c:pt>
                <c:pt idx="28">
                  <c:v>225.4341400411231</c:v>
                </c:pt>
                <c:pt idx="29">
                  <c:v>336.37264726356625</c:v>
                </c:pt>
                <c:pt idx="30">
                  <c:v>449.93173418592232</c:v>
                </c:pt>
                <c:pt idx="31">
                  <c:v>551.22854260841996</c:v>
                </c:pt>
                <c:pt idx="32">
                  <c:v>633.11077477109211</c:v>
                </c:pt>
                <c:pt idx="33">
                  <c:v>696.80125194315042</c:v>
                </c:pt>
                <c:pt idx="34">
                  <c:v>747.63085074361152</c:v>
                </c:pt>
                <c:pt idx="35">
                  <c:v>790.60029077874242</c:v>
                </c:pt>
                <c:pt idx="36">
                  <c:v>828.57249089664947</c:v>
                </c:pt>
                <c:pt idx="37">
                  <c:v>862.69729023390391</c:v>
                </c:pt>
                <c:pt idx="38">
                  <c:v>893.46442873938031</c:v>
                </c:pt>
                <c:pt idx="39">
                  <c:v>921.40240911428737</c:v>
                </c:pt>
                <c:pt idx="40">
                  <c:v>947.08612108848502</c:v>
                </c:pt>
                <c:pt idx="41">
                  <c:v>970.6329529106024</c:v>
                </c:pt>
                <c:pt idx="42">
                  <c:v>991.68986341224445</c:v>
                </c:pt>
                <c:pt idx="43">
                  <c:v>1010.1573712172903</c:v>
                </c:pt>
                <c:pt idx="44">
                  <c:v>1026.8373085284657</c:v>
                </c:pt>
              </c:numCache>
            </c:numRef>
          </c:val>
          <c:smooth val="0"/>
          <c:extLst>
            <c:ext xmlns:c16="http://schemas.microsoft.com/office/drawing/2014/chart" uri="{C3380CC4-5D6E-409C-BE32-E72D297353CC}">
              <c16:uniqueId val="{00000005-F2BD-4186-BCDF-7B5297BCA73B}"/>
            </c:ext>
          </c:extLst>
        </c:ser>
        <c:ser>
          <c:idx val="6"/>
          <c:order val="6"/>
          <c:tx>
            <c:strRef>
              <c:f>Triplex2_54C!$A$45</c:f>
              <c:strCache>
                <c:ptCount val="1"/>
                <c:pt idx="0">
                  <c:v>Well 7 green</c:v>
                </c:pt>
              </c:strCache>
            </c:strRef>
          </c:tx>
          <c:spPr>
            <a:ln w="28575" cap="rnd">
              <a:solidFill>
                <a:schemeClr val="accent1">
                  <a:lumMod val="60000"/>
                </a:schemeClr>
              </a:solidFill>
              <a:round/>
            </a:ln>
            <a:effectLst/>
          </c:spPr>
          <c:marker>
            <c:symbol val="none"/>
          </c:marker>
          <c:val>
            <c:numRef>
              <c:f>Triplex2_54C!$B$45:$AT$45</c:f>
              <c:numCache>
                <c:formatCode>General</c:formatCode>
                <c:ptCount val="45"/>
                <c:pt idx="0">
                  <c:v>-3.6537475758850633</c:v>
                </c:pt>
                <c:pt idx="1">
                  <c:v>-0.33100571154500358</c:v>
                </c:pt>
                <c:pt idx="2">
                  <c:v>1.9910296695816214</c:v>
                </c:pt>
                <c:pt idx="3">
                  <c:v>3.2936243453295901</c:v>
                </c:pt>
                <c:pt idx="4">
                  <c:v>4.1479255401300179</c:v>
                </c:pt>
                <c:pt idx="5">
                  <c:v>4.9045119368911401</c:v>
                </c:pt>
                <c:pt idx="6">
                  <c:v>5.3161832250061707</c:v>
                </c:pt>
                <c:pt idx="7">
                  <c:v>4.5042194719189865</c:v>
                </c:pt>
                <c:pt idx="8">
                  <c:v>1.7645434745281818</c:v>
                </c:pt>
                <c:pt idx="9">
                  <c:v>-2.0996635308947589</c:v>
                </c:pt>
                <c:pt idx="10">
                  <c:v>-5.1477724292890343</c:v>
                </c:pt>
                <c:pt idx="11">
                  <c:v>-6.2697195492746687</c:v>
                </c:pt>
                <c:pt idx="12">
                  <c:v>-5.7483722039505665</c:v>
                </c:pt>
                <c:pt idx="13">
                  <c:v>-4.2885010553018219</c:v>
                </c:pt>
                <c:pt idx="14">
                  <c:v>-2.5429854972044268</c:v>
                </c:pt>
                <c:pt idx="15">
                  <c:v>-1.0960691002819658</c:v>
                </c:pt>
                <c:pt idx="16">
                  <c:v>-0.19861610709449451</c:v>
                </c:pt>
                <c:pt idx="17">
                  <c:v>0.36252415330818621</c:v>
                </c:pt>
                <c:pt idx="18">
                  <c:v>1.00969946476107</c:v>
                </c:pt>
                <c:pt idx="19">
                  <c:v>2.0097755286187748</c:v>
                </c:pt>
                <c:pt idx="20">
                  <c:v>3.2205832752460992</c:v>
                </c:pt>
                <c:pt idx="21">
                  <c:v>4.2996589429822052</c:v>
                </c:pt>
                <c:pt idx="22">
                  <c:v>5.576753731827921</c:v>
                </c:pt>
                <c:pt idx="23">
                  <c:v>9.2252635844979523</c:v>
                </c:pt>
                <c:pt idx="24">
                  <c:v>20.27138953776921</c:v>
                </c:pt>
                <c:pt idx="25">
                  <c:v>46.70660530749592</c:v>
                </c:pt>
                <c:pt idx="26">
                  <c:v>97.19495414312405</c:v>
                </c:pt>
                <c:pt idx="27">
                  <c:v>175.92104693434158</c:v>
                </c:pt>
                <c:pt idx="28">
                  <c:v>277.72375118177115</c:v>
                </c:pt>
                <c:pt idx="29">
                  <c:v>388.43185479177009</c:v>
                </c:pt>
                <c:pt idx="30">
                  <c:v>491.59307999013799</c:v>
                </c:pt>
                <c:pt idx="31">
                  <c:v>576.62695989670465</c:v>
                </c:pt>
                <c:pt idx="32">
                  <c:v>642.00792697078032</c:v>
                </c:pt>
                <c:pt idx="33">
                  <c:v>692.39186724193132</c:v>
                </c:pt>
                <c:pt idx="34">
                  <c:v>733.80497796454983</c:v>
                </c:pt>
                <c:pt idx="35">
                  <c:v>770.6517132469944</c:v>
                </c:pt>
                <c:pt idx="36">
                  <c:v>805.05916501713364</c:v>
                </c:pt>
                <c:pt idx="37">
                  <c:v>837.48974030680256</c:v>
                </c:pt>
                <c:pt idx="38">
                  <c:v>867.75603497777956</c:v>
                </c:pt>
                <c:pt idx="39">
                  <c:v>895.771560670486</c:v>
                </c:pt>
                <c:pt idx="40">
                  <c:v>921.61211492168331</c:v>
                </c:pt>
                <c:pt idx="41">
                  <c:v>945.15296971069802</c:v>
                </c:pt>
                <c:pt idx="42">
                  <c:v>966.08957932368139</c:v>
                </c:pt>
                <c:pt idx="43">
                  <c:v>984.53962181898169</c:v>
                </c:pt>
                <c:pt idx="44">
                  <c:v>1001.4269386005471</c:v>
                </c:pt>
              </c:numCache>
            </c:numRef>
          </c:val>
          <c:smooth val="0"/>
          <c:extLst>
            <c:ext xmlns:c16="http://schemas.microsoft.com/office/drawing/2014/chart" uri="{C3380CC4-5D6E-409C-BE32-E72D297353CC}">
              <c16:uniqueId val="{00000006-F2BD-4186-BCDF-7B5297BCA73B}"/>
            </c:ext>
          </c:extLst>
        </c:ser>
        <c:ser>
          <c:idx val="7"/>
          <c:order val="7"/>
          <c:tx>
            <c:strRef>
              <c:f>Triplex2_54C!$A$48</c:f>
              <c:strCache>
                <c:ptCount val="1"/>
                <c:pt idx="0">
                  <c:v>Well 8 green</c:v>
                </c:pt>
              </c:strCache>
            </c:strRef>
          </c:tx>
          <c:spPr>
            <a:ln w="28575" cap="rnd">
              <a:solidFill>
                <a:schemeClr val="accent2">
                  <a:lumMod val="60000"/>
                </a:schemeClr>
              </a:solidFill>
              <a:round/>
            </a:ln>
            <a:effectLst/>
          </c:spPr>
          <c:marker>
            <c:symbol val="none"/>
          </c:marker>
          <c:val>
            <c:numRef>
              <c:f>Triplex2_54C!$B$48:$AT$48</c:f>
              <c:numCache>
                <c:formatCode>General</c:formatCode>
                <c:ptCount val="45"/>
                <c:pt idx="0">
                  <c:v>-6.5461585779084999</c:v>
                </c:pt>
                <c:pt idx="1">
                  <c:v>-4.7079702950395586</c:v>
                </c:pt>
                <c:pt idx="2">
                  <c:v>-3.1291422236772632</c:v>
                </c:pt>
                <c:pt idx="3">
                  <c:v>-1.8986478728693328</c:v>
                </c:pt>
                <c:pt idx="4">
                  <c:v>-1.0200630743493093</c:v>
                </c:pt>
                <c:pt idx="5">
                  <c:v>-0.69745845138277218</c:v>
                </c:pt>
                <c:pt idx="6">
                  <c:v>-0.962581697927817</c:v>
                </c:pt>
                <c:pt idx="7">
                  <c:v>-1.1798507890980545</c:v>
                </c:pt>
                <c:pt idx="8">
                  <c:v>-0.71048388293638709</c:v>
                </c:pt>
                <c:pt idx="9">
                  <c:v>0.27893646323536814</c:v>
                </c:pt>
                <c:pt idx="10">
                  <c:v>1.1681623396398209</c:v>
                </c:pt>
                <c:pt idx="11">
                  <c:v>1.5862133163118415</c:v>
                </c:pt>
                <c:pt idx="12">
                  <c:v>1.5679351745839085</c:v>
                </c:pt>
                <c:pt idx="13">
                  <c:v>1.3201722669491573</c:v>
                </c:pt>
                <c:pt idx="14">
                  <c:v>0.91072367111337371</c:v>
                </c:pt>
                <c:pt idx="15">
                  <c:v>0.2400278118384449</c:v>
                </c:pt>
                <c:pt idx="16">
                  <c:v>-0.63319319875517976</c:v>
                </c:pt>
                <c:pt idx="17">
                  <c:v>-1.3631464526624768</c:v>
                </c:pt>
                <c:pt idx="18">
                  <c:v>-1.5254565708946757</c:v>
                </c:pt>
                <c:pt idx="19">
                  <c:v>-0.42502178804534196</c:v>
                </c:pt>
                <c:pt idx="20">
                  <c:v>4.0273857905303885</c:v>
                </c:pt>
                <c:pt idx="21">
                  <c:v>16.716165321746303</c:v>
                </c:pt>
                <c:pt idx="22">
                  <c:v>45.304461953322971</c:v>
                </c:pt>
                <c:pt idx="23">
                  <c:v>97.342677128006471</c:v>
                </c:pt>
                <c:pt idx="24">
                  <c:v>175.21365463592883</c:v>
                </c:pt>
                <c:pt idx="25">
                  <c:v>272.4965951294871</c:v>
                </c:pt>
                <c:pt idx="26">
                  <c:v>375.57156809541266</c:v>
                </c:pt>
                <c:pt idx="27">
                  <c:v>470.15372143621062</c:v>
                </c:pt>
                <c:pt idx="28">
                  <c:v>547.85020691989848</c:v>
                </c:pt>
                <c:pt idx="29">
                  <c:v>608.12216939563041</c:v>
                </c:pt>
                <c:pt idx="30">
                  <c:v>655.39834641071684</c:v>
                </c:pt>
                <c:pt idx="31">
                  <c:v>694.81211997447099</c:v>
                </c:pt>
                <c:pt idx="32">
                  <c:v>729.88337839164706</c:v>
                </c:pt>
                <c:pt idx="33">
                  <c:v>762.47909332703966</c:v>
                </c:pt>
                <c:pt idx="34">
                  <c:v>793.58333526474416</c:v>
                </c:pt>
                <c:pt idx="35">
                  <c:v>823.84344825990956</c:v>
                </c:pt>
                <c:pt idx="36">
                  <c:v>853.61099135106451</c:v>
                </c:pt>
                <c:pt idx="37">
                  <c:v>882.61782758137088</c:v>
                </c:pt>
                <c:pt idx="38">
                  <c:v>909.84367028595261</c:v>
                </c:pt>
                <c:pt idx="39">
                  <c:v>934.23478823446021</c:v>
                </c:pt>
                <c:pt idx="40">
                  <c:v>955.76888218879685</c:v>
                </c:pt>
                <c:pt idx="41">
                  <c:v>975.20198106775752</c:v>
                </c:pt>
                <c:pt idx="42">
                  <c:v>992.82200827178531</c:v>
                </c:pt>
                <c:pt idx="43">
                  <c:v>1008.3875066849778</c:v>
                </c:pt>
                <c:pt idx="44">
                  <c:v>1022.3245719902789</c:v>
                </c:pt>
              </c:numCache>
            </c:numRef>
          </c:val>
          <c:smooth val="0"/>
          <c:extLst>
            <c:ext xmlns:c16="http://schemas.microsoft.com/office/drawing/2014/chart" uri="{C3380CC4-5D6E-409C-BE32-E72D297353CC}">
              <c16:uniqueId val="{00000007-F2BD-4186-BCDF-7B5297BCA73B}"/>
            </c:ext>
          </c:extLst>
        </c:ser>
        <c:ser>
          <c:idx val="8"/>
          <c:order val="8"/>
          <c:tx>
            <c:strRef>
              <c:f>Triplex2_54C!$A$51</c:f>
              <c:strCache>
                <c:ptCount val="1"/>
                <c:pt idx="0">
                  <c:v>Well 9 green</c:v>
                </c:pt>
              </c:strCache>
            </c:strRef>
          </c:tx>
          <c:spPr>
            <a:ln w="28575" cap="rnd">
              <a:solidFill>
                <a:schemeClr val="accent3">
                  <a:lumMod val="60000"/>
                </a:schemeClr>
              </a:solidFill>
              <a:round/>
            </a:ln>
            <a:effectLst/>
          </c:spPr>
          <c:marker>
            <c:symbol val="none"/>
          </c:marker>
          <c:val>
            <c:numRef>
              <c:f>Triplex2_54C!$B$51:$AT$51</c:f>
              <c:numCache>
                <c:formatCode>General</c:formatCode>
                <c:ptCount val="45"/>
                <c:pt idx="0">
                  <c:v>-18.582835745284683</c:v>
                </c:pt>
                <c:pt idx="1">
                  <c:v>-10.186997359858651</c:v>
                </c:pt>
                <c:pt idx="2">
                  <c:v>-4.3168414078572823</c:v>
                </c:pt>
                <c:pt idx="3">
                  <c:v>-1.7418066448444733</c:v>
                </c:pt>
                <c:pt idx="4">
                  <c:v>-1.3379589698506607</c:v>
                </c:pt>
                <c:pt idx="5">
                  <c:v>-1.4794266896478803</c:v>
                </c:pt>
                <c:pt idx="6">
                  <c:v>-1.2759297125885496</c:v>
                </c:pt>
                <c:pt idx="7">
                  <c:v>-0.64180012566612277</c:v>
                </c:pt>
                <c:pt idx="8">
                  <c:v>0.1524548332708946</c:v>
                </c:pt>
                <c:pt idx="9">
                  <c:v>0.75755074845619674</c:v>
                </c:pt>
                <c:pt idx="10">
                  <c:v>0.9982104719401832</c:v>
                </c:pt>
                <c:pt idx="11">
                  <c:v>1.0601347861302202</c:v>
                </c:pt>
                <c:pt idx="12">
                  <c:v>1.226315075165985</c:v>
                </c:pt>
                <c:pt idx="13">
                  <c:v>1.3964959280237963</c:v>
                </c:pt>
                <c:pt idx="14">
                  <c:v>1.1526427704575326</c:v>
                </c:pt>
                <c:pt idx="15">
                  <c:v>0.38973243998771068</c:v>
                </c:pt>
                <c:pt idx="16">
                  <c:v>-0.50549845435307361</c:v>
                </c:pt>
                <c:pt idx="17">
                  <c:v>-1.2547690326355223</c:v>
                </c:pt>
                <c:pt idx="18">
                  <c:v>-1.9761130385286378</c:v>
                </c:pt>
                <c:pt idx="19">
                  <c:v>-2.4173221432174614</c:v>
                </c:pt>
                <c:pt idx="20">
                  <c:v>-0.5886876847671374</c:v>
                </c:pt>
                <c:pt idx="21">
                  <c:v>8.4187498503742972</c:v>
                </c:pt>
                <c:pt idx="22">
                  <c:v>32.480160574164984</c:v>
                </c:pt>
                <c:pt idx="23">
                  <c:v>79.940421975386926</c:v>
                </c:pt>
                <c:pt idx="24">
                  <c:v>154.4877338975748</c:v>
                </c:pt>
                <c:pt idx="25">
                  <c:v>250.77749066883371</c:v>
                </c:pt>
                <c:pt idx="26">
                  <c:v>355.22972373392622</c:v>
                </c:pt>
                <c:pt idx="27">
                  <c:v>452.55789415050094</c:v>
                </c:pt>
                <c:pt idx="28">
                  <c:v>533.18252401497193</c:v>
                </c:pt>
                <c:pt idx="29">
                  <c:v>595.6503256450269</c:v>
                </c:pt>
                <c:pt idx="30">
                  <c:v>643.52059863300747</c:v>
                </c:pt>
                <c:pt idx="31">
                  <c:v>681.31132506450922</c:v>
                </c:pt>
                <c:pt idx="32">
                  <c:v>712.86161688741413</c:v>
                </c:pt>
                <c:pt idx="33">
                  <c:v>741.22027626324962</c:v>
                </c:pt>
                <c:pt idx="34">
                  <c:v>768.32996839934094</c:v>
                </c:pt>
                <c:pt idx="35">
                  <c:v>794.73526968927217</c:v>
                </c:pt>
                <c:pt idx="36">
                  <c:v>819.97033549473599</c:v>
                </c:pt>
                <c:pt idx="37">
                  <c:v>843.29164990802747</c:v>
                </c:pt>
                <c:pt idx="38">
                  <c:v>864.29945983042853</c:v>
                </c:pt>
                <c:pt idx="39">
                  <c:v>883.53385242339573</c:v>
                </c:pt>
                <c:pt idx="40">
                  <c:v>902.31009364998135</c:v>
                </c:pt>
                <c:pt idx="41">
                  <c:v>921.00990940971678</c:v>
                </c:pt>
                <c:pt idx="42">
                  <c:v>938.01493672872493</c:v>
                </c:pt>
                <c:pt idx="43">
                  <c:v>951.4261757702825</c:v>
                </c:pt>
                <c:pt idx="44">
                  <c:v>961.68679113952021</c:v>
                </c:pt>
              </c:numCache>
            </c:numRef>
          </c:val>
          <c:smooth val="0"/>
          <c:extLst>
            <c:ext xmlns:c16="http://schemas.microsoft.com/office/drawing/2014/chart" uri="{C3380CC4-5D6E-409C-BE32-E72D297353CC}">
              <c16:uniqueId val="{00000008-F2BD-4186-BCDF-7B5297BCA73B}"/>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in val="-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Dx Triplex:</a:t>
            </a:r>
            <a:r>
              <a:rPr lang="en-US" baseline="0"/>
              <a:t> </a:t>
            </a:r>
            <a:r>
              <a:rPr lang="en-US"/>
              <a:t>ORF1ab</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Dx assay'!$A$27</c:f>
              <c:strCache>
                <c:ptCount val="1"/>
                <c:pt idx="0">
                  <c:v>NTC</c:v>
                </c:pt>
              </c:strCache>
            </c:strRef>
          </c:tx>
          <c:spPr>
            <a:ln w="28575" cap="rnd">
              <a:solidFill>
                <a:schemeClr val="accent1"/>
              </a:solidFill>
              <a:round/>
            </a:ln>
            <a:effectLst/>
          </c:spPr>
          <c:marker>
            <c:symbol val="none"/>
          </c:marker>
          <c:val>
            <c:numRef>
              <c:f>'Dx assay'!$B$27:$AT$27</c:f>
              <c:numCache>
                <c:formatCode>General</c:formatCode>
                <c:ptCount val="45"/>
                <c:pt idx="0">
                  <c:v>-22.40379191944885</c:v>
                </c:pt>
                <c:pt idx="1">
                  <c:v>-16.622748796391534</c:v>
                </c:pt>
                <c:pt idx="2">
                  <c:v>-12.3554571344539</c:v>
                </c:pt>
                <c:pt idx="3">
                  <c:v>-9.9254480425352085</c:v>
                </c:pt>
                <c:pt idx="4">
                  <c:v>-8.6754703510960098</c:v>
                </c:pt>
                <c:pt idx="5">
                  <c:v>-7.6942203292437625</c:v>
                </c:pt>
                <c:pt idx="6">
                  <c:v>-6.3783999577535724</c:v>
                </c:pt>
                <c:pt idx="7">
                  <c:v>-4.7199965611889638</c:v>
                </c:pt>
                <c:pt idx="8">
                  <c:v>-3.0195278101582517</c:v>
                </c:pt>
                <c:pt idx="9">
                  <c:v>-1.5680474021082773</c:v>
                </c:pt>
                <c:pt idx="10">
                  <c:v>-0.64800175524578663</c:v>
                </c:pt>
                <c:pt idx="11">
                  <c:v>-0.32733048583941127</c:v>
                </c:pt>
                <c:pt idx="12">
                  <c:v>-0.27343600631684239</c:v>
                </c:pt>
                <c:pt idx="13">
                  <c:v>-0.12836607596545946</c:v>
                </c:pt>
                <c:pt idx="14">
                  <c:v>0.16984708357631462</c:v>
                </c:pt>
                <c:pt idx="15">
                  <c:v>0.62261060688797443</c:v>
                </c:pt>
                <c:pt idx="16">
                  <c:v>1.2761449670779257</c:v>
                </c:pt>
                <c:pt idx="17">
                  <c:v>2.0046439783782262</c:v>
                </c:pt>
                <c:pt idx="18">
                  <c:v>2.5720240714781539</c:v>
                </c:pt>
                <c:pt idx="19">
                  <c:v>2.865050153566699</c:v>
                </c:pt>
                <c:pt idx="20">
                  <c:v>2.9626430631669791</c:v>
                </c:pt>
                <c:pt idx="21">
                  <c:v>3.0608223982108029</c:v>
                </c:pt>
                <c:pt idx="22">
                  <c:v>3.371793614634953</c:v>
                </c:pt>
                <c:pt idx="23">
                  <c:v>4.0384387930462253</c:v>
                </c:pt>
                <c:pt idx="24">
                  <c:v>4.8245648928914306</c:v>
                </c:pt>
                <c:pt idx="25">
                  <c:v>5.0627881434065785</c:v>
                </c:pt>
                <c:pt idx="26">
                  <c:v>4.4013909703935497</c:v>
                </c:pt>
                <c:pt idx="27">
                  <c:v>3.3182656169283291</c:v>
                </c:pt>
                <c:pt idx="28">
                  <c:v>2.6066134430438979</c:v>
                </c:pt>
                <c:pt idx="29">
                  <c:v>2.4959954985552031</c:v>
                </c:pt>
                <c:pt idx="30">
                  <c:v>2.4147646244873613</c:v>
                </c:pt>
                <c:pt idx="31">
                  <c:v>1.7641769196779933</c:v>
                </c:pt>
                <c:pt idx="32">
                  <c:v>0.69093068222173315</c:v>
                </c:pt>
                <c:pt idx="33">
                  <c:v>-0.17726683262662846</c:v>
                </c:pt>
                <c:pt idx="34">
                  <c:v>-0.51963996697122639</c:v>
                </c:pt>
                <c:pt idx="35">
                  <c:v>-0.57818941308869398</c:v>
                </c:pt>
                <c:pt idx="36">
                  <c:v>-0.7791832099082967</c:v>
                </c:pt>
                <c:pt idx="37">
                  <c:v>-1.3855200880589109</c:v>
                </c:pt>
                <c:pt idx="38">
                  <c:v>-2.3739537026613107</c:v>
                </c:pt>
                <c:pt idx="39">
                  <c:v>-3.4440916804487642</c:v>
                </c:pt>
                <c:pt idx="40">
                  <c:v>-4.1512238652539963</c:v>
                </c:pt>
                <c:pt idx="41">
                  <c:v>-4.1257034710615699</c:v>
                </c:pt>
                <c:pt idx="42">
                  <c:v>-3.4370284722426732</c:v>
                </c:pt>
                <c:pt idx="43">
                  <c:v>-2.650235351657102</c:v>
                </c:pt>
                <c:pt idx="44">
                  <c:v>-2.1441470837671659</c:v>
                </c:pt>
              </c:numCache>
            </c:numRef>
          </c:val>
          <c:smooth val="0"/>
          <c:extLst>
            <c:ext xmlns:c16="http://schemas.microsoft.com/office/drawing/2014/chart" uri="{C3380CC4-5D6E-409C-BE32-E72D297353CC}">
              <c16:uniqueId val="{00000000-5116-49EF-BDF2-BBDBF16AC212}"/>
            </c:ext>
          </c:extLst>
        </c:ser>
        <c:ser>
          <c:idx val="1"/>
          <c:order val="1"/>
          <c:tx>
            <c:strRef>
              <c:f>'Dx assay'!$A$30</c:f>
              <c:strCache>
                <c:ptCount val="1"/>
                <c:pt idx="0">
                  <c:v>50 copies</c:v>
                </c:pt>
              </c:strCache>
            </c:strRef>
          </c:tx>
          <c:spPr>
            <a:ln w="28575" cap="rnd">
              <a:solidFill>
                <a:schemeClr val="accent2"/>
              </a:solidFill>
              <a:round/>
            </a:ln>
            <a:effectLst/>
          </c:spPr>
          <c:marker>
            <c:symbol val="none"/>
          </c:marker>
          <c:val>
            <c:numRef>
              <c:f>'Dx assay'!$B$30:$AT$30</c:f>
              <c:numCache>
                <c:formatCode>General</c:formatCode>
                <c:ptCount val="45"/>
                <c:pt idx="0">
                  <c:v>-5.8355637122713233</c:v>
                </c:pt>
                <c:pt idx="1">
                  <c:v>-2.4635809270093887</c:v>
                </c:pt>
                <c:pt idx="2">
                  <c:v>-0.31740138139139162</c:v>
                </c:pt>
                <c:pt idx="3">
                  <c:v>0.52160844188438205</c:v>
                </c:pt>
                <c:pt idx="4">
                  <c:v>0.68114573627644859</c:v>
                </c:pt>
                <c:pt idx="5">
                  <c:v>0.59868401028870721</c:v>
                </c:pt>
                <c:pt idx="6">
                  <c:v>0.42523129098481149</c:v>
                </c:pt>
                <c:pt idx="7">
                  <c:v>0.2730312672592845</c:v>
                </c:pt>
                <c:pt idx="8">
                  <c:v>0.30850803124303638</c:v>
                </c:pt>
                <c:pt idx="9">
                  <c:v>0.59361603915567684</c:v>
                </c:pt>
                <c:pt idx="10">
                  <c:v>0.87717504700776772</c:v>
                </c:pt>
                <c:pt idx="11">
                  <c:v>0.84716303640198021</c:v>
                </c:pt>
                <c:pt idx="12">
                  <c:v>0.49522610540770984</c:v>
                </c:pt>
                <c:pt idx="13">
                  <c:v>3.9909990133310203E-2</c:v>
                </c:pt>
                <c:pt idx="14">
                  <c:v>-0.29849472544810851</c:v>
                </c:pt>
                <c:pt idx="15">
                  <c:v>-0.39968744313409843</c:v>
                </c:pt>
                <c:pt idx="16">
                  <c:v>-0.30540246275631944</c:v>
                </c:pt>
                <c:pt idx="17">
                  <c:v>-0.20185049707288272</c:v>
                </c:pt>
                <c:pt idx="18">
                  <c:v>-0.22957049292381271</c:v>
                </c:pt>
                <c:pt idx="19">
                  <c:v>-0.39810968490928644</c:v>
                </c:pt>
                <c:pt idx="20">
                  <c:v>-0.71519323380380229</c:v>
                </c:pt>
                <c:pt idx="21">
                  <c:v>-1.2088283232915273</c:v>
                </c:pt>
                <c:pt idx="22">
                  <c:v>-1.7879763521523273</c:v>
                </c:pt>
                <c:pt idx="23">
                  <c:v>-2.1894694418697327</c:v>
                </c:pt>
                <c:pt idx="24">
                  <c:v>-2.2430571844688529</c:v>
                </c:pt>
                <c:pt idx="25">
                  <c:v>-2.0546564041796955</c:v>
                </c:pt>
                <c:pt idx="26">
                  <c:v>-1.699719775297126</c:v>
                </c:pt>
                <c:pt idx="27">
                  <c:v>-0.8728411915126344</c:v>
                </c:pt>
                <c:pt idx="28">
                  <c:v>1.5315479510227306</c:v>
                </c:pt>
                <c:pt idx="29">
                  <c:v>8.614764443889726</c:v>
                </c:pt>
                <c:pt idx="30">
                  <c:v>28.031316039556259</c:v>
                </c:pt>
                <c:pt idx="31">
                  <c:v>75.135509838755752</c:v>
                </c:pt>
                <c:pt idx="32">
                  <c:v>173.06973431221923</c:v>
                </c:pt>
                <c:pt idx="33">
                  <c:v>345.79705617741456</c:v>
                </c:pt>
                <c:pt idx="34">
                  <c:v>604.87336375884479</c:v>
                </c:pt>
                <c:pt idx="35">
                  <c:v>938.85884892417744</c:v>
                </c:pt>
                <c:pt idx="36">
                  <c:v>1316.6544088059545</c:v>
                </c:pt>
                <c:pt idx="37">
                  <c:v>1703.3821737198268</c:v>
                </c:pt>
                <c:pt idx="38">
                  <c:v>2074.9932397002958</c:v>
                </c:pt>
                <c:pt idx="39">
                  <c:v>2422.7601732906078</c:v>
                </c:pt>
                <c:pt idx="40">
                  <c:v>2748.2782509969766</c:v>
                </c:pt>
                <c:pt idx="41">
                  <c:v>3055.0295507394039</c:v>
                </c:pt>
                <c:pt idx="42">
                  <c:v>3344.8534869739506</c:v>
                </c:pt>
                <c:pt idx="43">
                  <c:v>3620.4473814506891</c:v>
                </c:pt>
                <c:pt idx="44">
                  <c:v>3887.4906298039732</c:v>
                </c:pt>
              </c:numCache>
            </c:numRef>
          </c:val>
          <c:smooth val="0"/>
          <c:extLst>
            <c:ext xmlns:c16="http://schemas.microsoft.com/office/drawing/2014/chart" uri="{C3380CC4-5D6E-409C-BE32-E72D297353CC}">
              <c16:uniqueId val="{00000001-5116-49EF-BDF2-BBDBF16AC212}"/>
            </c:ext>
          </c:extLst>
        </c:ser>
        <c:ser>
          <c:idx val="2"/>
          <c:order val="2"/>
          <c:tx>
            <c:strRef>
              <c:f>'Dx assay'!$A$33</c:f>
              <c:strCache>
                <c:ptCount val="1"/>
                <c:pt idx="0">
                  <c:v>50 copies</c:v>
                </c:pt>
              </c:strCache>
            </c:strRef>
          </c:tx>
          <c:spPr>
            <a:ln w="28575" cap="rnd">
              <a:solidFill>
                <a:schemeClr val="accent3"/>
              </a:solidFill>
              <a:round/>
            </a:ln>
            <a:effectLst/>
          </c:spPr>
          <c:marker>
            <c:symbol val="none"/>
          </c:marker>
          <c:val>
            <c:numRef>
              <c:f>'Dx assay'!$B$33:$AT$33</c:f>
              <c:numCache>
                <c:formatCode>General</c:formatCode>
                <c:ptCount val="45"/>
                <c:pt idx="0">
                  <c:v>0.57670665230580198</c:v>
                </c:pt>
                <c:pt idx="1">
                  <c:v>3.3866260529466672</c:v>
                </c:pt>
                <c:pt idx="2">
                  <c:v>5.1183192225635139</c:v>
                </c:pt>
                <c:pt idx="3">
                  <c:v>5.4895429333228094</c:v>
                </c:pt>
                <c:pt idx="4">
                  <c:v>4.9324771212832275</c:v>
                </c:pt>
                <c:pt idx="5">
                  <c:v>4.0630719986729673</c:v>
                </c:pt>
                <c:pt idx="6">
                  <c:v>3.3092216391469265</c:v>
                </c:pt>
                <c:pt idx="7">
                  <c:v>2.8126004578516586</c:v>
                </c:pt>
                <c:pt idx="8">
                  <c:v>2.4995509474756545</c:v>
                </c:pt>
                <c:pt idx="9">
                  <c:v>2.204112328859992</c:v>
                </c:pt>
                <c:pt idx="10">
                  <c:v>1.8026736102892755</c:v>
                </c:pt>
                <c:pt idx="11">
                  <c:v>1.2771285843282385</c:v>
                </c:pt>
                <c:pt idx="12">
                  <c:v>0.70886841829269542</c:v>
                </c:pt>
                <c:pt idx="13">
                  <c:v>0.16808467376540648</c:v>
                </c:pt>
                <c:pt idx="14">
                  <c:v>-0.37241030825862254</c:v>
                </c:pt>
                <c:pt idx="15">
                  <c:v>-0.93321662386188109</c:v>
                </c:pt>
                <c:pt idx="16">
                  <c:v>-1.5985638847287191</c:v>
                </c:pt>
                <c:pt idx="17">
                  <c:v>-2.6267315469649475</c:v>
                </c:pt>
                <c:pt idx="18">
                  <c:v>-4.0642776822405722</c:v>
                </c:pt>
                <c:pt idx="19">
                  <c:v>-5.4425266481575818</c:v>
                </c:pt>
                <c:pt idx="20">
                  <c:v>-6.2189369959614851</c:v>
                </c:pt>
                <c:pt idx="21">
                  <c:v>-6.3639136438523565</c:v>
                </c:pt>
                <c:pt idx="22">
                  <c:v>-6.2644047504236369</c:v>
                </c:pt>
                <c:pt idx="23">
                  <c:v>-6.1108160390722333</c:v>
                </c:pt>
                <c:pt idx="24">
                  <c:v>-5.6432897429640434</c:v>
                </c:pt>
                <c:pt idx="25">
                  <c:v>-4.5177502318147162</c:v>
                </c:pt>
                <c:pt idx="26">
                  <c:v>-2.6652569373745791</c:v>
                </c:pt>
                <c:pt idx="27">
                  <c:v>0.27416827661727439</c:v>
                </c:pt>
                <c:pt idx="28">
                  <c:v>7.1628896915353835</c:v>
                </c:pt>
                <c:pt idx="29">
                  <c:v>26.539724408874463</c:v>
                </c:pt>
                <c:pt idx="30">
                  <c:v>75.395854655662333</c:v>
                </c:pt>
                <c:pt idx="31">
                  <c:v>180.28511528791387</c:v>
                </c:pt>
                <c:pt idx="32">
                  <c:v>373.28281625211457</c:v>
                </c:pt>
                <c:pt idx="33">
                  <c:v>679.54185058010989</c:v>
                </c:pt>
                <c:pt idx="34">
                  <c:v>1101.3235435095339</c:v>
                </c:pt>
                <c:pt idx="35">
                  <c:v>1611.8298504029553</c:v>
                </c:pt>
                <c:pt idx="36">
                  <c:v>2167.3716018121122</c:v>
                </c:pt>
                <c:pt idx="37">
                  <c:v>2728.8338028593753</c:v>
                </c:pt>
                <c:pt idx="38">
                  <c:v>3274.5338844512862</c:v>
                </c:pt>
                <c:pt idx="39">
                  <c:v>3798.3710234624104</c:v>
                </c:pt>
                <c:pt idx="40">
                  <c:v>4300.9619067193034</c:v>
                </c:pt>
                <c:pt idx="41">
                  <c:v>4782.8965626059471</c:v>
                </c:pt>
                <c:pt idx="42">
                  <c:v>5244.2411306226768</c:v>
                </c:pt>
                <c:pt idx="43">
                  <c:v>5687.5710129131294</c:v>
                </c:pt>
                <c:pt idx="44">
                  <c:v>6119.6370516499937</c:v>
                </c:pt>
              </c:numCache>
            </c:numRef>
          </c:val>
          <c:smooth val="0"/>
          <c:extLst>
            <c:ext xmlns:c16="http://schemas.microsoft.com/office/drawing/2014/chart" uri="{C3380CC4-5D6E-409C-BE32-E72D297353CC}">
              <c16:uniqueId val="{00000002-5116-49EF-BDF2-BBDBF16AC212}"/>
            </c:ext>
          </c:extLst>
        </c:ser>
        <c:ser>
          <c:idx val="3"/>
          <c:order val="3"/>
          <c:tx>
            <c:strRef>
              <c:f>'Dx assay'!$A$36</c:f>
              <c:strCache>
                <c:ptCount val="1"/>
                <c:pt idx="0">
                  <c:v>500 copies</c:v>
                </c:pt>
              </c:strCache>
            </c:strRef>
          </c:tx>
          <c:spPr>
            <a:ln w="28575" cap="rnd">
              <a:solidFill>
                <a:schemeClr val="accent4"/>
              </a:solidFill>
              <a:round/>
            </a:ln>
            <a:effectLst/>
          </c:spPr>
          <c:marker>
            <c:symbol val="none"/>
          </c:marker>
          <c:val>
            <c:numRef>
              <c:f>'Dx assay'!$B$36:$AT$36</c:f>
              <c:numCache>
                <c:formatCode>General</c:formatCode>
                <c:ptCount val="45"/>
                <c:pt idx="0">
                  <c:v>-1.5957578162633581</c:v>
                </c:pt>
                <c:pt idx="1">
                  <c:v>2.2028994179745496</c:v>
                </c:pt>
                <c:pt idx="2">
                  <c:v>5.2111217961519287</c:v>
                </c:pt>
                <c:pt idx="3">
                  <c:v>6.6550389234671457</c:v>
                </c:pt>
                <c:pt idx="4">
                  <c:v>6.2716217663437419</c:v>
                </c:pt>
                <c:pt idx="5">
                  <c:v>4.7266622881579679</c:v>
                </c:pt>
                <c:pt idx="6">
                  <c:v>3.0797967102407711</c:v>
                </c:pt>
                <c:pt idx="7">
                  <c:v>1.8635289760222804</c:v>
                </c:pt>
                <c:pt idx="8">
                  <c:v>1.0159330289880018</c:v>
                </c:pt>
                <c:pt idx="9">
                  <c:v>0.39933283753271098</c:v>
                </c:pt>
                <c:pt idx="10">
                  <c:v>-8.9963525835628388E-2</c:v>
                </c:pt>
                <c:pt idx="11">
                  <c:v>-0.67073825087572914</c:v>
                </c:pt>
                <c:pt idx="12">
                  <c:v>-1.4682170970172592</c:v>
                </c:pt>
                <c:pt idx="13">
                  <c:v>-2.2624814740920556</c:v>
                </c:pt>
                <c:pt idx="14">
                  <c:v>-2.6799373341309547</c:v>
                </c:pt>
                <c:pt idx="15">
                  <c:v>-2.5939242980402923</c:v>
                </c:pt>
                <c:pt idx="16">
                  <c:v>-2.3076948902034928</c:v>
                </c:pt>
                <c:pt idx="17">
                  <c:v>-2.2557305912978336</c:v>
                </c:pt>
                <c:pt idx="18">
                  <c:v>-2.5353147350560903</c:v>
                </c:pt>
                <c:pt idx="19">
                  <c:v>-2.8975147811433999</c:v>
                </c:pt>
                <c:pt idx="20">
                  <c:v>-3.0235553313141281</c:v>
                </c:pt>
                <c:pt idx="21">
                  <c:v>-2.6119161075039301</c:v>
                </c:pt>
                <c:pt idx="22">
                  <c:v>-1.3919184892602061</c:v>
                </c:pt>
                <c:pt idx="23">
                  <c:v>0.79678753962616611</c:v>
                </c:pt>
                <c:pt idx="24">
                  <c:v>4.2368623348756955</c:v>
                </c:pt>
                <c:pt idx="25">
                  <c:v>10.670003190265561</c:v>
                </c:pt>
                <c:pt idx="26">
                  <c:v>26.280557094911273</c:v>
                </c:pt>
                <c:pt idx="27">
                  <c:v>65.497757330926106</c:v>
                </c:pt>
                <c:pt idx="28">
                  <c:v>153.02110334579083</c:v>
                </c:pt>
                <c:pt idx="29">
                  <c:v>320.00910225137523</c:v>
                </c:pt>
                <c:pt idx="30">
                  <c:v>591.23463002481731</c:v>
                </c:pt>
                <c:pt idx="31">
                  <c:v>968.03934143796869</c:v>
                </c:pt>
                <c:pt idx="32">
                  <c:v>1422.1967315420934</c:v>
                </c:pt>
                <c:pt idx="33">
                  <c:v>1909.817498490369</c:v>
                </c:pt>
                <c:pt idx="34">
                  <c:v>2393.335645882109</c:v>
                </c:pt>
                <c:pt idx="35">
                  <c:v>2852.9217842135149</c:v>
                </c:pt>
                <c:pt idx="36">
                  <c:v>3283.7660458998253</c:v>
                </c:pt>
                <c:pt idx="37">
                  <c:v>3688.0531624560717</c:v>
                </c:pt>
                <c:pt idx="38">
                  <c:v>4069.0287836377647</c:v>
                </c:pt>
                <c:pt idx="39">
                  <c:v>4428.6143015760736</c:v>
                </c:pt>
                <c:pt idx="40">
                  <c:v>4767.1405862584324</c:v>
                </c:pt>
                <c:pt idx="41">
                  <c:v>5084.0685406549164</c:v>
                </c:pt>
                <c:pt idx="42">
                  <c:v>5379.2969033885838</c:v>
                </c:pt>
                <c:pt idx="43">
                  <c:v>5655.024927871129</c:v>
                </c:pt>
                <c:pt idx="44">
                  <c:v>5918.0864439265333</c:v>
                </c:pt>
              </c:numCache>
            </c:numRef>
          </c:val>
          <c:smooth val="0"/>
          <c:extLst>
            <c:ext xmlns:c16="http://schemas.microsoft.com/office/drawing/2014/chart" uri="{C3380CC4-5D6E-409C-BE32-E72D297353CC}">
              <c16:uniqueId val="{00000003-5116-49EF-BDF2-BBDBF16AC212}"/>
            </c:ext>
          </c:extLst>
        </c:ser>
        <c:ser>
          <c:idx val="4"/>
          <c:order val="4"/>
          <c:tx>
            <c:strRef>
              <c:f>'Dx assay'!$A$39</c:f>
              <c:strCache>
                <c:ptCount val="1"/>
                <c:pt idx="0">
                  <c:v>500 copies</c:v>
                </c:pt>
              </c:strCache>
            </c:strRef>
          </c:tx>
          <c:spPr>
            <a:ln w="28575" cap="rnd">
              <a:solidFill>
                <a:schemeClr val="accent5"/>
              </a:solidFill>
              <a:round/>
            </a:ln>
            <a:effectLst/>
          </c:spPr>
          <c:marker>
            <c:symbol val="none"/>
          </c:marker>
          <c:val>
            <c:numRef>
              <c:f>'Dx assay'!$B$39:$AT$39</c:f>
              <c:numCache>
                <c:formatCode>General</c:formatCode>
                <c:ptCount val="45"/>
                <c:pt idx="0">
                  <c:v>11.847444541355799</c:v>
                </c:pt>
                <c:pt idx="1">
                  <c:v>12.514806719422268</c:v>
                </c:pt>
                <c:pt idx="2">
                  <c:v>12.987905128529746</c:v>
                </c:pt>
                <c:pt idx="3">
                  <c:v>13.001607693466212</c:v>
                </c:pt>
                <c:pt idx="4">
                  <c:v>12.126267898303922</c:v>
                </c:pt>
                <c:pt idx="5">
                  <c:v>9.9032395207505033</c:v>
                </c:pt>
                <c:pt idx="6">
                  <c:v>6.4316306690107012</c:v>
                </c:pt>
                <c:pt idx="7">
                  <c:v>2.759420995356777</c:v>
                </c:pt>
                <c:pt idx="8">
                  <c:v>7.4066388073333655E-2</c:v>
                </c:pt>
                <c:pt idx="9">
                  <c:v>-1.4385253604159516</c:v>
                </c:pt>
                <c:pt idx="10">
                  <c:v>-2.3707475863811851</c:v>
                </c:pt>
                <c:pt idx="11">
                  <c:v>-3.0966933836134558</c:v>
                </c:pt>
                <c:pt idx="12">
                  <c:v>-3.5302731947049324</c:v>
                </c:pt>
                <c:pt idx="13">
                  <c:v>-3.5729556790629431</c:v>
                </c:pt>
                <c:pt idx="14">
                  <c:v>-3.3650479888674454</c:v>
                </c:pt>
                <c:pt idx="15">
                  <c:v>-3.1622953857768152</c:v>
                </c:pt>
                <c:pt idx="16">
                  <c:v>-3.1959547627939173</c:v>
                </c:pt>
                <c:pt idx="17">
                  <c:v>-3.5016749747919675</c:v>
                </c:pt>
                <c:pt idx="18">
                  <c:v>-3.7558414979466761</c:v>
                </c:pt>
                <c:pt idx="19">
                  <c:v>-3.5121024010495603</c:v>
                </c:pt>
                <c:pt idx="20">
                  <c:v>-2.6300487372191128</c:v>
                </c:pt>
                <c:pt idx="21">
                  <c:v>-1.2999546482551523</c:v>
                </c:pt>
                <c:pt idx="22">
                  <c:v>0.29364056001759309</c:v>
                </c:pt>
                <c:pt idx="23">
                  <c:v>2.2548455388496222</c:v>
                </c:pt>
                <c:pt idx="24">
                  <c:v>5.244295785725626</c:v>
                </c:pt>
                <c:pt idx="25">
                  <c:v>11.470976143104053</c:v>
                </c:pt>
                <c:pt idx="26">
                  <c:v>27.139399614237846</c:v>
                </c:pt>
                <c:pt idx="27">
                  <c:v>65.74935244063272</c:v>
                </c:pt>
                <c:pt idx="28">
                  <c:v>149.81872671394558</c:v>
                </c:pt>
                <c:pt idx="29">
                  <c:v>307.38099449122456</c:v>
                </c:pt>
                <c:pt idx="30">
                  <c:v>560.71745270891734</c:v>
                </c:pt>
                <c:pt idx="31">
                  <c:v>911.41328494191293</c:v>
                </c:pt>
                <c:pt idx="32">
                  <c:v>1334.3758511866927</c:v>
                </c:pt>
                <c:pt idx="33">
                  <c:v>1789.6567127158669</c:v>
                </c:pt>
                <c:pt idx="34">
                  <c:v>2242.9502734153029</c:v>
                </c:pt>
                <c:pt idx="35">
                  <c:v>2676.7473240523614</c:v>
                </c:pt>
                <c:pt idx="36">
                  <c:v>3086.9761815796392</c:v>
                </c:pt>
                <c:pt idx="37">
                  <c:v>3474.2829894439528</c:v>
                </c:pt>
                <c:pt idx="38">
                  <c:v>3838.6196372647373</c:v>
                </c:pt>
                <c:pt idx="39">
                  <c:v>4179.2636062094662</c:v>
                </c:pt>
                <c:pt idx="40">
                  <c:v>4496.7841879230564</c:v>
                </c:pt>
                <c:pt idx="41">
                  <c:v>4792.5855510275542</c:v>
                </c:pt>
                <c:pt idx="42">
                  <c:v>5067.9028586340155</c:v>
                </c:pt>
                <c:pt idx="43">
                  <c:v>5325.5495022491014</c:v>
                </c:pt>
                <c:pt idx="44">
                  <c:v>5572.1775037029547</c:v>
                </c:pt>
              </c:numCache>
            </c:numRef>
          </c:val>
          <c:smooth val="0"/>
          <c:extLst>
            <c:ext xmlns:c16="http://schemas.microsoft.com/office/drawing/2014/chart" uri="{C3380CC4-5D6E-409C-BE32-E72D297353CC}">
              <c16:uniqueId val="{00000004-5116-49EF-BDF2-BBDBF16AC212}"/>
            </c:ext>
          </c:extLst>
        </c:ser>
        <c:ser>
          <c:idx val="5"/>
          <c:order val="5"/>
          <c:tx>
            <c:strRef>
              <c:f>'Dx assay'!$A$42</c:f>
              <c:strCache>
                <c:ptCount val="1"/>
                <c:pt idx="0">
                  <c:v>5,000 copies</c:v>
                </c:pt>
              </c:strCache>
            </c:strRef>
          </c:tx>
          <c:spPr>
            <a:ln w="28575" cap="rnd">
              <a:solidFill>
                <a:schemeClr val="accent6"/>
              </a:solidFill>
              <a:round/>
            </a:ln>
            <a:effectLst/>
          </c:spPr>
          <c:marker>
            <c:symbol val="none"/>
          </c:marker>
          <c:val>
            <c:numRef>
              <c:f>'Dx assay'!$B$42:$AT$42</c:f>
              <c:numCache>
                <c:formatCode>General</c:formatCode>
                <c:ptCount val="45"/>
                <c:pt idx="0">
                  <c:v>5.8777248524056631</c:v>
                </c:pt>
                <c:pt idx="1">
                  <c:v>5.9985547877950012</c:v>
                </c:pt>
                <c:pt idx="2">
                  <c:v>5.821429643110605</c:v>
                </c:pt>
                <c:pt idx="3">
                  <c:v>5.2205115898304939</c:v>
                </c:pt>
                <c:pt idx="4">
                  <c:v>4.2354610929214687</c:v>
                </c:pt>
                <c:pt idx="5">
                  <c:v>3.078386661989498</c:v>
                </c:pt>
                <c:pt idx="6">
                  <c:v>2.0287457479353179</c:v>
                </c:pt>
                <c:pt idx="7">
                  <c:v>1.2291331635569804</c:v>
                </c:pt>
                <c:pt idx="8">
                  <c:v>0.5917567767737637</c:v>
                </c:pt>
                <c:pt idx="9">
                  <c:v>-4.7634912456487655E-2</c:v>
                </c:pt>
                <c:pt idx="10">
                  <c:v>-0.6471756759146956</c:v>
                </c:pt>
                <c:pt idx="11">
                  <c:v>-1.058224213833455</c:v>
                </c:pt>
                <c:pt idx="12">
                  <c:v>-1.2810648194899841</c:v>
                </c:pt>
                <c:pt idx="13">
                  <c:v>-1.3947880517189333</c:v>
                </c:pt>
                <c:pt idx="14">
                  <c:v>-1.4041719135293533</c:v>
                </c:pt>
                <c:pt idx="15">
                  <c:v>-1.3089594527045847</c:v>
                </c:pt>
                <c:pt idx="16">
                  <c:v>-1.3579293897746538</c:v>
                </c:pt>
                <c:pt idx="17">
                  <c:v>-1.9480008274731517</c:v>
                </c:pt>
                <c:pt idx="18">
                  <c:v>-3.0350866335866158</c:v>
                </c:pt>
                <c:pt idx="19">
                  <c:v>-3.7745437376688642</c:v>
                </c:pt>
                <c:pt idx="20">
                  <c:v>-2.8349439046978659</c:v>
                </c:pt>
                <c:pt idx="21">
                  <c:v>1.2930089465426136</c:v>
                </c:pt>
                <c:pt idx="22">
                  <c:v>11.871492236003178</c:v>
                </c:pt>
                <c:pt idx="23">
                  <c:v>37.908844308154585</c:v>
                </c:pt>
                <c:pt idx="24">
                  <c:v>97.927642256467152</c:v>
                </c:pt>
                <c:pt idx="25">
                  <c:v>219.53287879398158</c:v>
                </c:pt>
                <c:pt idx="26">
                  <c:v>431.08909151001717</c:v>
                </c:pt>
                <c:pt idx="27">
                  <c:v>746.31688774778013</c:v>
                </c:pt>
                <c:pt idx="28">
                  <c:v>1152.2017409296241</c:v>
                </c:pt>
                <c:pt idx="29">
                  <c:v>1612.707863080037</c:v>
                </c:pt>
                <c:pt idx="30">
                  <c:v>2087.0732314619472</c:v>
                </c:pt>
                <c:pt idx="31">
                  <c:v>2547.2794465201059</c:v>
                </c:pt>
                <c:pt idx="32">
                  <c:v>2982.4806517700126</c:v>
                </c:pt>
                <c:pt idx="33">
                  <c:v>3392.2779444057378</c:v>
                </c:pt>
                <c:pt idx="34">
                  <c:v>3778.8378599585049</c:v>
                </c:pt>
                <c:pt idx="35">
                  <c:v>4143.8890000013889</c:v>
                </c:pt>
                <c:pt idx="36">
                  <c:v>4488.6705914539343</c:v>
                </c:pt>
                <c:pt idx="37">
                  <c:v>4813.7974739774181</c:v>
                </c:pt>
                <c:pt idx="38">
                  <c:v>5119.0213221073936</c:v>
                </c:pt>
                <c:pt idx="39">
                  <c:v>5403.7746258707502</c:v>
                </c:pt>
                <c:pt idx="40">
                  <c:v>5667.938148651263</c:v>
                </c:pt>
                <c:pt idx="41">
                  <c:v>5912.11131531512</c:v>
                </c:pt>
                <c:pt idx="42">
                  <c:v>6139.3674659585249</c:v>
                </c:pt>
                <c:pt idx="43">
                  <c:v>6356.4087231372559</c:v>
                </c:pt>
                <c:pt idx="44">
                  <c:v>6569.643973285687</c:v>
                </c:pt>
              </c:numCache>
            </c:numRef>
          </c:val>
          <c:smooth val="0"/>
          <c:extLst>
            <c:ext xmlns:c16="http://schemas.microsoft.com/office/drawing/2014/chart" uri="{C3380CC4-5D6E-409C-BE32-E72D297353CC}">
              <c16:uniqueId val="{00000005-5116-49EF-BDF2-BBDBF16AC212}"/>
            </c:ext>
          </c:extLst>
        </c:ser>
        <c:ser>
          <c:idx val="6"/>
          <c:order val="6"/>
          <c:tx>
            <c:strRef>
              <c:f>'Dx assay'!$A$45</c:f>
              <c:strCache>
                <c:ptCount val="1"/>
                <c:pt idx="0">
                  <c:v>5,000 copies</c:v>
                </c:pt>
              </c:strCache>
            </c:strRef>
          </c:tx>
          <c:spPr>
            <a:ln w="28575" cap="rnd">
              <a:solidFill>
                <a:schemeClr val="accent1">
                  <a:lumMod val="60000"/>
                </a:schemeClr>
              </a:solidFill>
              <a:round/>
            </a:ln>
            <a:effectLst/>
          </c:spPr>
          <c:marker>
            <c:symbol val="none"/>
          </c:marker>
          <c:val>
            <c:numRef>
              <c:f>'Dx assay'!$B$45:$AT$45</c:f>
              <c:numCache>
                <c:formatCode>General</c:formatCode>
                <c:ptCount val="45"/>
                <c:pt idx="0">
                  <c:v>6.6003628281159763</c:v>
                </c:pt>
                <c:pt idx="1">
                  <c:v>5.5079850881211314</c:v>
                </c:pt>
                <c:pt idx="2">
                  <c:v>4.3611420176985121</c:v>
                </c:pt>
                <c:pt idx="3">
                  <c:v>3.1159849316882173</c:v>
                </c:pt>
                <c:pt idx="4">
                  <c:v>1.8338881521576695</c:v>
                </c:pt>
                <c:pt idx="5">
                  <c:v>0.78321192178736965</c:v>
                </c:pt>
                <c:pt idx="6">
                  <c:v>0.37269567007751903</c:v>
                </c:pt>
                <c:pt idx="7">
                  <c:v>0.83106552083881979</c:v>
                </c:pt>
                <c:pt idx="8">
                  <c:v>1.8587871401941811</c:v>
                </c:pt>
                <c:pt idx="9">
                  <c:v>2.682222221248594</c:v>
                </c:pt>
                <c:pt idx="10">
                  <c:v>2.6448592642300355</c:v>
                </c:pt>
                <c:pt idx="11">
                  <c:v>1.7108281353412167</c:v>
                </c:pt>
                <c:pt idx="12">
                  <c:v>0.25834769046377914</c:v>
                </c:pt>
                <c:pt idx="13">
                  <c:v>-1.3513602065540908</c:v>
                </c:pt>
                <c:pt idx="14">
                  <c:v>-2.8001734009703796</c:v>
                </c:pt>
                <c:pt idx="15">
                  <c:v>-3.7827436375573598</c:v>
                </c:pt>
                <c:pt idx="16">
                  <c:v>-4.2317987064780027</c:v>
                </c:pt>
                <c:pt idx="17">
                  <c:v>-4.4022699311499309</c:v>
                </c:pt>
                <c:pt idx="18">
                  <c:v>-4.5569194478939608</c:v>
                </c:pt>
                <c:pt idx="19">
                  <c:v>-4.547764598935828</c:v>
                </c:pt>
                <c:pt idx="20">
                  <c:v>-3.4380803793646919</c:v>
                </c:pt>
                <c:pt idx="21">
                  <c:v>1.4155861635299516</c:v>
                </c:pt>
                <c:pt idx="22">
                  <c:v>16.553506581167312</c:v>
                </c:pt>
                <c:pt idx="23">
                  <c:v>55.742291830390968</c:v>
                </c:pt>
                <c:pt idx="24">
                  <c:v>142.51218364282431</c:v>
                </c:pt>
                <c:pt idx="25">
                  <c:v>307.96781155406461</c:v>
                </c:pt>
                <c:pt idx="26">
                  <c:v>580.54972780201024</c:v>
                </c:pt>
                <c:pt idx="27">
                  <c:v>970.34139855871763</c:v>
                </c:pt>
                <c:pt idx="28">
                  <c:v>1458.9310771687396</c:v>
                </c:pt>
                <c:pt idx="29">
                  <c:v>2005.8966222548625</c:v>
                </c:pt>
                <c:pt idx="30">
                  <c:v>2568.8895001797518</c:v>
                </c:pt>
                <c:pt idx="31">
                  <c:v>3120.9110000765504</c:v>
                </c:pt>
                <c:pt idx="32">
                  <c:v>3653.1852208469609</c:v>
                </c:pt>
                <c:pt idx="33">
                  <c:v>4167.1425652581038</c:v>
                </c:pt>
                <c:pt idx="34">
                  <c:v>4665.3045787327246</c:v>
                </c:pt>
                <c:pt idx="35">
                  <c:v>5146.8273698396897</c:v>
                </c:pt>
                <c:pt idx="36">
                  <c:v>5608.1993529017509</c:v>
                </c:pt>
                <c:pt idx="37">
                  <c:v>6046.1222127240671</c:v>
                </c:pt>
                <c:pt idx="38">
                  <c:v>6458.9263308745012</c:v>
                </c:pt>
                <c:pt idx="39">
                  <c:v>6846.2073816739194</c:v>
                </c:pt>
                <c:pt idx="40">
                  <c:v>7208.9318991350428</c:v>
                </c:pt>
                <c:pt idx="41">
                  <c:v>7549.5348184273698</c:v>
                </c:pt>
                <c:pt idx="42">
                  <c:v>7870.6914189260115</c:v>
                </c:pt>
                <c:pt idx="43">
                  <c:v>8175.4098994910873</c:v>
                </c:pt>
                <c:pt idx="44">
                  <c:v>8469.5484967122957</c:v>
                </c:pt>
              </c:numCache>
            </c:numRef>
          </c:val>
          <c:smooth val="0"/>
          <c:extLst>
            <c:ext xmlns:c16="http://schemas.microsoft.com/office/drawing/2014/chart" uri="{C3380CC4-5D6E-409C-BE32-E72D297353CC}">
              <c16:uniqueId val="{00000006-5116-49EF-BDF2-BBDBF16AC212}"/>
            </c:ext>
          </c:extLst>
        </c:ser>
        <c:ser>
          <c:idx val="7"/>
          <c:order val="7"/>
          <c:tx>
            <c:strRef>
              <c:f>'Dx assay'!$A$48</c:f>
              <c:strCache>
                <c:ptCount val="1"/>
                <c:pt idx="0">
                  <c:v>50,000 copies</c:v>
                </c:pt>
              </c:strCache>
            </c:strRef>
          </c:tx>
          <c:spPr>
            <a:ln w="28575" cap="rnd">
              <a:solidFill>
                <a:schemeClr val="accent2">
                  <a:lumMod val="60000"/>
                </a:schemeClr>
              </a:solidFill>
              <a:round/>
            </a:ln>
            <a:effectLst/>
          </c:spPr>
          <c:marker>
            <c:symbol val="none"/>
          </c:marker>
          <c:val>
            <c:numRef>
              <c:f>'Dx assay'!$B$48:$AT$48</c:f>
              <c:numCache>
                <c:formatCode>General</c:formatCode>
                <c:ptCount val="45"/>
                <c:pt idx="0">
                  <c:v>16.07654478843142</c:v>
                </c:pt>
                <c:pt idx="1">
                  <c:v>16.362656589661128</c:v>
                </c:pt>
                <c:pt idx="2">
                  <c:v>15.628829137225694</c:v>
                </c:pt>
                <c:pt idx="3">
                  <c:v>13.67294860639231</c:v>
                </c:pt>
                <c:pt idx="4">
                  <c:v>10.94267403291451</c:v>
                </c:pt>
                <c:pt idx="5">
                  <c:v>7.9503816636970441</c:v>
                </c:pt>
                <c:pt idx="6">
                  <c:v>5.0647265734278335</c:v>
                </c:pt>
                <c:pt idx="7">
                  <c:v>2.5538122197813209</c:v>
                </c:pt>
                <c:pt idx="8">
                  <c:v>0.58473681474606565</c:v>
                </c:pt>
                <c:pt idx="9">
                  <c:v>-0.91032212965728831</c:v>
                </c:pt>
                <c:pt idx="10">
                  <c:v>-2.305311494763373</c:v>
                </c:pt>
                <c:pt idx="11">
                  <c:v>-3.9246954072950757</c:v>
                </c:pt>
                <c:pt idx="12">
                  <c:v>-5.5950368221365352</c:v>
                </c:pt>
                <c:pt idx="13">
                  <c:v>-6.7156920822235406</c:v>
                </c:pt>
                <c:pt idx="14">
                  <c:v>-6.7895722717839817</c:v>
                </c:pt>
                <c:pt idx="15">
                  <c:v>-5.9321824335511337</c:v>
                </c:pt>
                <c:pt idx="16">
                  <c:v>-4.6339016724250541</c:v>
                </c:pt>
                <c:pt idx="17">
                  <c:v>-2.5511045032380935</c:v>
                </c:pt>
                <c:pt idx="18">
                  <c:v>3.1638630272209411</c:v>
                </c:pt>
                <c:pt idx="19">
                  <c:v>20.040298518189957</c:v>
                </c:pt>
                <c:pt idx="20">
                  <c:v>63.166312559067592</c:v>
                </c:pt>
                <c:pt idx="21">
                  <c:v>156.99480406084695</c:v>
                </c:pt>
                <c:pt idx="22">
                  <c:v>332.09161367757952</c:v>
                </c:pt>
                <c:pt idx="23">
                  <c:v>613.86107111462661</c:v>
                </c:pt>
                <c:pt idx="24">
                  <c:v>1007.1109664775577</c:v>
                </c:pt>
                <c:pt idx="25">
                  <c:v>1488.8397719750683</c:v>
                </c:pt>
                <c:pt idx="26">
                  <c:v>2018.4706647127387</c:v>
                </c:pt>
                <c:pt idx="27">
                  <c:v>2558.2062172509286</c:v>
                </c:pt>
                <c:pt idx="28">
                  <c:v>3086.7363435844691</c:v>
                </c:pt>
                <c:pt idx="29">
                  <c:v>3598.5469958252379</c:v>
                </c:pt>
                <c:pt idx="30">
                  <c:v>4095.0595649832794</c:v>
                </c:pt>
                <c:pt idx="31">
                  <c:v>4577.2179667620967</c:v>
                </c:pt>
                <c:pt idx="32">
                  <c:v>5042.9829537542264</c:v>
                </c:pt>
                <c:pt idx="33">
                  <c:v>5488.7733803088449</c:v>
                </c:pt>
                <c:pt idx="34">
                  <c:v>5912.9473912606263</c:v>
                </c:pt>
                <c:pt idx="35">
                  <c:v>6317.5742997956186</c:v>
                </c:pt>
                <c:pt idx="36">
                  <c:v>6706.4165855738647</c:v>
                </c:pt>
                <c:pt idx="37">
                  <c:v>7080.229993592493</c:v>
                </c:pt>
                <c:pt idx="38">
                  <c:v>7433.7017188056816</c:v>
                </c:pt>
                <c:pt idx="39">
                  <c:v>7761.0766868425017</c:v>
                </c:pt>
                <c:pt idx="40">
                  <c:v>8064.0823346102188</c:v>
                </c:pt>
                <c:pt idx="41">
                  <c:v>8348.7429990815144</c:v>
                </c:pt>
                <c:pt idx="42">
                  <c:v>8617.8929968968005</c:v>
                </c:pt>
                <c:pt idx="43">
                  <c:v>8872.2969057942064</c:v>
                </c:pt>
                <c:pt idx="44">
                  <c:v>9116.4591985107982</c:v>
                </c:pt>
              </c:numCache>
            </c:numRef>
          </c:val>
          <c:smooth val="0"/>
          <c:extLst>
            <c:ext xmlns:c16="http://schemas.microsoft.com/office/drawing/2014/chart" uri="{C3380CC4-5D6E-409C-BE32-E72D297353CC}">
              <c16:uniqueId val="{00000007-5116-49EF-BDF2-BBDBF16AC212}"/>
            </c:ext>
          </c:extLst>
        </c:ser>
        <c:ser>
          <c:idx val="8"/>
          <c:order val="8"/>
          <c:tx>
            <c:strRef>
              <c:f>'Dx assay'!$A$51</c:f>
              <c:strCache>
                <c:ptCount val="1"/>
                <c:pt idx="0">
                  <c:v>50,000 copies</c:v>
                </c:pt>
              </c:strCache>
            </c:strRef>
          </c:tx>
          <c:spPr>
            <a:ln w="28575" cap="rnd">
              <a:solidFill>
                <a:schemeClr val="accent3">
                  <a:lumMod val="60000"/>
                </a:schemeClr>
              </a:solidFill>
              <a:round/>
            </a:ln>
            <a:effectLst/>
          </c:spPr>
          <c:marker>
            <c:symbol val="none"/>
          </c:marker>
          <c:val>
            <c:numRef>
              <c:f>'Dx assay'!$B$51:$AT$51</c:f>
              <c:numCache>
                <c:formatCode>General</c:formatCode>
                <c:ptCount val="45"/>
                <c:pt idx="0">
                  <c:v>8.5823952303526312</c:v>
                </c:pt>
                <c:pt idx="1">
                  <c:v>9.1782274449251418</c:v>
                </c:pt>
                <c:pt idx="2">
                  <c:v>9.0487204598193784</c:v>
                </c:pt>
                <c:pt idx="3">
                  <c:v>7.9865010030935082</c:v>
                </c:pt>
                <c:pt idx="4">
                  <c:v>6.2978442530984466</c:v>
                </c:pt>
                <c:pt idx="5">
                  <c:v>4.6174314539384795</c:v>
                </c:pt>
                <c:pt idx="6">
                  <c:v>3.6391971447646938</c:v>
                </c:pt>
                <c:pt idx="7">
                  <c:v>3.501578696854267</c:v>
                </c:pt>
                <c:pt idx="8">
                  <c:v>3.4190630469165626</c:v>
                </c:pt>
                <c:pt idx="9">
                  <c:v>2.3408412158514693</c:v>
                </c:pt>
                <c:pt idx="10">
                  <c:v>-1.1145534681418212E-2</c:v>
                </c:pt>
                <c:pt idx="11">
                  <c:v>-2.9718253002538404</c:v>
                </c:pt>
                <c:pt idx="12">
                  <c:v>-5.6415064319007797</c:v>
                </c:pt>
                <c:pt idx="13">
                  <c:v>-7.5447594187971845</c:v>
                </c:pt>
                <c:pt idx="14">
                  <c:v>-8.616794549729093</c:v>
                </c:pt>
                <c:pt idx="15">
                  <c:v>-8.7767603874526685</c:v>
                </c:pt>
                <c:pt idx="16">
                  <c:v>-7.6932047127047554</c:v>
                </c:pt>
                <c:pt idx="17">
                  <c:v>-4.4396654305692209</c:v>
                </c:pt>
                <c:pt idx="18">
                  <c:v>3.7933197740767355</c:v>
                </c:pt>
                <c:pt idx="19">
                  <c:v>24.384230433690391</c:v>
                </c:pt>
                <c:pt idx="20">
                  <c:v>73.346102513463848</c:v>
                </c:pt>
                <c:pt idx="21">
                  <c:v>178.12100313584597</c:v>
                </c:pt>
                <c:pt idx="22">
                  <c:v>373.40711387906049</c:v>
                </c:pt>
                <c:pt idx="23">
                  <c:v>687.14458603678759</c:v>
                </c:pt>
                <c:pt idx="24">
                  <c:v>1122.977762760851</c:v>
                </c:pt>
                <c:pt idx="25">
                  <c:v>1653.2198840963829</c:v>
                </c:pt>
                <c:pt idx="26">
                  <c:v>2230.6816423759101</c:v>
                </c:pt>
                <c:pt idx="27">
                  <c:v>2810.9376309648305</c:v>
                </c:pt>
                <c:pt idx="28">
                  <c:v>3368.1650932825596</c:v>
                </c:pt>
                <c:pt idx="29">
                  <c:v>3895.7649767698531</c:v>
                </c:pt>
                <c:pt idx="30">
                  <c:v>4397.0426970751596</c:v>
                </c:pt>
                <c:pt idx="31">
                  <c:v>4876.7950546247084</c:v>
                </c:pt>
                <c:pt idx="32">
                  <c:v>5337.6369967539504</c:v>
                </c:pt>
                <c:pt idx="33">
                  <c:v>5778.4714282772056</c:v>
                </c:pt>
                <c:pt idx="34">
                  <c:v>6195.1595428364344</c:v>
                </c:pt>
                <c:pt idx="35">
                  <c:v>6584.4150891909958</c:v>
                </c:pt>
                <c:pt idx="36">
                  <c:v>6947.1547632055735</c:v>
                </c:pt>
                <c:pt idx="37">
                  <c:v>7287.5319926957091</c:v>
                </c:pt>
                <c:pt idx="38">
                  <c:v>7609.2966197686183</c:v>
                </c:pt>
                <c:pt idx="39">
                  <c:v>7913.4265682006153</c:v>
                </c:pt>
                <c:pt idx="40">
                  <c:v>8198.3508703138723</c:v>
                </c:pt>
                <c:pt idx="41">
                  <c:v>8461.8595356165388</c:v>
                </c:pt>
                <c:pt idx="42">
                  <c:v>8703.6532630143993</c:v>
                </c:pt>
                <c:pt idx="43">
                  <c:v>8926.9147465845344</c:v>
                </c:pt>
                <c:pt idx="44">
                  <c:v>9138.775508493025</c:v>
                </c:pt>
              </c:numCache>
            </c:numRef>
          </c:val>
          <c:smooth val="0"/>
          <c:extLst>
            <c:ext xmlns:c16="http://schemas.microsoft.com/office/drawing/2014/chart" uri="{C3380CC4-5D6E-409C-BE32-E72D297353CC}">
              <c16:uniqueId val="{00000008-5116-49EF-BDF2-BBDBF16AC212}"/>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Dx Triplex:</a:t>
            </a:r>
            <a:r>
              <a:rPr lang="en-US" baseline="0"/>
              <a:t> </a:t>
            </a:r>
            <a:r>
              <a:rPr lang="en-US"/>
              <a:t>Spike</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Dx assay'!$A$29</c:f>
              <c:strCache>
                <c:ptCount val="1"/>
                <c:pt idx="0">
                  <c:v>NTC</c:v>
                </c:pt>
              </c:strCache>
            </c:strRef>
          </c:tx>
          <c:spPr>
            <a:ln w="28575" cap="rnd">
              <a:solidFill>
                <a:schemeClr val="accent1"/>
              </a:solidFill>
              <a:round/>
            </a:ln>
            <a:effectLst/>
          </c:spPr>
          <c:marker>
            <c:symbol val="none"/>
          </c:marker>
          <c:val>
            <c:numRef>
              <c:f>'Dx assay'!$B$29:$AT$29</c:f>
              <c:numCache>
                <c:formatCode>General</c:formatCode>
                <c:ptCount val="45"/>
                <c:pt idx="0">
                  <c:v>39.660263263420347</c:v>
                </c:pt>
                <c:pt idx="1">
                  <c:v>39.010975434450302</c:v>
                </c:pt>
                <c:pt idx="2">
                  <c:v>36.34440139027538</c:v>
                </c:pt>
                <c:pt idx="3">
                  <c:v>31.393376488293143</c:v>
                </c:pt>
                <c:pt idx="4">
                  <c:v>24.840855472903058</c:v>
                </c:pt>
                <c:pt idx="5">
                  <c:v>17.576892485792996</c:v>
                </c:pt>
                <c:pt idx="6">
                  <c:v>10.82746042616418</c:v>
                </c:pt>
                <c:pt idx="7">
                  <c:v>5.6178652070448152</c:v>
                </c:pt>
                <c:pt idx="8">
                  <c:v>2.0302483176874375</c:v>
                </c:pt>
                <c:pt idx="9">
                  <c:v>-0.47840252174682973</c:v>
                </c:pt>
                <c:pt idx="10">
                  <c:v>-2.2033577929141757</c:v>
                </c:pt>
                <c:pt idx="11">
                  <c:v>-3.1934671651251847</c:v>
                </c:pt>
                <c:pt idx="12">
                  <c:v>-3.7466319455143093</c:v>
                </c:pt>
                <c:pt idx="13">
                  <c:v>-4.2949454397476075</c:v>
                </c:pt>
                <c:pt idx="14">
                  <c:v>-4.8095674176838656</c:v>
                </c:pt>
                <c:pt idx="15">
                  <c:v>-4.6692580864037154</c:v>
                </c:pt>
                <c:pt idx="16">
                  <c:v>-3.7202250741920579</c:v>
                </c:pt>
                <c:pt idx="17">
                  <c:v>-3.035896092400435</c:v>
                </c:pt>
                <c:pt idx="18">
                  <c:v>-3.5497545102844015</c:v>
                </c:pt>
                <c:pt idx="19">
                  <c:v>-4.5250168035745446</c:v>
                </c:pt>
                <c:pt idx="20">
                  <c:v>-4.5271922918418568</c:v>
                </c:pt>
                <c:pt idx="21">
                  <c:v>-3.3910580618230597</c:v>
                </c:pt>
                <c:pt idx="22">
                  <c:v>-2.1947837570332922</c:v>
                </c:pt>
                <c:pt idx="23">
                  <c:v>-1.7095726600873604</c:v>
                </c:pt>
                <c:pt idx="24">
                  <c:v>-1.7663241304708208</c:v>
                </c:pt>
                <c:pt idx="25">
                  <c:v>-1.8183796214889298</c:v>
                </c:pt>
                <c:pt idx="26">
                  <c:v>-1.6226815413647273</c:v>
                </c:pt>
                <c:pt idx="27">
                  <c:v>-1.4252431897311908</c:v>
                </c:pt>
                <c:pt idx="28">
                  <c:v>-1.4535303000648128</c:v>
                </c:pt>
                <c:pt idx="29">
                  <c:v>-1.4702777143374988</c:v>
                </c:pt>
                <c:pt idx="30">
                  <c:v>-1.0618692971838755</c:v>
                </c:pt>
                <c:pt idx="31">
                  <c:v>-8.4647728413983714E-2</c:v>
                </c:pt>
                <c:pt idx="32">
                  <c:v>1.3082553693584487</c:v>
                </c:pt>
                <c:pt idx="33">
                  <c:v>2.8052333732975967</c:v>
                </c:pt>
                <c:pt idx="34">
                  <c:v>3.9490535877248476</c:v>
                </c:pt>
                <c:pt idx="35">
                  <c:v>4.286564008327332</c:v>
                </c:pt>
                <c:pt idx="36">
                  <c:v>3.8413819245724881</c:v>
                </c:pt>
                <c:pt idx="37">
                  <c:v>3.151612398431098</c:v>
                </c:pt>
                <c:pt idx="38">
                  <c:v>2.4720685937936651</c:v>
                </c:pt>
                <c:pt idx="39">
                  <c:v>1.5588657028893067</c:v>
                </c:pt>
                <c:pt idx="40">
                  <c:v>0.41097715897558373</c:v>
                </c:pt>
                <c:pt idx="41">
                  <c:v>-0.53064727473065432</c:v>
                </c:pt>
                <c:pt idx="42">
                  <c:v>-0.71824923609710822</c:v>
                </c:pt>
                <c:pt idx="43">
                  <c:v>0.19874967027681123</c:v>
                </c:pt>
                <c:pt idx="44">
                  <c:v>1.9657514299578907</c:v>
                </c:pt>
              </c:numCache>
            </c:numRef>
          </c:val>
          <c:smooth val="0"/>
          <c:extLst>
            <c:ext xmlns:c16="http://schemas.microsoft.com/office/drawing/2014/chart" uri="{C3380CC4-5D6E-409C-BE32-E72D297353CC}">
              <c16:uniqueId val="{00000000-13B2-456C-AD51-1BDBB11F853F}"/>
            </c:ext>
          </c:extLst>
        </c:ser>
        <c:ser>
          <c:idx val="1"/>
          <c:order val="1"/>
          <c:tx>
            <c:strRef>
              <c:f>'Dx assay'!$A$32</c:f>
              <c:strCache>
                <c:ptCount val="1"/>
                <c:pt idx="0">
                  <c:v>50 copies</c:v>
                </c:pt>
              </c:strCache>
            </c:strRef>
          </c:tx>
          <c:spPr>
            <a:ln w="28575" cap="rnd">
              <a:solidFill>
                <a:schemeClr val="accent2"/>
              </a:solidFill>
              <a:round/>
            </a:ln>
            <a:effectLst/>
          </c:spPr>
          <c:marker>
            <c:symbol val="none"/>
          </c:marker>
          <c:val>
            <c:numRef>
              <c:f>'Dx assay'!$B$32:$AT$32</c:f>
              <c:numCache>
                <c:formatCode>General</c:formatCode>
                <c:ptCount val="45"/>
                <c:pt idx="0">
                  <c:v>61.162890479776252</c:v>
                </c:pt>
                <c:pt idx="1">
                  <c:v>49.865274416077227</c:v>
                </c:pt>
                <c:pt idx="2">
                  <c:v>39.195243750393274</c:v>
                </c:pt>
                <c:pt idx="3">
                  <c:v>30.166730749460839</c:v>
                </c:pt>
                <c:pt idx="4">
                  <c:v>23.072313313812629</c:v>
                </c:pt>
                <c:pt idx="5">
                  <c:v>17.210369158139656</c:v>
                </c:pt>
                <c:pt idx="6">
                  <c:v>11.969195856316219</c:v>
                </c:pt>
                <c:pt idx="7">
                  <c:v>7.3083925560276839</c:v>
                </c:pt>
                <c:pt idx="8">
                  <c:v>3.351710831411765</c:v>
                </c:pt>
                <c:pt idx="9">
                  <c:v>0.11065732167298847</c:v>
                </c:pt>
                <c:pt idx="10">
                  <c:v>-2.4506476998958533</c:v>
                </c:pt>
                <c:pt idx="11">
                  <c:v>-4.4200880367061472</c:v>
                </c:pt>
                <c:pt idx="12">
                  <c:v>-5.9450407446456666</c:v>
                </c:pt>
                <c:pt idx="13">
                  <c:v>-6.9937207124548877</c:v>
                </c:pt>
                <c:pt idx="14">
                  <c:v>-7.3525738608241227</c:v>
                </c:pt>
                <c:pt idx="15">
                  <c:v>-7.1357561298282235</c:v>
                </c:pt>
                <c:pt idx="16">
                  <c:v>-6.8262524570582173</c:v>
                </c:pt>
                <c:pt idx="17">
                  <c:v>-6.689222710152535</c:v>
                </c:pt>
                <c:pt idx="18">
                  <c:v>-6.6007884957234637</c:v>
                </c:pt>
                <c:pt idx="19">
                  <c:v>-6.3390366241346783</c:v>
                </c:pt>
                <c:pt idx="20">
                  <c:v>-5.8429668228891387</c:v>
                </c:pt>
                <c:pt idx="21">
                  <c:v>-5.1403170219564345</c:v>
                </c:pt>
                <c:pt idx="22">
                  <c:v>-4.0477500517808949</c:v>
                </c:pt>
                <c:pt idx="23">
                  <c:v>-2.2673400528728962</c:v>
                </c:pt>
                <c:pt idx="24">
                  <c:v>0.16497854925000865</c:v>
                </c:pt>
                <c:pt idx="25">
                  <c:v>2.802606617249694</c:v>
                </c:pt>
                <c:pt idx="26">
                  <c:v>5.5721660565504862</c:v>
                </c:pt>
                <c:pt idx="27">
                  <c:v>9.8995146911020129</c:v>
                </c:pt>
                <c:pt idx="28">
                  <c:v>19.661909783199008</c:v>
                </c:pt>
                <c:pt idx="29">
                  <c:v>43.193187729688361</c:v>
                </c:pt>
                <c:pt idx="30">
                  <c:v>97.331303883807777</c:v>
                </c:pt>
                <c:pt idx="31">
                  <c:v>211.07867478145636</c:v>
                </c:pt>
                <c:pt idx="32">
                  <c:v>422.56010136544683</c:v>
                </c:pt>
                <c:pt idx="33">
                  <c:v>763.74392758100294</c:v>
                </c:pt>
                <c:pt idx="34">
                  <c:v>1237.1326376789202</c:v>
                </c:pt>
                <c:pt idx="35">
                  <c:v>1801.8185103450469</c:v>
                </c:pt>
                <c:pt idx="36">
                  <c:v>2385.8532839468462</c:v>
                </c:pt>
                <c:pt idx="37">
                  <c:v>2919.8319784752966</c:v>
                </c:pt>
                <c:pt idx="38">
                  <c:v>3365.7975038890254</c:v>
                </c:pt>
                <c:pt idx="39">
                  <c:v>3721.8446415535327</c:v>
                </c:pt>
                <c:pt idx="40">
                  <c:v>4006.2974784520138</c:v>
                </c:pt>
                <c:pt idx="41">
                  <c:v>4239.2895553234976</c:v>
                </c:pt>
                <c:pt idx="42">
                  <c:v>4435.0224105885209</c:v>
                </c:pt>
                <c:pt idx="43">
                  <c:v>4604.1316592876028</c:v>
                </c:pt>
                <c:pt idx="44">
                  <c:v>4758.102847475162</c:v>
                </c:pt>
              </c:numCache>
            </c:numRef>
          </c:val>
          <c:smooth val="0"/>
          <c:extLst>
            <c:ext xmlns:c16="http://schemas.microsoft.com/office/drawing/2014/chart" uri="{C3380CC4-5D6E-409C-BE32-E72D297353CC}">
              <c16:uniqueId val="{00000001-13B2-456C-AD51-1BDBB11F853F}"/>
            </c:ext>
          </c:extLst>
        </c:ser>
        <c:ser>
          <c:idx val="2"/>
          <c:order val="2"/>
          <c:tx>
            <c:strRef>
              <c:f>'Dx assay'!$A$35</c:f>
              <c:strCache>
                <c:ptCount val="1"/>
                <c:pt idx="0">
                  <c:v>50 copies</c:v>
                </c:pt>
              </c:strCache>
            </c:strRef>
          </c:tx>
          <c:spPr>
            <a:ln w="28575" cap="rnd">
              <a:solidFill>
                <a:schemeClr val="accent3"/>
              </a:solidFill>
              <a:round/>
            </a:ln>
            <a:effectLst/>
          </c:spPr>
          <c:marker>
            <c:symbol val="none"/>
          </c:marker>
          <c:val>
            <c:numRef>
              <c:f>'Dx assay'!$B$35:$AT$35</c:f>
              <c:numCache>
                <c:formatCode>General</c:formatCode>
                <c:ptCount val="45"/>
                <c:pt idx="0">
                  <c:v>39.058349949549665</c:v>
                </c:pt>
                <c:pt idx="1">
                  <c:v>28.608454062297824</c:v>
                </c:pt>
                <c:pt idx="2">
                  <c:v>19.430990220369495</c:v>
                </c:pt>
                <c:pt idx="3">
                  <c:v>11.853754284342358</c:v>
                </c:pt>
                <c:pt idx="4">
                  <c:v>6.3222815934186656</c:v>
                </c:pt>
                <c:pt idx="5">
                  <c:v>3.4493860496204434</c:v>
                </c:pt>
                <c:pt idx="6">
                  <c:v>3.0096102696570597</c:v>
                </c:pt>
                <c:pt idx="7">
                  <c:v>4.3402389707134716</c:v>
                </c:pt>
                <c:pt idx="8">
                  <c:v>6.5187937615864939</c:v>
                </c:pt>
                <c:pt idx="9">
                  <c:v>7.9787745117737359</c:v>
                </c:pt>
                <c:pt idx="10">
                  <c:v>7.3803448485887202</c:v>
                </c:pt>
                <c:pt idx="11">
                  <c:v>4.3161471235398494</c:v>
                </c:pt>
                <c:pt idx="12">
                  <c:v>-0.19425994320044992</c:v>
                </c:pt>
                <c:pt idx="13">
                  <c:v>-3.7947403526832204</c:v>
                </c:pt>
                <c:pt idx="14">
                  <c:v>-5.2963425613434083</c:v>
                </c:pt>
                <c:pt idx="15">
                  <c:v>-5.9423425517070427</c:v>
                </c:pt>
                <c:pt idx="16">
                  <c:v>-7.3446091742753197</c:v>
                </c:pt>
                <c:pt idx="17">
                  <c:v>-9.2497426696227194</c:v>
                </c:pt>
                <c:pt idx="18">
                  <c:v>-9.6439666715141357</c:v>
                </c:pt>
                <c:pt idx="19">
                  <c:v>-7.4684104843981913</c:v>
                </c:pt>
                <c:pt idx="20">
                  <c:v>-4.5755943764415861</c:v>
                </c:pt>
                <c:pt idx="21">
                  <c:v>-3.8740152900154499</c:v>
                </c:pt>
                <c:pt idx="22">
                  <c:v>-5.7850989701255457</c:v>
                </c:pt>
                <c:pt idx="23">
                  <c:v>-7.6906476910917263</c:v>
                </c:pt>
                <c:pt idx="24">
                  <c:v>-7.0422697811991384</c:v>
                </c:pt>
                <c:pt idx="25">
                  <c:v>-3.5528892759557493</c:v>
                </c:pt>
                <c:pt idx="26">
                  <c:v>2.1474649124902498</c:v>
                </c:pt>
                <c:pt idx="27">
                  <c:v>11.50024260164173</c:v>
                </c:pt>
                <c:pt idx="28">
                  <c:v>30.813926743961929</c:v>
                </c:pt>
                <c:pt idx="29">
                  <c:v>74.923166333015615</c:v>
                </c:pt>
                <c:pt idx="30">
                  <c:v>172.46673195182484</c:v>
                </c:pt>
                <c:pt idx="31">
                  <c:v>368.13009246674665</c:v>
                </c:pt>
                <c:pt idx="32">
                  <c:v>715.09787670945479</c:v>
                </c:pt>
                <c:pt idx="33">
                  <c:v>1256.3708769662026</c:v>
                </c:pt>
                <c:pt idx="34">
                  <c:v>2001.4800357954337</c:v>
                </c:pt>
                <c:pt idx="35">
                  <c:v>2912.1480555592279</c:v>
                </c:pt>
                <c:pt idx="36">
                  <c:v>3909.809036567729</c:v>
                </c:pt>
                <c:pt idx="37">
                  <c:v>4903.0889234693168</c:v>
                </c:pt>
                <c:pt idx="38">
                  <c:v>5820.4708612266604</c:v>
                </c:pt>
                <c:pt idx="39">
                  <c:v>6632.4725278013229</c:v>
                </c:pt>
                <c:pt idx="40">
                  <c:v>7347.4377700270325</c:v>
                </c:pt>
                <c:pt idx="41">
                  <c:v>7985.6655445222368</c:v>
                </c:pt>
                <c:pt idx="42">
                  <c:v>8561.7985846906686</c:v>
                </c:pt>
                <c:pt idx="43">
                  <c:v>9086.3883919351192</c:v>
                </c:pt>
                <c:pt idx="44">
                  <c:v>9577.2834211193895</c:v>
                </c:pt>
              </c:numCache>
            </c:numRef>
          </c:val>
          <c:smooth val="0"/>
          <c:extLst>
            <c:ext xmlns:c16="http://schemas.microsoft.com/office/drawing/2014/chart" uri="{C3380CC4-5D6E-409C-BE32-E72D297353CC}">
              <c16:uniqueId val="{00000002-13B2-456C-AD51-1BDBB11F853F}"/>
            </c:ext>
          </c:extLst>
        </c:ser>
        <c:ser>
          <c:idx val="3"/>
          <c:order val="3"/>
          <c:tx>
            <c:strRef>
              <c:f>'Dx assay'!$A$38</c:f>
              <c:strCache>
                <c:ptCount val="1"/>
                <c:pt idx="0">
                  <c:v>500 copies</c:v>
                </c:pt>
              </c:strCache>
            </c:strRef>
          </c:tx>
          <c:spPr>
            <a:ln w="28575" cap="rnd">
              <a:solidFill>
                <a:schemeClr val="accent4"/>
              </a:solidFill>
              <a:round/>
            </a:ln>
            <a:effectLst/>
          </c:spPr>
          <c:marker>
            <c:symbol val="none"/>
          </c:marker>
          <c:val>
            <c:numRef>
              <c:f>'Dx assay'!$B$38:$AT$38</c:f>
              <c:numCache>
                <c:formatCode>General</c:formatCode>
                <c:ptCount val="45"/>
                <c:pt idx="0">
                  <c:v>80.885619604494423</c:v>
                </c:pt>
                <c:pt idx="1">
                  <c:v>67.553842687775614</c:v>
                </c:pt>
                <c:pt idx="2">
                  <c:v>56.152314725175529</c:v>
                </c:pt>
                <c:pt idx="3">
                  <c:v>46.117308422224596</c:v>
                </c:pt>
                <c:pt idx="4">
                  <c:v>35.491970073073389</c:v>
                </c:pt>
                <c:pt idx="5">
                  <c:v>24.257663485415833</c:v>
                </c:pt>
                <c:pt idx="6">
                  <c:v>14.406777833988599</c:v>
                </c:pt>
                <c:pt idx="7">
                  <c:v>7.1997059520945186</c:v>
                </c:pt>
                <c:pt idx="8">
                  <c:v>2.3820781940303277</c:v>
                </c:pt>
                <c:pt idx="9">
                  <c:v>-0.76911451449996093</c:v>
                </c:pt>
                <c:pt idx="10">
                  <c:v>-2.9163518594523339</c:v>
                </c:pt>
                <c:pt idx="11">
                  <c:v>-4.8293722072176024</c:v>
                </c:pt>
                <c:pt idx="12">
                  <c:v>-7.0520838826232648</c:v>
                </c:pt>
                <c:pt idx="13">
                  <c:v>-9.3236340520943486</c:v>
                </c:pt>
                <c:pt idx="14">
                  <c:v>-10.893600743896968</c:v>
                </c:pt>
                <c:pt idx="15">
                  <c:v>-11.160665468256411</c:v>
                </c:pt>
                <c:pt idx="16">
                  <c:v>-10.350110381015838</c:v>
                </c:pt>
                <c:pt idx="17">
                  <c:v>-9.7005953009665973</c:v>
                </c:pt>
                <c:pt idx="18">
                  <c:v>-10.128309010970042</c:v>
                </c:pt>
                <c:pt idx="19">
                  <c:v>-10.950443121297212</c:v>
                </c:pt>
                <c:pt idx="20">
                  <c:v>-10.547877765906378</c:v>
                </c:pt>
                <c:pt idx="21">
                  <c:v>-7.8221521342857159</c:v>
                </c:pt>
                <c:pt idx="22">
                  <c:v>-2.5002228003122582</c:v>
                </c:pt>
                <c:pt idx="23">
                  <c:v>5.5661182155618008</c:v>
                </c:pt>
                <c:pt idx="24">
                  <c:v>17.44020497746169</c:v>
                </c:pt>
                <c:pt idx="25">
                  <c:v>37.691984584222155</c:v>
                </c:pt>
                <c:pt idx="26">
                  <c:v>79.277100607998364</c:v>
                </c:pt>
                <c:pt idx="27">
                  <c:v>168.83262415387253</c:v>
                </c:pt>
                <c:pt idx="28">
                  <c:v>348.22361146022013</c:v>
                </c:pt>
                <c:pt idx="29">
                  <c:v>665.41359808547713</c:v>
                </c:pt>
                <c:pt idx="30">
                  <c:v>1151.4300716569887</c:v>
                </c:pt>
                <c:pt idx="31">
                  <c:v>1794.642003309842</c:v>
                </c:pt>
                <c:pt idx="32">
                  <c:v>2533.4469905409769</c:v>
                </c:pt>
                <c:pt idx="33">
                  <c:v>3278.4320931471848</c:v>
                </c:pt>
                <c:pt idx="34">
                  <c:v>3951.6397693282652</c:v>
                </c:pt>
                <c:pt idx="35">
                  <c:v>4515.4933929748349</c:v>
                </c:pt>
                <c:pt idx="36">
                  <c:v>4973.7003653815191</c:v>
                </c:pt>
                <c:pt idx="37">
                  <c:v>5351.1594577148644</c:v>
                </c:pt>
                <c:pt idx="38">
                  <c:v>5673.1248465311055</c:v>
                </c:pt>
                <c:pt idx="39">
                  <c:v>5956.660979460512</c:v>
                </c:pt>
                <c:pt idx="40">
                  <c:v>6211.2836117511088</c:v>
                </c:pt>
                <c:pt idx="41">
                  <c:v>6440.7794882692706</c:v>
                </c:pt>
                <c:pt idx="42">
                  <c:v>6646.9507394339798</c:v>
                </c:pt>
                <c:pt idx="43">
                  <c:v>6834.5822915239678</c:v>
                </c:pt>
                <c:pt idx="44">
                  <c:v>7011.8073579117427</c:v>
                </c:pt>
              </c:numCache>
            </c:numRef>
          </c:val>
          <c:smooth val="0"/>
          <c:extLst>
            <c:ext xmlns:c16="http://schemas.microsoft.com/office/drawing/2014/chart" uri="{C3380CC4-5D6E-409C-BE32-E72D297353CC}">
              <c16:uniqueId val="{00000003-13B2-456C-AD51-1BDBB11F853F}"/>
            </c:ext>
          </c:extLst>
        </c:ser>
        <c:ser>
          <c:idx val="4"/>
          <c:order val="4"/>
          <c:tx>
            <c:strRef>
              <c:f>'Dx assay'!$A$41</c:f>
              <c:strCache>
                <c:ptCount val="1"/>
                <c:pt idx="0">
                  <c:v>500 copies</c:v>
                </c:pt>
              </c:strCache>
            </c:strRef>
          </c:tx>
          <c:spPr>
            <a:ln w="28575" cap="rnd">
              <a:solidFill>
                <a:schemeClr val="accent5"/>
              </a:solidFill>
              <a:round/>
            </a:ln>
            <a:effectLst/>
          </c:spPr>
          <c:marker>
            <c:symbol val="none"/>
          </c:marker>
          <c:val>
            <c:numRef>
              <c:f>'Dx assay'!$B$41:$AT$41</c:f>
              <c:numCache>
                <c:formatCode>General</c:formatCode>
                <c:ptCount val="45"/>
                <c:pt idx="0">
                  <c:v>187.81493154059353</c:v>
                </c:pt>
                <c:pt idx="1">
                  <c:v>153.66445034844037</c:v>
                </c:pt>
                <c:pt idx="2">
                  <c:v>121.60312709038953</c:v>
                </c:pt>
                <c:pt idx="3">
                  <c:v>92.495670437610897</c:v>
                </c:pt>
                <c:pt idx="4">
                  <c:v>67.048058288786706</c:v>
                </c:pt>
                <c:pt idx="5">
                  <c:v>45.842909796401727</c:v>
                </c:pt>
                <c:pt idx="6">
                  <c:v>28.448065517823125</c:v>
                </c:pt>
                <c:pt idx="7">
                  <c:v>14.297231333777745</c:v>
                </c:pt>
                <c:pt idx="8">
                  <c:v>3.3912043759064545</c:v>
                </c:pt>
                <c:pt idx="9">
                  <c:v>-4.6860603063014423</c:v>
                </c:pt>
                <c:pt idx="10">
                  <c:v>-10.995865503655295</c:v>
                </c:pt>
                <c:pt idx="11">
                  <c:v>-16.069592616275258</c:v>
                </c:pt>
                <c:pt idx="12">
                  <c:v>-19.467291343855322</c:v>
                </c:pt>
                <c:pt idx="13">
                  <c:v>-20.505472015902342</c:v>
                </c:pt>
                <c:pt idx="14">
                  <c:v>-19.321828754944363</c:v>
                </c:pt>
                <c:pt idx="15">
                  <c:v>-17.420516940281232</c:v>
                </c:pt>
                <c:pt idx="16">
                  <c:v>-16.367393606462429</c:v>
                </c:pt>
                <c:pt idx="17">
                  <c:v>-16.00428689081491</c:v>
                </c:pt>
                <c:pt idx="18">
                  <c:v>-14.859910396078703</c:v>
                </c:pt>
                <c:pt idx="19">
                  <c:v>-11.813444342284129</c:v>
                </c:pt>
                <c:pt idx="20">
                  <c:v>-6.907818032465002</c:v>
                </c:pt>
                <c:pt idx="21">
                  <c:v>-0.90126606016565347</c:v>
                </c:pt>
                <c:pt idx="22">
                  <c:v>5.6855797291827912</c:v>
                </c:pt>
                <c:pt idx="23">
                  <c:v>13.181113869455658</c:v>
                </c:pt>
                <c:pt idx="24">
                  <c:v>23.368966173920853</c:v>
                </c:pt>
                <c:pt idx="25">
                  <c:v>41.105676013006814</c:v>
                </c:pt>
                <c:pt idx="26">
                  <c:v>78.286457587724726</c:v>
                </c:pt>
                <c:pt idx="27">
                  <c:v>159.15332270186082</c:v>
                </c:pt>
                <c:pt idx="28">
                  <c:v>321.61746734038206</c:v>
                </c:pt>
                <c:pt idx="29">
                  <c:v>609.48503308240288</c:v>
                </c:pt>
                <c:pt idx="30">
                  <c:v>1054.3210602107101</c:v>
                </c:pt>
                <c:pt idx="31">
                  <c:v>1653.0511318336667</c:v>
                </c:pt>
                <c:pt idx="32">
                  <c:v>2357.1622916452088</c:v>
                </c:pt>
                <c:pt idx="33">
                  <c:v>3087.4356158298651</c:v>
                </c:pt>
                <c:pt idx="34">
                  <c:v>3768.3445396997413</c:v>
                </c:pt>
                <c:pt idx="35">
                  <c:v>4356.9827509203078</c:v>
                </c:pt>
                <c:pt idx="36">
                  <c:v>4847.5784678849923</c:v>
                </c:pt>
                <c:pt idx="37">
                  <c:v>5256.8506152936898</c:v>
                </c:pt>
                <c:pt idx="38">
                  <c:v>5606.349269221686</c:v>
                </c:pt>
                <c:pt idx="39">
                  <c:v>5911.9224485319173</c:v>
                </c:pt>
                <c:pt idx="40">
                  <c:v>6182.1379137153344</c:v>
                </c:pt>
                <c:pt idx="41">
                  <c:v>6421.8005976692548</c:v>
                </c:pt>
                <c:pt idx="42">
                  <c:v>6635.2745812944158</c:v>
                </c:pt>
                <c:pt idx="43">
                  <c:v>6827.8865020573103</c:v>
                </c:pt>
                <c:pt idx="44">
                  <c:v>7007.6337754374545</c:v>
                </c:pt>
              </c:numCache>
            </c:numRef>
          </c:val>
          <c:smooth val="0"/>
          <c:extLst>
            <c:ext xmlns:c16="http://schemas.microsoft.com/office/drawing/2014/chart" uri="{C3380CC4-5D6E-409C-BE32-E72D297353CC}">
              <c16:uniqueId val="{00000004-13B2-456C-AD51-1BDBB11F853F}"/>
            </c:ext>
          </c:extLst>
        </c:ser>
        <c:ser>
          <c:idx val="5"/>
          <c:order val="5"/>
          <c:tx>
            <c:strRef>
              <c:f>'Dx assay'!$A$44</c:f>
              <c:strCache>
                <c:ptCount val="1"/>
                <c:pt idx="0">
                  <c:v>5,000 copies</c:v>
                </c:pt>
              </c:strCache>
            </c:strRef>
          </c:tx>
          <c:spPr>
            <a:ln w="28575" cap="rnd">
              <a:solidFill>
                <a:schemeClr val="accent6"/>
              </a:solidFill>
              <a:round/>
            </a:ln>
            <a:effectLst/>
          </c:spPr>
          <c:marker>
            <c:symbol val="none"/>
          </c:marker>
          <c:val>
            <c:numRef>
              <c:f>'Dx assay'!$B$44:$AT$44</c:f>
              <c:numCache>
                <c:formatCode>General</c:formatCode>
                <c:ptCount val="45"/>
                <c:pt idx="0">
                  <c:v>89.775379328406416</c:v>
                </c:pt>
                <c:pt idx="1">
                  <c:v>76.625437665412392</c:v>
                </c:pt>
                <c:pt idx="2">
                  <c:v>62.246899320971352</c:v>
                </c:pt>
                <c:pt idx="3">
                  <c:v>46.695161884917979</c:v>
                </c:pt>
                <c:pt idx="4">
                  <c:v>31.839605273735287</c:v>
                </c:pt>
                <c:pt idx="5">
                  <c:v>19.52897271573238</c:v>
                </c:pt>
                <c:pt idx="6">
                  <c:v>9.9329466492054053</c:v>
                </c:pt>
                <c:pt idx="7">
                  <c:v>2.5740112902876717</c:v>
                </c:pt>
                <c:pt idx="8">
                  <c:v>-2.5689984887867467</c:v>
                </c:pt>
                <c:pt idx="9">
                  <c:v>-5.5325988349213731</c:v>
                </c:pt>
                <c:pt idx="10">
                  <c:v>-6.9170665017591091</c:v>
                </c:pt>
                <c:pt idx="11">
                  <c:v>-7.6538888990035048</c:v>
                </c:pt>
                <c:pt idx="12">
                  <c:v>-8.2172231410604581</c:v>
                </c:pt>
                <c:pt idx="13">
                  <c:v>-8.1940221127533732</c:v>
                </c:pt>
                <c:pt idx="14">
                  <c:v>-7.0190611021171208</c:v>
                </c:pt>
                <c:pt idx="15">
                  <c:v>-5.1505123910119437</c:v>
                </c:pt>
                <c:pt idx="16">
                  <c:v>-3.7552070252022531</c:v>
                </c:pt>
                <c:pt idx="17">
                  <c:v>-2.9757802772182913</c:v>
                </c:pt>
                <c:pt idx="18">
                  <c:v>-1.6575354041506216</c:v>
                </c:pt>
                <c:pt idx="19">
                  <c:v>1.3979628643501201</c:v>
                </c:pt>
                <c:pt idx="20">
                  <c:v>7.3203895793121774</c:v>
                </c:pt>
                <c:pt idx="21">
                  <c:v>18.887611079069757</c:v>
                </c:pt>
                <c:pt idx="22">
                  <c:v>43.945595893093923</c:v>
                </c:pt>
                <c:pt idx="23">
                  <c:v>100.26241095813566</c:v>
                </c:pt>
                <c:pt idx="24">
                  <c:v>219.70813163936327</c:v>
                </c:pt>
                <c:pt idx="25">
                  <c:v>446.69725296506476</c:v>
                </c:pt>
                <c:pt idx="26">
                  <c:v>825.42769678661898</c:v>
                </c:pt>
                <c:pt idx="27">
                  <c:v>1377.0167816563626</c:v>
                </c:pt>
                <c:pt idx="28">
                  <c:v>2078.6629731779085</c:v>
                </c:pt>
                <c:pt idx="29">
                  <c:v>2862.9532861554781</c:v>
                </c:pt>
                <c:pt idx="30">
                  <c:v>3643.3896183434881</c:v>
                </c:pt>
                <c:pt idx="31">
                  <c:v>4349.6111455330556</c:v>
                </c:pt>
                <c:pt idx="32">
                  <c:v>4949.2243623913928</c:v>
                </c:pt>
                <c:pt idx="33">
                  <c:v>5446.699023840516</c:v>
                </c:pt>
                <c:pt idx="34">
                  <c:v>5866.1513851944692</c:v>
                </c:pt>
                <c:pt idx="35">
                  <c:v>6232.4435228360016</c:v>
                </c:pt>
                <c:pt idx="36">
                  <c:v>6561.421763600687</c:v>
                </c:pt>
                <c:pt idx="37">
                  <c:v>6859.4457875659718</c:v>
                </c:pt>
                <c:pt idx="38">
                  <c:v>7127.2446892204898</c:v>
                </c:pt>
                <c:pt idx="39">
                  <c:v>7366.601987777085</c:v>
                </c:pt>
                <c:pt idx="40">
                  <c:v>7583.8736276506061</c:v>
                </c:pt>
                <c:pt idx="41">
                  <c:v>7784.7665811368825</c:v>
                </c:pt>
                <c:pt idx="42">
                  <c:v>7971.1482994724429</c:v>
                </c:pt>
                <c:pt idx="43">
                  <c:v>8145.4010097601713</c:v>
                </c:pt>
                <c:pt idx="44">
                  <c:v>8312.6201054390222</c:v>
                </c:pt>
              </c:numCache>
            </c:numRef>
          </c:val>
          <c:smooth val="0"/>
          <c:extLst>
            <c:ext xmlns:c16="http://schemas.microsoft.com/office/drawing/2014/chart" uri="{C3380CC4-5D6E-409C-BE32-E72D297353CC}">
              <c16:uniqueId val="{00000005-13B2-456C-AD51-1BDBB11F853F}"/>
            </c:ext>
          </c:extLst>
        </c:ser>
        <c:ser>
          <c:idx val="6"/>
          <c:order val="6"/>
          <c:tx>
            <c:strRef>
              <c:f>'Dx assay'!$A$47</c:f>
              <c:strCache>
                <c:ptCount val="1"/>
                <c:pt idx="0">
                  <c:v>5,000 copies</c:v>
                </c:pt>
              </c:strCache>
            </c:strRef>
          </c:tx>
          <c:spPr>
            <a:ln w="28575" cap="rnd">
              <a:solidFill>
                <a:schemeClr val="accent1">
                  <a:lumMod val="60000"/>
                </a:schemeClr>
              </a:solidFill>
              <a:round/>
            </a:ln>
            <a:effectLst/>
          </c:spPr>
          <c:marker>
            <c:symbol val="none"/>
          </c:marker>
          <c:val>
            <c:numRef>
              <c:f>'Dx assay'!$B$47:$AT$47</c:f>
              <c:numCache>
                <c:formatCode>General</c:formatCode>
                <c:ptCount val="45"/>
                <c:pt idx="0">
                  <c:v>80.52632401394294</c:v>
                </c:pt>
                <c:pt idx="1">
                  <c:v>58.4055922106254</c:v>
                </c:pt>
                <c:pt idx="2">
                  <c:v>38.63220565778829</c:v>
                </c:pt>
                <c:pt idx="3">
                  <c:v>23.386006438031472</c:v>
                </c:pt>
                <c:pt idx="4">
                  <c:v>13.195260868715195</c:v>
                </c:pt>
                <c:pt idx="5">
                  <c:v>6.7600117542915541</c:v>
                </c:pt>
                <c:pt idx="6">
                  <c:v>2.7608550603490585</c:v>
                </c:pt>
                <c:pt idx="7">
                  <c:v>1.0114632416843961</c:v>
                </c:pt>
                <c:pt idx="8">
                  <c:v>1.4515561543157673</c:v>
                </c:pt>
                <c:pt idx="9">
                  <c:v>2.6972980006903526</c:v>
                </c:pt>
                <c:pt idx="10">
                  <c:v>2.7595880199169187</c:v>
                </c:pt>
                <c:pt idx="11">
                  <c:v>1.1286254586702853</c:v>
                </c:pt>
                <c:pt idx="12">
                  <c:v>-1.1382478585692297</c:v>
                </c:pt>
                <c:pt idx="13">
                  <c:v>-3.3007915253401734</c:v>
                </c:pt>
                <c:pt idx="14">
                  <c:v>-5.1802432370259339</c:v>
                </c:pt>
                <c:pt idx="15">
                  <c:v>-6.2707068085055653</c:v>
                </c:pt>
                <c:pt idx="16">
                  <c:v>-6.6196656171287032</c:v>
                </c:pt>
                <c:pt idx="17">
                  <c:v>-7.2573482495154167</c:v>
                </c:pt>
                <c:pt idx="18">
                  <c:v>-8.6052744557982805</c:v>
                </c:pt>
                <c:pt idx="19">
                  <c:v>-9.4238256844673742</c:v>
                </c:pt>
                <c:pt idx="20">
                  <c:v>-6.9022238416328037</c:v>
                </c:pt>
                <c:pt idx="21">
                  <c:v>3.7458275123553904</c:v>
                </c:pt>
                <c:pt idx="22">
                  <c:v>32.383102075715215</c:v>
                </c:pt>
                <c:pt idx="23">
                  <c:v>100.21108635241944</c:v>
                </c:pt>
                <c:pt idx="24">
                  <c:v>244.46969508465554</c:v>
                </c:pt>
                <c:pt idx="25">
                  <c:v>514.78725718965688</c:v>
                </c:pt>
                <c:pt idx="26">
                  <c:v>958.25741236407703</c:v>
                </c:pt>
                <c:pt idx="27">
                  <c:v>1598.97322816612</c:v>
                </c:pt>
                <c:pt idx="28">
                  <c:v>2423.1294306792624</c:v>
                </c:pt>
                <c:pt idx="29">
                  <c:v>3375.9575563375129</c:v>
                </c:pt>
                <c:pt idx="30">
                  <c:v>4374.3849080038217</c:v>
                </c:pt>
                <c:pt idx="31">
                  <c:v>5336.8663435435265</c:v>
                </c:pt>
                <c:pt idx="32">
                  <c:v>6212.9377215062414</c:v>
                </c:pt>
                <c:pt idx="33">
                  <c:v>6988.6441675747046</c:v>
                </c:pt>
                <c:pt idx="34">
                  <c:v>7672.0771583921269</c:v>
                </c:pt>
                <c:pt idx="35">
                  <c:v>8280.253581254954</c:v>
                </c:pt>
                <c:pt idx="36">
                  <c:v>8833.3666257649311</c:v>
                </c:pt>
                <c:pt idx="37">
                  <c:v>9348.876138081192</c:v>
                </c:pt>
                <c:pt idx="38">
                  <c:v>9833.0570952119197</c:v>
                </c:pt>
                <c:pt idx="39">
                  <c:v>10281.645143648402</c:v>
                </c:pt>
                <c:pt idx="40">
                  <c:v>10693.051414166013</c:v>
                </c:pt>
                <c:pt idx="41">
                  <c:v>11074.316732340321</c:v>
                </c:pt>
                <c:pt idx="42">
                  <c:v>11435.241756237196</c:v>
                </c:pt>
                <c:pt idx="43">
                  <c:v>11785.635291225222</c:v>
                </c:pt>
                <c:pt idx="44">
                  <c:v>12132.906172410101</c:v>
                </c:pt>
              </c:numCache>
            </c:numRef>
          </c:val>
          <c:smooth val="0"/>
          <c:extLst>
            <c:ext xmlns:c16="http://schemas.microsoft.com/office/drawing/2014/chart" uri="{C3380CC4-5D6E-409C-BE32-E72D297353CC}">
              <c16:uniqueId val="{00000006-13B2-456C-AD51-1BDBB11F853F}"/>
            </c:ext>
          </c:extLst>
        </c:ser>
        <c:ser>
          <c:idx val="7"/>
          <c:order val="7"/>
          <c:tx>
            <c:strRef>
              <c:f>'Dx assay'!$A$50</c:f>
              <c:strCache>
                <c:ptCount val="1"/>
                <c:pt idx="0">
                  <c:v>50,000 copies</c:v>
                </c:pt>
              </c:strCache>
            </c:strRef>
          </c:tx>
          <c:spPr>
            <a:ln w="28575" cap="rnd">
              <a:solidFill>
                <a:schemeClr val="accent2">
                  <a:lumMod val="60000"/>
                </a:schemeClr>
              </a:solidFill>
              <a:round/>
            </a:ln>
            <a:effectLst/>
          </c:spPr>
          <c:marker>
            <c:symbol val="none"/>
          </c:marker>
          <c:val>
            <c:numRef>
              <c:f>'Dx assay'!$B$50:$AT$50</c:f>
              <c:numCache>
                <c:formatCode>General</c:formatCode>
                <c:ptCount val="45"/>
                <c:pt idx="0">
                  <c:v>88.069246557792212</c:v>
                </c:pt>
                <c:pt idx="1">
                  <c:v>70.041901564825821</c:v>
                </c:pt>
                <c:pt idx="2">
                  <c:v>53.824051562844033</c:v>
                </c:pt>
                <c:pt idx="3">
                  <c:v>40.136796742319348</c:v>
                </c:pt>
                <c:pt idx="4">
                  <c:v>28.884206367160004</c:v>
                </c:pt>
                <c:pt idx="5">
                  <c:v>19.499777259503389</c:v>
                </c:pt>
                <c:pt idx="6">
                  <c:v>11.501748612863594</c:v>
                </c:pt>
                <c:pt idx="7">
                  <c:v>5.0041522240444465</c:v>
                </c:pt>
                <c:pt idx="8">
                  <c:v>-7.435012559290044E-2</c:v>
                </c:pt>
                <c:pt idx="9">
                  <c:v>-4.2273137071042584</c:v>
                </c:pt>
                <c:pt idx="10">
                  <c:v>-7.5306448332121363</c:v>
                </c:pt>
                <c:pt idx="11">
                  <c:v>-10.027074197820184</c:v>
                </c:pt>
                <c:pt idx="12">
                  <c:v>-12.12223653628098</c:v>
                </c:pt>
                <c:pt idx="13">
                  <c:v>-13.494945962127531</c:v>
                </c:pt>
                <c:pt idx="14">
                  <c:v>-13.011059323323934</c:v>
                </c:pt>
                <c:pt idx="15">
                  <c:v>-10.496528095489339</c:v>
                </c:pt>
                <c:pt idx="16">
                  <c:v>-7.0583990853338037</c:v>
                </c:pt>
                <c:pt idx="17">
                  <c:v>-2.5972755760540167</c:v>
                </c:pt>
                <c:pt idx="18">
                  <c:v>7.7504341787935118</c:v>
                </c:pt>
                <c:pt idx="19">
                  <c:v>36.883715167148694</c:v>
                </c:pt>
                <c:pt idx="20">
                  <c:v>108.53392440992502</c:v>
                </c:pt>
                <c:pt idx="21">
                  <c:v>259.83404629073084</c:v>
                </c:pt>
                <c:pt idx="22">
                  <c:v>539.08398329249212</c:v>
                </c:pt>
                <c:pt idx="23">
                  <c:v>992.33580873026949</c:v>
                </c:pt>
                <c:pt idx="24">
                  <c:v>1641.5749529450677</c:v>
                </c:pt>
                <c:pt idx="25">
                  <c:v>2465.6460451822895</c:v>
                </c:pt>
                <c:pt idx="26">
                  <c:v>3398.7162848737571</c:v>
                </c:pt>
                <c:pt idx="27">
                  <c:v>4353.259946228929</c:v>
                </c:pt>
                <c:pt idx="28">
                  <c:v>5254.4751953873783</c:v>
                </c:pt>
                <c:pt idx="29">
                  <c:v>6064.5574871990902</c:v>
                </c:pt>
                <c:pt idx="30">
                  <c:v>6783.2637644875904</c:v>
                </c:pt>
                <c:pt idx="31">
                  <c:v>7428.6671416460194</c:v>
                </c:pt>
                <c:pt idx="32">
                  <c:v>8016.8550629739766</c:v>
                </c:pt>
                <c:pt idx="33">
                  <c:v>8555.6373547690564</c:v>
                </c:pt>
                <c:pt idx="34">
                  <c:v>9051.9018429872158</c:v>
                </c:pt>
                <c:pt idx="35">
                  <c:v>9517.2371896499862</c:v>
                </c:pt>
                <c:pt idx="36">
                  <c:v>9962.9926655231757</c:v>
                </c:pt>
                <c:pt idx="37">
                  <c:v>10393.188527853268</c:v>
                </c:pt>
                <c:pt idx="38">
                  <c:v>10804.069208778175</c:v>
                </c:pt>
                <c:pt idx="39">
                  <c:v>11192.809560307658</c:v>
                </c:pt>
                <c:pt idx="40">
                  <c:v>11562.518418186683</c:v>
                </c:pt>
                <c:pt idx="41">
                  <c:v>11914.349357829018</c:v>
                </c:pt>
                <c:pt idx="42">
                  <c:v>12243.499888494509</c:v>
                </c:pt>
                <c:pt idx="43">
                  <c:v>12546.795573009011</c:v>
                </c:pt>
                <c:pt idx="44">
                  <c:v>12831.244831033018</c:v>
                </c:pt>
              </c:numCache>
            </c:numRef>
          </c:val>
          <c:smooth val="0"/>
          <c:extLst>
            <c:ext xmlns:c16="http://schemas.microsoft.com/office/drawing/2014/chart" uri="{C3380CC4-5D6E-409C-BE32-E72D297353CC}">
              <c16:uniqueId val="{00000007-13B2-456C-AD51-1BDBB11F853F}"/>
            </c:ext>
          </c:extLst>
        </c:ser>
        <c:ser>
          <c:idx val="8"/>
          <c:order val="8"/>
          <c:tx>
            <c:strRef>
              <c:f>'Dx assay'!$A$53</c:f>
              <c:strCache>
                <c:ptCount val="1"/>
                <c:pt idx="0">
                  <c:v>50,000 copies</c:v>
                </c:pt>
              </c:strCache>
            </c:strRef>
          </c:tx>
          <c:spPr>
            <a:ln w="28575" cap="rnd">
              <a:solidFill>
                <a:schemeClr val="accent3">
                  <a:lumMod val="60000"/>
                </a:schemeClr>
              </a:solidFill>
              <a:round/>
            </a:ln>
            <a:effectLst/>
          </c:spPr>
          <c:marker>
            <c:symbol val="none"/>
          </c:marker>
          <c:val>
            <c:numRef>
              <c:f>'Dx assay'!$B$53:$AT$53</c:f>
              <c:numCache>
                <c:formatCode>General</c:formatCode>
                <c:ptCount val="45"/>
                <c:pt idx="0">
                  <c:v>44.797228409910531</c:v>
                </c:pt>
                <c:pt idx="1">
                  <c:v>37.033941835536098</c:v>
                </c:pt>
                <c:pt idx="2">
                  <c:v>29.575617309330482</c:v>
                </c:pt>
                <c:pt idx="3">
                  <c:v>22.325021482858574</c:v>
                </c:pt>
                <c:pt idx="4">
                  <c:v>15.552640260826593</c:v>
                </c:pt>
                <c:pt idx="5">
                  <c:v>10.237999618635513</c:v>
                </c:pt>
                <c:pt idx="6">
                  <c:v>7.2704233193089749</c:v>
                </c:pt>
                <c:pt idx="7">
                  <c:v>6.3620665973521682</c:v>
                </c:pt>
                <c:pt idx="8">
                  <c:v>5.5591415587623487</c:v>
                </c:pt>
                <c:pt idx="9">
                  <c:v>2.716681617359427</c:v>
                </c:pt>
                <c:pt idx="10">
                  <c:v>-2.193321295624628</c:v>
                </c:pt>
                <c:pt idx="11">
                  <c:v>-7.2940939266482019</c:v>
                </c:pt>
                <c:pt idx="12">
                  <c:v>-10.930342896543152</c:v>
                </c:pt>
                <c:pt idx="13">
                  <c:v>-12.808982991857192</c:v>
                </c:pt>
                <c:pt idx="14">
                  <c:v>-13.540401983029369</c:v>
                </c:pt>
                <c:pt idx="15">
                  <c:v>-13.640413799334056</c:v>
                </c:pt>
                <c:pt idx="16">
                  <c:v>-12.743723576799312</c:v>
                </c:pt>
                <c:pt idx="17">
                  <c:v>-8.3210374633745232</c:v>
                </c:pt>
                <c:pt idx="18">
                  <c:v>6.0861817699551466</c:v>
                </c:pt>
                <c:pt idx="19">
                  <c:v>43.239823451835036</c:v>
                </c:pt>
                <c:pt idx="20">
                  <c:v>126.85264378691681</c:v>
                </c:pt>
                <c:pt idx="21">
                  <c:v>296.24251596115391</c:v>
                </c:pt>
                <c:pt idx="22">
                  <c:v>602.64265366339714</c:v>
                </c:pt>
                <c:pt idx="23">
                  <c:v>1091.574663580308</c:v>
                </c:pt>
                <c:pt idx="24">
                  <c:v>1778.1811554166143</c:v>
                </c:pt>
                <c:pt idx="25">
                  <c:v>2630.7361232253406</c:v>
                </c:pt>
                <c:pt idx="26">
                  <c:v>3574.9663364078606</c:v>
                </c:pt>
                <c:pt idx="27">
                  <c:v>4520.50252080674</c:v>
                </c:pt>
                <c:pt idx="28">
                  <c:v>5394.9060447237316</c:v>
                </c:pt>
                <c:pt idx="29">
                  <c:v>6164.3591184141351</c:v>
                </c:pt>
                <c:pt idx="30">
                  <c:v>6830.2016819467517</c:v>
                </c:pt>
                <c:pt idx="31">
                  <c:v>7411.1191527595638</c:v>
                </c:pt>
                <c:pt idx="32">
                  <c:v>7930.0453370359483</c:v>
                </c:pt>
                <c:pt idx="33">
                  <c:v>8408.7847454728017</c:v>
                </c:pt>
                <c:pt idx="34">
                  <c:v>8861.7734291901816</c:v>
                </c:pt>
                <c:pt idx="35">
                  <c:v>9290.2537557706983</c:v>
                </c:pt>
                <c:pt idx="36">
                  <c:v>9686.4293415370103</c:v>
                </c:pt>
                <c:pt idx="37">
                  <c:v>10046.332244476247</c:v>
                </c:pt>
                <c:pt idx="38">
                  <c:v>10376.226777811889</c:v>
                </c:pt>
                <c:pt idx="39">
                  <c:v>10687.616094987616</c:v>
                </c:pt>
                <c:pt idx="40">
                  <c:v>10988.982671720571</c:v>
                </c:pt>
                <c:pt idx="41">
                  <c:v>11279.71007556881</c:v>
                </c:pt>
                <c:pt idx="42">
                  <c:v>11551.28348274181</c:v>
                </c:pt>
                <c:pt idx="43">
                  <c:v>11796.410881042886</c:v>
                </c:pt>
                <c:pt idx="44">
                  <c:v>12020.308842516881</c:v>
                </c:pt>
              </c:numCache>
            </c:numRef>
          </c:val>
          <c:smooth val="0"/>
          <c:extLst>
            <c:ext xmlns:c16="http://schemas.microsoft.com/office/drawing/2014/chart" uri="{C3380CC4-5D6E-409C-BE32-E72D297353CC}">
              <c16:uniqueId val="{00000008-13B2-456C-AD51-1BDBB11F853F}"/>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 S:484K</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62C!$A$28</c:f>
              <c:strCache>
                <c:ptCount val="1"/>
                <c:pt idx="0">
                  <c:v>NTC</c:v>
                </c:pt>
              </c:strCache>
            </c:strRef>
          </c:tx>
          <c:spPr>
            <a:ln w="28575" cap="rnd">
              <a:solidFill>
                <a:schemeClr val="accent1"/>
              </a:solidFill>
              <a:round/>
            </a:ln>
            <a:effectLst/>
          </c:spPr>
          <c:marker>
            <c:symbol val="none"/>
          </c:marker>
          <c:val>
            <c:numRef>
              <c:f>Triplex2_62C!$B$28:$AT$28</c:f>
              <c:numCache>
                <c:formatCode>General</c:formatCode>
                <c:ptCount val="45"/>
                <c:pt idx="0">
                  <c:v>-47.268695834922255</c:v>
                </c:pt>
                <c:pt idx="1">
                  <c:v>-46.240137988614151</c:v>
                </c:pt>
                <c:pt idx="2">
                  <c:v>-45.158496203570394</c:v>
                </c:pt>
                <c:pt idx="3">
                  <c:v>-44.388861602914403</c:v>
                </c:pt>
                <c:pt idx="4">
                  <c:v>-44.152054958067311</c:v>
                </c:pt>
                <c:pt idx="5">
                  <c:v>-43.623307572301201</c:v>
                </c:pt>
                <c:pt idx="6">
                  <c:v>-41.148719773973426</c:v>
                </c:pt>
                <c:pt idx="7">
                  <c:v>-35.606516262594596</c:v>
                </c:pt>
                <c:pt idx="8">
                  <c:v>-27.823824811261147</c:v>
                </c:pt>
                <c:pt idx="9">
                  <c:v>-20.111909075443691</c:v>
                </c:pt>
                <c:pt idx="10">
                  <c:v>-13.737621932610637</c:v>
                </c:pt>
                <c:pt idx="11">
                  <c:v>-7.8752877360366256</c:v>
                </c:pt>
                <c:pt idx="12">
                  <c:v>-1.5016247262992692</c:v>
                </c:pt>
                <c:pt idx="13">
                  <c:v>4.8856605845430749</c:v>
                </c:pt>
                <c:pt idx="14">
                  <c:v>9.8197192408006231</c:v>
                </c:pt>
                <c:pt idx="15">
                  <c:v>12.491597403988635</c:v>
                </c:pt>
                <c:pt idx="16">
                  <c:v>13.51187671516891</c:v>
                </c:pt>
                <c:pt idx="17">
                  <c:v>14.07522688672907</c:v>
                </c:pt>
                <c:pt idx="18">
                  <c:v>14.926975615908304</c:v>
                </c:pt>
                <c:pt idx="19">
                  <c:v>16.522778290691349</c:v>
                </c:pt>
                <c:pt idx="20">
                  <c:v>19.300579950573592</c:v>
                </c:pt>
                <c:pt idx="21">
                  <c:v>22.828163599899199</c:v>
                </c:pt>
                <c:pt idx="22">
                  <c:v>25.323616120078441</c:v>
                </c:pt>
                <c:pt idx="23">
                  <c:v>25.415210540355474</c:v>
                </c:pt>
                <c:pt idx="24">
                  <c:v>23.876013425162455</c:v>
                </c:pt>
                <c:pt idx="25">
                  <c:v>22.418232763706328</c:v>
                </c:pt>
                <c:pt idx="26">
                  <c:v>21.669593403194085</c:v>
                </c:pt>
                <c:pt idx="27">
                  <c:v>21.082425996173697</c:v>
                </c:pt>
                <c:pt idx="28">
                  <c:v>19.935686933531542</c:v>
                </c:pt>
                <c:pt idx="29">
                  <c:v>17.983987634153891</c:v>
                </c:pt>
                <c:pt idx="30">
                  <c:v>15.505674131292835</c:v>
                </c:pt>
                <c:pt idx="31">
                  <c:v>12.946558694800842</c:v>
                </c:pt>
                <c:pt idx="32">
                  <c:v>10.509538130956571</c:v>
                </c:pt>
                <c:pt idx="33">
                  <c:v>8.0474711762781226</c:v>
                </c:pt>
                <c:pt idx="34">
                  <c:v>5.3172460770110774</c:v>
                </c:pt>
                <c:pt idx="35">
                  <c:v>2.3775717329554027</c:v>
                </c:pt>
                <c:pt idx="36">
                  <c:v>-0.35732410253876878</c:v>
                </c:pt>
                <c:pt idx="37">
                  <c:v>-2.6516966955332464</c:v>
                </c:pt>
                <c:pt idx="38">
                  <c:v>-4.8557872681813024</c:v>
                </c:pt>
                <c:pt idx="39">
                  <c:v>-7.7771187817379541</c:v>
                </c:pt>
                <c:pt idx="40">
                  <c:v>-12.518763564336041</c:v>
                </c:pt>
                <c:pt idx="41">
                  <c:v>-19.951134089144034</c:v>
                </c:pt>
                <c:pt idx="42">
                  <c:v>-29.707570051530638</c:v>
                </c:pt>
                <c:pt idx="43">
                  <c:v>-40.405926946757972</c:v>
                </c:pt>
                <c:pt idx="44">
                  <c:v>-51.117271657672973</c:v>
                </c:pt>
              </c:numCache>
            </c:numRef>
          </c:val>
          <c:smooth val="0"/>
          <c:extLst>
            <c:ext xmlns:c16="http://schemas.microsoft.com/office/drawing/2014/chart" uri="{C3380CC4-5D6E-409C-BE32-E72D297353CC}">
              <c16:uniqueId val="{00000000-A4F0-4C02-840D-510D3EA7FF30}"/>
            </c:ext>
          </c:extLst>
        </c:ser>
        <c:ser>
          <c:idx val="1"/>
          <c:order val="1"/>
          <c:tx>
            <c:strRef>
              <c:f>Triplex2_62C!$A$31</c:f>
              <c:strCache>
                <c:ptCount val="1"/>
                <c:pt idx="0">
                  <c:v>50 copies</c:v>
                </c:pt>
              </c:strCache>
            </c:strRef>
          </c:tx>
          <c:spPr>
            <a:ln w="28575" cap="rnd">
              <a:solidFill>
                <a:schemeClr val="accent2"/>
              </a:solidFill>
              <a:round/>
            </a:ln>
            <a:effectLst/>
          </c:spPr>
          <c:marker>
            <c:symbol val="none"/>
          </c:marker>
          <c:val>
            <c:numRef>
              <c:f>Triplex2_62C!$B$31:$AT$31</c:f>
              <c:numCache>
                <c:formatCode>General</c:formatCode>
                <c:ptCount val="45"/>
                <c:pt idx="0">
                  <c:v>32.231250821450885</c:v>
                </c:pt>
                <c:pt idx="1">
                  <c:v>25.040449146816172</c:v>
                </c:pt>
                <c:pt idx="2">
                  <c:v>17.721120834286921</c:v>
                </c:pt>
                <c:pt idx="3">
                  <c:v>10.79536113251379</c:v>
                </c:pt>
                <c:pt idx="4">
                  <c:v>5.2293719011086068</c:v>
                </c:pt>
                <c:pt idx="5">
                  <c:v>1.7090901765859599</c:v>
                </c:pt>
                <c:pt idx="6">
                  <c:v>0.1741087922018778</c:v>
                </c:pt>
                <c:pt idx="7">
                  <c:v>-6.7609004267069395E-2</c:v>
                </c:pt>
                <c:pt idx="8">
                  <c:v>8.8910134276375175E-2</c:v>
                </c:pt>
                <c:pt idx="9">
                  <c:v>-8.3995414226592402E-2</c:v>
                </c:pt>
                <c:pt idx="10">
                  <c:v>-0.7188829605893261</c:v>
                </c:pt>
                <c:pt idx="11">
                  <c:v>-1.243323499797043</c:v>
                </c:pt>
                <c:pt idx="12">
                  <c:v>-1.1904197553812992</c:v>
                </c:pt>
                <c:pt idx="13">
                  <c:v>-0.84530616133270087</c:v>
                </c:pt>
                <c:pt idx="14">
                  <c:v>-0.69802069569414016</c:v>
                </c:pt>
                <c:pt idx="15">
                  <c:v>-0.81858038981954451</c:v>
                </c:pt>
                <c:pt idx="16">
                  <c:v>-1.0288153970650455</c:v>
                </c:pt>
                <c:pt idx="17">
                  <c:v>-1.1743084253739653</c:v>
                </c:pt>
                <c:pt idx="18">
                  <c:v>-1.1468054485667381</c:v>
                </c:pt>
                <c:pt idx="19">
                  <c:v>-0.89057061933999648</c:v>
                </c:pt>
                <c:pt idx="20">
                  <c:v>-0.36329666918936709</c:v>
                </c:pt>
                <c:pt idx="21">
                  <c:v>0.47463056944798154</c:v>
                </c:pt>
                <c:pt idx="22">
                  <c:v>1.4307147916351823</c:v>
                </c:pt>
                <c:pt idx="23">
                  <c:v>1.9509334741560451</c:v>
                </c:pt>
                <c:pt idx="24">
                  <c:v>1.6638127965907188</c:v>
                </c:pt>
                <c:pt idx="25">
                  <c:v>0.93212665585451759</c:v>
                </c:pt>
                <c:pt idx="26">
                  <c:v>0.41854904525644088</c:v>
                </c:pt>
                <c:pt idx="27">
                  <c:v>0.38164225028049259</c:v>
                </c:pt>
                <c:pt idx="28">
                  <c:v>0.64769982160942163</c:v>
                </c:pt>
                <c:pt idx="29">
                  <c:v>0.92460581713203283</c:v>
                </c:pt>
                <c:pt idx="30">
                  <c:v>1.0189497844239668</c:v>
                </c:pt>
                <c:pt idx="31">
                  <c:v>0.9296863177078194</c:v>
                </c:pt>
                <c:pt idx="32">
                  <c:v>0.78757345675330725</c:v>
                </c:pt>
                <c:pt idx="33">
                  <c:v>0.69525927475478966</c:v>
                </c:pt>
                <c:pt idx="34">
                  <c:v>0.66247514184578904</c:v>
                </c:pt>
                <c:pt idx="35">
                  <c:v>0.65141542627497984</c:v>
                </c:pt>
                <c:pt idx="36">
                  <c:v>0.59833257971149578</c:v>
                </c:pt>
                <c:pt idx="37">
                  <c:v>0.42795195135113318</c:v>
                </c:pt>
                <c:pt idx="38">
                  <c:v>0.1169100456918386</c:v>
                </c:pt>
                <c:pt idx="39">
                  <c:v>-0.29052610649341659</c:v>
                </c:pt>
                <c:pt idx="40">
                  <c:v>-0.74230655533028767</c:v>
                </c:pt>
                <c:pt idx="41">
                  <c:v>-1.1691072652101866</c:v>
                </c:pt>
                <c:pt idx="42">
                  <c:v>-1.4454777258069953</c:v>
                </c:pt>
                <c:pt idx="43">
                  <c:v>-1.4711586308876576</c:v>
                </c:pt>
                <c:pt idx="44">
                  <c:v>-1.2968675791089481</c:v>
                </c:pt>
              </c:numCache>
            </c:numRef>
          </c:val>
          <c:smooth val="0"/>
          <c:extLst>
            <c:ext xmlns:c16="http://schemas.microsoft.com/office/drawing/2014/chart" uri="{C3380CC4-5D6E-409C-BE32-E72D297353CC}">
              <c16:uniqueId val="{00000001-A4F0-4C02-840D-510D3EA7FF30}"/>
            </c:ext>
          </c:extLst>
        </c:ser>
        <c:ser>
          <c:idx val="2"/>
          <c:order val="2"/>
          <c:tx>
            <c:strRef>
              <c:f>Triplex2_62C!$A$34</c:f>
              <c:strCache>
                <c:ptCount val="1"/>
                <c:pt idx="0">
                  <c:v>50 copies</c:v>
                </c:pt>
              </c:strCache>
            </c:strRef>
          </c:tx>
          <c:spPr>
            <a:ln w="28575" cap="rnd">
              <a:solidFill>
                <a:schemeClr val="accent3"/>
              </a:solidFill>
              <a:round/>
            </a:ln>
            <a:effectLst/>
          </c:spPr>
          <c:marker>
            <c:symbol val="none"/>
          </c:marker>
          <c:val>
            <c:numRef>
              <c:f>Triplex2_62C!$B$34:$AT$34</c:f>
              <c:numCache>
                <c:formatCode>General</c:formatCode>
                <c:ptCount val="45"/>
                <c:pt idx="0">
                  <c:v>8.5051641016634676</c:v>
                </c:pt>
                <c:pt idx="1">
                  <c:v>5.2443491808480758</c:v>
                </c:pt>
                <c:pt idx="2">
                  <c:v>2.8948754938901402</c:v>
                </c:pt>
                <c:pt idx="3">
                  <c:v>1.5910524414248357</c:v>
                </c:pt>
                <c:pt idx="4">
                  <c:v>0.86639755322721612</c:v>
                </c:pt>
                <c:pt idx="5">
                  <c:v>0.30929527211992536</c:v>
                </c:pt>
                <c:pt idx="6">
                  <c:v>-0.13820222874346655</c:v>
                </c:pt>
                <c:pt idx="7">
                  <c:v>-0.32936082600826921</c:v>
                </c:pt>
                <c:pt idx="8">
                  <c:v>-0.16385275020184054</c:v>
                </c:pt>
                <c:pt idx="9">
                  <c:v>0.32212053284274589</c:v>
                </c:pt>
                <c:pt idx="10">
                  <c:v>1.0337075665756856</c:v>
                </c:pt>
                <c:pt idx="11">
                  <c:v>1.9537160237578064</c:v>
                </c:pt>
                <c:pt idx="12">
                  <c:v>3.1685271348251263</c:v>
                </c:pt>
                <c:pt idx="13">
                  <c:v>4.6932111342503049</c:v>
                </c:pt>
                <c:pt idx="14">
                  <c:v>6.359884534327648</c:v>
                </c:pt>
                <c:pt idx="15">
                  <c:v>7.9502871797576518</c:v>
                </c:pt>
                <c:pt idx="16">
                  <c:v>9.3411420917345822</c:v>
                </c:pt>
                <c:pt idx="17">
                  <c:v>10.524902553364882</c:v>
                </c:pt>
                <c:pt idx="18">
                  <c:v>11.589661654821612</c:v>
                </c:pt>
                <c:pt idx="19">
                  <c:v>12.658684218729832</c:v>
                </c:pt>
                <c:pt idx="20">
                  <c:v>13.812214056839366</c:v>
                </c:pt>
                <c:pt idx="21">
                  <c:v>15.115490633414083</c:v>
                </c:pt>
                <c:pt idx="22">
                  <c:v>16.683633558479414</c:v>
                </c:pt>
                <c:pt idx="23">
                  <c:v>18.58226960187676</c:v>
                </c:pt>
                <c:pt idx="24">
                  <c:v>20.682904718478312</c:v>
                </c:pt>
                <c:pt idx="25">
                  <c:v>22.723548800584467</c:v>
                </c:pt>
                <c:pt idx="26">
                  <c:v>24.48495661479501</c:v>
                </c:pt>
                <c:pt idx="27">
                  <c:v>25.925731344474116</c:v>
                </c:pt>
                <c:pt idx="28">
                  <c:v>27.250881190368091</c:v>
                </c:pt>
                <c:pt idx="29">
                  <c:v>28.763706223782719</c:v>
                </c:pt>
                <c:pt idx="30">
                  <c:v>30.589183615271395</c:v>
                </c:pt>
                <c:pt idx="31">
                  <c:v>32.628809757612544</c:v>
                </c:pt>
                <c:pt idx="32">
                  <c:v>34.705435082605618</c:v>
                </c:pt>
                <c:pt idx="33">
                  <c:v>36.731706477656189</c:v>
                </c:pt>
                <c:pt idx="34">
                  <c:v>38.787150518883209</c:v>
                </c:pt>
                <c:pt idx="35">
                  <c:v>40.907309785226971</c:v>
                </c:pt>
                <c:pt idx="36">
                  <c:v>42.902528283913853</c:v>
                </c:pt>
                <c:pt idx="37">
                  <c:v>44.626884765561044</c:v>
                </c:pt>
                <c:pt idx="38">
                  <c:v>46.280029825249585</c:v>
                </c:pt>
                <c:pt idx="39">
                  <c:v>48.176953847912955</c:v>
                </c:pt>
                <c:pt idx="40">
                  <c:v>50.33269732199733</c:v>
                </c:pt>
                <c:pt idx="41">
                  <c:v>52.429020452078476</c:v>
                </c:pt>
                <c:pt idx="42">
                  <c:v>54.028630625522055</c:v>
                </c:pt>
                <c:pt idx="43">
                  <c:v>54.853584235921517</c:v>
                </c:pt>
                <c:pt idx="44">
                  <c:v>55.07541699747344</c:v>
                </c:pt>
              </c:numCache>
            </c:numRef>
          </c:val>
          <c:smooth val="0"/>
          <c:extLst>
            <c:ext xmlns:c16="http://schemas.microsoft.com/office/drawing/2014/chart" uri="{C3380CC4-5D6E-409C-BE32-E72D297353CC}">
              <c16:uniqueId val="{00000002-A4F0-4C02-840D-510D3EA7FF30}"/>
            </c:ext>
          </c:extLst>
        </c:ser>
        <c:ser>
          <c:idx val="3"/>
          <c:order val="3"/>
          <c:tx>
            <c:strRef>
              <c:f>Triplex2_62C!$A$37</c:f>
              <c:strCache>
                <c:ptCount val="1"/>
                <c:pt idx="0">
                  <c:v>500 copies</c:v>
                </c:pt>
              </c:strCache>
            </c:strRef>
          </c:tx>
          <c:spPr>
            <a:ln w="28575" cap="rnd">
              <a:solidFill>
                <a:schemeClr val="accent4"/>
              </a:solidFill>
              <a:round/>
            </a:ln>
            <a:effectLst/>
          </c:spPr>
          <c:marker>
            <c:symbol val="none"/>
          </c:marker>
          <c:val>
            <c:numRef>
              <c:f>Triplex2_62C!$B$37:$AT$37</c:f>
              <c:numCache>
                <c:formatCode>General</c:formatCode>
                <c:ptCount val="45"/>
                <c:pt idx="0">
                  <c:v>38.19340694026323</c:v>
                </c:pt>
                <c:pt idx="1">
                  <c:v>29.808444147422051</c:v>
                </c:pt>
                <c:pt idx="2">
                  <c:v>22.451810010896224</c:v>
                </c:pt>
                <c:pt idx="3">
                  <c:v>16.576315182064718</c:v>
                </c:pt>
                <c:pt idx="4">
                  <c:v>12.242133231147818</c:v>
                </c:pt>
                <c:pt idx="5">
                  <c:v>9.2666095558888628</c:v>
                </c:pt>
                <c:pt idx="6">
                  <c:v>7.1295948285332997</c:v>
                </c:pt>
                <c:pt idx="7">
                  <c:v>5.2543350155410735</c:v>
                </c:pt>
                <c:pt idx="8">
                  <c:v>3.3978020057311369</c:v>
                </c:pt>
                <c:pt idx="9">
                  <c:v>1.5768055391763482</c:v>
                </c:pt>
                <c:pt idx="10">
                  <c:v>-0.13043470310003613</c:v>
                </c:pt>
                <c:pt idx="11">
                  <c:v>-1.5662803793693456</c:v>
                </c:pt>
                <c:pt idx="12">
                  <c:v>-2.5185818624431704</c:v>
                </c:pt>
                <c:pt idx="13">
                  <c:v>-2.9002975512103149</c:v>
                </c:pt>
                <c:pt idx="14">
                  <c:v>-2.913495449553011</c:v>
                </c:pt>
                <c:pt idx="15">
                  <c:v>-2.8753146488579659</c:v>
                </c:pt>
                <c:pt idx="16">
                  <c:v>-2.8617125812470476</c:v>
                </c:pt>
                <c:pt idx="17">
                  <c:v>-2.7388825635807734</c:v>
                </c:pt>
                <c:pt idx="18">
                  <c:v>-2.4402476319428388</c:v>
                </c:pt>
                <c:pt idx="19">
                  <c:v>-2.0907880957565794</c:v>
                </c:pt>
                <c:pt idx="20">
                  <c:v>-1.8699602961696655</c:v>
                </c:pt>
                <c:pt idx="21">
                  <c:v>-1.6925191328609799</c:v>
                </c:pt>
                <c:pt idx="22">
                  <c:v>-1.2865624295227462</c:v>
                </c:pt>
                <c:pt idx="23">
                  <c:v>-0.68696577567243367</c:v>
                </c:pt>
                <c:pt idx="24">
                  <c:v>-0.2864110787086247</c:v>
                </c:pt>
                <c:pt idx="25">
                  <c:v>-0.45009539927377773</c:v>
                </c:pt>
                <c:pt idx="26">
                  <c:v>-1.1950090960126545</c:v>
                </c:pt>
                <c:pt idx="27">
                  <c:v>-2.1131203560762515</c:v>
                </c:pt>
                <c:pt idx="28">
                  <c:v>-2.736978760229249</c:v>
                </c:pt>
                <c:pt idx="29">
                  <c:v>-2.9145286053080781</c:v>
                </c:pt>
                <c:pt idx="30">
                  <c:v>-2.6831968663500447</c:v>
                </c:pt>
                <c:pt idx="31">
                  <c:v>-2.0694945594859746</c:v>
                </c:pt>
                <c:pt idx="32">
                  <c:v>-1.19007055153088</c:v>
                </c:pt>
                <c:pt idx="33">
                  <c:v>-0.35403850444527052</c:v>
                </c:pt>
                <c:pt idx="34">
                  <c:v>3.1102177847060375E-2</c:v>
                </c:pt>
                <c:pt idx="35">
                  <c:v>-0.23820488152523467</c:v>
                </c:pt>
                <c:pt idx="36">
                  <c:v>-0.79137476156211051</c:v>
                </c:pt>
                <c:pt idx="37">
                  <c:v>-0.92676891529117711</c:v>
                </c:pt>
                <c:pt idx="38">
                  <c:v>-0.29330092977579625</c:v>
                </c:pt>
                <c:pt idx="39">
                  <c:v>1.0515976334263542</c:v>
                </c:pt>
                <c:pt idx="40">
                  <c:v>2.9491435864929372</c:v>
                </c:pt>
                <c:pt idx="41">
                  <c:v>4.915209181868704</c:v>
                </c:pt>
                <c:pt idx="42">
                  <c:v>5.7880605667887721</c:v>
                </c:pt>
                <c:pt idx="43">
                  <c:v>4.4055766134042642</c:v>
                </c:pt>
                <c:pt idx="44">
                  <c:v>1.0487996622396167</c:v>
                </c:pt>
              </c:numCache>
            </c:numRef>
          </c:val>
          <c:smooth val="0"/>
          <c:extLst>
            <c:ext xmlns:c16="http://schemas.microsoft.com/office/drawing/2014/chart" uri="{C3380CC4-5D6E-409C-BE32-E72D297353CC}">
              <c16:uniqueId val="{00000003-A4F0-4C02-840D-510D3EA7FF30}"/>
            </c:ext>
          </c:extLst>
        </c:ser>
        <c:ser>
          <c:idx val="4"/>
          <c:order val="4"/>
          <c:tx>
            <c:strRef>
              <c:f>Triplex2_62C!$A$40</c:f>
              <c:strCache>
                <c:ptCount val="1"/>
                <c:pt idx="0">
                  <c:v>500 copies</c:v>
                </c:pt>
              </c:strCache>
            </c:strRef>
          </c:tx>
          <c:spPr>
            <a:ln w="28575" cap="rnd">
              <a:solidFill>
                <a:schemeClr val="accent5"/>
              </a:solidFill>
              <a:round/>
            </a:ln>
            <a:effectLst/>
          </c:spPr>
          <c:marker>
            <c:symbol val="none"/>
          </c:marker>
          <c:val>
            <c:numRef>
              <c:f>Triplex2_62C!$B$40:$AT$40</c:f>
              <c:numCache>
                <c:formatCode>General</c:formatCode>
                <c:ptCount val="45"/>
                <c:pt idx="0">
                  <c:v>28.413259612749243</c:v>
                </c:pt>
                <c:pt idx="1">
                  <c:v>20.004592150409735</c:v>
                </c:pt>
                <c:pt idx="2">
                  <c:v>12.792310964239732</c:v>
                </c:pt>
                <c:pt idx="3">
                  <c:v>7.1826634704757453</c:v>
                </c:pt>
                <c:pt idx="4">
                  <c:v>3.0979752788607584</c:v>
                </c:pt>
                <c:pt idx="5">
                  <c:v>0.28944580172355927</c:v>
                </c:pt>
                <c:pt idx="6">
                  <c:v>-1.9416152673238685</c:v>
                </c:pt>
                <c:pt idx="7">
                  <c:v>-4.5535559294658015</c:v>
                </c:pt>
                <c:pt idx="8">
                  <c:v>-7.7318812024441286</c:v>
                </c:pt>
                <c:pt idx="9">
                  <c:v>-10.288821373032988</c:v>
                </c:pt>
                <c:pt idx="10">
                  <c:v>-10.518025782877885</c:v>
                </c:pt>
                <c:pt idx="11">
                  <c:v>-7.8623238087729987</c:v>
                </c:pt>
                <c:pt idx="12">
                  <c:v>-3.51968402791681</c:v>
                </c:pt>
                <c:pt idx="13">
                  <c:v>0.75311125992084271</c:v>
                </c:pt>
                <c:pt idx="14">
                  <c:v>3.926395706979747</c:v>
                </c:pt>
                <c:pt idx="15">
                  <c:v>5.8418991230628308</c:v>
                </c:pt>
                <c:pt idx="16">
                  <c:v>6.7935076860667323</c:v>
                </c:pt>
                <c:pt idx="17">
                  <c:v>7.060338118866639</c:v>
                </c:pt>
                <c:pt idx="18">
                  <c:v>6.6725707301357033</c:v>
                </c:pt>
                <c:pt idx="19">
                  <c:v>5.6941770999201253</c:v>
                </c:pt>
                <c:pt idx="20">
                  <c:v>4.4614690412490745</c:v>
                </c:pt>
                <c:pt idx="21">
                  <c:v>3.2552510879686452</c:v>
                </c:pt>
                <c:pt idx="22">
                  <c:v>2.2533001020874508</c:v>
                </c:pt>
                <c:pt idx="23">
                  <c:v>1.8714065984568151</c:v>
                </c:pt>
                <c:pt idx="24">
                  <c:v>2.4224803649758542</c:v>
                </c:pt>
                <c:pt idx="25">
                  <c:v>3.5658020389473677</c:v>
                </c:pt>
                <c:pt idx="26">
                  <c:v>4.5156143249496381</c:v>
                </c:pt>
                <c:pt idx="27">
                  <c:v>4.5498061775688257</c:v>
                </c:pt>
                <c:pt idx="28">
                  <c:v>3.4626661604306719</c:v>
                </c:pt>
                <c:pt idx="29">
                  <c:v>1.8710601842776668</c:v>
                </c:pt>
                <c:pt idx="30">
                  <c:v>0.70163756020883739</c:v>
                </c:pt>
                <c:pt idx="31">
                  <c:v>0.32883028648029722</c:v>
                </c:pt>
                <c:pt idx="32">
                  <c:v>0.50183231134542439</c:v>
                </c:pt>
                <c:pt idx="33">
                  <c:v>0.74431220493352157</c:v>
                </c:pt>
                <c:pt idx="34">
                  <c:v>0.63183403584480402</c:v>
                </c:pt>
                <c:pt idx="35">
                  <c:v>2.2498883472508169E-2</c:v>
                </c:pt>
                <c:pt idx="36">
                  <c:v>-0.86435396263550501</c:v>
                </c:pt>
                <c:pt idx="37">
                  <c:v>-1.6498214761959389</c:v>
                </c:pt>
                <c:pt idx="38">
                  <c:v>-2.061672771225858</c:v>
                </c:pt>
                <c:pt idx="39">
                  <c:v>-2.1469909601746622</c:v>
                </c:pt>
                <c:pt idx="40">
                  <c:v>-2.3024874875700334</c:v>
                </c:pt>
                <c:pt idx="41">
                  <c:v>-2.9138596867705928</c:v>
                </c:pt>
                <c:pt idx="42">
                  <c:v>-3.8960255067486287</c:v>
                </c:pt>
                <c:pt idx="43">
                  <c:v>-4.7416813592935796</c:v>
                </c:pt>
                <c:pt idx="44">
                  <c:v>-5.1984462875097961</c:v>
                </c:pt>
              </c:numCache>
            </c:numRef>
          </c:val>
          <c:smooth val="0"/>
          <c:extLst>
            <c:ext xmlns:c16="http://schemas.microsoft.com/office/drawing/2014/chart" uri="{C3380CC4-5D6E-409C-BE32-E72D297353CC}">
              <c16:uniqueId val="{00000004-A4F0-4C02-840D-510D3EA7FF30}"/>
            </c:ext>
          </c:extLst>
        </c:ser>
        <c:ser>
          <c:idx val="5"/>
          <c:order val="5"/>
          <c:tx>
            <c:strRef>
              <c:f>Triplex2_62C!$A$43</c:f>
              <c:strCache>
                <c:ptCount val="1"/>
                <c:pt idx="0">
                  <c:v>5,000 copies</c:v>
                </c:pt>
              </c:strCache>
            </c:strRef>
          </c:tx>
          <c:spPr>
            <a:ln w="28575" cap="rnd">
              <a:solidFill>
                <a:schemeClr val="accent6"/>
              </a:solidFill>
              <a:round/>
            </a:ln>
            <a:effectLst/>
          </c:spPr>
          <c:marker>
            <c:symbol val="none"/>
          </c:marker>
          <c:val>
            <c:numRef>
              <c:f>Triplex2_62C!$B$43:$AT$43</c:f>
              <c:numCache>
                <c:formatCode>General</c:formatCode>
                <c:ptCount val="45"/>
                <c:pt idx="0">
                  <c:v>13.892343795052511</c:v>
                </c:pt>
                <c:pt idx="1">
                  <c:v>13.964361099577218</c:v>
                </c:pt>
                <c:pt idx="2">
                  <c:v>13.387022080649331</c:v>
                </c:pt>
                <c:pt idx="3">
                  <c:v>12.029680527923119</c:v>
                </c:pt>
                <c:pt idx="4">
                  <c:v>10.162205198756055</c:v>
                </c:pt>
                <c:pt idx="5">
                  <c:v>8.1124902998526522</c:v>
                </c:pt>
                <c:pt idx="6">
                  <c:v>6.1206122156982019</c:v>
                </c:pt>
                <c:pt idx="7">
                  <c:v>4.3295744257338811</c:v>
                </c:pt>
                <c:pt idx="8">
                  <c:v>2.8212068944703788</c:v>
                </c:pt>
                <c:pt idx="9">
                  <c:v>1.623039306330611</c:v>
                </c:pt>
                <c:pt idx="10">
                  <c:v>0.68296651678610942</c:v>
                </c:pt>
                <c:pt idx="11">
                  <c:v>-6.3718628514834563E-2</c:v>
                </c:pt>
                <c:pt idx="12">
                  <c:v>-0.58521385700623796</c:v>
                </c:pt>
                <c:pt idx="13">
                  <c:v>-0.80427745924316696</c:v>
                </c:pt>
                <c:pt idx="14">
                  <c:v>-0.76573747256952629</c:v>
                </c:pt>
                <c:pt idx="15">
                  <c:v>-0.70987167964085529</c:v>
                </c:pt>
                <c:pt idx="16">
                  <c:v>-0.94125545270981092</c:v>
                </c:pt>
                <c:pt idx="17">
                  <c:v>-1.5682856795065163</c:v>
                </c:pt>
                <c:pt idx="18">
                  <c:v>-2.3898394133448164</c:v>
                </c:pt>
                <c:pt idx="19">
                  <c:v>-3.0962835814880236</c:v>
                </c:pt>
                <c:pt idx="20">
                  <c:v>-3.5173179828125285</c:v>
                </c:pt>
                <c:pt idx="21">
                  <c:v>-3.6213675542931014</c:v>
                </c:pt>
                <c:pt idx="22">
                  <c:v>-3.4427665436778625</c:v>
                </c:pt>
                <c:pt idx="23">
                  <c:v>-3.1181277048999618</c:v>
                </c:pt>
                <c:pt idx="24">
                  <c:v>-2.8421858476704074</c:v>
                </c:pt>
                <c:pt idx="25">
                  <c:v>-2.7185361131905665</c:v>
                </c:pt>
                <c:pt idx="26">
                  <c:v>-2.727299540907552</c:v>
                </c:pt>
                <c:pt idx="27">
                  <c:v>-2.778681775153018</c:v>
                </c:pt>
                <c:pt idx="28">
                  <c:v>-2.7138256342896057</c:v>
                </c:pt>
                <c:pt idx="29">
                  <c:v>-2.4108358006251365</c:v>
                </c:pt>
                <c:pt idx="30">
                  <c:v>-1.9340667958203994</c:v>
                </c:pt>
                <c:pt idx="31">
                  <c:v>-1.3856394654703763</c:v>
                </c:pt>
                <c:pt idx="32">
                  <c:v>-0.78621685115831497</c:v>
                </c:pt>
                <c:pt idx="33">
                  <c:v>-0.21033686098417093</c:v>
                </c:pt>
                <c:pt idx="34">
                  <c:v>0.25832677028847684</c:v>
                </c:pt>
                <c:pt idx="35">
                  <c:v>0.59667147144136834</c:v>
                </c:pt>
                <c:pt idx="36">
                  <c:v>0.72547284517168009</c:v>
                </c:pt>
                <c:pt idx="37">
                  <c:v>0.63714922948202002</c:v>
                </c:pt>
                <c:pt idx="38">
                  <c:v>0.61945635901793139</c:v>
                </c:pt>
                <c:pt idx="39">
                  <c:v>1.0457158577974042</c:v>
                </c:pt>
                <c:pt idx="40">
                  <c:v>1.9952889015366964</c:v>
                </c:pt>
                <c:pt idx="41">
                  <c:v>3.1582015723524819</c:v>
                </c:pt>
                <c:pt idx="42">
                  <c:v>4.0334217487052229</c:v>
                </c:pt>
                <c:pt idx="43">
                  <c:v>4.2977770364796015</c:v>
                </c:pt>
                <c:pt idx="44">
                  <c:v>4.0743162439302978</c:v>
                </c:pt>
              </c:numCache>
            </c:numRef>
          </c:val>
          <c:smooth val="0"/>
          <c:extLst>
            <c:ext xmlns:c16="http://schemas.microsoft.com/office/drawing/2014/chart" uri="{C3380CC4-5D6E-409C-BE32-E72D297353CC}">
              <c16:uniqueId val="{00000005-A4F0-4C02-840D-510D3EA7FF30}"/>
            </c:ext>
          </c:extLst>
        </c:ser>
        <c:ser>
          <c:idx val="6"/>
          <c:order val="6"/>
          <c:tx>
            <c:strRef>
              <c:f>Triplex2_62C!$A$46</c:f>
              <c:strCache>
                <c:ptCount val="1"/>
                <c:pt idx="0">
                  <c:v>5,000 copies</c:v>
                </c:pt>
              </c:strCache>
            </c:strRef>
          </c:tx>
          <c:spPr>
            <a:ln w="28575" cap="rnd">
              <a:solidFill>
                <a:schemeClr val="accent1">
                  <a:lumMod val="60000"/>
                </a:schemeClr>
              </a:solidFill>
              <a:round/>
            </a:ln>
            <a:effectLst/>
          </c:spPr>
          <c:marker>
            <c:symbol val="none"/>
          </c:marker>
          <c:val>
            <c:numRef>
              <c:f>Triplex2_62C!$B$46:$AT$46</c:f>
              <c:numCache>
                <c:formatCode>General</c:formatCode>
                <c:ptCount val="45"/>
                <c:pt idx="0">
                  <c:v>30.170757546044115</c:v>
                </c:pt>
                <c:pt idx="1">
                  <c:v>24.151419504310979</c:v>
                </c:pt>
                <c:pt idx="2">
                  <c:v>19.094968603651068</c:v>
                </c:pt>
                <c:pt idx="3">
                  <c:v>15.237222954187018</c:v>
                </c:pt>
                <c:pt idx="4">
                  <c:v>12.233207388933806</c:v>
                </c:pt>
                <c:pt idx="5">
                  <c:v>9.6598280498201348</c:v>
                </c:pt>
                <c:pt idx="6">
                  <c:v>7.2467087210861791</c:v>
                </c:pt>
                <c:pt idx="7">
                  <c:v>4.9504116494317714</c:v>
                </c:pt>
                <c:pt idx="8">
                  <c:v>2.9191530851494463</c:v>
                </c:pt>
                <c:pt idx="9">
                  <c:v>1.302872471163937</c:v>
                </c:pt>
                <c:pt idx="10">
                  <c:v>0.13333567701010907</c:v>
                </c:pt>
                <c:pt idx="11">
                  <c:v>-0.63351132013121969</c:v>
                </c:pt>
                <c:pt idx="12">
                  <c:v>-1.0762786265822797</c:v>
                </c:pt>
                <c:pt idx="13">
                  <c:v>-1.3437223754517618</c:v>
                </c:pt>
                <c:pt idx="14">
                  <c:v>-1.6256690307527606</c:v>
                </c:pt>
                <c:pt idx="15">
                  <c:v>-1.9971094205320696</c:v>
                </c:pt>
                <c:pt idx="16">
                  <c:v>-2.385591071430099</c:v>
                </c:pt>
                <c:pt idx="17">
                  <c:v>-2.7203277129701746</c:v>
                </c:pt>
                <c:pt idx="18">
                  <c:v>-2.9769671965950693</c:v>
                </c:pt>
                <c:pt idx="19">
                  <c:v>-3.1181899639541371</c:v>
                </c:pt>
                <c:pt idx="20">
                  <c:v>-3.0895563643844071</c:v>
                </c:pt>
                <c:pt idx="21">
                  <c:v>-2.8842434338494058</c:v>
                </c:pt>
                <c:pt idx="22">
                  <c:v>-2.6354576742232894</c:v>
                </c:pt>
                <c:pt idx="23">
                  <c:v>-2.5457954955145397</c:v>
                </c:pt>
                <c:pt idx="24">
                  <c:v>-2.635303025790563</c:v>
                </c:pt>
                <c:pt idx="25">
                  <c:v>-2.6861153140835086</c:v>
                </c:pt>
                <c:pt idx="26">
                  <c:v>-2.5282713265678467</c:v>
                </c:pt>
                <c:pt idx="27">
                  <c:v>-2.2423957673436234</c:v>
                </c:pt>
                <c:pt idx="28">
                  <c:v>-1.9929526599498786</c:v>
                </c:pt>
                <c:pt idx="29">
                  <c:v>-1.804766578012277</c:v>
                </c:pt>
                <c:pt idx="30">
                  <c:v>-1.5831347757430194</c:v>
                </c:pt>
                <c:pt idx="31">
                  <c:v>-1.2555923325471667</c:v>
                </c:pt>
                <c:pt idx="32">
                  <c:v>-0.84764375300437678</c:v>
                </c:pt>
                <c:pt idx="33">
                  <c:v>-0.43886829066286737</c:v>
                </c:pt>
                <c:pt idx="34">
                  <c:v>-8.6473610263055889E-2</c:v>
                </c:pt>
                <c:pt idx="35">
                  <c:v>0.20715260725955886</c:v>
                </c:pt>
                <c:pt idx="36">
                  <c:v>0.53433949505961209</c:v>
                </c:pt>
                <c:pt idx="37">
                  <c:v>1.0094703178383497</c:v>
                </c:pt>
                <c:pt idx="38">
                  <c:v>1.5949193657543219</c:v>
                </c:pt>
                <c:pt idx="39">
                  <c:v>2.1325819410740223</c:v>
                </c:pt>
                <c:pt idx="40">
                  <c:v>2.5279751030666375</c:v>
                </c:pt>
                <c:pt idx="41">
                  <c:v>2.8050375556940708</c:v>
                </c:pt>
                <c:pt idx="42">
                  <c:v>3.0470078260714217</c:v>
                </c:pt>
                <c:pt idx="43">
                  <c:v>3.3438987203226134</c:v>
                </c:pt>
                <c:pt idx="44">
                  <c:v>3.7192445344971929</c:v>
                </c:pt>
              </c:numCache>
            </c:numRef>
          </c:val>
          <c:smooth val="0"/>
          <c:extLst>
            <c:ext xmlns:c16="http://schemas.microsoft.com/office/drawing/2014/chart" uri="{C3380CC4-5D6E-409C-BE32-E72D297353CC}">
              <c16:uniqueId val="{00000006-A4F0-4C02-840D-510D3EA7FF30}"/>
            </c:ext>
          </c:extLst>
        </c:ser>
        <c:ser>
          <c:idx val="7"/>
          <c:order val="7"/>
          <c:tx>
            <c:strRef>
              <c:f>Triplex2_62C!$A$49</c:f>
              <c:strCache>
                <c:ptCount val="1"/>
                <c:pt idx="0">
                  <c:v>50,000 copies</c:v>
                </c:pt>
              </c:strCache>
            </c:strRef>
          </c:tx>
          <c:spPr>
            <a:ln w="28575" cap="rnd">
              <a:solidFill>
                <a:schemeClr val="accent2">
                  <a:lumMod val="60000"/>
                </a:schemeClr>
              </a:solidFill>
              <a:round/>
            </a:ln>
            <a:effectLst/>
          </c:spPr>
          <c:marker>
            <c:symbol val="none"/>
          </c:marker>
          <c:val>
            <c:numRef>
              <c:f>Triplex2_62C!$B$49:$AT$49</c:f>
              <c:numCache>
                <c:formatCode>General</c:formatCode>
                <c:ptCount val="45"/>
                <c:pt idx="0">
                  <c:v>6.8031902968432405</c:v>
                </c:pt>
                <c:pt idx="1">
                  <c:v>4.195512118671104</c:v>
                </c:pt>
                <c:pt idx="2">
                  <c:v>2.0789949692571099</c:v>
                </c:pt>
                <c:pt idx="3">
                  <c:v>0.75751685519389866</c:v>
                </c:pt>
                <c:pt idx="4">
                  <c:v>0.2068340555888426</c:v>
                </c:pt>
                <c:pt idx="5">
                  <c:v>0.14591261503119313</c:v>
                </c:pt>
                <c:pt idx="6">
                  <c:v>0.25045287523971638</c:v>
                </c:pt>
                <c:pt idx="7">
                  <c:v>0.25422498585976427</c:v>
                </c:pt>
                <c:pt idx="8">
                  <c:v>-2.1280770251905778E-3</c:v>
                </c:pt>
                <c:pt idx="9">
                  <c:v>-0.42428764505166328</c:v>
                </c:pt>
                <c:pt idx="10">
                  <c:v>-0.66087093775058747</c:v>
                </c:pt>
                <c:pt idx="11">
                  <c:v>-0.44270482365755015</c:v>
                </c:pt>
                <c:pt idx="12">
                  <c:v>0.12999246374056384</c:v>
                </c:pt>
                <c:pt idx="13">
                  <c:v>0.74940854361193487</c:v>
                </c:pt>
                <c:pt idx="14">
                  <c:v>1.2814249521416059</c:v>
                </c:pt>
                <c:pt idx="15">
                  <c:v>1.8811996324875508</c:v>
                </c:pt>
                <c:pt idx="16">
                  <c:v>2.7483453005697811</c:v>
                </c:pt>
                <c:pt idx="17">
                  <c:v>3.8712690787888278</c:v>
                </c:pt>
                <c:pt idx="18">
                  <c:v>5.0296110447361571</c:v>
                </c:pt>
                <c:pt idx="19">
                  <c:v>6.0400902886303811</c:v>
                </c:pt>
                <c:pt idx="20">
                  <c:v>6.9763769117507763</c:v>
                </c:pt>
                <c:pt idx="21">
                  <c:v>8.0551990378244227</c:v>
                </c:pt>
                <c:pt idx="22">
                  <c:v>9.335325823220046</c:v>
                </c:pt>
                <c:pt idx="23">
                  <c:v>10.649890059703466</c:v>
                </c:pt>
                <c:pt idx="24">
                  <c:v>11.865230275867361</c:v>
                </c:pt>
                <c:pt idx="25">
                  <c:v>13.071225123158001</c:v>
                </c:pt>
                <c:pt idx="26">
                  <c:v>14.394592056016336</c:v>
                </c:pt>
                <c:pt idx="27">
                  <c:v>15.782841481992364</c:v>
                </c:pt>
                <c:pt idx="28">
                  <c:v>17.119284137163049</c:v>
                </c:pt>
                <c:pt idx="29">
                  <c:v>18.395244304738299</c:v>
                </c:pt>
                <c:pt idx="30">
                  <c:v>19.650105151444222</c:v>
                </c:pt>
                <c:pt idx="31">
                  <c:v>20.883347141696504</c:v>
                </c:pt>
                <c:pt idx="32">
                  <c:v>22.1127329975061</c:v>
                </c:pt>
                <c:pt idx="33">
                  <c:v>23.416611739781729</c:v>
                </c:pt>
                <c:pt idx="34">
                  <c:v>24.851329402054034</c:v>
                </c:pt>
                <c:pt idx="35">
                  <c:v>26.351225468588382</c:v>
                </c:pt>
                <c:pt idx="36">
                  <c:v>27.781542353752229</c:v>
                </c:pt>
                <c:pt idx="37">
                  <c:v>29.096635885982323</c:v>
                </c:pt>
                <c:pt idx="38">
                  <c:v>30.361749108709773</c:v>
                </c:pt>
                <c:pt idx="39">
                  <c:v>31.618262460891856</c:v>
                </c:pt>
                <c:pt idx="40">
                  <c:v>32.837069859306212</c:v>
                </c:pt>
                <c:pt idx="41">
                  <c:v>34.029944367926873</c:v>
                </c:pt>
                <c:pt idx="42">
                  <c:v>35.285159497081622</c:v>
                </c:pt>
                <c:pt idx="43">
                  <c:v>36.688376352938576</c:v>
                </c:pt>
                <c:pt idx="44">
                  <c:v>38.231853484532621</c:v>
                </c:pt>
              </c:numCache>
            </c:numRef>
          </c:val>
          <c:smooth val="0"/>
          <c:extLst>
            <c:ext xmlns:c16="http://schemas.microsoft.com/office/drawing/2014/chart" uri="{C3380CC4-5D6E-409C-BE32-E72D297353CC}">
              <c16:uniqueId val="{00000007-A4F0-4C02-840D-510D3EA7FF30}"/>
            </c:ext>
          </c:extLst>
        </c:ser>
        <c:ser>
          <c:idx val="8"/>
          <c:order val="8"/>
          <c:tx>
            <c:strRef>
              <c:f>Triplex2_62C!$A$52</c:f>
              <c:strCache>
                <c:ptCount val="1"/>
                <c:pt idx="0">
                  <c:v>50,000 copies</c:v>
                </c:pt>
              </c:strCache>
            </c:strRef>
          </c:tx>
          <c:spPr>
            <a:ln w="28575" cap="rnd">
              <a:solidFill>
                <a:schemeClr val="accent3">
                  <a:lumMod val="60000"/>
                </a:schemeClr>
              </a:solidFill>
              <a:round/>
            </a:ln>
            <a:effectLst/>
          </c:spPr>
          <c:marker>
            <c:symbol val="none"/>
          </c:marker>
          <c:val>
            <c:numRef>
              <c:f>Triplex2_62C!$B$52:$AT$52</c:f>
              <c:numCache>
                <c:formatCode>General</c:formatCode>
                <c:ptCount val="45"/>
                <c:pt idx="0">
                  <c:v>16.135893566448431</c:v>
                </c:pt>
                <c:pt idx="1">
                  <c:v>13.054954697423454</c:v>
                </c:pt>
                <c:pt idx="2">
                  <c:v>9.6058835112089582</c:v>
                </c:pt>
                <c:pt idx="3">
                  <c:v>5.9762331382680713</c:v>
                </c:pt>
                <c:pt idx="4">
                  <c:v>3.0015125095233088</c:v>
                </c:pt>
                <c:pt idx="5">
                  <c:v>1.6751675276373135</c:v>
                </c:pt>
                <c:pt idx="6">
                  <c:v>2.1356920063917642</c:v>
                </c:pt>
                <c:pt idx="7">
                  <c:v>3.2868768149310199</c:v>
                </c:pt>
                <c:pt idx="8">
                  <c:v>3.8745224402809981</c:v>
                </c:pt>
                <c:pt idx="9">
                  <c:v>3.5715136665075988</c:v>
                </c:pt>
                <c:pt idx="10">
                  <c:v>2.7588342746894341</c:v>
                </c:pt>
                <c:pt idx="11">
                  <c:v>1.8556301869230083</c:v>
                </c:pt>
                <c:pt idx="12">
                  <c:v>1.1367475007973553</c:v>
                </c:pt>
                <c:pt idx="13">
                  <c:v>0.7575290976674296</c:v>
                </c:pt>
                <c:pt idx="14">
                  <c:v>0.68030084019301285</c:v>
                </c:pt>
                <c:pt idx="15">
                  <c:v>0.5895450112693652</c:v>
                </c:pt>
                <c:pt idx="16">
                  <c:v>6.7858662094295141E-2</c:v>
                </c:pt>
                <c:pt idx="17">
                  <c:v>-0.96824071109949728</c:v>
                </c:pt>
                <c:pt idx="18">
                  <c:v>-2.1425081143715943</c:v>
                </c:pt>
                <c:pt idx="19">
                  <c:v>-2.955107117542866</c:v>
                </c:pt>
                <c:pt idx="20">
                  <c:v>-3.1712600115242822</c:v>
                </c:pt>
                <c:pt idx="21">
                  <c:v>-2.9525528380527248</c:v>
                </c:pt>
                <c:pt idx="22">
                  <c:v>-2.6526620636996086</c:v>
                </c:pt>
                <c:pt idx="23">
                  <c:v>-2.5669646554324572</c:v>
                </c:pt>
                <c:pt idx="24">
                  <c:v>-2.7712588279955526</c:v>
                </c:pt>
                <c:pt idx="25">
                  <c:v>-3.0480444378990796</c:v>
                </c:pt>
                <c:pt idx="26">
                  <c:v>-3.2079085316363489</c:v>
                </c:pt>
                <c:pt idx="27">
                  <c:v>-3.3829919872914616</c:v>
                </c:pt>
                <c:pt idx="28">
                  <c:v>-3.6343937910587556</c:v>
                </c:pt>
                <c:pt idx="29">
                  <c:v>-3.6593346987010591</c:v>
                </c:pt>
                <c:pt idx="30">
                  <c:v>-3.208923675265396</c:v>
                </c:pt>
                <c:pt idx="31">
                  <c:v>-2.3996990595314855</c:v>
                </c:pt>
                <c:pt idx="32">
                  <c:v>-1.5242340505883476</c:v>
                </c:pt>
                <c:pt idx="33">
                  <c:v>-0.74856344320505741</c:v>
                </c:pt>
                <c:pt idx="34">
                  <c:v>-2.8915889202835388E-2</c:v>
                </c:pt>
                <c:pt idx="35">
                  <c:v>0.65175264935714949</c:v>
                </c:pt>
                <c:pt idx="36">
                  <c:v>1.125261657512965</c:v>
                </c:pt>
                <c:pt idx="37">
                  <c:v>1.302515065532134</c:v>
                </c:pt>
                <c:pt idx="38">
                  <c:v>1.3860665897864237</c:v>
                </c:pt>
                <c:pt idx="39">
                  <c:v>1.642358457802402</c:v>
                </c:pt>
                <c:pt idx="40">
                  <c:v>2.2105085740186041</c:v>
                </c:pt>
                <c:pt idx="41">
                  <c:v>3.0185618140003498</c:v>
                </c:pt>
                <c:pt idx="42">
                  <c:v>3.6911588792754628</c:v>
                </c:pt>
                <c:pt idx="43">
                  <c:v>3.8927941310976166</c:v>
                </c:pt>
                <c:pt idx="44">
                  <c:v>3.7123680563036032</c:v>
                </c:pt>
              </c:numCache>
            </c:numRef>
          </c:val>
          <c:smooth val="0"/>
          <c:extLst>
            <c:ext xmlns:c16="http://schemas.microsoft.com/office/drawing/2014/chart" uri="{C3380CC4-5D6E-409C-BE32-E72D297353CC}">
              <c16:uniqueId val="{00000008-A4F0-4C02-840D-510D3EA7FF30}"/>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1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 S:215G</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62C!$A$29</c:f>
              <c:strCache>
                <c:ptCount val="1"/>
                <c:pt idx="0">
                  <c:v>NTC</c:v>
                </c:pt>
              </c:strCache>
            </c:strRef>
          </c:tx>
          <c:spPr>
            <a:ln w="28575" cap="rnd">
              <a:solidFill>
                <a:schemeClr val="accent1"/>
              </a:solidFill>
              <a:round/>
            </a:ln>
            <a:effectLst/>
          </c:spPr>
          <c:marker>
            <c:symbol val="none"/>
          </c:marker>
          <c:val>
            <c:numRef>
              <c:f>Triplex2_62C!$B$29:$AT$29</c:f>
              <c:numCache>
                <c:formatCode>General</c:formatCode>
                <c:ptCount val="45"/>
                <c:pt idx="0">
                  <c:v>0.85603632271340757</c:v>
                </c:pt>
                <c:pt idx="1">
                  <c:v>-4.0140204193994578</c:v>
                </c:pt>
                <c:pt idx="2">
                  <c:v>-7.6642449963328545</c:v>
                </c:pt>
                <c:pt idx="3">
                  <c:v>-9.6464527588250348</c:v>
                </c:pt>
                <c:pt idx="4">
                  <c:v>-10.220264970861535</c:v>
                </c:pt>
                <c:pt idx="5">
                  <c:v>-9.8783280808929703</c:v>
                </c:pt>
                <c:pt idx="6">
                  <c:v>-9.0312909070889873</c:v>
                </c:pt>
                <c:pt idx="7">
                  <c:v>-7.943107073126157</c:v>
                </c:pt>
                <c:pt idx="8">
                  <c:v>-6.8244564783854003</c:v>
                </c:pt>
                <c:pt idx="9">
                  <c:v>-5.8358547057632677</c:v>
                </c:pt>
                <c:pt idx="10">
                  <c:v>-4.8975561626994022</c:v>
                </c:pt>
                <c:pt idx="11">
                  <c:v>-3.5707402809530322</c:v>
                </c:pt>
                <c:pt idx="12">
                  <c:v>-1.3536837017254584</c:v>
                </c:pt>
                <c:pt idx="13">
                  <c:v>1.6062852692921297</c:v>
                </c:pt>
                <c:pt idx="14">
                  <c:v>4.2018555042723165</c:v>
                </c:pt>
                <c:pt idx="15">
                  <c:v>5.3697167656955571</c:v>
                </c:pt>
                <c:pt idx="16">
                  <c:v>5.2695409269526863</c:v>
                </c:pt>
                <c:pt idx="17">
                  <c:v>4.7662761788360513</c:v>
                </c:pt>
                <c:pt idx="18">
                  <c:v>4.3403204410678882</c:v>
                </c:pt>
                <c:pt idx="19">
                  <c:v>4.2912149680723815</c:v>
                </c:pt>
                <c:pt idx="20">
                  <c:v>5.088166928566352</c:v>
                </c:pt>
                <c:pt idx="21">
                  <c:v>6.503891261838362</c:v>
                </c:pt>
                <c:pt idx="22">
                  <c:v>7.1433749921416165</c:v>
                </c:pt>
                <c:pt idx="23">
                  <c:v>6.0573991832079628</c:v>
                </c:pt>
                <c:pt idx="24">
                  <c:v>4.1732790490423213</c:v>
                </c:pt>
                <c:pt idx="25">
                  <c:v>3.0432829630572087</c:v>
                </c:pt>
                <c:pt idx="26">
                  <c:v>3.0789728200270474</c:v>
                </c:pt>
                <c:pt idx="27">
                  <c:v>3.6269500656981108</c:v>
                </c:pt>
                <c:pt idx="28">
                  <c:v>3.9217532037346245</c:v>
                </c:pt>
                <c:pt idx="29">
                  <c:v>3.6957536869758769</c:v>
                </c:pt>
                <c:pt idx="30">
                  <c:v>3.1812760801058175</c:v>
                </c:pt>
                <c:pt idx="31">
                  <c:v>2.6272391045786208</c:v>
                </c:pt>
                <c:pt idx="32">
                  <c:v>1.9958852605850552</c:v>
                </c:pt>
                <c:pt idx="33">
                  <c:v>1.1523383322855807</c:v>
                </c:pt>
                <c:pt idx="34">
                  <c:v>0.11430253711841942</c:v>
                </c:pt>
                <c:pt idx="35">
                  <c:v>-0.82884706119148177</c:v>
                </c:pt>
                <c:pt idx="36">
                  <c:v>-1.3093457010581915</c:v>
                </c:pt>
                <c:pt idx="37">
                  <c:v>-1.360130325285354</c:v>
                </c:pt>
                <c:pt idx="38">
                  <c:v>-1.3522142853071273</c:v>
                </c:pt>
                <c:pt idx="39">
                  <c:v>-1.49713316829002</c:v>
                </c:pt>
                <c:pt idx="40">
                  <c:v>-1.9017007181428198</c:v>
                </c:pt>
                <c:pt idx="41">
                  <c:v>-2.8896591447519313</c:v>
                </c:pt>
                <c:pt idx="42">
                  <c:v>-4.8732804967621632</c:v>
                </c:pt>
                <c:pt idx="43">
                  <c:v>-7.9960896692682581</c:v>
                </c:pt>
                <c:pt idx="44">
                  <c:v>-11.905657562472697</c:v>
                </c:pt>
              </c:numCache>
            </c:numRef>
          </c:val>
          <c:smooth val="0"/>
          <c:extLst>
            <c:ext xmlns:c16="http://schemas.microsoft.com/office/drawing/2014/chart" uri="{C3380CC4-5D6E-409C-BE32-E72D297353CC}">
              <c16:uniqueId val="{00000000-D437-4A5A-AAFA-D1AE512EDE85}"/>
            </c:ext>
          </c:extLst>
        </c:ser>
        <c:ser>
          <c:idx val="1"/>
          <c:order val="1"/>
          <c:tx>
            <c:strRef>
              <c:f>Triplex2_62C!$A$32</c:f>
              <c:strCache>
                <c:ptCount val="1"/>
                <c:pt idx="0">
                  <c:v>50 copies</c:v>
                </c:pt>
              </c:strCache>
            </c:strRef>
          </c:tx>
          <c:spPr>
            <a:ln w="28575" cap="rnd">
              <a:solidFill>
                <a:schemeClr val="accent2"/>
              </a:solidFill>
              <a:round/>
            </a:ln>
            <a:effectLst/>
          </c:spPr>
          <c:marker>
            <c:symbol val="none"/>
          </c:marker>
          <c:val>
            <c:numRef>
              <c:f>Triplex2_62C!$B$32:$AT$32</c:f>
              <c:numCache>
                <c:formatCode>General</c:formatCode>
                <c:ptCount val="45"/>
                <c:pt idx="0">
                  <c:v>8.156113225095396</c:v>
                </c:pt>
                <c:pt idx="1">
                  <c:v>10.213679785158092</c:v>
                </c:pt>
                <c:pt idx="2">
                  <c:v>10.19325849066081</c:v>
                </c:pt>
                <c:pt idx="3">
                  <c:v>7.7606286942154838</c:v>
                </c:pt>
                <c:pt idx="4">
                  <c:v>4.2823025045217946</c:v>
                </c:pt>
                <c:pt idx="5">
                  <c:v>1.4526594885992381</c:v>
                </c:pt>
                <c:pt idx="6">
                  <c:v>2.2427885414799675E-3</c:v>
                </c:pt>
                <c:pt idx="7">
                  <c:v>-0.53537548500753473</c:v>
                </c:pt>
                <c:pt idx="8">
                  <c:v>-0.9309628411756421</c:v>
                </c:pt>
                <c:pt idx="9">
                  <c:v>-1.4056117482577974</c:v>
                </c:pt>
                <c:pt idx="10">
                  <c:v>-1.7269521818998328</c:v>
                </c:pt>
                <c:pt idx="11">
                  <c:v>-1.6284840841653931</c:v>
                </c:pt>
                <c:pt idx="12">
                  <c:v>-1.0714905798649852</c:v>
                </c:pt>
                <c:pt idx="13">
                  <c:v>-0.43218160309515952</c:v>
                </c:pt>
                <c:pt idx="14">
                  <c:v>-0.15672564079250151</c:v>
                </c:pt>
                <c:pt idx="15">
                  <c:v>-0.27697794389314367</c:v>
                </c:pt>
                <c:pt idx="16">
                  <c:v>-0.55627587980779936</c:v>
                </c:pt>
                <c:pt idx="17">
                  <c:v>-0.74521785867182189</c:v>
                </c:pt>
                <c:pt idx="18">
                  <c:v>-0.6750886516601895</c:v>
                </c:pt>
                <c:pt idx="19">
                  <c:v>-0.39962986228965747</c:v>
                </c:pt>
                <c:pt idx="20">
                  <c:v>-0.10317210904759122</c:v>
                </c:pt>
                <c:pt idx="21">
                  <c:v>0.1946996416318143</c:v>
                </c:pt>
                <c:pt idx="22">
                  <c:v>0.62552876672998536</c:v>
                </c:pt>
                <c:pt idx="23">
                  <c:v>1.1712003684042429</c:v>
                </c:pt>
                <c:pt idx="24">
                  <c:v>1.6151863263639825</c:v>
                </c:pt>
                <c:pt idx="25">
                  <c:v>1.7867735035761143</c:v>
                </c:pt>
                <c:pt idx="26">
                  <c:v>1.6896259531349642</c:v>
                </c:pt>
                <c:pt idx="27">
                  <c:v>1.440102160020615</c:v>
                </c:pt>
                <c:pt idx="28">
                  <c:v>1.2031871560848231</c:v>
                </c:pt>
                <c:pt idx="29">
                  <c:v>1.1054568838881096</c:v>
                </c:pt>
                <c:pt idx="30">
                  <c:v>1.1532067796470074</c:v>
                </c:pt>
                <c:pt idx="31">
                  <c:v>1.3054414741891378</c:v>
                </c:pt>
                <c:pt idx="32">
                  <c:v>1.4878965313109802</c:v>
                </c:pt>
                <c:pt idx="33">
                  <c:v>1.5129605911024555</c:v>
                </c:pt>
                <c:pt idx="34">
                  <c:v>1.244534335897697</c:v>
                </c:pt>
                <c:pt idx="35">
                  <c:v>0.80034482770315662</c:v>
                </c:pt>
                <c:pt idx="36">
                  <c:v>0.43689231421376462</c:v>
                </c:pt>
                <c:pt idx="37">
                  <c:v>0.30860076767748978</c:v>
                </c:pt>
                <c:pt idx="38">
                  <c:v>0.34631636657650233</c:v>
                </c:pt>
                <c:pt idx="39">
                  <c:v>0.28304274102083582</c:v>
                </c:pt>
                <c:pt idx="40">
                  <c:v>-0.18645350029873953</c:v>
                </c:pt>
                <c:pt idx="41">
                  <c:v>-1.1363489904870221</c:v>
                </c:pt>
                <c:pt idx="42">
                  <c:v>-2.2651861485555855</c:v>
                </c:pt>
                <c:pt idx="43">
                  <c:v>-3.1672192333062412</c:v>
                </c:pt>
                <c:pt idx="44">
                  <c:v>-3.7665454239704559</c:v>
                </c:pt>
              </c:numCache>
            </c:numRef>
          </c:val>
          <c:smooth val="0"/>
          <c:extLst>
            <c:ext xmlns:c16="http://schemas.microsoft.com/office/drawing/2014/chart" uri="{C3380CC4-5D6E-409C-BE32-E72D297353CC}">
              <c16:uniqueId val="{00000001-D437-4A5A-AAFA-D1AE512EDE85}"/>
            </c:ext>
          </c:extLst>
        </c:ser>
        <c:ser>
          <c:idx val="2"/>
          <c:order val="2"/>
          <c:tx>
            <c:strRef>
              <c:f>Triplex2_62C!$A$35</c:f>
              <c:strCache>
                <c:ptCount val="1"/>
                <c:pt idx="0">
                  <c:v>50 copies</c:v>
                </c:pt>
              </c:strCache>
            </c:strRef>
          </c:tx>
          <c:spPr>
            <a:ln w="28575" cap="rnd">
              <a:solidFill>
                <a:schemeClr val="accent3"/>
              </a:solidFill>
              <a:round/>
            </a:ln>
            <a:effectLst/>
          </c:spPr>
          <c:marker>
            <c:symbol val="none"/>
          </c:marker>
          <c:val>
            <c:numRef>
              <c:f>Triplex2_62C!$B$35:$AT$35</c:f>
              <c:numCache>
                <c:formatCode>General</c:formatCode>
                <c:ptCount val="45"/>
                <c:pt idx="0">
                  <c:v>10.921147686229233</c:v>
                </c:pt>
                <c:pt idx="1">
                  <c:v>10.29174288575814</c:v>
                </c:pt>
                <c:pt idx="2">
                  <c:v>9.5037790712303831</c:v>
                </c:pt>
                <c:pt idx="3">
                  <c:v>8.4539239787027327</c:v>
                </c:pt>
                <c:pt idx="4">
                  <c:v>7.1563840870221611</c:v>
                </c:pt>
                <c:pt idx="5">
                  <c:v>5.7233335167966288</c:v>
                </c:pt>
                <c:pt idx="6">
                  <c:v>4.2820426331218187</c:v>
                </c:pt>
                <c:pt idx="7">
                  <c:v>2.960503752965451</c:v>
                </c:pt>
                <c:pt idx="8">
                  <c:v>1.8464957416508696</c:v>
                </c:pt>
                <c:pt idx="9">
                  <c:v>0.87280470588666503</c:v>
                </c:pt>
                <c:pt idx="10">
                  <c:v>-0.10369337177689886</c:v>
                </c:pt>
                <c:pt idx="11">
                  <c:v>-1.0491673259857635</c:v>
                </c:pt>
                <c:pt idx="12">
                  <c:v>-1.7358670192861609</c:v>
                </c:pt>
                <c:pt idx="13">
                  <c:v>-2.0109553527090611</c:v>
                </c:pt>
                <c:pt idx="14">
                  <c:v>-1.94831350167442</c:v>
                </c:pt>
                <c:pt idx="15">
                  <c:v>-1.7434743862213509</c:v>
                </c:pt>
                <c:pt idx="16">
                  <c:v>-1.5812421782138699</c:v>
                </c:pt>
                <c:pt idx="17">
                  <c:v>-1.5386780708140577</c:v>
                </c:pt>
                <c:pt idx="18">
                  <c:v>-1.5550319410122029</c:v>
                </c:pt>
                <c:pt idx="19">
                  <c:v>-1.5955144461076998</c:v>
                </c:pt>
                <c:pt idx="20">
                  <c:v>-1.7063242300027923</c:v>
                </c:pt>
                <c:pt idx="21">
                  <c:v>-1.7872075126797426</c:v>
                </c:pt>
                <c:pt idx="22">
                  <c:v>-1.6339173651449528</c:v>
                </c:pt>
                <c:pt idx="23">
                  <c:v>-1.3067621941627294</c:v>
                </c:pt>
                <c:pt idx="24">
                  <c:v>-1.0729139998657047</c:v>
                </c:pt>
                <c:pt idx="25">
                  <c:v>-0.94707281308365054</c:v>
                </c:pt>
                <c:pt idx="26">
                  <c:v>-0.67960576283803675</c:v>
                </c:pt>
                <c:pt idx="27">
                  <c:v>-0.20297400344134076</c:v>
                </c:pt>
                <c:pt idx="28">
                  <c:v>0.24119174750194361</c:v>
                </c:pt>
                <c:pt idx="29">
                  <c:v>0.43770614775712602</c:v>
                </c:pt>
                <c:pt idx="30">
                  <c:v>0.43881834747480752</c:v>
                </c:pt>
                <c:pt idx="31">
                  <c:v>0.39845887769479305</c:v>
                </c:pt>
                <c:pt idx="32">
                  <c:v>0.34234285256934527</c:v>
                </c:pt>
                <c:pt idx="33">
                  <c:v>0.24035113011814246</c:v>
                </c:pt>
                <c:pt idx="34">
                  <c:v>0.12620674235404294</c:v>
                </c:pt>
                <c:pt idx="35">
                  <c:v>3.4324655709497165E-2</c:v>
                </c:pt>
                <c:pt idx="36">
                  <c:v>-2.5935975005268119E-2</c:v>
                </c:pt>
                <c:pt idx="37">
                  <c:v>-1.6659720957250101E-2</c:v>
                </c:pt>
                <c:pt idx="38">
                  <c:v>9.2686414789568516E-2</c:v>
                </c:pt>
                <c:pt idx="39">
                  <c:v>0.25381381279112247</c:v>
                </c:pt>
                <c:pt idx="40">
                  <c:v>0.42485102517093765</c:v>
                </c:pt>
                <c:pt idx="41">
                  <c:v>0.69585569292758009</c:v>
                </c:pt>
                <c:pt idx="42">
                  <c:v>1.1409521377445344</c:v>
                </c:pt>
                <c:pt idx="43">
                  <c:v>1.6359843014215585</c:v>
                </c:pt>
                <c:pt idx="44">
                  <c:v>2.0525869345547108</c:v>
                </c:pt>
              </c:numCache>
            </c:numRef>
          </c:val>
          <c:smooth val="0"/>
          <c:extLst>
            <c:ext xmlns:c16="http://schemas.microsoft.com/office/drawing/2014/chart" uri="{C3380CC4-5D6E-409C-BE32-E72D297353CC}">
              <c16:uniqueId val="{00000002-D437-4A5A-AAFA-D1AE512EDE85}"/>
            </c:ext>
          </c:extLst>
        </c:ser>
        <c:ser>
          <c:idx val="3"/>
          <c:order val="3"/>
          <c:tx>
            <c:strRef>
              <c:f>Triplex2_62C!$A$38</c:f>
              <c:strCache>
                <c:ptCount val="1"/>
                <c:pt idx="0">
                  <c:v>500 copies</c:v>
                </c:pt>
              </c:strCache>
            </c:strRef>
          </c:tx>
          <c:spPr>
            <a:ln w="28575" cap="rnd">
              <a:solidFill>
                <a:schemeClr val="accent4"/>
              </a:solidFill>
              <a:round/>
            </a:ln>
            <a:effectLst/>
          </c:spPr>
          <c:marker>
            <c:symbol val="none"/>
          </c:marker>
          <c:val>
            <c:numRef>
              <c:f>Triplex2_62C!$B$38:$AT$38</c:f>
              <c:numCache>
                <c:formatCode>General</c:formatCode>
                <c:ptCount val="45"/>
                <c:pt idx="0">
                  <c:v>25.143979062419021</c:v>
                </c:pt>
                <c:pt idx="1">
                  <c:v>19.826361223631466</c:v>
                </c:pt>
                <c:pt idx="2">
                  <c:v>14.900784284760448</c:v>
                </c:pt>
                <c:pt idx="3">
                  <c:v>10.642224885408723</c:v>
                </c:pt>
                <c:pt idx="4">
                  <c:v>7.4548868154488446</c:v>
                </c:pt>
                <c:pt idx="5">
                  <c:v>5.5697544356044091</c:v>
                </c:pt>
                <c:pt idx="6">
                  <c:v>4.5456805664725835</c:v>
                </c:pt>
                <c:pt idx="7">
                  <c:v>3.6202176554197649</c:v>
                </c:pt>
                <c:pt idx="8">
                  <c:v>2.4521590852582449</c:v>
                </c:pt>
                <c:pt idx="9">
                  <c:v>1.2168841748734849</c:v>
                </c:pt>
                <c:pt idx="10">
                  <c:v>0.1750820050801849</c:v>
                </c:pt>
                <c:pt idx="11">
                  <c:v>-0.61031400237152411</c:v>
                </c:pt>
                <c:pt idx="12">
                  <c:v>-1.228039949954109</c:v>
                </c:pt>
                <c:pt idx="13">
                  <c:v>-1.718521858112581</c:v>
                </c:pt>
                <c:pt idx="14">
                  <c:v>-2.0988625980553479</c:v>
                </c:pt>
                <c:pt idx="15">
                  <c:v>-2.455581455700667</c:v>
                </c:pt>
                <c:pt idx="16">
                  <c:v>-2.7653914362290379</c:v>
                </c:pt>
                <c:pt idx="17">
                  <c:v>-2.8424401193478843</c:v>
                </c:pt>
                <c:pt idx="18">
                  <c:v>-2.5719222343323054</c:v>
                </c:pt>
                <c:pt idx="19">
                  <c:v>-2.0825154232970817</c:v>
                </c:pt>
                <c:pt idx="20">
                  <c:v>-1.6790206683472206</c:v>
                </c:pt>
                <c:pt idx="21">
                  <c:v>-1.4734252883245063</c:v>
                </c:pt>
                <c:pt idx="22">
                  <c:v>-1.1825767643658764</c:v>
                </c:pt>
                <c:pt idx="23">
                  <c:v>-0.5523599813986948</c:v>
                </c:pt>
                <c:pt idx="24">
                  <c:v>0.20683195536548737</c:v>
                </c:pt>
                <c:pt idx="25">
                  <c:v>0.58273163556077634</c:v>
                </c:pt>
                <c:pt idx="26">
                  <c:v>0.34004614621517248</c:v>
                </c:pt>
                <c:pt idx="27">
                  <c:v>-0.20103545852180105</c:v>
                </c:pt>
                <c:pt idx="28">
                  <c:v>-0.6088327094566921</c:v>
                </c:pt>
                <c:pt idx="29">
                  <c:v>-0.78653353548725136</c:v>
                </c:pt>
                <c:pt idx="30">
                  <c:v>-0.83690077320716227</c:v>
                </c:pt>
                <c:pt idx="31">
                  <c:v>-0.80422117964735662</c:v>
                </c:pt>
                <c:pt idx="32">
                  <c:v>-0.71136161016875121</c:v>
                </c:pt>
                <c:pt idx="33">
                  <c:v>-0.63441331131798506</c:v>
                </c:pt>
                <c:pt idx="34">
                  <c:v>-0.58486273997550597</c:v>
                </c:pt>
                <c:pt idx="35">
                  <c:v>-0.47586863412288949</c:v>
                </c:pt>
                <c:pt idx="36">
                  <c:v>-0.26961427063542942</c:v>
                </c:pt>
                <c:pt idx="37">
                  <c:v>-9.2786520381196169E-3</c:v>
                </c:pt>
                <c:pt idx="38">
                  <c:v>0.27920111747334886</c:v>
                </c:pt>
                <c:pt idx="39">
                  <c:v>0.66157817152998177</c:v>
                </c:pt>
                <c:pt idx="40">
                  <c:v>1.3044346429305733</c:v>
                </c:pt>
                <c:pt idx="41">
                  <c:v>2.2000322752137436</c:v>
                </c:pt>
                <c:pt idx="42">
                  <c:v>2.7959619609264337</c:v>
                </c:pt>
                <c:pt idx="43">
                  <c:v>2.3493755400122609</c:v>
                </c:pt>
                <c:pt idx="44">
                  <c:v>0.88392328643021756</c:v>
                </c:pt>
              </c:numCache>
            </c:numRef>
          </c:val>
          <c:smooth val="0"/>
          <c:extLst>
            <c:ext xmlns:c16="http://schemas.microsoft.com/office/drawing/2014/chart" uri="{C3380CC4-5D6E-409C-BE32-E72D297353CC}">
              <c16:uniqueId val="{00000003-D437-4A5A-AAFA-D1AE512EDE85}"/>
            </c:ext>
          </c:extLst>
        </c:ser>
        <c:ser>
          <c:idx val="4"/>
          <c:order val="4"/>
          <c:tx>
            <c:strRef>
              <c:f>Triplex2_62C!$A$41</c:f>
              <c:strCache>
                <c:ptCount val="1"/>
                <c:pt idx="0">
                  <c:v>500 copies</c:v>
                </c:pt>
              </c:strCache>
            </c:strRef>
          </c:tx>
          <c:spPr>
            <a:ln w="28575" cap="rnd">
              <a:solidFill>
                <a:schemeClr val="accent5"/>
              </a:solidFill>
              <a:round/>
            </a:ln>
            <a:effectLst/>
          </c:spPr>
          <c:marker>
            <c:symbol val="none"/>
          </c:marker>
          <c:val>
            <c:numRef>
              <c:f>Triplex2_62C!$B$41:$AT$41</c:f>
              <c:numCache>
                <c:formatCode>General</c:formatCode>
                <c:ptCount val="45"/>
                <c:pt idx="0">
                  <c:v>24.762846655170506</c:v>
                </c:pt>
                <c:pt idx="1">
                  <c:v>20.024002396550713</c:v>
                </c:pt>
                <c:pt idx="2">
                  <c:v>15.487510635517538</c:v>
                </c:pt>
                <c:pt idx="3">
                  <c:v>11.084580362356064</c:v>
                </c:pt>
                <c:pt idx="4">
                  <c:v>7.1560882484882313</c:v>
                </c:pt>
                <c:pt idx="5">
                  <c:v>4.4672606245403585</c:v>
                </c:pt>
                <c:pt idx="6">
                  <c:v>3.2542999733777833</c:v>
                </c:pt>
                <c:pt idx="7">
                  <c:v>2.8193237268860685</c:v>
                </c:pt>
                <c:pt idx="8">
                  <c:v>2.2294351874388667</c:v>
                </c:pt>
                <c:pt idx="9">
                  <c:v>1.2206311127720255</c:v>
                </c:pt>
                <c:pt idx="10">
                  <c:v>0.17293745613278588</c:v>
                </c:pt>
                <c:pt idx="11">
                  <c:v>-0.54394903487263946</c:v>
                </c:pt>
                <c:pt idx="12">
                  <c:v>-0.69549345217455993</c:v>
                </c:pt>
                <c:pt idx="13">
                  <c:v>-0.12414002711739158</c:v>
                </c:pt>
                <c:pt idx="14">
                  <c:v>0.84003244021187129</c:v>
                </c:pt>
                <c:pt idx="15">
                  <c:v>1.3329422376700677</c:v>
                </c:pt>
                <c:pt idx="16">
                  <c:v>0.53487660456266894</c:v>
                </c:pt>
                <c:pt idx="17">
                  <c:v>-1.5766617489352939</c:v>
                </c:pt>
                <c:pt idx="18">
                  <c:v>-3.8939771507230034</c:v>
                </c:pt>
                <c:pt idx="19">
                  <c:v>-5.1389467068438535</c:v>
                </c:pt>
                <c:pt idx="20">
                  <c:v>-5.0987834045445197</c:v>
                </c:pt>
                <c:pt idx="21">
                  <c:v>-4.4333486871128116</c:v>
                </c:pt>
                <c:pt idx="22">
                  <c:v>-3.5800753345083649</c:v>
                </c:pt>
                <c:pt idx="23">
                  <c:v>-2.4183039971449034</c:v>
                </c:pt>
                <c:pt idx="24">
                  <c:v>-0.94509832043331699</c:v>
                </c:pt>
                <c:pt idx="25">
                  <c:v>0.35739035008191422</c:v>
                </c:pt>
                <c:pt idx="26">
                  <c:v>0.96258718653734832</c:v>
                </c:pt>
                <c:pt idx="27">
                  <c:v>0.7644902568681573</c:v>
                </c:pt>
                <c:pt idx="28">
                  <c:v>0.18170880576326454</c:v>
                </c:pt>
                <c:pt idx="29">
                  <c:v>-0.23924657730276522</c:v>
                </c:pt>
                <c:pt idx="30">
                  <c:v>-0.43624474599346286</c:v>
                </c:pt>
                <c:pt idx="31">
                  <c:v>-0.57341530180747213</c:v>
                </c:pt>
                <c:pt idx="32">
                  <c:v>-0.47737946960842237</c:v>
                </c:pt>
                <c:pt idx="33">
                  <c:v>5.5576146738530952E-2</c:v>
                </c:pt>
                <c:pt idx="34">
                  <c:v>0.87333485431008739</c:v>
                </c:pt>
                <c:pt idx="35">
                  <c:v>1.536182107305649</c:v>
                </c:pt>
                <c:pt idx="36">
                  <c:v>1.5888429116457701</c:v>
                </c:pt>
                <c:pt idx="37">
                  <c:v>1.066808721570851</c:v>
                </c:pt>
                <c:pt idx="38">
                  <c:v>0.55802029128426511</c:v>
                </c:pt>
                <c:pt idx="39">
                  <c:v>0.53006261764494411</c:v>
                </c:pt>
                <c:pt idx="40">
                  <c:v>0.98579470199547359</c:v>
                </c:pt>
                <c:pt idx="41">
                  <c:v>1.5496886467899458</c:v>
                </c:pt>
                <c:pt idx="42">
                  <c:v>1.6166894415873685</c:v>
                </c:pt>
                <c:pt idx="43">
                  <c:v>0.91683447745344893</c:v>
                </c:pt>
                <c:pt idx="44">
                  <c:v>-0.24068692210312292</c:v>
                </c:pt>
              </c:numCache>
            </c:numRef>
          </c:val>
          <c:smooth val="0"/>
          <c:extLst>
            <c:ext xmlns:c16="http://schemas.microsoft.com/office/drawing/2014/chart" uri="{C3380CC4-5D6E-409C-BE32-E72D297353CC}">
              <c16:uniqueId val="{00000004-D437-4A5A-AAFA-D1AE512EDE85}"/>
            </c:ext>
          </c:extLst>
        </c:ser>
        <c:ser>
          <c:idx val="5"/>
          <c:order val="5"/>
          <c:tx>
            <c:strRef>
              <c:f>Triplex2_62C!$A$44</c:f>
              <c:strCache>
                <c:ptCount val="1"/>
                <c:pt idx="0">
                  <c:v>5,000 copies</c:v>
                </c:pt>
              </c:strCache>
            </c:strRef>
          </c:tx>
          <c:spPr>
            <a:ln w="28575" cap="rnd">
              <a:solidFill>
                <a:schemeClr val="accent6"/>
              </a:solidFill>
              <a:round/>
            </a:ln>
            <a:effectLst/>
          </c:spPr>
          <c:marker>
            <c:symbol val="none"/>
          </c:marker>
          <c:val>
            <c:numRef>
              <c:f>Triplex2_62C!$B$44:$AT$44</c:f>
              <c:numCache>
                <c:formatCode>General</c:formatCode>
                <c:ptCount val="45"/>
                <c:pt idx="0">
                  <c:v>14.291123326855086</c:v>
                </c:pt>
                <c:pt idx="1">
                  <c:v>14.067988835218785</c:v>
                </c:pt>
                <c:pt idx="2">
                  <c:v>13.064839708549698</c:v>
                </c:pt>
                <c:pt idx="3">
                  <c:v>11.168834165502631</c:v>
                </c:pt>
                <c:pt idx="4">
                  <c:v>8.8287972941488988</c:v>
                </c:pt>
                <c:pt idx="5">
                  <c:v>6.5627495013086445</c:v>
                </c:pt>
                <c:pt idx="6">
                  <c:v>4.6922336668521893</c:v>
                </c:pt>
                <c:pt idx="7">
                  <c:v>3.3084642411977256</c:v>
                </c:pt>
                <c:pt idx="8">
                  <c:v>2.2626112559519242</c:v>
                </c:pt>
                <c:pt idx="9">
                  <c:v>1.2868706218578154</c:v>
                </c:pt>
                <c:pt idx="10">
                  <c:v>0.30373328050700366</c:v>
                </c:pt>
                <c:pt idx="11">
                  <c:v>-0.47756389304595359</c:v>
                </c:pt>
                <c:pt idx="12">
                  <c:v>-0.88661456151567108</c:v>
                </c:pt>
                <c:pt idx="13">
                  <c:v>-1.0211712387317675</c:v>
                </c:pt>
                <c:pt idx="14">
                  <c:v>-1.0568955153466959</c:v>
                </c:pt>
                <c:pt idx="15">
                  <c:v>-1.1025692633884319</c:v>
                </c:pt>
                <c:pt idx="16">
                  <c:v>-1.2974500035252277</c:v>
                </c:pt>
                <c:pt idx="17">
                  <c:v>-1.7668226775731455</c:v>
                </c:pt>
                <c:pt idx="18">
                  <c:v>-2.4304300942076225</c:v>
                </c:pt>
                <c:pt idx="19">
                  <c:v>-3.0184715375071391</c:v>
                </c:pt>
                <c:pt idx="20">
                  <c:v>-3.2588994024627027</c:v>
                </c:pt>
                <c:pt idx="21">
                  <c:v>-3.0738752125835163</c:v>
                </c:pt>
                <c:pt idx="22">
                  <c:v>-2.6663126060902869</c:v>
                </c:pt>
                <c:pt idx="23">
                  <c:v>-2.2974692435691395</c:v>
                </c:pt>
                <c:pt idx="24">
                  <c:v>-2.0198545003659092</c:v>
                </c:pt>
                <c:pt idx="25">
                  <c:v>-1.7250460276736703</c:v>
                </c:pt>
                <c:pt idx="26">
                  <c:v>-1.3765568763919873</c:v>
                </c:pt>
                <c:pt idx="27">
                  <c:v>-1.1047922796242347</c:v>
                </c:pt>
                <c:pt idx="28">
                  <c:v>-0.99908414353376429</c:v>
                </c:pt>
                <c:pt idx="29">
                  <c:v>-0.91587437006273831</c:v>
                </c:pt>
                <c:pt idx="30">
                  <c:v>-0.63123587721202057</c:v>
                </c:pt>
                <c:pt idx="31">
                  <c:v>-0.10832480925091659</c:v>
                </c:pt>
                <c:pt idx="32">
                  <c:v>0.4494175397339859</c:v>
                </c:pt>
                <c:pt idx="33">
                  <c:v>0.82237309376978374</c:v>
                </c:pt>
                <c:pt idx="34">
                  <c:v>0.96594491768883017</c:v>
                </c:pt>
                <c:pt idx="35">
                  <c:v>0.95975184191047447</c:v>
                </c:pt>
                <c:pt idx="36">
                  <c:v>0.97534760387861752</c:v>
                </c:pt>
                <c:pt idx="37">
                  <c:v>1.1936964099841134</c:v>
                </c:pt>
                <c:pt idx="38">
                  <c:v>1.5698238776094513</c:v>
                </c:pt>
                <c:pt idx="39">
                  <c:v>1.8257986050921318</c:v>
                </c:pt>
                <c:pt idx="40">
                  <c:v>1.7303085827279574</c:v>
                </c:pt>
                <c:pt idx="41">
                  <c:v>1.337472006207463</c:v>
                </c:pt>
                <c:pt idx="42">
                  <c:v>0.9593325588866719</c:v>
                </c:pt>
                <c:pt idx="43">
                  <c:v>0.89269787069679296</c:v>
                </c:pt>
                <c:pt idx="44">
                  <c:v>1.1366866577936889</c:v>
                </c:pt>
              </c:numCache>
            </c:numRef>
          </c:val>
          <c:smooth val="0"/>
          <c:extLst>
            <c:ext xmlns:c16="http://schemas.microsoft.com/office/drawing/2014/chart" uri="{C3380CC4-5D6E-409C-BE32-E72D297353CC}">
              <c16:uniqueId val="{00000005-D437-4A5A-AAFA-D1AE512EDE85}"/>
            </c:ext>
          </c:extLst>
        </c:ser>
        <c:ser>
          <c:idx val="6"/>
          <c:order val="6"/>
          <c:tx>
            <c:strRef>
              <c:f>Triplex2_62C!$A$47</c:f>
              <c:strCache>
                <c:ptCount val="1"/>
                <c:pt idx="0">
                  <c:v>5,000 copies</c:v>
                </c:pt>
              </c:strCache>
            </c:strRef>
          </c:tx>
          <c:spPr>
            <a:ln w="28575" cap="rnd">
              <a:solidFill>
                <a:schemeClr val="accent1">
                  <a:lumMod val="60000"/>
                </a:schemeClr>
              </a:solidFill>
              <a:round/>
            </a:ln>
            <a:effectLst/>
          </c:spPr>
          <c:marker>
            <c:symbol val="none"/>
          </c:marker>
          <c:val>
            <c:numRef>
              <c:f>Triplex2_62C!$B$47:$AT$47</c:f>
              <c:numCache>
                <c:formatCode>General</c:formatCode>
                <c:ptCount val="45"/>
                <c:pt idx="0">
                  <c:v>28.572758355639962</c:v>
                </c:pt>
                <c:pt idx="1">
                  <c:v>23.273956815713973</c:v>
                </c:pt>
                <c:pt idx="2">
                  <c:v>18.841670382749726</c:v>
                </c:pt>
                <c:pt idx="3">
                  <c:v>15.430325097990135</c:v>
                </c:pt>
                <c:pt idx="4">
                  <c:v>12.626757587295288</c:v>
                </c:pt>
                <c:pt idx="5">
                  <c:v>10.084484501920087</c:v>
                </c:pt>
                <c:pt idx="6">
                  <c:v>7.7556058115333144</c:v>
                </c:pt>
                <c:pt idx="7">
                  <c:v>5.7058457298662688</c:v>
                </c:pt>
                <c:pt idx="8">
                  <c:v>3.9854084209346183</c:v>
                </c:pt>
                <c:pt idx="9">
                  <c:v>2.5634897318159346</c:v>
                </c:pt>
                <c:pt idx="10">
                  <c:v>1.3064175044892181</c:v>
                </c:pt>
                <c:pt idx="11">
                  <c:v>0.1124307580266759</c:v>
                </c:pt>
                <c:pt idx="12">
                  <c:v>-1.0501519575791463</c:v>
                </c:pt>
                <c:pt idx="13">
                  <c:v>-2.190750728281273</c:v>
                </c:pt>
                <c:pt idx="14">
                  <c:v>-3.1841771181734657</c:v>
                </c:pt>
                <c:pt idx="15">
                  <c:v>-3.8096963718762709</c:v>
                </c:pt>
                <c:pt idx="16">
                  <c:v>-4.0039453168719774</c:v>
                </c:pt>
                <c:pt idx="17">
                  <c:v>-3.9385537218313402</c:v>
                </c:pt>
                <c:pt idx="18">
                  <c:v>-3.8824496317120065</c:v>
                </c:pt>
                <c:pt idx="19">
                  <c:v>-3.968221080953299</c:v>
                </c:pt>
                <c:pt idx="20">
                  <c:v>-4.0712799846605776</c:v>
                </c:pt>
                <c:pt idx="21">
                  <c:v>-4.0260974181383062</c:v>
                </c:pt>
                <c:pt idx="22">
                  <c:v>-3.8553698897976574</c:v>
                </c:pt>
                <c:pt idx="23">
                  <c:v>-3.646327428488803</c:v>
                </c:pt>
                <c:pt idx="24">
                  <c:v>-3.3486440368851618</c:v>
                </c:pt>
                <c:pt idx="25">
                  <c:v>-2.8033698039052979</c:v>
                </c:pt>
                <c:pt idx="26">
                  <c:v>-1.9724637422150408</c:v>
                </c:pt>
                <c:pt idx="27">
                  <c:v>-1.1049912801518076</c:v>
                </c:pt>
                <c:pt idx="28">
                  <c:v>-0.49742752215206565</c:v>
                </c:pt>
                <c:pt idx="29">
                  <c:v>-0.20214031789873843</c:v>
                </c:pt>
                <c:pt idx="30">
                  <c:v>-0.1499852105298487</c:v>
                </c:pt>
                <c:pt idx="31">
                  <c:v>-0.21032828198258358</c:v>
                </c:pt>
                <c:pt idx="32">
                  <c:v>-0.10920016513045994</c:v>
                </c:pt>
                <c:pt idx="33">
                  <c:v>0.34008441442347248</c:v>
                </c:pt>
                <c:pt idx="34">
                  <c:v>1.0231924351228372</c:v>
                </c:pt>
                <c:pt idx="35">
                  <c:v>1.6483890105610044</c:v>
                </c:pt>
                <c:pt idx="36">
                  <c:v>1.9748038684283529</c:v>
                </c:pt>
                <c:pt idx="37">
                  <c:v>1.948074112431641</c:v>
                </c:pt>
                <c:pt idx="38">
                  <c:v>1.6756765318568796</c:v>
                </c:pt>
                <c:pt idx="39">
                  <c:v>1.3188565640866727</c:v>
                </c:pt>
                <c:pt idx="40">
                  <c:v>1.0749617919445882</c:v>
                </c:pt>
                <c:pt idx="41">
                  <c:v>1.1872343693485163</c:v>
                </c:pt>
                <c:pt idx="42">
                  <c:v>1.7795403810468997</c:v>
                </c:pt>
                <c:pt idx="43">
                  <c:v>2.7270288954696298</c:v>
                </c:pt>
                <c:pt idx="44">
                  <c:v>3.8140461758775928</c:v>
                </c:pt>
              </c:numCache>
            </c:numRef>
          </c:val>
          <c:smooth val="0"/>
          <c:extLst>
            <c:ext xmlns:c16="http://schemas.microsoft.com/office/drawing/2014/chart" uri="{C3380CC4-5D6E-409C-BE32-E72D297353CC}">
              <c16:uniqueId val="{00000006-D437-4A5A-AAFA-D1AE512EDE85}"/>
            </c:ext>
          </c:extLst>
        </c:ser>
        <c:ser>
          <c:idx val="7"/>
          <c:order val="7"/>
          <c:tx>
            <c:strRef>
              <c:f>Triplex2_62C!$A$50</c:f>
              <c:strCache>
                <c:ptCount val="1"/>
                <c:pt idx="0">
                  <c:v>50,000 copies</c:v>
                </c:pt>
              </c:strCache>
            </c:strRef>
          </c:tx>
          <c:spPr>
            <a:ln w="28575" cap="rnd">
              <a:solidFill>
                <a:schemeClr val="accent2">
                  <a:lumMod val="60000"/>
                </a:schemeClr>
              </a:solidFill>
              <a:round/>
            </a:ln>
            <a:effectLst/>
          </c:spPr>
          <c:marker>
            <c:symbol val="none"/>
          </c:marker>
          <c:val>
            <c:numRef>
              <c:f>Triplex2_62C!$B$50:$AT$50</c:f>
              <c:numCache>
                <c:formatCode>General</c:formatCode>
                <c:ptCount val="45"/>
                <c:pt idx="0">
                  <c:v>14.016284346113025</c:v>
                </c:pt>
                <c:pt idx="1">
                  <c:v>10.961138442526135</c:v>
                </c:pt>
                <c:pt idx="2">
                  <c:v>8.2620668658310024</c:v>
                </c:pt>
                <c:pt idx="3">
                  <c:v>6.3371782479571266</c:v>
                </c:pt>
                <c:pt idx="4">
                  <c:v>5.2362347876060085</c:v>
                </c:pt>
                <c:pt idx="5">
                  <c:v>4.5832392818210792</c:v>
                </c:pt>
                <c:pt idx="6">
                  <c:v>3.9794386948178726</c:v>
                </c:pt>
                <c:pt idx="7">
                  <c:v>3.1703790837036649</c:v>
                </c:pt>
                <c:pt idx="8">
                  <c:v>2.0121969665724464</c:v>
                </c:pt>
                <c:pt idx="9">
                  <c:v>0.6192845495952497</c:v>
                </c:pt>
                <c:pt idx="10">
                  <c:v>-0.53336660485729226</c:v>
                </c:pt>
                <c:pt idx="11">
                  <c:v>-1.0282234658043308</c:v>
                </c:pt>
                <c:pt idx="12">
                  <c:v>-0.99488168205607508</c:v>
                </c:pt>
                <c:pt idx="13">
                  <c:v>-0.94726415149307286</c:v>
                </c:pt>
                <c:pt idx="14">
                  <c:v>-1.1859027549307939</c:v>
                </c:pt>
                <c:pt idx="15">
                  <c:v>-1.4949196823527018</c:v>
                </c:pt>
                <c:pt idx="16">
                  <c:v>-1.4852971793243341</c:v>
                </c:pt>
                <c:pt idx="17">
                  <c:v>-1.1584850701256073</c:v>
                </c:pt>
                <c:pt idx="18">
                  <c:v>-0.99185388660407625</c:v>
                </c:pt>
                <c:pt idx="19">
                  <c:v>-1.384912515834003</c:v>
                </c:pt>
                <c:pt idx="20">
                  <c:v>-2.1199562538058672</c:v>
                </c:pt>
                <c:pt idx="21">
                  <c:v>-2.5389023068491952</c:v>
                </c:pt>
                <c:pt idx="22">
                  <c:v>-2.2263860138955351</c:v>
                </c:pt>
                <c:pt idx="23">
                  <c:v>-1.4283599849659367</c:v>
                </c:pt>
                <c:pt idx="24">
                  <c:v>-0.69991346718052228</c:v>
                </c:pt>
                <c:pt idx="25">
                  <c:v>-0.2980518019048759</c:v>
                </c:pt>
                <c:pt idx="26">
                  <c:v>-0.16847065721412946</c:v>
                </c:pt>
                <c:pt idx="27">
                  <c:v>-0.21567613442311995</c:v>
                </c:pt>
                <c:pt idx="28">
                  <c:v>-0.31035360004534596</c:v>
                </c:pt>
                <c:pt idx="29">
                  <c:v>-0.29230143998029234</c:v>
                </c:pt>
                <c:pt idx="30">
                  <c:v>-0.15137507010513218</c:v>
                </c:pt>
                <c:pt idx="31">
                  <c:v>-5.2564403124051751E-2</c:v>
                </c:pt>
                <c:pt idx="32">
                  <c:v>-0.11048473818846105</c:v>
                </c:pt>
                <c:pt idx="33">
                  <c:v>-0.26891798451651994</c:v>
                </c:pt>
                <c:pt idx="34">
                  <c:v>-0.38263853484386345</c:v>
                </c:pt>
                <c:pt idx="35">
                  <c:v>-0.34080073266159161</c:v>
                </c:pt>
                <c:pt idx="36">
                  <c:v>-0.13283571026295249</c:v>
                </c:pt>
                <c:pt idx="37">
                  <c:v>0.20007520811668655</c:v>
                </c:pt>
                <c:pt idx="38">
                  <c:v>0.60216062795552716</c:v>
                </c:pt>
                <c:pt idx="39">
                  <c:v>0.969138095551898</c:v>
                </c:pt>
                <c:pt idx="40">
                  <c:v>1.218552002659635</c:v>
                </c:pt>
                <c:pt idx="41">
                  <c:v>1.3631505197172373</c:v>
                </c:pt>
                <c:pt idx="42">
                  <c:v>1.4266171471099369</c:v>
                </c:pt>
                <c:pt idx="43">
                  <c:v>1.4192082302997733</c:v>
                </c:pt>
                <c:pt idx="44">
                  <c:v>1.3796554192867916</c:v>
                </c:pt>
              </c:numCache>
            </c:numRef>
          </c:val>
          <c:smooth val="0"/>
          <c:extLst>
            <c:ext xmlns:c16="http://schemas.microsoft.com/office/drawing/2014/chart" uri="{C3380CC4-5D6E-409C-BE32-E72D297353CC}">
              <c16:uniqueId val="{00000007-D437-4A5A-AAFA-D1AE512EDE85}"/>
            </c:ext>
          </c:extLst>
        </c:ser>
        <c:ser>
          <c:idx val="8"/>
          <c:order val="8"/>
          <c:tx>
            <c:strRef>
              <c:f>Triplex2_62C!$A$53</c:f>
              <c:strCache>
                <c:ptCount val="1"/>
                <c:pt idx="0">
                  <c:v>50,000 copies</c:v>
                </c:pt>
              </c:strCache>
            </c:strRef>
          </c:tx>
          <c:spPr>
            <a:ln w="28575" cap="rnd">
              <a:solidFill>
                <a:schemeClr val="accent3">
                  <a:lumMod val="60000"/>
                </a:schemeClr>
              </a:solidFill>
              <a:round/>
            </a:ln>
            <a:effectLst/>
          </c:spPr>
          <c:marker>
            <c:symbol val="none"/>
          </c:marker>
          <c:val>
            <c:numRef>
              <c:f>Triplex2_62C!$B$53:$AT$53</c:f>
              <c:numCache>
                <c:formatCode>General</c:formatCode>
                <c:ptCount val="45"/>
                <c:pt idx="0">
                  <c:v>33.526947562899295</c:v>
                </c:pt>
                <c:pt idx="1">
                  <c:v>35.257118607780285</c:v>
                </c:pt>
                <c:pt idx="2">
                  <c:v>34.830541542210995</c:v>
                </c:pt>
                <c:pt idx="3">
                  <c:v>31.77162177370883</c:v>
                </c:pt>
                <c:pt idx="4">
                  <c:v>26.8523870896679</c:v>
                </c:pt>
                <c:pt idx="5">
                  <c:v>20.829672677793496</c:v>
                </c:pt>
                <c:pt idx="6">
                  <c:v>13.973413870993681</c:v>
                </c:pt>
                <c:pt idx="7">
                  <c:v>6.7378631397859863</c:v>
                </c:pt>
                <c:pt idx="8">
                  <c:v>0.42548338460619561</c:v>
                </c:pt>
                <c:pt idx="9">
                  <c:v>-3.6945742023053754</c:v>
                </c:pt>
                <c:pt idx="10">
                  <c:v>-5.5208913692076749</c:v>
                </c:pt>
                <c:pt idx="11">
                  <c:v>-5.6865223167715158</c:v>
                </c:pt>
                <c:pt idx="12">
                  <c:v>-4.7601089787767705</c:v>
                </c:pt>
                <c:pt idx="13">
                  <c:v>-3.3252246788433695</c:v>
                </c:pt>
                <c:pt idx="14">
                  <c:v>-2.1295823116161046</c:v>
                </c:pt>
                <c:pt idx="15">
                  <c:v>-1.7613056882037199</c:v>
                </c:pt>
                <c:pt idx="16">
                  <c:v>-2.3003621182360803</c:v>
                </c:pt>
                <c:pt idx="17">
                  <c:v>-3.2866037604981102</c:v>
                </c:pt>
                <c:pt idx="18">
                  <c:v>-4.0489590213601332</c:v>
                </c:pt>
                <c:pt idx="19">
                  <c:v>-4.1533756566968805</c:v>
                </c:pt>
                <c:pt idx="20">
                  <c:v>-3.5955676314861194</c:v>
                </c:pt>
                <c:pt idx="21">
                  <c:v>-2.7471584378581611</c:v>
                </c:pt>
                <c:pt idx="22">
                  <c:v>-2.1574937799759937</c:v>
                </c:pt>
                <c:pt idx="23">
                  <c:v>-2.1930238965342141</c:v>
                </c:pt>
                <c:pt idx="24">
                  <c:v>-2.696219337913135</c:v>
                </c:pt>
                <c:pt idx="25">
                  <c:v>-3.0154211091648904</c:v>
                </c:pt>
                <c:pt idx="26">
                  <c:v>-2.6608740885039879</c:v>
                </c:pt>
                <c:pt idx="27">
                  <c:v>-1.87286304907866</c:v>
                </c:pt>
                <c:pt idx="28">
                  <c:v>-1.1171009947865969</c:v>
                </c:pt>
                <c:pt idx="29">
                  <c:v>-0.44669622572291701</c:v>
                </c:pt>
                <c:pt idx="30">
                  <c:v>0.16867736890162632</c:v>
                </c:pt>
                <c:pt idx="31">
                  <c:v>0.53912851135100937</c:v>
                </c:pt>
                <c:pt idx="32">
                  <c:v>0.57972918908308202</c:v>
                </c:pt>
                <c:pt idx="33">
                  <c:v>0.48459478650875099</c:v>
                </c:pt>
                <c:pt idx="34">
                  <c:v>0.47809114582923939</c:v>
                </c:pt>
                <c:pt idx="35">
                  <c:v>0.59021254809340462</c:v>
                </c:pt>
                <c:pt idx="36">
                  <c:v>0.7593508758709504</c:v>
                </c:pt>
                <c:pt idx="37">
                  <c:v>1.0050668442945607</c:v>
                </c:pt>
                <c:pt idx="38">
                  <c:v>1.3856702679422597</c:v>
                </c:pt>
                <c:pt idx="39">
                  <c:v>1.8637442405743059</c:v>
                </c:pt>
                <c:pt idx="40">
                  <c:v>2.3011716528635588</c:v>
                </c:pt>
                <c:pt idx="41">
                  <c:v>2.6003198721900844</c:v>
                </c:pt>
                <c:pt idx="42">
                  <c:v>2.7639418440903682</c:v>
                </c:pt>
                <c:pt idx="43">
                  <c:v>2.8325600322041282</c:v>
                </c:pt>
                <c:pt idx="44">
                  <c:v>2.8512364005910058</c:v>
                </c:pt>
              </c:numCache>
            </c:numRef>
          </c:val>
          <c:smooth val="0"/>
          <c:extLst>
            <c:ext xmlns:c16="http://schemas.microsoft.com/office/drawing/2014/chart" uri="{C3380CC4-5D6E-409C-BE32-E72D297353CC}">
              <c16:uniqueId val="{00000008-D437-4A5A-AAFA-D1AE512EDE85}"/>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1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 S:484K</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54C!$A$28</c:f>
              <c:strCache>
                <c:ptCount val="1"/>
                <c:pt idx="0">
                  <c:v>Well 1 amber</c:v>
                </c:pt>
              </c:strCache>
            </c:strRef>
          </c:tx>
          <c:spPr>
            <a:ln w="28575" cap="rnd">
              <a:solidFill>
                <a:schemeClr val="accent1"/>
              </a:solidFill>
              <a:round/>
            </a:ln>
            <a:effectLst/>
          </c:spPr>
          <c:marker>
            <c:symbol val="none"/>
          </c:marker>
          <c:val>
            <c:numRef>
              <c:f>Triplex2_54C!$B$28:$AT$28</c:f>
              <c:numCache>
                <c:formatCode>General</c:formatCode>
                <c:ptCount val="45"/>
                <c:pt idx="0">
                  <c:v>-49.074060668821403</c:v>
                </c:pt>
                <c:pt idx="1">
                  <c:v>-37.932908561626391</c:v>
                </c:pt>
                <c:pt idx="2">
                  <c:v>-28.454841877166473</c:v>
                </c:pt>
                <c:pt idx="3">
                  <c:v>-21.265528200565313</c:v>
                </c:pt>
                <c:pt idx="4">
                  <c:v>-16.040229856113001</c:v>
                </c:pt>
                <c:pt idx="5">
                  <c:v>-12.248883278738504</c:v>
                </c:pt>
                <c:pt idx="6">
                  <c:v>-9.4366006597556407</c:v>
                </c:pt>
                <c:pt idx="7">
                  <c:v>-6.8874786891919939</c:v>
                </c:pt>
                <c:pt idx="8">
                  <c:v>-3.8418035260110628</c:v>
                </c:pt>
                <c:pt idx="9">
                  <c:v>-0.31069723649488878</c:v>
                </c:pt>
                <c:pt idx="10">
                  <c:v>2.6886074289923272</c:v>
                </c:pt>
                <c:pt idx="11">
                  <c:v>3.9503596711674618</c:v>
                </c:pt>
                <c:pt idx="12">
                  <c:v>3.4450695418563555</c:v>
                </c:pt>
                <c:pt idx="13">
                  <c:v>2.4554864874226041</c:v>
                </c:pt>
                <c:pt idx="14">
                  <c:v>2.2457099470648245</c:v>
                </c:pt>
                <c:pt idx="15">
                  <c:v>3.3187783625453449</c:v>
                </c:pt>
                <c:pt idx="16">
                  <c:v>5.4991727085343882</c:v>
                </c:pt>
                <c:pt idx="17">
                  <c:v>7.9859735174450179</c:v>
                </c:pt>
                <c:pt idx="18">
                  <c:v>9.6323621498886496</c:v>
                </c:pt>
                <c:pt idx="19">
                  <c:v>9.6100952540091384</c:v>
                </c:pt>
                <c:pt idx="20">
                  <c:v>8.0152695838878572</c:v>
                </c:pt>
                <c:pt idx="21">
                  <c:v>5.653244493454622</c:v>
                </c:pt>
                <c:pt idx="22">
                  <c:v>3.1383376584853977</c:v>
                </c:pt>
                <c:pt idx="23">
                  <c:v>0.62757014868111582</c:v>
                </c:pt>
                <c:pt idx="24">
                  <c:v>-1.7340596641060984</c:v>
                </c:pt>
                <c:pt idx="25">
                  <c:v>-3.8054015005527617</c:v>
                </c:pt>
                <c:pt idx="26">
                  <c:v>-5.6271959166624583</c:v>
                </c:pt>
                <c:pt idx="27">
                  <c:v>-7.1357733996446768</c:v>
                </c:pt>
                <c:pt idx="28">
                  <c:v>-8.1911551630400936</c:v>
                </c:pt>
                <c:pt idx="29">
                  <c:v>-9.0469879192478402</c:v>
                </c:pt>
                <c:pt idx="30">
                  <c:v>-10.291161825982272</c:v>
                </c:pt>
                <c:pt idx="31">
                  <c:v>-12.202410518430042</c:v>
                </c:pt>
                <c:pt idx="32">
                  <c:v>-14.269479386166495</c:v>
                </c:pt>
                <c:pt idx="33">
                  <c:v>-15.198816994432491</c:v>
                </c:pt>
                <c:pt idx="34">
                  <c:v>-13.088349696448859</c:v>
                </c:pt>
                <c:pt idx="35">
                  <c:v>-5.9638093086887238</c:v>
                </c:pt>
                <c:pt idx="36">
                  <c:v>6.7793472858993482</c:v>
                </c:pt>
                <c:pt idx="37">
                  <c:v>23.165687759439606</c:v>
                </c:pt>
                <c:pt idx="38">
                  <c:v>39.50226926220239</c:v>
                </c:pt>
                <c:pt idx="39">
                  <c:v>52.71814969288971</c:v>
                </c:pt>
                <c:pt idx="40">
                  <c:v>61.819030431550345</c:v>
                </c:pt>
                <c:pt idx="41">
                  <c:v>67.488287324769772</c:v>
                </c:pt>
                <c:pt idx="42">
                  <c:v>70.627042926595095</c:v>
                </c:pt>
                <c:pt idx="43">
                  <c:v>71.45114806084166</c:v>
                </c:pt>
                <c:pt idx="44">
                  <c:v>70.451015337977879</c:v>
                </c:pt>
              </c:numCache>
            </c:numRef>
          </c:val>
          <c:smooth val="0"/>
          <c:extLst>
            <c:ext xmlns:c16="http://schemas.microsoft.com/office/drawing/2014/chart" uri="{C3380CC4-5D6E-409C-BE32-E72D297353CC}">
              <c16:uniqueId val="{00000000-9E95-437A-86C0-3528D5B3E06B}"/>
            </c:ext>
          </c:extLst>
        </c:ser>
        <c:ser>
          <c:idx val="1"/>
          <c:order val="1"/>
          <c:tx>
            <c:strRef>
              <c:f>Triplex2_54C!$A$31</c:f>
              <c:strCache>
                <c:ptCount val="1"/>
                <c:pt idx="0">
                  <c:v>Well 2 amber</c:v>
                </c:pt>
              </c:strCache>
            </c:strRef>
          </c:tx>
          <c:spPr>
            <a:ln w="28575" cap="rnd">
              <a:solidFill>
                <a:schemeClr val="accent2"/>
              </a:solidFill>
              <a:round/>
            </a:ln>
            <a:effectLst/>
          </c:spPr>
          <c:marker>
            <c:symbol val="none"/>
          </c:marker>
          <c:val>
            <c:numRef>
              <c:f>Triplex2_54C!$B$31:$AT$31</c:f>
              <c:numCache>
                <c:formatCode>General</c:formatCode>
                <c:ptCount val="45"/>
                <c:pt idx="0">
                  <c:v>-29.004313220639233</c:v>
                </c:pt>
                <c:pt idx="1">
                  <c:v>-21.924294312912025</c:v>
                </c:pt>
                <c:pt idx="2">
                  <c:v>-17.186900708040412</c:v>
                </c:pt>
                <c:pt idx="3">
                  <c:v>-15.109519225465192</c:v>
                </c:pt>
                <c:pt idx="4">
                  <c:v>-14.332985086566623</c:v>
                </c:pt>
                <c:pt idx="5">
                  <c:v>-13.551508968572307</c:v>
                </c:pt>
                <c:pt idx="6">
                  <c:v>-12.235244314257216</c:v>
                </c:pt>
                <c:pt idx="7">
                  <c:v>-10.398237326395247</c:v>
                </c:pt>
                <c:pt idx="8">
                  <c:v>-8.4104112985878601</c:v>
                </c:pt>
                <c:pt idx="9">
                  <c:v>-6.6217087176046334</c:v>
                </c:pt>
                <c:pt idx="10">
                  <c:v>-5.0097439880719321</c:v>
                </c:pt>
                <c:pt idx="11">
                  <c:v>-3.3100755714858678</c:v>
                </c:pt>
                <c:pt idx="12">
                  <c:v>-1.3511917100604478</c:v>
                </c:pt>
                <c:pt idx="13">
                  <c:v>0.66507665067911148</c:v>
                </c:pt>
                <c:pt idx="14">
                  <c:v>2.2531055417657626</c:v>
                </c:pt>
                <c:pt idx="15">
                  <c:v>3.130957706081972</c:v>
                </c:pt>
                <c:pt idx="16">
                  <c:v>3.4709639585653349</c:v>
                </c:pt>
                <c:pt idx="17">
                  <c:v>3.6295462076723197</c:v>
                </c:pt>
                <c:pt idx="18">
                  <c:v>3.7991335778660869</c:v>
                </c:pt>
                <c:pt idx="19">
                  <c:v>3.9782063499642391</c:v>
                </c:pt>
                <c:pt idx="20">
                  <c:v>4.1804608518286841</c:v>
                </c:pt>
                <c:pt idx="21">
                  <c:v>4.5752184898010455</c:v>
                </c:pt>
                <c:pt idx="22">
                  <c:v>5.3958010025362455</c:v>
                </c:pt>
                <c:pt idx="23">
                  <c:v>6.6746512804256781</c:v>
                </c:pt>
                <c:pt idx="24">
                  <c:v>8.0968243024981348</c:v>
                </c:pt>
                <c:pt idx="25">
                  <c:v>9.3073765448680206</c:v>
                </c:pt>
                <c:pt idx="26">
                  <c:v>10.241683772605029</c:v>
                </c:pt>
                <c:pt idx="27">
                  <c:v>10.935356531752404</c:v>
                </c:pt>
                <c:pt idx="28">
                  <c:v>11.299955881502683</c:v>
                </c:pt>
                <c:pt idx="29">
                  <c:v>11.108237806398392</c:v>
                </c:pt>
                <c:pt idx="30">
                  <c:v>9.9780390278701816</c:v>
                </c:pt>
                <c:pt idx="31">
                  <c:v>7.6772999622826319</c:v>
                </c:pt>
                <c:pt idx="32">
                  <c:v>4.518389681199551</c:v>
                </c:pt>
                <c:pt idx="33">
                  <c:v>1.2765828268275072</c:v>
                </c:pt>
                <c:pt idx="34">
                  <c:v>-1.1185092681498645</c:v>
                </c:pt>
                <c:pt idx="35">
                  <c:v>-2.0007836444092391</c:v>
                </c:pt>
                <c:pt idx="36">
                  <c:v>-1.5593228834986803</c:v>
                </c:pt>
                <c:pt idx="37">
                  <c:v>-1.0030945011767471</c:v>
                </c:pt>
                <c:pt idx="38">
                  <c:v>-1.6542681390656071</c:v>
                </c:pt>
                <c:pt idx="39">
                  <c:v>-3.7396930743670964</c:v>
                </c:pt>
                <c:pt idx="40">
                  <c:v>-6.4501664929939579</c:v>
                </c:pt>
                <c:pt idx="41">
                  <c:v>-9.0144077909717453</c:v>
                </c:pt>
                <c:pt idx="42">
                  <c:v>-11.195168491962249</c:v>
                </c:pt>
                <c:pt idx="43">
                  <c:v>-13.00733307043447</c:v>
                </c:pt>
                <c:pt idx="44">
                  <c:v>-14.561998702953133</c:v>
                </c:pt>
              </c:numCache>
            </c:numRef>
          </c:val>
          <c:smooth val="0"/>
          <c:extLst>
            <c:ext xmlns:c16="http://schemas.microsoft.com/office/drawing/2014/chart" uri="{C3380CC4-5D6E-409C-BE32-E72D297353CC}">
              <c16:uniqueId val="{00000001-9E95-437A-86C0-3528D5B3E06B}"/>
            </c:ext>
          </c:extLst>
        </c:ser>
        <c:ser>
          <c:idx val="2"/>
          <c:order val="2"/>
          <c:tx>
            <c:strRef>
              <c:f>Triplex2_54C!$A$34</c:f>
              <c:strCache>
                <c:ptCount val="1"/>
                <c:pt idx="0">
                  <c:v>Well 3 amber</c:v>
                </c:pt>
              </c:strCache>
            </c:strRef>
          </c:tx>
          <c:spPr>
            <a:ln w="28575" cap="rnd">
              <a:solidFill>
                <a:schemeClr val="accent3"/>
              </a:solidFill>
              <a:round/>
            </a:ln>
            <a:effectLst/>
          </c:spPr>
          <c:marker>
            <c:symbol val="none"/>
          </c:marker>
          <c:val>
            <c:numRef>
              <c:f>Triplex2_54C!$B$34:$AT$34</c:f>
              <c:numCache>
                <c:formatCode>General</c:formatCode>
                <c:ptCount val="45"/>
                <c:pt idx="0">
                  <c:v>-51.3940102243414</c:v>
                </c:pt>
                <c:pt idx="1">
                  <c:v>-41.870370529741194</c:v>
                </c:pt>
                <c:pt idx="2">
                  <c:v>-34.824594470394004</c:v>
                </c:pt>
                <c:pt idx="3">
                  <c:v>-30.74193456377543</c:v>
                </c:pt>
                <c:pt idx="4">
                  <c:v>-28.463187227265735</c:v>
                </c:pt>
                <c:pt idx="5">
                  <c:v>-26.511720446305844</c:v>
                </c:pt>
                <c:pt idx="6">
                  <c:v>-23.794665876564977</c:v>
                </c:pt>
                <c:pt idx="7">
                  <c:v>-19.9944560427939</c:v>
                </c:pt>
                <c:pt idx="8">
                  <c:v>-15.573129211892592</c:v>
                </c:pt>
                <c:pt idx="9">
                  <c:v>-11.111611902311779</c:v>
                </c:pt>
                <c:pt idx="10">
                  <c:v>-6.866304367515113</c:v>
                </c:pt>
                <c:pt idx="11">
                  <c:v>-3.047651119872171</c:v>
                </c:pt>
                <c:pt idx="12">
                  <c:v>5.6269616949066403E-2</c:v>
                </c:pt>
                <c:pt idx="13">
                  <c:v>2.3826245565924182</c:v>
                </c:pt>
                <c:pt idx="14">
                  <c:v>4.2165745149377472</c:v>
                </c:pt>
                <c:pt idx="15">
                  <c:v>5.9762154958625615</c:v>
                </c:pt>
                <c:pt idx="16">
                  <c:v>7.7697200321781565</c:v>
                </c:pt>
                <c:pt idx="17">
                  <c:v>9.2469666902397876</c:v>
                </c:pt>
                <c:pt idx="18">
                  <c:v>10.130601932029094</c:v>
                </c:pt>
                <c:pt idx="19">
                  <c:v>10.69610017670675</c:v>
                </c:pt>
                <c:pt idx="20">
                  <c:v>11.501574516376422</c:v>
                </c:pt>
                <c:pt idx="21">
                  <c:v>12.740854060850324</c:v>
                </c:pt>
                <c:pt idx="22">
                  <c:v>14.090277182138379</c:v>
                </c:pt>
                <c:pt idx="23">
                  <c:v>15.220509789898642</c:v>
                </c:pt>
                <c:pt idx="24">
                  <c:v>16.033231959288969</c:v>
                </c:pt>
                <c:pt idx="25">
                  <c:v>16.306602532129546</c:v>
                </c:pt>
                <c:pt idx="26">
                  <c:v>15.622322469469509</c:v>
                </c:pt>
                <c:pt idx="27">
                  <c:v>13.762061228648236</c:v>
                </c:pt>
                <c:pt idx="28">
                  <c:v>10.993952497758073</c:v>
                </c:pt>
                <c:pt idx="29">
                  <c:v>7.9760868751163798</c:v>
                </c:pt>
                <c:pt idx="30">
                  <c:v>5.3260468050102645</c:v>
                </c:pt>
                <c:pt idx="31">
                  <c:v>3.2191888068246044</c:v>
                </c:pt>
                <c:pt idx="32">
                  <c:v>1.4915659176895133</c:v>
                </c:pt>
                <c:pt idx="33">
                  <c:v>9.3423125685148989E-2</c:v>
                </c:pt>
                <c:pt idx="34">
                  <c:v>-0.79207994714124652</c:v>
                </c:pt>
                <c:pt idx="35">
                  <c:v>-1.145151392720436</c:v>
                </c:pt>
                <c:pt idx="36">
                  <c:v>-1.3165569218508608</c:v>
                </c:pt>
                <c:pt idx="37">
                  <c:v>-1.7241437304455758</c:v>
                </c:pt>
                <c:pt idx="38">
                  <c:v>-2.6722714012794313</c:v>
                </c:pt>
                <c:pt idx="39">
                  <c:v>-4.3781681230939284</c:v>
                </c:pt>
                <c:pt idx="40">
                  <c:v>-6.9573127905459842</c:v>
                </c:pt>
                <c:pt idx="41">
                  <c:v>-10.480800946783347</c:v>
                </c:pt>
                <c:pt idx="42">
                  <c:v>-14.828455272536303</c:v>
                </c:pt>
                <c:pt idx="43">
                  <c:v>-19.517321254405033</c:v>
                </c:pt>
                <c:pt idx="44">
                  <c:v>-24.14097003430652</c:v>
                </c:pt>
              </c:numCache>
            </c:numRef>
          </c:val>
          <c:smooth val="0"/>
          <c:extLst>
            <c:ext xmlns:c16="http://schemas.microsoft.com/office/drawing/2014/chart" uri="{C3380CC4-5D6E-409C-BE32-E72D297353CC}">
              <c16:uniqueId val="{00000002-9E95-437A-86C0-3528D5B3E06B}"/>
            </c:ext>
          </c:extLst>
        </c:ser>
        <c:ser>
          <c:idx val="3"/>
          <c:order val="3"/>
          <c:tx>
            <c:strRef>
              <c:f>Triplex2_54C!$A$37</c:f>
              <c:strCache>
                <c:ptCount val="1"/>
                <c:pt idx="0">
                  <c:v>Well 4 amber</c:v>
                </c:pt>
              </c:strCache>
            </c:strRef>
          </c:tx>
          <c:spPr>
            <a:ln w="28575" cap="rnd">
              <a:solidFill>
                <a:schemeClr val="accent4"/>
              </a:solidFill>
              <a:round/>
            </a:ln>
            <a:effectLst/>
          </c:spPr>
          <c:marker>
            <c:symbol val="none"/>
          </c:marker>
          <c:val>
            <c:numRef>
              <c:f>Triplex2_54C!$B$37:$AT$37</c:f>
              <c:numCache>
                <c:formatCode>General</c:formatCode>
                <c:ptCount val="45"/>
                <c:pt idx="0">
                  <c:v>1.6222966276745865</c:v>
                </c:pt>
                <c:pt idx="1">
                  <c:v>3.6019993552217784</c:v>
                </c:pt>
                <c:pt idx="2">
                  <c:v>4.6212439166974946</c:v>
                </c:pt>
                <c:pt idx="3">
                  <c:v>4.5637151255887147</c:v>
                </c:pt>
                <c:pt idx="4">
                  <c:v>3.9350681399064342</c:v>
                </c:pt>
                <c:pt idx="5">
                  <c:v>3.170611441901201</c:v>
                </c:pt>
                <c:pt idx="6">
                  <c:v>2.4189994848165952</c:v>
                </c:pt>
                <c:pt idx="7">
                  <c:v>1.7338323205676716</c:v>
                </c:pt>
                <c:pt idx="8">
                  <c:v>1.1759015376628668</c:v>
                </c:pt>
                <c:pt idx="9">
                  <c:v>0.75051608188550745</c:v>
                </c:pt>
                <c:pt idx="10">
                  <c:v>0.41375056983815739</c:v>
                </c:pt>
                <c:pt idx="11">
                  <c:v>0.13375820568944619</c:v>
                </c:pt>
                <c:pt idx="12">
                  <c:v>-0.1151913632711512</c:v>
                </c:pt>
                <c:pt idx="13">
                  <c:v>-0.3461547389961197</c:v>
                </c:pt>
                <c:pt idx="14">
                  <c:v>-0.52647007155974279</c:v>
                </c:pt>
                <c:pt idx="15">
                  <c:v>-0.62845473702691379</c:v>
                </c:pt>
                <c:pt idx="16">
                  <c:v>-0.70449900614403305</c:v>
                </c:pt>
                <c:pt idx="17">
                  <c:v>-0.83790403165585303</c:v>
                </c:pt>
                <c:pt idx="18">
                  <c:v>-1.04035067021141</c:v>
                </c:pt>
                <c:pt idx="19">
                  <c:v>-1.2493705048236734</c:v>
                </c:pt>
                <c:pt idx="20">
                  <c:v>-1.3906756686465087</c:v>
                </c:pt>
                <c:pt idx="21">
                  <c:v>-1.4318775538067712</c:v>
                </c:pt>
                <c:pt idx="22">
                  <c:v>-1.4015330049423937</c:v>
                </c:pt>
                <c:pt idx="23">
                  <c:v>-1.3424442360428657</c:v>
                </c:pt>
                <c:pt idx="24">
                  <c:v>-1.2789804648764402</c:v>
                </c:pt>
                <c:pt idx="25">
                  <c:v>-1.2382204626428575</c:v>
                </c:pt>
                <c:pt idx="26">
                  <c:v>-1.2271965074196487</c:v>
                </c:pt>
                <c:pt idx="27">
                  <c:v>-1.2006660534152616</c:v>
                </c:pt>
                <c:pt idx="28">
                  <c:v>-1.1026894251390331</c:v>
                </c:pt>
                <c:pt idx="29">
                  <c:v>-0.91859648268473393</c:v>
                </c:pt>
                <c:pt idx="30">
                  <c:v>-0.6694941887344612</c:v>
                </c:pt>
                <c:pt idx="31">
                  <c:v>-0.37549107094855572</c:v>
                </c:pt>
                <c:pt idx="32">
                  <c:v>-5.8495725790635333E-2</c:v>
                </c:pt>
                <c:pt idx="33">
                  <c:v>0.22930660428210103</c:v>
                </c:pt>
                <c:pt idx="34">
                  <c:v>0.44444445728186111</c:v>
                </c:pt>
                <c:pt idx="35">
                  <c:v>0.60914919336028106</c:v>
                </c:pt>
                <c:pt idx="36">
                  <c:v>0.76589129002968548</c:v>
                </c:pt>
                <c:pt idx="37">
                  <c:v>0.90366691900453588</c:v>
                </c:pt>
                <c:pt idx="38">
                  <c:v>0.98897746358852601</c:v>
                </c:pt>
                <c:pt idx="39">
                  <c:v>1.0273608956158569</c:v>
                </c:pt>
                <c:pt idx="40">
                  <c:v>1.031231281142027</c:v>
                </c:pt>
                <c:pt idx="41">
                  <c:v>0.98271610356823658</c:v>
                </c:pt>
                <c:pt idx="42">
                  <c:v>0.88281688285496784</c:v>
                </c:pt>
                <c:pt idx="43">
                  <c:v>0.76729734541913786</c:v>
                </c:pt>
                <c:pt idx="44">
                  <c:v>0.65452789027949621</c:v>
                </c:pt>
              </c:numCache>
            </c:numRef>
          </c:val>
          <c:smooth val="0"/>
          <c:extLst>
            <c:ext xmlns:c16="http://schemas.microsoft.com/office/drawing/2014/chart" uri="{C3380CC4-5D6E-409C-BE32-E72D297353CC}">
              <c16:uniqueId val="{00000003-9E95-437A-86C0-3528D5B3E06B}"/>
            </c:ext>
          </c:extLst>
        </c:ser>
        <c:ser>
          <c:idx val="4"/>
          <c:order val="4"/>
          <c:tx>
            <c:strRef>
              <c:f>Triplex2_54C!$A$40</c:f>
              <c:strCache>
                <c:ptCount val="1"/>
                <c:pt idx="0">
                  <c:v>Well 5 amber</c:v>
                </c:pt>
              </c:strCache>
            </c:strRef>
          </c:tx>
          <c:spPr>
            <a:ln w="28575" cap="rnd">
              <a:solidFill>
                <a:schemeClr val="accent5"/>
              </a:solidFill>
              <a:round/>
            </a:ln>
            <a:effectLst/>
          </c:spPr>
          <c:marker>
            <c:symbol val="none"/>
          </c:marker>
          <c:val>
            <c:numRef>
              <c:f>Triplex2_54C!$B$40:$AT$40</c:f>
              <c:numCache>
                <c:formatCode>General</c:formatCode>
                <c:ptCount val="45"/>
                <c:pt idx="0">
                  <c:v>1.7686702376558969</c:v>
                </c:pt>
                <c:pt idx="1">
                  <c:v>2.5864260588641628</c:v>
                </c:pt>
                <c:pt idx="2">
                  <c:v>2.8031260732714145</c:v>
                </c:pt>
                <c:pt idx="3">
                  <c:v>2.3146835207844561</c:v>
                </c:pt>
                <c:pt idx="4">
                  <c:v>1.4812929973686551</c:v>
                </c:pt>
                <c:pt idx="5">
                  <c:v>0.72851979382539866</c:v>
                </c:pt>
                <c:pt idx="6">
                  <c:v>0.24677508125932945</c:v>
                </c:pt>
                <c:pt idx="7">
                  <c:v>-2.5934760153177194E-2</c:v>
                </c:pt>
                <c:pt idx="8">
                  <c:v>-0.21152400469327404</c:v>
                </c:pt>
                <c:pt idx="9">
                  <c:v>-0.34592622226409731</c:v>
                </c:pt>
                <c:pt idx="10">
                  <c:v>-0.42800787958549336</c:v>
                </c:pt>
                <c:pt idx="11">
                  <c:v>-0.4579610894616053</c:v>
                </c:pt>
                <c:pt idx="12">
                  <c:v>-0.40623499872162938</c:v>
                </c:pt>
                <c:pt idx="13">
                  <c:v>-0.27200735704172985</c:v>
                </c:pt>
                <c:pt idx="14">
                  <c:v>-0.11670959426555783</c:v>
                </c:pt>
                <c:pt idx="15">
                  <c:v>7.6036102091165958E-3</c:v>
                </c:pt>
                <c:pt idx="16">
                  <c:v>7.4861826627966366E-2</c:v>
                </c:pt>
                <c:pt idx="17">
                  <c:v>6.069532564470137E-2</c:v>
                </c:pt>
                <c:pt idx="18">
                  <c:v>-3.1203630733216414E-2</c:v>
                </c:pt>
                <c:pt idx="19">
                  <c:v>-0.15155698106354976</c:v>
                </c:pt>
                <c:pt idx="20">
                  <c:v>-0.24066975019377423</c:v>
                </c:pt>
                <c:pt idx="21">
                  <c:v>-0.27054364069772419</c:v>
                </c:pt>
                <c:pt idx="22">
                  <c:v>-0.23902395831100876</c:v>
                </c:pt>
                <c:pt idx="23">
                  <c:v>-0.15231738893089641</c:v>
                </c:pt>
                <c:pt idx="24">
                  <c:v>-5.0348433758699684E-2</c:v>
                </c:pt>
                <c:pt idx="25">
                  <c:v>4.163455272646388E-3</c:v>
                </c:pt>
                <c:pt idx="26">
                  <c:v>1.8872399377869442E-3</c:v>
                </c:pt>
                <c:pt idx="27">
                  <c:v>1.0166055193622014E-2</c:v>
                </c:pt>
                <c:pt idx="28">
                  <c:v>0.10779026450836682</c:v>
                </c:pt>
                <c:pt idx="29">
                  <c:v>0.29682736792710784</c:v>
                </c:pt>
                <c:pt idx="30">
                  <c:v>0.47292310042030294</c:v>
                </c:pt>
                <c:pt idx="31">
                  <c:v>0.53564501942310017</c:v>
                </c:pt>
                <c:pt idx="32">
                  <c:v>0.5216965083454852</c:v>
                </c:pt>
                <c:pt idx="33">
                  <c:v>0.54568705099154613</c:v>
                </c:pt>
                <c:pt idx="34">
                  <c:v>0.65110348241069005</c:v>
                </c:pt>
                <c:pt idx="35">
                  <c:v>0.78959283691801829</c:v>
                </c:pt>
                <c:pt idx="36">
                  <c:v>0.87978972687051282</c:v>
                </c:pt>
                <c:pt idx="37">
                  <c:v>0.84120524891659443</c:v>
                </c:pt>
                <c:pt idx="38">
                  <c:v>0.63444919194080285</c:v>
                </c:pt>
                <c:pt idx="39">
                  <c:v>0.29701507059144205</c:v>
                </c:pt>
                <c:pt idx="40">
                  <c:v>-8.7846166359668132E-2</c:v>
                </c:pt>
                <c:pt idx="41">
                  <c:v>-0.4541947987745516</c:v>
                </c:pt>
                <c:pt idx="42">
                  <c:v>-0.80618574148138578</c:v>
                </c:pt>
                <c:pt idx="43">
                  <c:v>-1.2220221502630011</c:v>
                </c:pt>
                <c:pt idx="44">
                  <c:v>-1.7381787103604438</c:v>
                </c:pt>
              </c:numCache>
            </c:numRef>
          </c:val>
          <c:smooth val="0"/>
          <c:extLst>
            <c:ext xmlns:c16="http://schemas.microsoft.com/office/drawing/2014/chart" uri="{C3380CC4-5D6E-409C-BE32-E72D297353CC}">
              <c16:uniqueId val="{00000004-9E95-437A-86C0-3528D5B3E06B}"/>
            </c:ext>
          </c:extLst>
        </c:ser>
        <c:ser>
          <c:idx val="5"/>
          <c:order val="5"/>
          <c:tx>
            <c:strRef>
              <c:f>Triplex2_54C!$A$43</c:f>
              <c:strCache>
                <c:ptCount val="1"/>
                <c:pt idx="0">
                  <c:v>Well 6 amber</c:v>
                </c:pt>
              </c:strCache>
            </c:strRef>
          </c:tx>
          <c:spPr>
            <a:ln w="28575" cap="rnd">
              <a:solidFill>
                <a:schemeClr val="accent6"/>
              </a:solidFill>
              <a:round/>
            </a:ln>
            <a:effectLst/>
          </c:spPr>
          <c:marker>
            <c:symbol val="none"/>
          </c:marker>
          <c:val>
            <c:numRef>
              <c:f>Triplex2_54C!$B$43:$AT$43</c:f>
              <c:numCache>
                <c:formatCode>General</c:formatCode>
                <c:ptCount val="45"/>
                <c:pt idx="0">
                  <c:v>11.605509849938244</c:v>
                </c:pt>
                <c:pt idx="1">
                  <c:v>9.7655232924789743</c:v>
                </c:pt>
                <c:pt idx="2">
                  <c:v>7.8446259398278926</c:v>
                </c:pt>
                <c:pt idx="3">
                  <c:v>5.908326216342175</c:v>
                </c:pt>
                <c:pt idx="4">
                  <c:v>4.0644079058492935</c:v>
                </c:pt>
                <c:pt idx="5">
                  <c:v>2.371821828017346</c:v>
                </c:pt>
                <c:pt idx="6">
                  <c:v>0.91635324516028049</c:v>
                </c:pt>
                <c:pt idx="7">
                  <c:v>-0.19497368035081308</c:v>
                </c:pt>
                <c:pt idx="8">
                  <c:v>-0.93657869734852284</c:v>
                </c:pt>
                <c:pt idx="9">
                  <c:v>-1.350593863908216</c:v>
                </c:pt>
                <c:pt idx="10">
                  <c:v>-1.4746303712618101</c:v>
                </c:pt>
                <c:pt idx="11">
                  <c:v>-1.3534204306979518</c:v>
                </c:pt>
                <c:pt idx="12">
                  <c:v>-1.0156647045369027</c:v>
                </c:pt>
                <c:pt idx="13">
                  <c:v>-0.36180716603303154</c:v>
                </c:pt>
                <c:pt idx="14">
                  <c:v>0.81144804575160379</c:v>
                </c:pt>
                <c:pt idx="15">
                  <c:v>2.5880457951952849</c:v>
                </c:pt>
                <c:pt idx="16">
                  <c:v>4.8112036882739631</c:v>
                </c:pt>
                <c:pt idx="17">
                  <c:v>7.246197381085949</c:v>
                </c:pt>
                <c:pt idx="18">
                  <c:v>9.8037044448610686</c:v>
                </c:pt>
                <c:pt idx="19">
                  <c:v>12.55080198900032</c:v>
                </c:pt>
                <c:pt idx="20">
                  <c:v>15.551817008221406</c:v>
                </c:pt>
                <c:pt idx="21">
                  <c:v>18.772838216471428</c:v>
                </c:pt>
                <c:pt idx="22">
                  <c:v>22.150056381839022</c:v>
                </c:pt>
                <c:pt idx="23">
                  <c:v>25.687939895256932</c:v>
                </c:pt>
                <c:pt idx="24">
                  <c:v>29.437118353760525</c:v>
                </c:pt>
                <c:pt idx="25">
                  <c:v>33.418544677739192</c:v>
                </c:pt>
                <c:pt idx="26">
                  <c:v>37.636764282542572</c:v>
                </c:pt>
                <c:pt idx="27">
                  <c:v>42.153721852539093</c:v>
                </c:pt>
                <c:pt idx="28">
                  <c:v>47.083592253247843</c:v>
                </c:pt>
                <c:pt idx="29">
                  <c:v>52.492894541102942</c:v>
                </c:pt>
                <c:pt idx="30">
                  <c:v>58.361677672537553</c:v>
                </c:pt>
                <c:pt idx="31">
                  <c:v>64.641094507791422</c:v>
                </c:pt>
                <c:pt idx="32">
                  <c:v>71.277962832917183</c:v>
                </c:pt>
                <c:pt idx="33">
                  <c:v>78.214968502437841</c:v>
                </c:pt>
                <c:pt idx="34">
                  <c:v>85.399880964878321</c:v>
                </c:pt>
                <c:pt idx="35">
                  <c:v>92.725168717348424</c:v>
                </c:pt>
                <c:pt idx="36">
                  <c:v>99.974077490916898</c:v>
                </c:pt>
                <c:pt idx="37">
                  <c:v>106.94859592144712</c:v>
                </c:pt>
                <c:pt idx="38">
                  <c:v>113.65516751544783</c:v>
                </c:pt>
                <c:pt idx="39">
                  <c:v>120.25254000038694</c:v>
                </c:pt>
                <c:pt idx="40">
                  <c:v>126.82723568692018</c:v>
                </c:pt>
                <c:pt idx="41">
                  <c:v>133.30072174779889</c:v>
                </c:pt>
                <c:pt idx="42">
                  <c:v>139.51976517222829</c:v>
                </c:pt>
                <c:pt idx="43">
                  <c:v>145.40290601321249</c:v>
                </c:pt>
                <c:pt idx="44">
                  <c:v>151.03648891822559</c:v>
                </c:pt>
              </c:numCache>
            </c:numRef>
          </c:val>
          <c:smooth val="0"/>
          <c:extLst>
            <c:ext xmlns:c16="http://schemas.microsoft.com/office/drawing/2014/chart" uri="{C3380CC4-5D6E-409C-BE32-E72D297353CC}">
              <c16:uniqueId val="{00000005-9E95-437A-86C0-3528D5B3E06B}"/>
            </c:ext>
          </c:extLst>
        </c:ser>
        <c:ser>
          <c:idx val="6"/>
          <c:order val="6"/>
          <c:tx>
            <c:strRef>
              <c:f>Triplex2_54C!$A$46</c:f>
              <c:strCache>
                <c:ptCount val="1"/>
                <c:pt idx="0">
                  <c:v>Well 7 amber</c:v>
                </c:pt>
              </c:strCache>
            </c:strRef>
          </c:tx>
          <c:spPr>
            <a:ln w="28575" cap="rnd">
              <a:solidFill>
                <a:schemeClr val="accent1">
                  <a:lumMod val="60000"/>
                </a:schemeClr>
              </a:solidFill>
              <a:round/>
            </a:ln>
            <a:effectLst/>
          </c:spPr>
          <c:marker>
            <c:symbol val="none"/>
          </c:marker>
          <c:val>
            <c:numRef>
              <c:f>Triplex2_54C!$B$46:$AT$46</c:f>
              <c:numCache>
                <c:formatCode>General</c:formatCode>
                <c:ptCount val="45"/>
                <c:pt idx="0">
                  <c:v>-1.8688884388920997</c:v>
                </c:pt>
                <c:pt idx="1">
                  <c:v>-0.89409670613167691</c:v>
                </c:pt>
                <c:pt idx="2">
                  <c:v>-0.47277596054300375</c:v>
                </c:pt>
                <c:pt idx="3">
                  <c:v>-0.4131105049400503</c:v>
                </c:pt>
                <c:pt idx="4">
                  <c:v>-0.28353108480405353</c:v>
                </c:pt>
                <c:pt idx="5">
                  <c:v>-5.8523599936961546E-2</c:v>
                </c:pt>
                <c:pt idx="6">
                  <c:v>7.9653520877400297E-2</c:v>
                </c:pt>
                <c:pt idx="7">
                  <c:v>6.9138448583544232E-2</c:v>
                </c:pt>
                <c:pt idx="8">
                  <c:v>-5.4027519036026206E-2</c:v>
                </c:pt>
                <c:pt idx="9">
                  <c:v>-0.12535639147972688</c:v>
                </c:pt>
                <c:pt idx="10">
                  <c:v>8.9115541000865051E-2</c:v>
                </c:pt>
                <c:pt idx="11">
                  <c:v>0.61809933850781817</c:v>
                </c:pt>
                <c:pt idx="12">
                  <c:v>1.4213367874781397</c:v>
                </c:pt>
                <c:pt idx="13">
                  <c:v>2.6132282671005669</c:v>
                </c:pt>
                <c:pt idx="14">
                  <c:v>4.1548868271165702</c:v>
                </c:pt>
                <c:pt idx="15">
                  <c:v>5.7625985028080322</c:v>
                </c:pt>
                <c:pt idx="16">
                  <c:v>7.3476578609042917</c:v>
                </c:pt>
                <c:pt idx="17">
                  <c:v>9.1475953667159047</c:v>
                </c:pt>
                <c:pt idx="18">
                  <c:v>11.362450263959545</c:v>
                </c:pt>
                <c:pt idx="19">
                  <c:v>13.905332713946336</c:v>
                </c:pt>
                <c:pt idx="20">
                  <c:v>16.511747768980058</c:v>
                </c:pt>
                <c:pt idx="21">
                  <c:v>18.931067464694934</c:v>
                </c:pt>
                <c:pt idx="22">
                  <c:v>21.007683867814194</c:v>
                </c:pt>
                <c:pt idx="23">
                  <c:v>22.709406445352215</c:v>
                </c:pt>
                <c:pt idx="24">
                  <c:v>24.148221985740747</c:v>
                </c:pt>
                <c:pt idx="25">
                  <c:v>25.540324466825041</c:v>
                </c:pt>
                <c:pt idx="26">
                  <c:v>27.071630902204561</c:v>
                </c:pt>
                <c:pt idx="27">
                  <c:v>28.773164370630184</c:v>
                </c:pt>
                <c:pt idx="28">
                  <c:v>30.543941280817307</c:v>
                </c:pt>
                <c:pt idx="29">
                  <c:v>32.312036676183197</c:v>
                </c:pt>
                <c:pt idx="30">
                  <c:v>34.112354134336783</c:v>
                </c:pt>
                <c:pt idx="31">
                  <c:v>35.974351722243227</c:v>
                </c:pt>
                <c:pt idx="32">
                  <c:v>37.845786962227066</c:v>
                </c:pt>
                <c:pt idx="33">
                  <c:v>39.666244300331527</c:v>
                </c:pt>
                <c:pt idx="34">
                  <c:v>41.457780389566324</c:v>
                </c:pt>
                <c:pt idx="35">
                  <c:v>43.332378212584445</c:v>
                </c:pt>
                <c:pt idx="36">
                  <c:v>45.391540468259336</c:v>
                </c:pt>
                <c:pt idx="37">
                  <c:v>47.597317005178411</c:v>
                </c:pt>
                <c:pt idx="38">
                  <c:v>49.762762098302119</c:v>
                </c:pt>
                <c:pt idx="39">
                  <c:v>51.690710293629309</c:v>
                </c:pt>
                <c:pt idx="40">
                  <c:v>53.343815628582888</c:v>
                </c:pt>
                <c:pt idx="41">
                  <c:v>54.850568476857006</c:v>
                </c:pt>
                <c:pt idx="42">
                  <c:v>56.284626558568561</c:v>
                </c:pt>
                <c:pt idx="43">
                  <c:v>57.526537312380242</c:v>
                </c:pt>
                <c:pt idx="44">
                  <c:v>58.519095607767667</c:v>
                </c:pt>
              </c:numCache>
            </c:numRef>
          </c:val>
          <c:smooth val="0"/>
          <c:extLst>
            <c:ext xmlns:c16="http://schemas.microsoft.com/office/drawing/2014/chart" uri="{C3380CC4-5D6E-409C-BE32-E72D297353CC}">
              <c16:uniqueId val="{00000006-9E95-437A-86C0-3528D5B3E06B}"/>
            </c:ext>
          </c:extLst>
        </c:ser>
        <c:ser>
          <c:idx val="7"/>
          <c:order val="7"/>
          <c:tx>
            <c:strRef>
              <c:f>Triplex2_54C!$A$49</c:f>
              <c:strCache>
                <c:ptCount val="1"/>
                <c:pt idx="0">
                  <c:v>Well 8 amber</c:v>
                </c:pt>
              </c:strCache>
            </c:strRef>
          </c:tx>
          <c:spPr>
            <a:ln w="28575" cap="rnd">
              <a:solidFill>
                <a:schemeClr val="accent2">
                  <a:lumMod val="60000"/>
                </a:schemeClr>
              </a:solidFill>
              <a:round/>
            </a:ln>
            <a:effectLst/>
          </c:spPr>
          <c:marker>
            <c:symbol val="none"/>
          </c:marker>
          <c:val>
            <c:numRef>
              <c:f>Triplex2_54C!$B$49:$AT$49</c:f>
              <c:numCache>
                <c:formatCode>General</c:formatCode>
                <c:ptCount val="45"/>
                <c:pt idx="0">
                  <c:v>24.907380792996264</c:v>
                </c:pt>
                <c:pt idx="1">
                  <c:v>21.995552049382241</c:v>
                </c:pt>
                <c:pt idx="2">
                  <c:v>19.459836064759656</c:v>
                </c:pt>
                <c:pt idx="3">
                  <c:v>17.226249303001168</c:v>
                </c:pt>
                <c:pt idx="4">
                  <c:v>15.045537992407844</c:v>
                </c:pt>
                <c:pt idx="5">
                  <c:v>12.865694922023977</c:v>
                </c:pt>
                <c:pt idx="6">
                  <c:v>10.762191404839541</c:v>
                </c:pt>
                <c:pt idx="7">
                  <c:v>8.7761031666868803</c:v>
                </c:pt>
                <c:pt idx="8">
                  <c:v>6.9102985582539986</c:v>
                </c:pt>
                <c:pt idx="9">
                  <c:v>5.1570408814550319</c:v>
                </c:pt>
                <c:pt idx="10">
                  <c:v>3.5306611252763105</c:v>
                </c:pt>
                <c:pt idx="11">
                  <c:v>2.0976825081434072</c:v>
                </c:pt>
                <c:pt idx="12">
                  <c:v>0.87511327834727126</c:v>
                </c:pt>
                <c:pt idx="13">
                  <c:v>-0.28673594173233141</c:v>
                </c:pt>
                <c:pt idx="14">
                  <c:v>-1.5532277319653076</c:v>
                </c:pt>
                <c:pt idx="15">
                  <c:v>-2.8474838412239478</c:v>
                </c:pt>
                <c:pt idx="16">
                  <c:v>-3.9505907830080105</c:v>
                </c:pt>
                <c:pt idx="17">
                  <c:v>-4.8619972489759675</c:v>
                </c:pt>
                <c:pt idx="18">
                  <c:v>-5.8091409619100887</c:v>
                </c:pt>
                <c:pt idx="19">
                  <c:v>-6.9274318539155502</c:v>
                </c:pt>
                <c:pt idx="20">
                  <c:v>-8.1176086607592879</c:v>
                </c:pt>
                <c:pt idx="21">
                  <c:v>-9.0945204797408223</c:v>
                </c:pt>
                <c:pt idx="22">
                  <c:v>-9.5011937265153392</c:v>
                </c:pt>
                <c:pt idx="23">
                  <c:v>-9.1534720351573924</c:v>
                </c:pt>
                <c:pt idx="24">
                  <c:v>-8.2552918378150935</c:v>
                </c:pt>
                <c:pt idx="25">
                  <c:v>-7.2920526882280683</c:v>
                </c:pt>
                <c:pt idx="26">
                  <c:v>-6.637165545791504</c:v>
                </c:pt>
                <c:pt idx="27">
                  <c:v>-6.1974426512606442</c:v>
                </c:pt>
                <c:pt idx="28">
                  <c:v>-5.4973312381825963</c:v>
                </c:pt>
                <c:pt idx="29">
                  <c:v>-4.2075190480591118</c:v>
                </c:pt>
                <c:pt idx="30">
                  <c:v>-2.4449995758914156</c:v>
                </c:pt>
                <c:pt idx="31">
                  <c:v>-0.51669299834793492</c:v>
                </c:pt>
                <c:pt idx="32">
                  <c:v>1.3923244645447994</c:v>
                </c:pt>
                <c:pt idx="33">
                  <c:v>3.1893474042299204</c:v>
                </c:pt>
                <c:pt idx="34">
                  <c:v>4.7060295531973679</c:v>
                </c:pt>
                <c:pt idx="35">
                  <c:v>5.7393417217626848</c:v>
                </c:pt>
                <c:pt idx="36">
                  <c:v>6.2095662459523737</c:v>
                </c:pt>
                <c:pt idx="37">
                  <c:v>6.1624164277236559</c:v>
                </c:pt>
                <c:pt idx="38">
                  <c:v>5.7624123924942978</c:v>
                </c:pt>
                <c:pt idx="39">
                  <c:v>5.3366300272409717</c:v>
                </c:pt>
                <c:pt idx="40">
                  <c:v>5.0972060913718451</c:v>
                </c:pt>
                <c:pt idx="41">
                  <c:v>4.7375247790550929</c:v>
                </c:pt>
                <c:pt idx="42">
                  <c:v>3.6298733566236479</c:v>
                </c:pt>
                <c:pt idx="43">
                  <c:v>1.5044931585507584</c:v>
                </c:pt>
                <c:pt idx="44">
                  <c:v>-1.2900526192388497</c:v>
                </c:pt>
              </c:numCache>
            </c:numRef>
          </c:val>
          <c:smooth val="0"/>
          <c:extLst>
            <c:ext xmlns:c16="http://schemas.microsoft.com/office/drawing/2014/chart" uri="{C3380CC4-5D6E-409C-BE32-E72D297353CC}">
              <c16:uniqueId val="{00000007-9E95-437A-86C0-3528D5B3E06B}"/>
            </c:ext>
          </c:extLst>
        </c:ser>
        <c:ser>
          <c:idx val="8"/>
          <c:order val="8"/>
          <c:tx>
            <c:strRef>
              <c:f>Triplex2_54C!$A$52</c:f>
              <c:strCache>
                <c:ptCount val="1"/>
                <c:pt idx="0">
                  <c:v>Well 9 amber</c:v>
                </c:pt>
              </c:strCache>
            </c:strRef>
          </c:tx>
          <c:spPr>
            <a:ln w="28575" cap="rnd">
              <a:solidFill>
                <a:schemeClr val="accent3">
                  <a:lumMod val="60000"/>
                </a:schemeClr>
              </a:solidFill>
              <a:round/>
            </a:ln>
            <a:effectLst/>
          </c:spPr>
          <c:marker>
            <c:symbol val="none"/>
          </c:marker>
          <c:val>
            <c:numRef>
              <c:f>Triplex2_54C!$B$52:$AT$52</c:f>
              <c:numCache>
                <c:formatCode>General</c:formatCode>
                <c:ptCount val="45"/>
                <c:pt idx="0">
                  <c:v>-85.984892055179444</c:v>
                </c:pt>
                <c:pt idx="1">
                  <c:v>-61.273199846820717</c:v>
                </c:pt>
                <c:pt idx="2">
                  <c:v>-42.304071629758255</c:v>
                </c:pt>
                <c:pt idx="3">
                  <c:v>-30.647300100603388</c:v>
                </c:pt>
                <c:pt idx="4">
                  <c:v>-24.185256701688559</c:v>
                </c:pt>
                <c:pt idx="5">
                  <c:v>-20.181024283996521</c:v>
                </c:pt>
                <c:pt idx="6">
                  <c:v>-17.022099930651166</c:v>
                </c:pt>
                <c:pt idx="7">
                  <c:v>-14.118758992188305</c:v>
                </c:pt>
                <c:pt idx="8">
                  <c:v>-11.271232163146124</c:v>
                </c:pt>
                <c:pt idx="9">
                  <c:v>-8.3921752424812439</c:v>
                </c:pt>
                <c:pt idx="10">
                  <c:v>-5.4299208558732062</c:v>
                </c:pt>
                <c:pt idx="11">
                  <c:v>-2.2878165987167449</c:v>
                </c:pt>
                <c:pt idx="12">
                  <c:v>1.0428001590389613</c:v>
                </c:pt>
                <c:pt idx="13">
                  <c:v>4.0474780483673385</c:v>
                </c:pt>
                <c:pt idx="14">
                  <c:v>5.7331247057718429</c:v>
                </c:pt>
                <c:pt idx="15">
                  <c:v>5.8859829559860373</c:v>
                </c:pt>
                <c:pt idx="16">
                  <c:v>5.6197632149742276</c:v>
                </c:pt>
                <c:pt idx="17">
                  <c:v>6.0455103660096938</c:v>
                </c:pt>
                <c:pt idx="18">
                  <c:v>7.3640483551680518</c:v>
                </c:pt>
                <c:pt idx="19">
                  <c:v>9.2143373779435933</c:v>
                </c:pt>
                <c:pt idx="20">
                  <c:v>10.930116319555964</c:v>
                </c:pt>
                <c:pt idx="21">
                  <c:v>11.715326711790112</c:v>
                </c:pt>
                <c:pt idx="22">
                  <c:v>11.302325681450384</c:v>
                </c:pt>
                <c:pt idx="23">
                  <c:v>10.212248105224717</c:v>
                </c:pt>
                <c:pt idx="24">
                  <c:v>9.0780060993165534</c:v>
                </c:pt>
                <c:pt idx="25">
                  <c:v>8.1359603288601647</c:v>
                </c:pt>
                <c:pt idx="26">
                  <c:v>7.3800584904220159</c:v>
                </c:pt>
                <c:pt idx="27">
                  <c:v>6.7195053228460893</c:v>
                </c:pt>
                <c:pt idx="28">
                  <c:v>5.983546518960793</c:v>
                </c:pt>
                <c:pt idx="29">
                  <c:v>5.0535861470380041</c:v>
                </c:pt>
                <c:pt idx="30">
                  <c:v>3.9900515118933981</c:v>
                </c:pt>
                <c:pt idx="31">
                  <c:v>2.888671476410309</c:v>
                </c:pt>
                <c:pt idx="32">
                  <c:v>1.7115942793861905</c:v>
                </c:pt>
                <c:pt idx="33">
                  <c:v>0.4526442542555742</c:v>
                </c:pt>
                <c:pt idx="34">
                  <c:v>-0.70359138536150567</c:v>
                </c:pt>
                <c:pt idx="35">
                  <c:v>-1.6311229827988427</c:v>
                </c:pt>
                <c:pt idx="36">
                  <c:v>-2.5025282959286415</c:v>
                </c:pt>
                <c:pt idx="37">
                  <c:v>-3.5732128838353674</c:v>
                </c:pt>
                <c:pt idx="38">
                  <c:v>-4.8035458959275275</c:v>
                </c:pt>
                <c:pt idx="39">
                  <c:v>-5.85886331751135</c:v>
                </c:pt>
                <c:pt idx="40">
                  <c:v>-6.5017540909266245</c:v>
                </c:pt>
                <c:pt idx="41">
                  <c:v>-6.9247457185938401</c:v>
                </c:pt>
                <c:pt idx="42">
                  <c:v>-7.7351228785755666</c:v>
                </c:pt>
                <c:pt idx="43">
                  <c:v>-9.4910070191035629</c:v>
                </c:pt>
                <c:pt idx="44">
                  <c:v>-12.078163894990212</c:v>
                </c:pt>
              </c:numCache>
            </c:numRef>
          </c:val>
          <c:smooth val="0"/>
          <c:extLst>
            <c:ext xmlns:c16="http://schemas.microsoft.com/office/drawing/2014/chart" uri="{C3380CC4-5D6E-409C-BE32-E72D297353CC}">
              <c16:uniqueId val="{00000008-9E95-437A-86C0-3528D5B3E06B}"/>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1100"/>
          <c:min val="-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iplex 2 S:215G</a:t>
            </a: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Triplex2_54C!$A$29</c:f>
              <c:strCache>
                <c:ptCount val="1"/>
                <c:pt idx="0">
                  <c:v>Well 1 red</c:v>
                </c:pt>
              </c:strCache>
            </c:strRef>
          </c:tx>
          <c:spPr>
            <a:ln w="28575" cap="rnd">
              <a:solidFill>
                <a:schemeClr val="accent1"/>
              </a:solidFill>
              <a:round/>
            </a:ln>
            <a:effectLst/>
          </c:spPr>
          <c:marker>
            <c:symbol val="none"/>
          </c:marker>
          <c:val>
            <c:numRef>
              <c:f>Triplex2_54C!$B$29:$AT$29</c:f>
              <c:numCache>
                <c:formatCode>General</c:formatCode>
                <c:ptCount val="45"/>
                <c:pt idx="0">
                  <c:v>-72.538314348876156</c:v>
                </c:pt>
                <c:pt idx="1">
                  <c:v>-53.57368633061742</c:v>
                </c:pt>
                <c:pt idx="2">
                  <c:v>-39.45594323804653</c:v>
                </c:pt>
                <c:pt idx="3">
                  <c:v>-30.480189437739682</c:v>
                </c:pt>
                <c:pt idx="4">
                  <c:v>-24.073890701236451</c:v>
                </c:pt>
                <c:pt idx="5">
                  <c:v>-18.731813734386378</c:v>
                </c:pt>
                <c:pt idx="6">
                  <c:v>-14.351730056598171</c:v>
                </c:pt>
                <c:pt idx="7">
                  <c:v>-10.407678563011359</c:v>
                </c:pt>
                <c:pt idx="8">
                  <c:v>-5.9416588411495468</c:v>
                </c:pt>
                <c:pt idx="9">
                  <c:v>-0.99272514362746733</c:v>
                </c:pt>
                <c:pt idx="10">
                  <c:v>2.896121005556779</c:v>
                </c:pt>
                <c:pt idx="11">
                  <c:v>4.0080140334375756</c:v>
                </c:pt>
                <c:pt idx="12">
                  <c:v>2.5917619312258466</c:v>
                </c:pt>
                <c:pt idx="13">
                  <c:v>0.78896623469699989</c:v>
                </c:pt>
                <c:pt idx="14">
                  <c:v>0.48568762221839279</c:v>
                </c:pt>
                <c:pt idx="15">
                  <c:v>2.4380113435345265</c:v>
                </c:pt>
                <c:pt idx="16">
                  <c:v>6.4159707233739027</c:v>
                </c:pt>
                <c:pt idx="17">
                  <c:v>11.030327846583532</c:v>
                </c:pt>
                <c:pt idx="18">
                  <c:v>14.230007881167694</c:v>
                </c:pt>
                <c:pt idx="19">
                  <c:v>14.614946859426709</c:v>
                </c:pt>
                <c:pt idx="20">
                  <c:v>12.47117509990494</c:v>
                </c:pt>
                <c:pt idx="21">
                  <c:v>9.3088403844867571</c:v>
                </c:pt>
                <c:pt idx="22">
                  <c:v>6.2041652916104795</c:v>
                </c:pt>
                <c:pt idx="23">
                  <c:v>3.3408487444376078</c:v>
                </c:pt>
                <c:pt idx="24">
                  <c:v>0.95264205261628376</c:v>
                </c:pt>
                <c:pt idx="25">
                  <c:v>-0.59179285637765133</c:v>
                </c:pt>
                <c:pt idx="26">
                  <c:v>-1.2950692056438129</c:v>
                </c:pt>
                <c:pt idx="27">
                  <c:v>-1.2172998047681176</c:v>
                </c:pt>
                <c:pt idx="28">
                  <c:v>-0.40752924128355517</c:v>
                </c:pt>
                <c:pt idx="29">
                  <c:v>0.44536378818884259</c:v>
                </c:pt>
                <c:pt idx="30">
                  <c:v>0.26567255289410241</c:v>
                </c:pt>
                <c:pt idx="31">
                  <c:v>-1.2347690694532503</c:v>
                </c:pt>
                <c:pt idx="32">
                  <c:v>-3.386693914380885</c:v>
                </c:pt>
                <c:pt idx="33">
                  <c:v>-5.4819213606806443</c:v>
                </c:pt>
                <c:pt idx="34">
                  <c:v>-7.0004564956598188</c:v>
                </c:pt>
                <c:pt idx="35">
                  <c:v>-7.3633957183228631</c:v>
                </c:pt>
                <c:pt idx="36">
                  <c:v>-6.5329971294522693</c:v>
                </c:pt>
                <c:pt idx="37">
                  <c:v>-5.5107132702778472</c:v>
                </c:pt>
                <c:pt idx="38">
                  <c:v>-5.2353638521781249</c:v>
                </c:pt>
                <c:pt idx="39">
                  <c:v>-5.2132645074416359</c:v>
                </c:pt>
                <c:pt idx="40">
                  <c:v>-4.1705233949560352</c:v>
                </c:pt>
                <c:pt idx="41">
                  <c:v>-1.6054862386590685</c:v>
                </c:pt>
                <c:pt idx="42">
                  <c:v>1.8650213958062523</c:v>
                </c:pt>
                <c:pt idx="43">
                  <c:v>5.026645387057215</c:v>
                </c:pt>
                <c:pt idx="44">
                  <c:v>7.2926922201586422</c:v>
                </c:pt>
              </c:numCache>
            </c:numRef>
          </c:val>
          <c:smooth val="0"/>
          <c:extLst>
            <c:ext xmlns:c16="http://schemas.microsoft.com/office/drawing/2014/chart" uri="{C3380CC4-5D6E-409C-BE32-E72D297353CC}">
              <c16:uniqueId val="{00000000-3005-4218-AEE4-07C4DBFA50BC}"/>
            </c:ext>
          </c:extLst>
        </c:ser>
        <c:ser>
          <c:idx val="1"/>
          <c:order val="1"/>
          <c:tx>
            <c:strRef>
              <c:f>Triplex2_54C!$A$32</c:f>
              <c:strCache>
                <c:ptCount val="1"/>
                <c:pt idx="0">
                  <c:v>Well 2 red</c:v>
                </c:pt>
              </c:strCache>
            </c:strRef>
          </c:tx>
          <c:spPr>
            <a:ln w="28575" cap="rnd">
              <a:solidFill>
                <a:schemeClr val="accent2"/>
              </a:solidFill>
              <a:round/>
            </a:ln>
            <a:effectLst/>
          </c:spPr>
          <c:marker>
            <c:symbol val="none"/>
          </c:marker>
          <c:val>
            <c:numRef>
              <c:f>Triplex2_54C!$B$32:$AT$32</c:f>
              <c:numCache>
                <c:formatCode>General</c:formatCode>
                <c:ptCount val="45"/>
                <c:pt idx="0">
                  <c:v>-29.830851768754655</c:v>
                </c:pt>
                <c:pt idx="1">
                  <c:v>-18.240066343303624</c:v>
                </c:pt>
                <c:pt idx="2">
                  <c:v>-11.506536929427966</c:v>
                </c:pt>
                <c:pt idx="3">
                  <c:v>-9.8714739561419265</c:v>
                </c:pt>
                <c:pt idx="4">
                  <c:v>-10.218058515567463</c:v>
                </c:pt>
                <c:pt idx="5">
                  <c:v>-10.048386382066383</c:v>
                </c:pt>
                <c:pt idx="6">
                  <c:v>-8.663692457954312</c:v>
                </c:pt>
                <c:pt idx="7">
                  <c:v>-6.411263721080104</c:v>
                </c:pt>
                <c:pt idx="8">
                  <c:v>-4.2892262154964556</c:v>
                </c:pt>
                <c:pt idx="9">
                  <c:v>-3.0863750208718557</c:v>
                </c:pt>
                <c:pt idx="10">
                  <c:v>-2.6667802783831576</c:v>
                </c:pt>
                <c:pt idx="11">
                  <c:v>-2.4669767734303605</c:v>
                </c:pt>
                <c:pt idx="12">
                  <c:v>-2.0468783302803786</c:v>
                </c:pt>
                <c:pt idx="13">
                  <c:v>-1.2664646844114031</c:v>
                </c:pt>
                <c:pt idx="14">
                  <c:v>-0.36831030599205405</c:v>
                </c:pt>
                <c:pt idx="15">
                  <c:v>0.31698966288786323</c:v>
                </c:pt>
                <c:pt idx="16">
                  <c:v>0.78868889093610051</c:v>
                </c:pt>
                <c:pt idx="17">
                  <c:v>1.3537159182615142</c:v>
                </c:pt>
                <c:pt idx="18">
                  <c:v>2.2183035104244482</c:v>
                </c:pt>
                <c:pt idx="19">
                  <c:v>3.2139115623213002</c:v>
                </c:pt>
                <c:pt idx="20">
                  <c:v>4.0228745663407608</c:v>
                </c:pt>
                <c:pt idx="21">
                  <c:v>4.5998620391874283</c:v>
                </c:pt>
                <c:pt idx="22">
                  <c:v>5.1751486553112045</c:v>
                </c:pt>
                <c:pt idx="23">
                  <c:v>5.8196810593744885</c:v>
                </c:pt>
                <c:pt idx="24">
                  <c:v>6.2813622567064158</c:v>
                </c:pt>
                <c:pt idx="25">
                  <c:v>6.5024094310920191</c:v>
                </c:pt>
                <c:pt idx="26">
                  <c:v>6.880829714516949</c:v>
                </c:pt>
                <c:pt idx="27">
                  <c:v>7.6197964250604855</c:v>
                </c:pt>
                <c:pt idx="28">
                  <c:v>8.3424151760591485</c:v>
                </c:pt>
                <c:pt idx="29">
                  <c:v>8.4356780718844675</c:v>
                </c:pt>
                <c:pt idx="30">
                  <c:v>7.3832178082084283</c:v>
                </c:pt>
                <c:pt idx="31">
                  <c:v>5.1529794670350384</c:v>
                </c:pt>
                <c:pt idx="32">
                  <c:v>2.3263224722995801</c:v>
                </c:pt>
                <c:pt idx="33">
                  <c:v>-0.30851273781809141</c:v>
                </c:pt>
                <c:pt idx="34">
                  <c:v>-1.9267792765331251</c:v>
                </c:pt>
                <c:pt idx="35">
                  <c:v>-1.8690073123962065</c:v>
                </c:pt>
                <c:pt idx="36">
                  <c:v>-0.37379734365640616</c:v>
                </c:pt>
                <c:pt idx="37">
                  <c:v>1.1691402761480276</c:v>
                </c:pt>
                <c:pt idx="38">
                  <c:v>1.199246804086215</c:v>
                </c:pt>
                <c:pt idx="39">
                  <c:v>-0.76491785794860334</c:v>
                </c:pt>
                <c:pt idx="40">
                  <c:v>-3.9016610370672424</c:v>
                </c:pt>
                <c:pt idx="41">
                  <c:v>-6.9547367394570756</c:v>
                </c:pt>
                <c:pt idx="42">
                  <c:v>-9.2148957150911883</c:v>
                </c:pt>
                <c:pt idx="43">
                  <c:v>-10.64170961419768</c:v>
                </c:pt>
                <c:pt idx="44">
                  <c:v>-11.532201963971602</c:v>
                </c:pt>
              </c:numCache>
            </c:numRef>
          </c:val>
          <c:smooth val="0"/>
          <c:extLst>
            <c:ext xmlns:c16="http://schemas.microsoft.com/office/drawing/2014/chart" uri="{C3380CC4-5D6E-409C-BE32-E72D297353CC}">
              <c16:uniqueId val="{00000001-3005-4218-AEE4-07C4DBFA50BC}"/>
            </c:ext>
          </c:extLst>
        </c:ser>
        <c:ser>
          <c:idx val="2"/>
          <c:order val="2"/>
          <c:tx>
            <c:strRef>
              <c:f>Triplex2_54C!$A$35</c:f>
              <c:strCache>
                <c:ptCount val="1"/>
                <c:pt idx="0">
                  <c:v>Well 3 red</c:v>
                </c:pt>
              </c:strCache>
            </c:strRef>
          </c:tx>
          <c:spPr>
            <a:ln w="28575" cap="rnd">
              <a:solidFill>
                <a:schemeClr val="accent3"/>
              </a:solidFill>
              <a:round/>
            </a:ln>
            <a:effectLst/>
          </c:spPr>
          <c:marker>
            <c:symbol val="none"/>
          </c:marker>
          <c:val>
            <c:numRef>
              <c:f>Triplex2_54C!$B$35:$AT$35</c:f>
              <c:numCache>
                <c:formatCode>General</c:formatCode>
                <c:ptCount val="45"/>
                <c:pt idx="0">
                  <c:v>-33.037509673087698</c:v>
                </c:pt>
                <c:pt idx="1">
                  <c:v>-23.862689636922369</c:v>
                </c:pt>
                <c:pt idx="2">
                  <c:v>-18.068464530677375</c:v>
                </c:pt>
                <c:pt idx="3">
                  <c:v>-16.233661230307916</c:v>
                </c:pt>
                <c:pt idx="4">
                  <c:v>-16.843977327594985</c:v>
                </c:pt>
                <c:pt idx="5">
                  <c:v>-18.04855406462957</c:v>
                </c:pt>
                <c:pt idx="6">
                  <c:v>-18.146139677768588</c:v>
                </c:pt>
                <c:pt idx="7">
                  <c:v>-16.203230048216938</c:v>
                </c:pt>
                <c:pt idx="8">
                  <c:v>-12.75696565351609</c:v>
                </c:pt>
                <c:pt idx="9">
                  <c:v>-8.9829868972210534</c:v>
                </c:pt>
                <c:pt idx="10">
                  <c:v>-5.4261274129366939</c:v>
                </c:pt>
                <c:pt idx="11">
                  <c:v>-2.1586560486721282</c:v>
                </c:pt>
                <c:pt idx="12">
                  <c:v>0.61079436455111136</c:v>
                </c:pt>
                <c:pt idx="13">
                  <c:v>2.6407443667649204</c:v>
                </c:pt>
                <c:pt idx="14">
                  <c:v>4.0150833884163148</c:v>
                </c:pt>
                <c:pt idx="15">
                  <c:v>5.2268841836303181</c:v>
                </c:pt>
                <c:pt idx="16">
                  <c:v>6.618096121103008</c:v>
                </c:pt>
                <c:pt idx="17">
                  <c:v>7.8225986470879434</c:v>
                </c:pt>
                <c:pt idx="18">
                  <c:v>8.2688383944387169</c:v>
                </c:pt>
                <c:pt idx="19">
                  <c:v>8.1104501340560091</c:v>
                </c:pt>
                <c:pt idx="20">
                  <c:v>8.2317640320325154</c:v>
                </c:pt>
                <c:pt idx="21">
                  <c:v>9.1691763933049515</c:v>
                </c:pt>
                <c:pt idx="22">
                  <c:v>10.390473663626835</c:v>
                </c:pt>
                <c:pt idx="23">
                  <c:v>11.107688766309366</c:v>
                </c:pt>
                <c:pt idx="24">
                  <c:v>11.10510230359796</c:v>
                </c:pt>
                <c:pt idx="25">
                  <c:v>10.349101469333618</c:v>
                </c:pt>
                <c:pt idx="26">
                  <c:v>8.8826653651976812</c:v>
                </c:pt>
                <c:pt idx="27">
                  <c:v>7.1530619973564171</c:v>
                </c:pt>
                <c:pt idx="28">
                  <c:v>5.6480942593261716</c:v>
                </c:pt>
                <c:pt idx="29">
                  <c:v>4.5672168106702884</c:v>
                </c:pt>
                <c:pt idx="30">
                  <c:v>3.885249005874357</c:v>
                </c:pt>
                <c:pt idx="31">
                  <c:v>3.2994345042425266</c:v>
                </c:pt>
                <c:pt idx="32">
                  <c:v>2.5002959074281534</c:v>
                </c:pt>
                <c:pt idx="33">
                  <c:v>1.6604562438460562</c:v>
                </c:pt>
                <c:pt idx="34">
                  <c:v>1.2485443491877959</c:v>
                </c:pt>
                <c:pt idx="35">
                  <c:v>1.3433559972418152</c:v>
                </c:pt>
                <c:pt idx="36">
                  <c:v>1.5430477593963587</c:v>
                </c:pt>
                <c:pt idx="37">
                  <c:v>1.4701194744575332</c:v>
                </c:pt>
                <c:pt idx="38">
                  <c:v>0.7752052898886177</c:v>
                </c:pt>
                <c:pt idx="39">
                  <c:v>-1.040963908584672</c:v>
                </c:pt>
                <c:pt idx="40">
                  <c:v>-4.2578374066542892</c:v>
                </c:pt>
                <c:pt idx="41">
                  <c:v>-8.6009791988981306</c:v>
                </c:pt>
                <c:pt idx="42">
                  <c:v>-13.301233813799627</c:v>
                </c:pt>
                <c:pt idx="43">
                  <c:v>-17.546100599653073</c:v>
                </c:pt>
                <c:pt idx="44">
                  <c:v>-21.173768461716463</c:v>
                </c:pt>
              </c:numCache>
            </c:numRef>
          </c:val>
          <c:smooth val="0"/>
          <c:extLst>
            <c:ext xmlns:c16="http://schemas.microsoft.com/office/drawing/2014/chart" uri="{C3380CC4-5D6E-409C-BE32-E72D297353CC}">
              <c16:uniqueId val="{00000002-3005-4218-AEE4-07C4DBFA50BC}"/>
            </c:ext>
          </c:extLst>
        </c:ser>
        <c:ser>
          <c:idx val="3"/>
          <c:order val="3"/>
          <c:tx>
            <c:strRef>
              <c:f>Triplex2_54C!$A$38</c:f>
              <c:strCache>
                <c:ptCount val="1"/>
                <c:pt idx="0">
                  <c:v>Well 4 red</c:v>
                </c:pt>
              </c:strCache>
            </c:strRef>
          </c:tx>
          <c:spPr>
            <a:ln w="28575" cap="rnd">
              <a:solidFill>
                <a:schemeClr val="accent4"/>
              </a:solidFill>
              <a:round/>
            </a:ln>
            <a:effectLst/>
          </c:spPr>
          <c:marker>
            <c:symbol val="none"/>
          </c:marker>
          <c:val>
            <c:numRef>
              <c:f>Triplex2_54C!$B$38:$AT$38</c:f>
              <c:numCache>
                <c:formatCode>General</c:formatCode>
                <c:ptCount val="45"/>
                <c:pt idx="0">
                  <c:v>10.606538835778338</c:v>
                </c:pt>
                <c:pt idx="1">
                  <c:v>11.546225600010075</c:v>
                </c:pt>
                <c:pt idx="2">
                  <c:v>11.413614087061433</c:v>
                </c:pt>
                <c:pt idx="3">
                  <c:v>10.08326275156287</c:v>
                </c:pt>
                <c:pt idx="4">
                  <c:v>8.2322784503940056</c:v>
                </c:pt>
                <c:pt idx="5">
                  <c:v>6.4829813043597824</c:v>
                </c:pt>
                <c:pt idx="6">
                  <c:v>4.9224976063305803</c:v>
                </c:pt>
                <c:pt idx="7">
                  <c:v>3.4348299701559881</c:v>
                </c:pt>
                <c:pt idx="8">
                  <c:v>2.0773430734279827</c:v>
                </c:pt>
                <c:pt idx="9">
                  <c:v>0.93445848248484253</c:v>
                </c:pt>
                <c:pt idx="10">
                  <c:v>3.0932355914046639E-2</c:v>
                </c:pt>
                <c:pt idx="11">
                  <c:v>-0.54037797303681145</c:v>
                </c:pt>
                <c:pt idx="12">
                  <c:v>-0.75901322001118388</c:v>
                </c:pt>
                <c:pt idx="13">
                  <c:v>-0.81721249304609955</c:v>
                </c:pt>
                <c:pt idx="14">
                  <c:v>-0.87781900549452985</c:v>
                </c:pt>
                <c:pt idx="15">
                  <c:v>-0.9156593606385286</c:v>
                </c:pt>
                <c:pt idx="16">
                  <c:v>-0.92281001000992546</c:v>
                </c:pt>
                <c:pt idx="17">
                  <c:v>-1.0226255843754188</c:v>
                </c:pt>
                <c:pt idx="18">
                  <c:v>-1.3102442128583789</c:v>
                </c:pt>
                <c:pt idx="19">
                  <c:v>-1.7370446440709202</c:v>
                </c:pt>
                <c:pt idx="20">
                  <c:v>-2.1487270823072322</c:v>
                </c:pt>
                <c:pt idx="21">
                  <c:v>-2.3807724685193534</c:v>
                </c:pt>
                <c:pt idx="22">
                  <c:v>-2.371143155349273</c:v>
                </c:pt>
                <c:pt idx="23">
                  <c:v>-2.2105470167352905</c:v>
                </c:pt>
                <c:pt idx="24">
                  <c:v>-2.080759468532051</c:v>
                </c:pt>
                <c:pt idx="25">
                  <c:v>-2.1189716826484073</c:v>
                </c:pt>
                <c:pt idx="26">
                  <c:v>-2.2992183119313268</c:v>
                </c:pt>
                <c:pt idx="27">
                  <c:v>-2.4369916683936026</c:v>
                </c:pt>
                <c:pt idx="28">
                  <c:v>-2.3390523671132541</c:v>
                </c:pt>
                <c:pt idx="29">
                  <c:v>-1.9887575745160575</c:v>
                </c:pt>
                <c:pt idx="30">
                  <c:v>-1.5781587672554451</c:v>
                </c:pt>
                <c:pt idx="31">
                  <c:v>-1.2940426018994913</c:v>
                </c:pt>
                <c:pt idx="32">
                  <c:v>-1.0697893764645414</c:v>
                </c:pt>
                <c:pt idx="33">
                  <c:v>-0.66618167004344286</c:v>
                </c:pt>
                <c:pt idx="34">
                  <c:v>1.1938665747948107E-2</c:v>
                </c:pt>
                <c:pt idx="35">
                  <c:v>0.80358480386166775</c:v>
                </c:pt>
                <c:pt idx="36">
                  <c:v>1.4680071683833376</c:v>
                </c:pt>
                <c:pt idx="37">
                  <c:v>1.8539769331619027</c:v>
                </c:pt>
                <c:pt idx="38">
                  <c:v>1.9061452948062652</c:v>
                </c:pt>
                <c:pt idx="39">
                  <c:v>1.7439367701390438</c:v>
                </c:pt>
                <c:pt idx="40">
                  <c:v>1.7007105626780685</c:v>
                </c:pt>
                <c:pt idx="41">
                  <c:v>1.9525446682418988</c:v>
                </c:pt>
                <c:pt idx="42">
                  <c:v>2.2617960731749918</c:v>
                </c:pt>
                <c:pt idx="43">
                  <c:v>2.2917973085841368</c:v>
                </c:pt>
                <c:pt idx="44">
                  <c:v>2.008438673830824</c:v>
                </c:pt>
              </c:numCache>
            </c:numRef>
          </c:val>
          <c:smooth val="0"/>
          <c:extLst>
            <c:ext xmlns:c16="http://schemas.microsoft.com/office/drawing/2014/chart" uri="{C3380CC4-5D6E-409C-BE32-E72D297353CC}">
              <c16:uniqueId val="{00000003-3005-4218-AEE4-07C4DBFA50BC}"/>
            </c:ext>
          </c:extLst>
        </c:ser>
        <c:ser>
          <c:idx val="4"/>
          <c:order val="4"/>
          <c:tx>
            <c:strRef>
              <c:f>Triplex2_54C!$A$41</c:f>
              <c:strCache>
                <c:ptCount val="1"/>
                <c:pt idx="0">
                  <c:v>Well 5 red</c:v>
                </c:pt>
              </c:strCache>
            </c:strRef>
          </c:tx>
          <c:spPr>
            <a:ln w="28575" cap="rnd">
              <a:solidFill>
                <a:schemeClr val="accent5"/>
              </a:solidFill>
              <a:round/>
            </a:ln>
            <a:effectLst/>
          </c:spPr>
          <c:marker>
            <c:symbol val="none"/>
          </c:marker>
          <c:val>
            <c:numRef>
              <c:f>Triplex2_54C!$B$41:$AT$41</c:f>
              <c:numCache>
                <c:formatCode>General</c:formatCode>
                <c:ptCount val="45"/>
                <c:pt idx="0">
                  <c:v>7.3918182860343222</c:v>
                </c:pt>
                <c:pt idx="1">
                  <c:v>8.8514489899225737</c:v>
                </c:pt>
                <c:pt idx="2">
                  <c:v>8.8175464024516259</c:v>
                </c:pt>
                <c:pt idx="3">
                  <c:v>7.1872842366428813</c:v>
                </c:pt>
                <c:pt idx="4">
                  <c:v>4.9475590496313089</c:v>
                </c:pt>
                <c:pt idx="5">
                  <c:v>3.0717587019207713</c:v>
                </c:pt>
                <c:pt idx="6">
                  <c:v>1.9718972474147449</c:v>
                </c:pt>
                <c:pt idx="7">
                  <c:v>1.5021194780201768</c:v>
                </c:pt>
                <c:pt idx="8">
                  <c:v>1.250113387219244</c:v>
                </c:pt>
                <c:pt idx="9">
                  <c:v>0.94788809345664049</c:v>
                </c:pt>
                <c:pt idx="10">
                  <c:v>0.57707030831443262</c:v>
                </c:pt>
                <c:pt idx="11">
                  <c:v>0.1800341270663921</c:v>
                </c:pt>
                <c:pt idx="12">
                  <c:v>-0.20665875285158108</c:v>
                </c:pt>
                <c:pt idx="13">
                  <c:v>-0.48578289870056324</c:v>
                </c:pt>
                <c:pt idx="14">
                  <c:v>-0.56804093413484225</c:v>
                </c:pt>
                <c:pt idx="15">
                  <c:v>-0.53889384087233339</c:v>
                </c:pt>
                <c:pt idx="16">
                  <c:v>-0.5946381947142072</c:v>
                </c:pt>
                <c:pt idx="17">
                  <c:v>-0.79080508860533882</c:v>
                </c:pt>
                <c:pt idx="18">
                  <c:v>-1.0108689230746677</c:v>
                </c:pt>
                <c:pt idx="19">
                  <c:v>-1.1342345499506337</c:v>
                </c:pt>
                <c:pt idx="20">
                  <c:v>-1.1570855218906217</c:v>
                </c:pt>
                <c:pt idx="21">
                  <c:v>-1.198839228878569</c:v>
                </c:pt>
                <c:pt idx="22">
                  <c:v>-1.3395579759144312</c:v>
                </c:pt>
                <c:pt idx="23">
                  <c:v>-1.4846281881236791</c:v>
                </c:pt>
                <c:pt idx="24">
                  <c:v>-1.4986179775023629</c:v>
                </c:pt>
                <c:pt idx="25">
                  <c:v>-1.3775027648789546</c:v>
                </c:pt>
                <c:pt idx="26">
                  <c:v>-1.2109899218394276</c:v>
                </c:pt>
                <c:pt idx="27">
                  <c:v>-1.0811226490113768</c:v>
                </c:pt>
                <c:pt idx="28">
                  <c:v>-1.0161822084373853</c:v>
                </c:pt>
                <c:pt idx="29">
                  <c:v>-0.97690684894041624</c:v>
                </c:pt>
                <c:pt idx="30">
                  <c:v>-0.8887453609277145</c:v>
                </c:pt>
                <c:pt idx="31">
                  <c:v>-0.66900532727595419</c:v>
                </c:pt>
                <c:pt idx="32">
                  <c:v>-0.25069708120463474</c:v>
                </c:pt>
                <c:pt idx="33">
                  <c:v>0.35328676295466721</c:v>
                </c:pt>
                <c:pt idx="34">
                  <c:v>1.0170356076796452</c:v>
                </c:pt>
                <c:pt idx="35">
                  <c:v>1.5227331076166593</c:v>
                </c:pt>
                <c:pt idx="36">
                  <c:v>1.6302724062152265</c:v>
                </c:pt>
                <c:pt idx="37">
                  <c:v>1.2521009002030041</c:v>
                </c:pt>
                <c:pt idx="38">
                  <c:v>0.62641285617610265</c:v>
                </c:pt>
                <c:pt idx="39">
                  <c:v>0.20173709023765696</c:v>
                </c:pt>
                <c:pt idx="40">
                  <c:v>0.25380199807841564</c:v>
                </c:pt>
                <c:pt idx="41">
                  <c:v>0.65759984828036977</c:v>
                </c:pt>
                <c:pt idx="42">
                  <c:v>1.0119938252901193</c:v>
                </c:pt>
                <c:pt idx="43">
                  <c:v>0.95664811166534491</c:v>
                </c:pt>
                <c:pt idx="44">
                  <c:v>0.49530038001284993</c:v>
                </c:pt>
              </c:numCache>
            </c:numRef>
          </c:val>
          <c:smooth val="0"/>
          <c:extLst>
            <c:ext xmlns:c16="http://schemas.microsoft.com/office/drawing/2014/chart" uri="{C3380CC4-5D6E-409C-BE32-E72D297353CC}">
              <c16:uniqueId val="{00000004-3005-4218-AEE4-07C4DBFA50BC}"/>
            </c:ext>
          </c:extLst>
        </c:ser>
        <c:ser>
          <c:idx val="5"/>
          <c:order val="5"/>
          <c:tx>
            <c:strRef>
              <c:f>Triplex2_54C!$A$44</c:f>
              <c:strCache>
                <c:ptCount val="1"/>
                <c:pt idx="0">
                  <c:v>Well 6 red</c:v>
                </c:pt>
              </c:strCache>
            </c:strRef>
          </c:tx>
          <c:spPr>
            <a:ln w="28575" cap="rnd">
              <a:solidFill>
                <a:schemeClr val="accent6"/>
              </a:solidFill>
              <a:round/>
            </a:ln>
            <a:effectLst/>
          </c:spPr>
          <c:marker>
            <c:symbol val="none"/>
          </c:marker>
          <c:val>
            <c:numRef>
              <c:f>Triplex2_54C!$B$44:$AT$44</c:f>
              <c:numCache>
                <c:formatCode>General</c:formatCode>
                <c:ptCount val="45"/>
                <c:pt idx="0">
                  <c:v>29.486670818669154</c:v>
                </c:pt>
                <c:pt idx="1">
                  <c:v>27.075947831870508</c:v>
                </c:pt>
                <c:pt idx="2">
                  <c:v>23.981386782244954</c:v>
                </c:pt>
                <c:pt idx="3">
                  <c:v>20.231669937935294</c:v>
                </c:pt>
                <c:pt idx="4">
                  <c:v>16.263264183480715</c:v>
                </c:pt>
                <c:pt idx="5">
                  <c:v>12.270349130456452</c:v>
                </c:pt>
                <c:pt idx="6">
                  <c:v>8.3189197588126262</c:v>
                </c:pt>
                <c:pt idx="7">
                  <c:v>4.729713542465106</c:v>
                </c:pt>
                <c:pt idx="8">
                  <c:v>1.8856527786974766</c:v>
                </c:pt>
                <c:pt idx="9">
                  <c:v>-7.294186344188347E-2</c:v>
                </c:pt>
                <c:pt idx="10">
                  <c:v>-1.208012049066383</c:v>
                </c:pt>
                <c:pt idx="11">
                  <c:v>-1.7479154544580524</c:v>
                </c:pt>
                <c:pt idx="12">
                  <c:v>-2.1130883556415938</c:v>
                </c:pt>
                <c:pt idx="13">
                  <c:v>-2.6351541039985023</c:v>
                </c:pt>
                <c:pt idx="14">
                  <c:v>-3.1829413215637032</c:v>
                </c:pt>
                <c:pt idx="15">
                  <c:v>-3.3472565750798822</c:v>
                </c:pt>
                <c:pt idx="16">
                  <c:v>-3.004514624377407</c:v>
                </c:pt>
                <c:pt idx="17">
                  <c:v>-2.4250546596631466</c:v>
                </c:pt>
                <c:pt idx="18">
                  <c:v>-1.9007148369801143</c:v>
                </c:pt>
                <c:pt idx="19">
                  <c:v>-1.5303529607772361</c:v>
                </c:pt>
                <c:pt idx="20">
                  <c:v>-1.2785610698047094</c:v>
                </c:pt>
                <c:pt idx="21">
                  <c:v>-1.1076780864113971</c:v>
                </c:pt>
                <c:pt idx="22">
                  <c:v>-1.1003320050895127</c:v>
                </c:pt>
                <c:pt idx="23">
                  <c:v>-1.3813819406732364</c:v>
                </c:pt>
                <c:pt idx="24">
                  <c:v>-1.899169117306883</c:v>
                </c:pt>
                <c:pt idx="25">
                  <c:v>-2.4341748832121084</c:v>
                </c:pt>
                <c:pt idx="26">
                  <c:v>-2.7860016251579509</c:v>
                </c:pt>
                <c:pt idx="27">
                  <c:v>-2.8552272081651608</c:v>
                </c:pt>
                <c:pt idx="28">
                  <c:v>-2.6478167170371307</c:v>
                </c:pt>
                <c:pt idx="29">
                  <c:v>-2.2462545538564882</c:v>
                </c:pt>
                <c:pt idx="30">
                  <c:v>-1.7555820639227022</c:v>
                </c:pt>
                <c:pt idx="31">
                  <c:v>-1.2669216180020157</c:v>
                </c:pt>
                <c:pt idx="32">
                  <c:v>-0.83496803157140675</c:v>
                </c:pt>
                <c:pt idx="33">
                  <c:v>-0.50309070347429952</c:v>
                </c:pt>
                <c:pt idx="34">
                  <c:v>-0.28295473612342903</c:v>
                </c:pt>
                <c:pt idx="35">
                  <c:v>-3.8992122437775834E-2</c:v>
                </c:pt>
                <c:pt idx="36">
                  <c:v>0.46438342628971441</c:v>
                </c:pt>
                <c:pt idx="37">
                  <c:v>1.2895228836769093</c:v>
                </c:pt>
                <c:pt idx="38">
                  <c:v>2.1968147401530587</c:v>
                </c:pt>
                <c:pt idx="39">
                  <c:v>2.8500739365190384</c:v>
                </c:pt>
                <c:pt idx="40">
                  <c:v>3.1346037712191901</c:v>
                </c:pt>
                <c:pt idx="41">
                  <c:v>3.198278874371681</c:v>
                </c:pt>
                <c:pt idx="42">
                  <c:v>3.086562546537607</c:v>
                </c:pt>
                <c:pt idx="43">
                  <c:v>2.5684240776245133</c:v>
                </c:pt>
                <c:pt idx="44">
                  <c:v>1.5937538204161683</c:v>
                </c:pt>
              </c:numCache>
            </c:numRef>
          </c:val>
          <c:smooth val="0"/>
          <c:extLst>
            <c:ext xmlns:c16="http://schemas.microsoft.com/office/drawing/2014/chart" uri="{C3380CC4-5D6E-409C-BE32-E72D297353CC}">
              <c16:uniqueId val="{00000005-3005-4218-AEE4-07C4DBFA50BC}"/>
            </c:ext>
          </c:extLst>
        </c:ser>
        <c:ser>
          <c:idx val="6"/>
          <c:order val="6"/>
          <c:tx>
            <c:strRef>
              <c:f>Triplex2_54C!$A$47</c:f>
              <c:strCache>
                <c:ptCount val="1"/>
                <c:pt idx="0">
                  <c:v>Well 7 red</c:v>
                </c:pt>
              </c:strCache>
            </c:strRef>
          </c:tx>
          <c:spPr>
            <a:ln w="28575" cap="rnd">
              <a:solidFill>
                <a:schemeClr val="accent1">
                  <a:lumMod val="60000"/>
                </a:schemeClr>
              </a:solidFill>
              <a:round/>
            </a:ln>
            <a:effectLst/>
          </c:spPr>
          <c:marker>
            <c:symbol val="none"/>
          </c:marker>
          <c:val>
            <c:numRef>
              <c:f>Triplex2_54C!$B$47:$AT$47</c:f>
              <c:numCache>
                <c:formatCode>General</c:formatCode>
                <c:ptCount val="45"/>
                <c:pt idx="0">
                  <c:v>28.010232375327178</c:v>
                </c:pt>
                <c:pt idx="1">
                  <c:v>27.740794429309972</c:v>
                </c:pt>
                <c:pt idx="2">
                  <c:v>26.01175674084152</c:v>
                </c:pt>
                <c:pt idx="3">
                  <c:v>23.079917900373403</c:v>
                </c:pt>
                <c:pt idx="4">
                  <c:v>20.088278111861655</c:v>
                </c:pt>
                <c:pt idx="5">
                  <c:v>17.565917917467232</c:v>
                </c:pt>
                <c:pt idx="6">
                  <c:v>15.146160845459235</c:v>
                </c:pt>
                <c:pt idx="7">
                  <c:v>12.046913588585085</c:v>
                </c:pt>
                <c:pt idx="8">
                  <c:v>7.7524374102576985</c:v>
                </c:pt>
                <c:pt idx="9">
                  <c:v>2.7022420034772949</c:v>
                </c:pt>
                <c:pt idx="10">
                  <c:v>-1.8892714069461363</c:v>
                </c:pt>
                <c:pt idx="11">
                  <c:v>-5.2057486218982376</c:v>
                </c:pt>
                <c:pt idx="12">
                  <c:v>-7.1990645405803662</c:v>
                </c:pt>
                <c:pt idx="13">
                  <c:v>-7.9655819263207377</c:v>
                </c:pt>
                <c:pt idx="14">
                  <c:v>-7.7757016540199402</c:v>
                </c:pt>
                <c:pt idx="15">
                  <c:v>-7.2463427211769158</c:v>
                </c:pt>
                <c:pt idx="16">
                  <c:v>-6.7554780582086096</c:v>
                </c:pt>
                <c:pt idx="17">
                  <c:v>-6.1781787842537597</c:v>
                </c:pt>
                <c:pt idx="18">
                  <c:v>-5.3435371816231054</c:v>
                </c:pt>
                <c:pt idx="19">
                  <c:v>-4.3243257328977052</c:v>
                </c:pt>
                <c:pt idx="20">
                  <c:v>-3.3270378374309075</c:v>
                </c:pt>
                <c:pt idx="21">
                  <c:v>-2.5371049148579914</c:v>
                </c:pt>
                <c:pt idx="22">
                  <c:v>-2.0279554095941421</c:v>
                </c:pt>
                <c:pt idx="23">
                  <c:v>-1.7751808816574339</c:v>
                </c:pt>
                <c:pt idx="24">
                  <c:v>-1.7379021930191811</c:v>
                </c:pt>
                <c:pt idx="25">
                  <c:v>-1.8409276822385436</c:v>
                </c:pt>
                <c:pt idx="26">
                  <c:v>-1.9743456175274332</c:v>
                </c:pt>
                <c:pt idx="27">
                  <c:v>-2.0279209796026407</c:v>
                </c:pt>
                <c:pt idx="28">
                  <c:v>-1.8373559450119501</c:v>
                </c:pt>
                <c:pt idx="29">
                  <c:v>-1.2859725707294274</c:v>
                </c:pt>
                <c:pt idx="30">
                  <c:v>-0.55313085933812545</c:v>
                </c:pt>
                <c:pt idx="31">
                  <c:v>-2.7193932606678572E-2</c:v>
                </c:pt>
                <c:pt idx="32">
                  <c:v>0.1260325260936952</c:v>
                </c:pt>
                <c:pt idx="33">
                  <c:v>0.13081703790885513</c:v>
                </c:pt>
                <c:pt idx="34">
                  <c:v>0.32129757720940688</c:v>
                </c:pt>
                <c:pt idx="35">
                  <c:v>0.80876145035108493</c:v>
                </c:pt>
                <c:pt idx="36">
                  <c:v>1.4093855980881926</c:v>
                </c:pt>
                <c:pt idx="37">
                  <c:v>1.8864230546405452</c:v>
                </c:pt>
                <c:pt idx="38">
                  <c:v>2.1991311209567357</c:v>
                </c:pt>
                <c:pt idx="39">
                  <c:v>2.5003889957806678</c:v>
                </c:pt>
                <c:pt idx="40">
                  <c:v>2.9369291506864101</c:v>
                </c:pt>
                <c:pt idx="41">
                  <c:v>3.4157124747707712</c:v>
                </c:pt>
                <c:pt idx="42">
                  <c:v>3.65280728180187</c:v>
                </c:pt>
                <c:pt idx="43">
                  <c:v>3.4292882559329882</c:v>
                </c:pt>
                <c:pt idx="44">
                  <c:v>2.8046131620794768</c:v>
                </c:pt>
              </c:numCache>
            </c:numRef>
          </c:val>
          <c:smooth val="0"/>
          <c:extLst>
            <c:ext xmlns:c16="http://schemas.microsoft.com/office/drawing/2014/chart" uri="{C3380CC4-5D6E-409C-BE32-E72D297353CC}">
              <c16:uniqueId val="{00000006-3005-4218-AEE4-07C4DBFA50BC}"/>
            </c:ext>
          </c:extLst>
        </c:ser>
        <c:ser>
          <c:idx val="7"/>
          <c:order val="7"/>
          <c:tx>
            <c:strRef>
              <c:f>Triplex2_54C!$A$50</c:f>
              <c:strCache>
                <c:ptCount val="1"/>
                <c:pt idx="0">
                  <c:v>Well 8 red</c:v>
                </c:pt>
              </c:strCache>
            </c:strRef>
          </c:tx>
          <c:spPr>
            <a:ln w="28575" cap="rnd">
              <a:solidFill>
                <a:schemeClr val="accent2">
                  <a:lumMod val="60000"/>
                </a:schemeClr>
              </a:solidFill>
              <a:round/>
            </a:ln>
            <a:effectLst/>
          </c:spPr>
          <c:marker>
            <c:symbol val="none"/>
          </c:marker>
          <c:val>
            <c:numRef>
              <c:f>Triplex2_54C!$B$50:$AT$50</c:f>
              <c:numCache>
                <c:formatCode>General</c:formatCode>
                <c:ptCount val="45"/>
                <c:pt idx="0">
                  <c:v>17.362817582959906</c:v>
                </c:pt>
                <c:pt idx="1">
                  <c:v>15.724340750317424</c:v>
                </c:pt>
                <c:pt idx="2">
                  <c:v>14.246228292864544</c:v>
                </c:pt>
                <c:pt idx="3">
                  <c:v>12.888917071668402</c:v>
                </c:pt>
                <c:pt idx="4">
                  <c:v>11.458970446448802</c:v>
                </c:pt>
                <c:pt idx="5">
                  <c:v>9.8273921346117277</c:v>
                </c:pt>
                <c:pt idx="6">
                  <c:v>8.0879373655279778</c:v>
                </c:pt>
                <c:pt idx="7">
                  <c:v>6.4958061391389492</c:v>
                </c:pt>
                <c:pt idx="8">
                  <c:v>5.1856596312718466</c:v>
                </c:pt>
                <c:pt idx="9">
                  <c:v>4.0242078864066571</c:v>
                </c:pt>
                <c:pt idx="10">
                  <c:v>2.8359499294692796</c:v>
                </c:pt>
                <c:pt idx="11">
                  <c:v>1.6293440300669317</c:v>
                </c:pt>
                <c:pt idx="12">
                  <c:v>0.52529879448957217</c:v>
                </c:pt>
                <c:pt idx="13">
                  <c:v>-0.41251079737776308</c:v>
                </c:pt>
                <c:pt idx="14">
                  <c:v>-1.215502065990222</c:v>
                </c:pt>
                <c:pt idx="15">
                  <c:v>-1.9188499012452667</c:v>
                </c:pt>
                <c:pt idx="16">
                  <c:v>-2.5388750061811152</c:v>
                </c:pt>
                <c:pt idx="17">
                  <c:v>-3.1829949116454372</c:v>
                </c:pt>
                <c:pt idx="18">
                  <c:v>-3.9720045684516663</c:v>
                </c:pt>
                <c:pt idx="19">
                  <c:v>-4.8218495734217868</c:v>
                </c:pt>
                <c:pt idx="20">
                  <c:v>-5.5574700466841023</c:v>
                </c:pt>
                <c:pt idx="21">
                  <c:v>-6.1128784580650972</c:v>
                </c:pt>
                <c:pt idx="22">
                  <c:v>-6.4162500177608308</c:v>
                </c:pt>
                <c:pt idx="23">
                  <c:v>-6.330151190966717</c:v>
                </c:pt>
                <c:pt idx="24">
                  <c:v>-5.8243611349571438</c:v>
                </c:pt>
                <c:pt idx="25">
                  <c:v>-5.0376235693383933</c:v>
                </c:pt>
                <c:pt idx="26">
                  <c:v>-4.1900339230451209</c:v>
                </c:pt>
                <c:pt idx="27">
                  <c:v>-3.4840386762352864</c:v>
                </c:pt>
                <c:pt idx="28">
                  <c:v>-2.973213494196898</c:v>
                </c:pt>
                <c:pt idx="29">
                  <c:v>-2.5491222899654531</c:v>
                </c:pt>
                <c:pt idx="30">
                  <c:v>-2.1054096828320326</c:v>
                </c:pt>
                <c:pt idx="31">
                  <c:v>-1.6321117474872153</c:v>
                </c:pt>
                <c:pt idx="32">
                  <c:v>-1.1644328230177052</c:v>
                </c:pt>
                <c:pt idx="33">
                  <c:v>-0.69211107449700648</c:v>
                </c:pt>
                <c:pt idx="34">
                  <c:v>-0.12541124189920083</c:v>
                </c:pt>
                <c:pt idx="35">
                  <c:v>0.62008025212526263</c:v>
                </c:pt>
                <c:pt idx="36">
                  <c:v>1.5211324358715501</c:v>
                </c:pt>
                <c:pt idx="37">
                  <c:v>2.450873492505707</c:v>
                </c:pt>
                <c:pt idx="38">
                  <c:v>3.2316729008343827</c:v>
                </c:pt>
                <c:pt idx="39">
                  <c:v>3.7222537863581238</c:v>
                </c:pt>
                <c:pt idx="40">
                  <c:v>3.9526485714904993</c:v>
                </c:pt>
                <c:pt idx="41">
                  <c:v>4.1207194103899383</c:v>
                </c:pt>
                <c:pt idx="42">
                  <c:v>4.3774871222085494</c:v>
                </c:pt>
                <c:pt idx="43">
                  <c:v>4.6858267140542011</c:v>
                </c:pt>
                <c:pt idx="44">
                  <c:v>4.9629155984875979</c:v>
                </c:pt>
              </c:numCache>
            </c:numRef>
          </c:val>
          <c:smooth val="0"/>
          <c:extLst>
            <c:ext xmlns:c16="http://schemas.microsoft.com/office/drawing/2014/chart" uri="{C3380CC4-5D6E-409C-BE32-E72D297353CC}">
              <c16:uniqueId val="{00000007-3005-4218-AEE4-07C4DBFA50BC}"/>
            </c:ext>
          </c:extLst>
        </c:ser>
        <c:ser>
          <c:idx val="8"/>
          <c:order val="8"/>
          <c:tx>
            <c:strRef>
              <c:f>Triplex2_54C!$A$53</c:f>
              <c:strCache>
                <c:ptCount val="1"/>
                <c:pt idx="0">
                  <c:v>Well 9 red</c:v>
                </c:pt>
              </c:strCache>
            </c:strRef>
          </c:tx>
          <c:spPr>
            <a:ln w="28575" cap="rnd">
              <a:solidFill>
                <a:schemeClr val="accent3">
                  <a:lumMod val="60000"/>
                </a:schemeClr>
              </a:solidFill>
              <a:round/>
            </a:ln>
            <a:effectLst/>
          </c:spPr>
          <c:marker>
            <c:symbol val="none"/>
          </c:marker>
          <c:val>
            <c:numRef>
              <c:f>Triplex2_54C!$B$53:$AT$53</c:f>
              <c:numCache>
                <c:formatCode>General</c:formatCode>
                <c:ptCount val="45"/>
                <c:pt idx="0">
                  <c:v>-6.6397734607890015</c:v>
                </c:pt>
                <c:pt idx="1">
                  <c:v>-3.2819463061787246</c:v>
                </c:pt>
                <c:pt idx="2">
                  <c:v>-1.7654826742509613</c:v>
                </c:pt>
                <c:pt idx="3">
                  <c:v>-2.4136435712698585</c:v>
                </c:pt>
                <c:pt idx="4">
                  <c:v>-4.1156894926461973</c:v>
                </c:pt>
                <c:pt idx="5">
                  <c:v>-5.5267919808975421</c:v>
                </c:pt>
                <c:pt idx="6">
                  <c:v>-5.7900850800378976</c:v>
                </c:pt>
                <c:pt idx="7">
                  <c:v>-4.5342569851927692</c:v>
                </c:pt>
                <c:pt idx="8">
                  <c:v>-1.9174379203268472</c:v>
                </c:pt>
                <c:pt idx="9">
                  <c:v>1.3319962304794899</c:v>
                </c:pt>
                <c:pt idx="10">
                  <c:v>4.4363811605344381</c:v>
                </c:pt>
                <c:pt idx="11">
                  <c:v>6.7837791664460383</c:v>
                </c:pt>
                <c:pt idx="12">
                  <c:v>7.5390816136095964</c:v>
                </c:pt>
                <c:pt idx="13">
                  <c:v>5.9869050692468591</c:v>
                </c:pt>
                <c:pt idx="14">
                  <c:v>2.2941405203364411</c:v>
                </c:pt>
                <c:pt idx="15">
                  <c:v>-2.1117433692616032</c:v>
                </c:pt>
                <c:pt idx="16">
                  <c:v>-5.1056647081513802</c:v>
                </c:pt>
                <c:pt idx="17">
                  <c:v>-5.5471214414228598</c:v>
                </c:pt>
                <c:pt idx="18">
                  <c:v>-3.9598838448218885</c:v>
                </c:pt>
                <c:pt idx="19">
                  <c:v>-1.5121919082266686</c:v>
                </c:pt>
                <c:pt idx="20">
                  <c:v>0.74693556761121727</c:v>
                </c:pt>
                <c:pt idx="21">
                  <c:v>1.9477274623313861</c:v>
                </c:pt>
                <c:pt idx="22">
                  <c:v>1.7845703365146619</c:v>
                </c:pt>
                <c:pt idx="23">
                  <c:v>0.86185829359237687</c:v>
                </c:pt>
                <c:pt idx="24">
                  <c:v>3.8445671107183443E-2</c:v>
                </c:pt>
                <c:pt idx="25">
                  <c:v>-0.35624209280285868</c:v>
                </c:pt>
                <c:pt idx="26">
                  <c:v>-0.36865276203934627</c:v>
                </c:pt>
                <c:pt idx="27">
                  <c:v>-3.1454061489057494E-2</c:v>
                </c:pt>
                <c:pt idx="28">
                  <c:v>0.57053016853205918</c:v>
                </c:pt>
                <c:pt idx="29">
                  <c:v>1.2733442708213261</c:v>
                </c:pt>
                <c:pt idx="30">
                  <c:v>1.9574327552672912</c:v>
                </c:pt>
                <c:pt idx="31">
                  <c:v>2.3693528459771187</c:v>
                </c:pt>
                <c:pt idx="32">
                  <c:v>2.1167666259480029</c:v>
                </c:pt>
                <c:pt idx="33">
                  <c:v>1.2351532315879012</c:v>
                </c:pt>
                <c:pt idx="34">
                  <c:v>0.37092326453603164</c:v>
                </c:pt>
                <c:pt idx="35">
                  <c:v>9.9461159616112127E-2</c:v>
                </c:pt>
                <c:pt idx="36">
                  <c:v>0.38059133275055501</c:v>
                </c:pt>
                <c:pt idx="37">
                  <c:v>0.78001222599232278</c:v>
                </c:pt>
                <c:pt idx="38">
                  <c:v>0.93939779388529132</c:v>
                </c:pt>
                <c:pt idx="39">
                  <c:v>0.76992290950875031</c:v>
                </c:pt>
                <c:pt idx="40">
                  <c:v>0.37039330909829005</c:v>
                </c:pt>
                <c:pt idx="41">
                  <c:v>-0.22264475927113381</c:v>
                </c:pt>
                <c:pt idx="42">
                  <c:v>-1.2663739230411011</c:v>
                </c:pt>
                <c:pt idx="43">
                  <c:v>-3.1056752624754154</c:v>
                </c:pt>
                <c:pt idx="44">
                  <c:v>-5.6288828858923807</c:v>
                </c:pt>
              </c:numCache>
            </c:numRef>
          </c:val>
          <c:smooth val="0"/>
          <c:extLst>
            <c:ext xmlns:c16="http://schemas.microsoft.com/office/drawing/2014/chart" uri="{C3380CC4-5D6E-409C-BE32-E72D297353CC}">
              <c16:uniqueId val="{00000008-3005-4218-AEE4-07C4DBFA50BC}"/>
            </c:ext>
          </c:extLst>
        </c:ser>
        <c:dLbls>
          <c:showLegendKey val="0"/>
          <c:showVal val="0"/>
          <c:showCatName val="0"/>
          <c:showSerName val="0"/>
          <c:showPercent val="0"/>
          <c:showBubbleSize val="0"/>
        </c:dLbls>
        <c:smooth val="0"/>
        <c:axId val="607811208"/>
        <c:axId val="607809568"/>
      </c:lineChart>
      <c:catAx>
        <c:axId val="607811208"/>
        <c:scaling>
          <c:orientation val="minMax"/>
        </c:scaling>
        <c:delete val="0"/>
        <c:axPos val="b"/>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09568"/>
        <c:crosses val="autoZero"/>
        <c:auto val="1"/>
        <c:lblAlgn val="ctr"/>
        <c:lblOffset val="100"/>
        <c:noMultiLvlLbl val="0"/>
      </c:catAx>
      <c:valAx>
        <c:axId val="607809568"/>
        <c:scaling>
          <c:orientation val="minMax"/>
          <c:max val="1100"/>
          <c:min val="-1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607811208"/>
        <c:crosses val="autoZero"/>
        <c:crossBetween val="between"/>
      </c:valAx>
      <c:spPr>
        <a:noFill/>
        <a:ln>
          <a:noFill/>
        </a:ln>
        <a:effectLst/>
      </c:spPr>
    </c:plotArea>
    <c:plotVisOnly val="1"/>
    <c:dispBlanksAs val="gap"/>
    <c:showDLblsOverMax val="0"/>
  </c:chart>
  <c:spPr>
    <a:noFill/>
    <a:ln>
      <a:solidFill>
        <a:schemeClr val="tx1"/>
      </a:solid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2EF3AEA-E4D5-4667-95DB-06F80ECB8BF2}" type="datetimeFigureOut">
              <a:rPr lang="en-US" smtClean="0"/>
              <a:t>7/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12621098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2EF3AEA-E4D5-4667-95DB-06F80ECB8BF2}" type="datetimeFigureOut">
              <a:rPr lang="en-US" smtClean="0"/>
              <a:t>7/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10605315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2EF3AEA-E4D5-4667-95DB-06F80ECB8BF2}" type="datetimeFigureOut">
              <a:rPr lang="en-US" smtClean="0"/>
              <a:t>7/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42551482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2EF3AEA-E4D5-4667-95DB-06F80ECB8BF2}" type="datetimeFigureOut">
              <a:rPr lang="en-US" smtClean="0"/>
              <a:t>7/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1385897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C2EF3AEA-E4D5-4667-95DB-06F80ECB8BF2}" type="datetimeFigureOut">
              <a:rPr lang="en-US" smtClean="0"/>
              <a:t>7/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23948665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2EF3AEA-E4D5-4667-95DB-06F80ECB8BF2}" type="datetimeFigureOut">
              <a:rPr lang="en-US" smtClean="0"/>
              <a:t>7/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2927548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2EF3AEA-E4D5-4667-95DB-06F80ECB8BF2}" type="datetimeFigureOut">
              <a:rPr lang="en-US" smtClean="0"/>
              <a:t>7/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3435485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2EF3AEA-E4D5-4667-95DB-06F80ECB8BF2}" type="datetimeFigureOut">
              <a:rPr lang="en-US" smtClean="0"/>
              <a:t>7/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2333049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EF3AEA-E4D5-4667-95DB-06F80ECB8BF2}" type="datetimeFigureOut">
              <a:rPr lang="en-US" smtClean="0"/>
              <a:t>7/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27377453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2EF3AEA-E4D5-4667-95DB-06F80ECB8BF2}" type="datetimeFigureOut">
              <a:rPr lang="en-US" smtClean="0"/>
              <a:t>7/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39420412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C2EF3AEA-E4D5-4667-95DB-06F80ECB8BF2}" type="datetimeFigureOut">
              <a:rPr lang="en-US" smtClean="0"/>
              <a:t>7/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4469E4-140A-4D3B-8BD9-E67B2E106C0C}" type="slidenum">
              <a:rPr lang="en-US" smtClean="0"/>
              <a:t>‹#›</a:t>
            </a:fld>
            <a:endParaRPr lang="en-US"/>
          </a:p>
        </p:txBody>
      </p:sp>
    </p:spTree>
    <p:extLst>
      <p:ext uri="{BB962C8B-B14F-4D97-AF65-F5344CB8AC3E}">
        <p14:creationId xmlns:p14="http://schemas.microsoft.com/office/powerpoint/2010/main" val="1322233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2EF3AEA-E4D5-4667-95DB-06F80ECB8BF2}" type="datetimeFigureOut">
              <a:rPr lang="en-US" smtClean="0"/>
              <a:t>7/7/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84469E4-140A-4D3B-8BD9-E67B2E106C0C}" type="slidenum">
              <a:rPr lang="en-US" smtClean="0"/>
              <a:t>‹#›</a:t>
            </a:fld>
            <a:endParaRPr lang="en-US"/>
          </a:p>
        </p:txBody>
      </p:sp>
    </p:spTree>
    <p:extLst>
      <p:ext uri="{BB962C8B-B14F-4D97-AF65-F5344CB8AC3E}">
        <p14:creationId xmlns:p14="http://schemas.microsoft.com/office/powerpoint/2010/main" val="41377328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3" Type="http://schemas.openxmlformats.org/officeDocument/2006/relationships/chart" Target="../charts/chart5.xml"/><Relationship Id="rId7" Type="http://schemas.openxmlformats.org/officeDocument/2006/relationships/chart" Target="../charts/chart9.xml"/><Relationship Id="rId2" Type="http://schemas.openxmlformats.org/officeDocument/2006/relationships/chart" Target="../charts/chart4.xml"/><Relationship Id="rId1" Type="http://schemas.openxmlformats.org/officeDocument/2006/relationships/slideLayout" Target="../slideLayouts/slideLayout2.xml"/><Relationship Id="rId6" Type="http://schemas.openxmlformats.org/officeDocument/2006/relationships/chart" Target="../charts/chart8.xml"/><Relationship Id="rId5" Type="http://schemas.openxmlformats.org/officeDocument/2006/relationships/chart" Target="../charts/chart7.xml"/><Relationship Id="rId4" Type="http://schemas.openxmlformats.org/officeDocument/2006/relationships/chart" Target="../charts/chart6.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chart" Target="../charts/chart1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20262" y="315310"/>
            <a:ext cx="11132599" cy="369332"/>
          </a:xfrm>
          <a:prstGeom prst="rect">
            <a:avLst/>
          </a:prstGeom>
          <a:noFill/>
        </p:spPr>
        <p:txBody>
          <a:bodyPr wrap="none" rtlCol="0">
            <a:spAutoFit/>
          </a:bodyPr>
          <a:lstStyle/>
          <a:p>
            <a:r>
              <a:rPr lang="en-US" b="1" dirty="0" smtClean="0">
                <a:latin typeface="Times New Roman" panose="02020603050405020304" pitchFamily="18" charset="0"/>
                <a:cs typeface="Times New Roman" panose="02020603050405020304" pitchFamily="18" charset="0"/>
              </a:rPr>
              <a:t>Figure </a:t>
            </a:r>
            <a:r>
              <a:rPr lang="en-US" b="1" dirty="0" smtClean="0">
                <a:latin typeface="Times New Roman" panose="02020603050405020304" pitchFamily="18" charset="0"/>
                <a:cs typeface="Times New Roman" panose="02020603050405020304" pitchFamily="18" charset="0"/>
              </a:rPr>
              <a:t>S1: </a:t>
            </a:r>
            <a:r>
              <a:rPr lang="en-US" b="1" dirty="0" err="1" smtClean="0">
                <a:latin typeface="Times New Roman" panose="02020603050405020304" pitchFamily="18" charset="0"/>
                <a:cs typeface="Times New Roman" panose="02020603050405020304" pitchFamily="18" charset="0"/>
              </a:rPr>
              <a:t>Clustal</a:t>
            </a:r>
            <a:r>
              <a:rPr lang="en-US" b="1" dirty="0" smtClean="0">
                <a:latin typeface="Times New Roman" panose="02020603050405020304" pitchFamily="18" charset="0"/>
                <a:cs typeface="Times New Roman" panose="02020603050405020304" pitchFamily="18" charset="0"/>
              </a:rPr>
              <a:t> alignment of sequences spanning the N:501Y position across the Wuhan 1 and other variants</a:t>
            </a:r>
            <a:endParaRPr lang="en-US" b="1" dirty="0">
              <a:latin typeface="Times New Roman" panose="02020603050405020304" pitchFamily="18" charset="0"/>
              <a:cs typeface="Times New Roman" panose="02020603050405020304" pitchFamily="18" charset="0"/>
            </a:endParaRPr>
          </a:p>
        </p:txBody>
      </p:sp>
      <p:pic>
        <p:nvPicPr>
          <p:cNvPr id="3" name="Picture 2"/>
          <p:cNvPicPr>
            <a:picLocks noChangeAspect="1"/>
          </p:cNvPicPr>
          <p:nvPr/>
        </p:nvPicPr>
        <p:blipFill rotWithShape="1">
          <a:blip r:embed="rId2" cstate="screen">
            <a:extLst>
              <a:ext uri="{28A0092B-C50C-407E-A947-70E740481C1C}">
                <a14:useLocalDpi xmlns:a14="http://schemas.microsoft.com/office/drawing/2010/main" val="0"/>
              </a:ext>
            </a:extLst>
          </a:blip>
          <a:srcRect t="2124"/>
          <a:stretch/>
        </p:blipFill>
        <p:spPr>
          <a:xfrm>
            <a:off x="183846" y="1156449"/>
            <a:ext cx="11824308" cy="1180926"/>
          </a:xfrm>
          <a:prstGeom prst="rect">
            <a:avLst/>
          </a:prstGeom>
        </p:spPr>
      </p:pic>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3068" y="2919538"/>
            <a:ext cx="12148376" cy="2900363"/>
          </a:xfrm>
          <a:prstGeom prst="rect">
            <a:avLst/>
          </a:prstGeom>
        </p:spPr>
      </p:pic>
    </p:spTree>
    <p:extLst>
      <p:ext uri="{BB962C8B-B14F-4D97-AF65-F5344CB8AC3E}">
        <p14:creationId xmlns:p14="http://schemas.microsoft.com/office/powerpoint/2010/main" val="5383118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62910" y="141918"/>
            <a:ext cx="11456276"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Figure S2: </a:t>
            </a:r>
            <a:r>
              <a:rPr lang="en-US" b="1" dirty="0" err="1">
                <a:latin typeface="Times New Roman" panose="02020603050405020304" pitchFamily="18" charset="0"/>
                <a:cs typeface="Times New Roman" panose="02020603050405020304" pitchFamily="18" charset="0"/>
              </a:rPr>
              <a:t>Clustal</a:t>
            </a:r>
            <a:r>
              <a:rPr lang="en-US" b="1" dirty="0">
                <a:latin typeface="Times New Roman" panose="02020603050405020304" pitchFamily="18" charset="0"/>
                <a:cs typeface="Times New Roman" panose="02020603050405020304" pitchFamily="18" charset="0"/>
              </a:rPr>
              <a:t> alignment of sequences spanning </a:t>
            </a:r>
            <a:r>
              <a:rPr lang="en-US" b="1" dirty="0" smtClean="0">
                <a:latin typeface="Times New Roman" panose="02020603050405020304" pitchFamily="18" charset="0"/>
                <a:cs typeface="Times New Roman" panose="02020603050405020304" pitchFamily="18" charset="0"/>
              </a:rPr>
              <a:t>DEL S:69-70 position </a:t>
            </a:r>
            <a:r>
              <a:rPr lang="en-US" b="1" dirty="0">
                <a:latin typeface="Times New Roman" panose="02020603050405020304" pitchFamily="18" charset="0"/>
                <a:cs typeface="Times New Roman" panose="02020603050405020304" pitchFamily="18" charset="0"/>
              </a:rPr>
              <a:t>across the Wuhan 1 and </a:t>
            </a:r>
            <a:r>
              <a:rPr lang="en-US" b="1" dirty="0">
                <a:latin typeface="Times New Roman" panose="02020603050405020304" pitchFamily="18" charset="0"/>
                <a:cs typeface="Times New Roman" panose="02020603050405020304" pitchFamily="18" charset="0"/>
              </a:rPr>
              <a:t>A</a:t>
            </a:r>
            <a:r>
              <a:rPr lang="en-US" b="1" dirty="0" smtClean="0">
                <a:latin typeface="Times New Roman" panose="02020603050405020304" pitchFamily="18" charset="0"/>
                <a:cs typeface="Times New Roman" panose="02020603050405020304" pitchFamily="18" charset="0"/>
              </a:rPr>
              <a:t>lpha variant</a:t>
            </a:r>
            <a:endParaRPr lang="en-US" b="1" dirty="0">
              <a:latin typeface="Times New Roman" panose="02020603050405020304" pitchFamily="18" charset="0"/>
              <a:cs typeface="Times New Roman" panose="02020603050405020304" pitchFamily="18" charset="0"/>
            </a:endParaRPr>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2810" y="1270145"/>
            <a:ext cx="12059190" cy="4177105"/>
          </a:xfrm>
          <a:prstGeom prst="rect">
            <a:avLst/>
          </a:prstGeom>
        </p:spPr>
      </p:pic>
    </p:spTree>
    <p:extLst>
      <p:ext uri="{BB962C8B-B14F-4D97-AF65-F5344CB8AC3E}">
        <p14:creationId xmlns:p14="http://schemas.microsoft.com/office/powerpoint/2010/main" val="278699442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5606" y="1056664"/>
            <a:ext cx="11993245" cy="4388168"/>
          </a:xfrm>
          <a:prstGeom prst="rect">
            <a:avLst/>
          </a:prstGeom>
        </p:spPr>
      </p:pic>
      <p:sp>
        <p:nvSpPr>
          <p:cNvPr id="5" name="Rectangle 4"/>
          <p:cNvSpPr/>
          <p:nvPr/>
        </p:nvSpPr>
        <p:spPr>
          <a:xfrm>
            <a:off x="162910" y="141918"/>
            <a:ext cx="11456276" cy="369332"/>
          </a:xfrm>
          <a:prstGeom prst="rect">
            <a:avLst/>
          </a:prstGeom>
        </p:spPr>
        <p:txBody>
          <a:bodyPr wrap="square">
            <a:spAutoFit/>
          </a:bodyPr>
          <a:lstStyle/>
          <a:p>
            <a:r>
              <a:rPr lang="en-US" b="1" dirty="0">
                <a:latin typeface="Times New Roman" panose="02020603050405020304" pitchFamily="18" charset="0"/>
                <a:cs typeface="Times New Roman" panose="02020603050405020304" pitchFamily="18" charset="0"/>
              </a:rPr>
              <a:t>Figure </a:t>
            </a:r>
            <a:r>
              <a:rPr lang="en-US" b="1" dirty="0" smtClean="0">
                <a:latin typeface="Times New Roman" panose="02020603050405020304" pitchFamily="18" charset="0"/>
                <a:cs typeface="Times New Roman" panose="02020603050405020304" pitchFamily="18" charset="0"/>
              </a:rPr>
              <a:t>S3: </a:t>
            </a:r>
            <a:r>
              <a:rPr lang="en-US" b="1" dirty="0" err="1">
                <a:latin typeface="Times New Roman" panose="02020603050405020304" pitchFamily="18" charset="0"/>
                <a:cs typeface="Times New Roman" panose="02020603050405020304" pitchFamily="18" charset="0"/>
              </a:rPr>
              <a:t>Clustal</a:t>
            </a:r>
            <a:r>
              <a:rPr lang="en-US" b="1" dirty="0">
                <a:latin typeface="Times New Roman" panose="02020603050405020304" pitchFamily="18" charset="0"/>
                <a:cs typeface="Times New Roman" panose="02020603050405020304" pitchFamily="18" charset="0"/>
              </a:rPr>
              <a:t> alignment of sequences spanning </a:t>
            </a:r>
            <a:r>
              <a:rPr lang="en-US" b="1" dirty="0" smtClean="0">
                <a:latin typeface="Times New Roman" panose="02020603050405020304" pitchFamily="18" charset="0"/>
                <a:cs typeface="Times New Roman" panose="02020603050405020304" pitchFamily="18" charset="0"/>
              </a:rPr>
              <a:t>DEL S:69-70 position </a:t>
            </a:r>
            <a:r>
              <a:rPr lang="en-US" b="1" dirty="0">
                <a:latin typeface="Times New Roman" panose="02020603050405020304" pitchFamily="18" charset="0"/>
                <a:cs typeface="Times New Roman" panose="02020603050405020304" pitchFamily="18" charset="0"/>
              </a:rPr>
              <a:t>across the Wuhan 1 and other variants</a:t>
            </a:r>
          </a:p>
        </p:txBody>
      </p:sp>
    </p:spTree>
    <p:extLst>
      <p:ext uri="{BB962C8B-B14F-4D97-AF65-F5344CB8AC3E}">
        <p14:creationId xmlns:p14="http://schemas.microsoft.com/office/powerpoint/2010/main" val="291611830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8052" y="-59703"/>
            <a:ext cx="12115800" cy="759000"/>
          </a:xfrm>
        </p:spPr>
        <p:txBody>
          <a:bodyPr>
            <a:noAutofit/>
          </a:bodyPr>
          <a:lstStyle/>
          <a:p>
            <a:r>
              <a:rPr lang="en-US" sz="1800" b="1" dirty="0" smtClean="0">
                <a:latin typeface="Times New Roman" panose="02020603050405020304" pitchFamily="18" charset="0"/>
                <a:cs typeface="Times New Roman" panose="02020603050405020304" pitchFamily="18" charset="0"/>
              </a:rPr>
              <a:t>Figure S4-a. Triplex </a:t>
            </a:r>
            <a:r>
              <a:rPr lang="en-US" sz="1800" b="1" dirty="0">
                <a:latin typeface="Times New Roman" panose="02020603050405020304" pitchFamily="18" charset="0"/>
                <a:cs typeface="Times New Roman" panose="02020603050405020304" pitchFamily="18" charset="0"/>
              </a:rPr>
              <a:t>2 Testing with a Dilution Series of Omicron Synthetic RNA (Twist)</a:t>
            </a:r>
          </a:p>
        </p:txBody>
      </p:sp>
      <p:sp>
        <p:nvSpPr>
          <p:cNvPr id="3" name="Content Placeholder 2"/>
          <p:cNvSpPr>
            <a:spLocks noGrp="1"/>
          </p:cNvSpPr>
          <p:nvPr>
            <p:ph idx="1"/>
          </p:nvPr>
        </p:nvSpPr>
        <p:spPr>
          <a:xfrm>
            <a:off x="258052" y="674055"/>
            <a:ext cx="5310299" cy="5540477"/>
          </a:xfrm>
        </p:spPr>
        <p:txBody>
          <a:bodyPr>
            <a:noAutofit/>
          </a:bodyPr>
          <a:lstStyle/>
          <a:p>
            <a:r>
              <a:rPr lang="en-US" sz="1400" dirty="0"/>
              <a:t>A 10-fold serial dilution of omicron synthetic RNA (50-50,000 copies/reaction) was prepared and tested on Biomeme three9 devices</a:t>
            </a:r>
          </a:p>
          <a:p>
            <a:r>
              <a:rPr lang="en-US" sz="1400" dirty="0"/>
              <a:t>Variant Triplex 2 was used with the standard thermal cycling protocol, as well as with a reduced anneal temp of 54°C instead of 62°C</a:t>
            </a:r>
          </a:p>
          <a:p>
            <a:r>
              <a:rPr lang="en-US" sz="1400" dirty="0"/>
              <a:t>The same dilution series was also tested with the Biomeme </a:t>
            </a:r>
            <a:r>
              <a:rPr lang="en-US" sz="1400" dirty="0" err="1"/>
              <a:t>Dx</a:t>
            </a:r>
            <a:r>
              <a:rPr lang="en-US" sz="1400" dirty="0"/>
              <a:t> triplex as a control/comparator</a:t>
            </a:r>
          </a:p>
          <a:p>
            <a:r>
              <a:rPr lang="en-US" sz="1400" dirty="0"/>
              <a:t>Positive results were obtained for the S:69/70del assay (and </a:t>
            </a:r>
            <a:r>
              <a:rPr lang="en-US" sz="1400" dirty="0" err="1"/>
              <a:t>Dx</a:t>
            </a:r>
            <a:r>
              <a:rPr lang="en-US" sz="1400" dirty="0"/>
              <a:t> assays), and negative results were obtained for the other two mutation assays</a:t>
            </a:r>
          </a:p>
          <a:p>
            <a:r>
              <a:rPr lang="en-US" sz="1400" dirty="0"/>
              <a:t>The S:69/70del assay was brighter at the lower anneal temp, but cycles to amplification were similar between the two protocols (and similar to the </a:t>
            </a:r>
            <a:r>
              <a:rPr lang="en-US" sz="1400" dirty="0" err="1"/>
              <a:t>Dx</a:t>
            </a:r>
            <a:r>
              <a:rPr lang="en-US" sz="1400" dirty="0"/>
              <a:t> assays)</a:t>
            </a:r>
          </a:p>
          <a:p>
            <a:r>
              <a:rPr lang="en-US" sz="1400" dirty="0"/>
              <a:t>Conclusion: The Triplex 2 S:69/70del assay can be used with the standard protocol to screen for the omicron variant, but users should be aware that it will produce dimmer amplification curves than usually observed for this assay (e.g., for the alpha variant), and the app may also report later Ct values because of this. For brighter results and more consistent Ct values, the assay can alternatively be run with a lower anneal temp of 54°C.</a:t>
            </a:r>
          </a:p>
        </p:txBody>
      </p:sp>
      <p:graphicFrame>
        <p:nvGraphicFramePr>
          <p:cNvPr id="6" name="Chart 5"/>
          <p:cNvGraphicFramePr>
            <a:graphicFrameLocks/>
          </p:cNvGraphicFramePr>
          <p:nvPr>
            <p:extLst>
              <p:ext uri="{D42A27DB-BD31-4B8C-83A1-F6EECF244321}">
                <p14:modId xmlns:p14="http://schemas.microsoft.com/office/powerpoint/2010/main" val="3994508788"/>
              </p:ext>
            </p:extLst>
          </p:nvPr>
        </p:nvGraphicFramePr>
        <p:xfrm>
          <a:off x="5695117" y="858120"/>
          <a:ext cx="3200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p:cNvGraphicFramePr>
            <a:graphicFrameLocks/>
          </p:cNvGraphicFramePr>
          <p:nvPr>
            <p:extLst>
              <p:ext uri="{D42A27DB-BD31-4B8C-83A1-F6EECF244321}">
                <p14:modId xmlns:p14="http://schemas.microsoft.com/office/powerpoint/2010/main" val="986904542"/>
              </p:ext>
            </p:extLst>
          </p:nvPr>
        </p:nvGraphicFramePr>
        <p:xfrm>
          <a:off x="5695117" y="3938081"/>
          <a:ext cx="3200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538508916"/>
              </p:ext>
            </p:extLst>
          </p:nvPr>
        </p:nvGraphicFramePr>
        <p:xfrm>
          <a:off x="8936515" y="3938081"/>
          <a:ext cx="32004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10" name="Rectangle 9"/>
          <p:cNvSpPr/>
          <p:nvPr/>
        </p:nvSpPr>
        <p:spPr>
          <a:xfrm>
            <a:off x="5612586" y="519817"/>
            <a:ext cx="1913922" cy="369332"/>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62°C (</a:t>
            </a:r>
            <a:r>
              <a:rPr kumimoji="0" lang="en-US" sz="1800" b="1" i="0" u="none" strike="noStrike" kern="1200" cap="none" spc="0" normalizeH="0" baseline="0" noProof="0" dirty="0" err="1">
                <a:ln>
                  <a:noFill/>
                </a:ln>
                <a:solidFill>
                  <a:srgbClr val="000000"/>
                </a:solidFill>
                <a:effectLst/>
                <a:uLnTx/>
                <a:uFillTx/>
                <a:latin typeface="Arial"/>
                <a:ea typeface="+mn-ea"/>
                <a:cs typeface="+mn-cs"/>
              </a:rPr>
              <a:t>autoscaled</a:t>
            </a:r>
            <a:r>
              <a:rPr kumimoji="0" lang="en-US" sz="1800" b="1" i="0" u="none" strike="noStrike" kern="1200" cap="none" spc="0" normalizeH="0" baseline="0" noProof="0" dirty="0">
                <a:ln>
                  <a:noFill/>
                </a:ln>
                <a:solidFill>
                  <a:srgbClr val="000000"/>
                </a:solidFill>
                <a:effectLst/>
                <a:uLnTx/>
                <a:uFillTx/>
                <a:latin typeface="Arial"/>
                <a:ea typeface="+mn-ea"/>
                <a:cs typeface="+mn-cs"/>
              </a:rPr>
              <a:t>):</a:t>
            </a:r>
          </a:p>
        </p:txBody>
      </p:sp>
      <p:sp>
        <p:nvSpPr>
          <p:cNvPr id="11" name="Rectangle 10"/>
          <p:cNvSpPr/>
          <p:nvPr/>
        </p:nvSpPr>
        <p:spPr>
          <a:xfrm>
            <a:off x="5606629" y="3620434"/>
            <a:ext cx="2975943" cy="369332"/>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62°C (scaled for comparison):</a:t>
            </a:r>
          </a:p>
        </p:txBody>
      </p:sp>
      <p:sp>
        <p:nvSpPr>
          <p:cNvPr id="12" name="Rectangle 11"/>
          <p:cNvSpPr/>
          <p:nvPr/>
        </p:nvSpPr>
        <p:spPr>
          <a:xfrm>
            <a:off x="8861143" y="3638126"/>
            <a:ext cx="2975943" cy="369332"/>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54°C (scaled for comparison):</a:t>
            </a:r>
          </a:p>
        </p:txBody>
      </p:sp>
    </p:spTree>
    <p:extLst>
      <p:ext uri="{BB962C8B-B14F-4D97-AF65-F5344CB8AC3E}">
        <p14:creationId xmlns:p14="http://schemas.microsoft.com/office/powerpoint/2010/main" val="374668492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2548" y="79593"/>
            <a:ext cx="10515600" cy="759000"/>
          </a:xfrm>
        </p:spPr>
        <p:txBody>
          <a:bodyPr>
            <a:normAutofit/>
          </a:bodyPr>
          <a:lstStyle/>
          <a:p>
            <a:r>
              <a:rPr lang="en-US" sz="1800" b="1" dirty="0" smtClean="0">
                <a:latin typeface="Times New Roman" panose="02020603050405020304" pitchFamily="18" charset="0"/>
                <a:cs typeface="Times New Roman" panose="02020603050405020304" pitchFamily="18" charset="0"/>
              </a:rPr>
              <a:t>Figure S4-b. Triplex </a:t>
            </a:r>
            <a:r>
              <a:rPr lang="en-US" sz="1800" b="1" dirty="0">
                <a:latin typeface="Times New Roman" panose="02020603050405020304" pitchFamily="18" charset="0"/>
                <a:cs typeface="Times New Roman" panose="02020603050405020304" pitchFamily="18" charset="0"/>
              </a:rPr>
              <a:t>2 Testing with a Dilution Series of Omicron Synthetic RNA (Twist)</a:t>
            </a:r>
          </a:p>
        </p:txBody>
      </p:sp>
      <p:sp>
        <p:nvSpPr>
          <p:cNvPr id="3" name="Content Placeholder 2"/>
          <p:cNvSpPr>
            <a:spLocks noGrp="1"/>
          </p:cNvSpPr>
          <p:nvPr>
            <p:ph idx="1"/>
          </p:nvPr>
        </p:nvSpPr>
        <p:spPr>
          <a:xfrm>
            <a:off x="343249" y="1506843"/>
            <a:ext cx="4512608" cy="1560822"/>
          </a:xfrm>
        </p:spPr>
        <p:txBody>
          <a:bodyPr/>
          <a:lstStyle/>
          <a:p>
            <a:pPr marL="0" indent="0" algn="ctr">
              <a:buNone/>
            </a:pPr>
            <a:r>
              <a:rPr lang="en-US" i="1" dirty="0"/>
              <a:t>(Additional results for assays other than S:69/70del are shown here)</a:t>
            </a:r>
          </a:p>
        </p:txBody>
      </p:sp>
      <p:graphicFrame>
        <p:nvGraphicFramePr>
          <p:cNvPr id="4" name="Chart 3"/>
          <p:cNvGraphicFramePr>
            <a:graphicFrameLocks/>
          </p:cNvGraphicFramePr>
          <p:nvPr/>
        </p:nvGraphicFramePr>
        <p:xfrm>
          <a:off x="5440877" y="939312"/>
          <a:ext cx="32004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Chart 4"/>
          <p:cNvGraphicFramePr>
            <a:graphicFrameLocks/>
          </p:cNvGraphicFramePr>
          <p:nvPr/>
        </p:nvGraphicFramePr>
        <p:xfrm>
          <a:off x="8724851" y="956934"/>
          <a:ext cx="3200400"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p:cNvGraphicFramePr>
            <a:graphicFrameLocks/>
          </p:cNvGraphicFramePr>
          <p:nvPr>
            <p:extLst>
              <p:ext uri="{D42A27DB-BD31-4B8C-83A1-F6EECF244321}">
                <p14:modId xmlns:p14="http://schemas.microsoft.com/office/powerpoint/2010/main" val="4199966048"/>
              </p:ext>
            </p:extLst>
          </p:nvPr>
        </p:nvGraphicFramePr>
        <p:xfrm>
          <a:off x="192548" y="4272331"/>
          <a:ext cx="2743200" cy="2286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7" name="Chart 6"/>
          <p:cNvGraphicFramePr>
            <a:graphicFrameLocks/>
          </p:cNvGraphicFramePr>
          <p:nvPr>
            <p:extLst>
              <p:ext uri="{D42A27DB-BD31-4B8C-83A1-F6EECF244321}">
                <p14:modId xmlns:p14="http://schemas.microsoft.com/office/powerpoint/2010/main" val="3803506321"/>
              </p:ext>
            </p:extLst>
          </p:nvPr>
        </p:nvGraphicFramePr>
        <p:xfrm>
          <a:off x="3019322" y="4272331"/>
          <a:ext cx="2743200" cy="2286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8" name="Chart 7"/>
          <p:cNvGraphicFramePr>
            <a:graphicFrameLocks/>
          </p:cNvGraphicFramePr>
          <p:nvPr>
            <p:extLst>
              <p:ext uri="{D42A27DB-BD31-4B8C-83A1-F6EECF244321}">
                <p14:modId xmlns:p14="http://schemas.microsoft.com/office/powerpoint/2010/main" val="2415388789"/>
              </p:ext>
            </p:extLst>
          </p:nvPr>
        </p:nvGraphicFramePr>
        <p:xfrm>
          <a:off x="6495168" y="4272230"/>
          <a:ext cx="2743200" cy="2286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9" name="Chart 8"/>
          <p:cNvGraphicFramePr>
            <a:graphicFrameLocks/>
          </p:cNvGraphicFramePr>
          <p:nvPr>
            <p:extLst>
              <p:ext uri="{D42A27DB-BD31-4B8C-83A1-F6EECF244321}">
                <p14:modId xmlns:p14="http://schemas.microsoft.com/office/powerpoint/2010/main" val="1160274476"/>
              </p:ext>
            </p:extLst>
          </p:nvPr>
        </p:nvGraphicFramePr>
        <p:xfrm>
          <a:off x="9335408" y="4272230"/>
          <a:ext cx="2743200" cy="2286000"/>
        </p:xfrm>
        <a:graphic>
          <a:graphicData uri="http://schemas.openxmlformats.org/drawingml/2006/chart">
            <c:chart xmlns:c="http://schemas.openxmlformats.org/drawingml/2006/chart" xmlns:r="http://schemas.openxmlformats.org/officeDocument/2006/relationships" r:id="rId7"/>
          </a:graphicData>
        </a:graphic>
      </p:graphicFrame>
      <p:sp>
        <p:nvSpPr>
          <p:cNvPr id="10" name="Rectangle 9"/>
          <p:cNvSpPr/>
          <p:nvPr/>
        </p:nvSpPr>
        <p:spPr>
          <a:xfrm>
            <a:off x="84396" y="3902999"/>
            <a:ext cx="683200" cy="369332"/>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62°C:</a:t>
            </a:r>
          </a:p>
        </p:txBody>
      </p:sp>
      <p:sp>
        <p:nvSpPr>
          <p:cNvPr id="11" name="Rectangle 10"/>
          <p:cNvSpPr/>
          <p:nvPr/>
        </p:nvSpPr>
        <p:spPr>
          <a:xfrm>
            <a:off x="6379568" y="3902999"/>
            <a:ext cx="683200" cy="369332"/>
          </a:xfrm>
          <a:prstGeom prst="rect">
            <a:avLst/>
          </a:prstGeom>
        </p:spPr>
        <p:txBody>
          <a:bodyPr wrap="non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54°C:</a:t>
            </a:r>
          </a:p>
        </p:txBody>
      </p:sp>
    </p:spTree>
    <p:extLst>
      <p:ext uri="{BB962C8B-B14F-4D97-AF65-F5344CB8AC3E}">
        <p14:creationId xmlns:p14="http://schemas.microsoft.com/office/powerpoint/2010/main" val="379250871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333351" y="188162"/>
            <a:ext cx="9277038" cy="381439"/>
          </a:xfrm>
        </p:spPr>
        <p:txBody>
          <a:bodyPr>
            <a:noAutofit/>
          </a:bodyPr>
          <a:lstStyle/>
          <a:p>
            <a:r>
              <a:rPr lang="en-US" sz="1800" b="1" dirty="0" smtClean="0">
                <a:latin typeface="Times New Roman" panose="02020603050405020304" pitchFamily="18" charset="0"/>
                <a:cs typeface="Times New Roman" panose="02020603050405020304" pitchFamily="18" charset="0"/>
              </a:rPr>
              <a:t>Figure S4-c. Testing </a:t>
            </a:r>
            <a:r>
              <a:rPr lang="en-US" sz="1800" b="1" dirty="0" smtClean="0">
                <a:latin typeface="Times New Roman" panose="02020603050405020304" pitchFamily="18" charset="0"/>
                <a:cs typeface="Times New Roman" panose="02020603050405020304" pitchFamily="18" charset="0"/>
              </a:rPr>
              <a:t>alternative S:69/70 del plus S:A67V probes</a:t>
            </a:r>
            <a:endParaRPr lang="en-US" sz="1800" b="1" dirty="0">
              <a:latin typeface="Times New Roman" panose="02020603050405020304" pitchFamily="18" charset="0"/>
              <a:cs typeface="Times New Roman" panose="02020603050405020304" pitchFamily="18" charset="0"/>
            </a:endParaRPr>
          </a:p>
        </p:txBody>
      </p:sp>
      <p:sp>
        <p:nvSpPr>
          <p:cNvPr id="5" name="Content Placeholder 2"/>
          <p:cNvSpPr>
            <a:spLocks noGrp="1"/>
          </p:cNvSpPr>
          <p:nvPr>
            <p:ph idx="4294967295"/>
          </p:nvPr>
        </p:nvSpPr>
        <p:spPr>
          <a:xfrm>
            <a:off x="333351" y="1037341"/>
            <a:ext cx="6437313" cy="5707062"/>
          </a:xfrm>
        </p:spPr>
        <p:txBody>
          <a:bodyPr>
            <a:normAutofit/>
          </a:bodyPr>
          <a:lstStyle/>
          <a:p>
            <a:r>
              <a:rPr lang="en-US" sz="1700" dirty="0" smtClean="0"/>
              <a:t>Background: Because of a SNP in the S:69/70del probe binding region, omicron template produces much dimmer amplification with the original probe designed for B.1.1.7</a:t>
            </a:r>
          </a:p>
          <a:p>
            <a:r>
              <a:rPr lang="en-US" sz="1700" dirty="0" smtClean="0"/>
              <a:t>Two alternative probes were designed based on the omicron sequence: a shorter (more discriminatory) probe, and a longer (less discriminatory) probe</a:t>
            </a:r>
          </a:p>
          <a:p>
            <a:r>
              <a:rPr lang="en-US" sz="1700" dirty="0" smtClean="0"/>
              <a:t>Results: Both new probes produce bright signal with omicron template, and no signal with </a:t>
            </a:r>
            <a:r>
              <a:rPr lang="en-US" sz="1700" dirty="0" err="1" smtClean="0"/>
              <a:t>wildtype</a:t>
            </a:r>
            <a:r>
              <a:rPr lang="en-US" sz="1700" dirty="0" smtClean="0"/>
              <a:t> (no-deletion) template</a:t>
            </a:r>
          </a:p>
          <a:p>
            <a:pPr lvl="1"/>
            <a:r>
              <a:rPr lang="en-US" sz="1700" dirty="0" smtClean="0"/>
              <a:t>Both probes </a:t>
            </a:r>
            <a:r>
              <a:rPr lang="en-US" sz="1700" i="1" dirty="0" smtClean="0"/>
              <a:t>also</a:t>
            </a:r>
            <a:r>
              <a:rPr lang="en-US" sz="1700" dirty="0" smtClean="0"/>
              <a:t> produce “off-target” signal for the B.1.1.7 template, which is significantly dimmer for the shorter probe, and only a little dimmer for the longer probe</a:t>
            </a:r>
          </a:p>
          <a:p>
            <a:r>
              <a:rPr lang="en-US" sz="1700" dirty="0" smtClean="0"/>
              <a:t>Conclusion: It may be impossible to have an S:69/70del assay that completely discriminates between B.1.1.7 and omicron except by comparing relative brightness (in which case, alt probe 1 is better). If, however, the objective is to have an assay that strongly detects </a:t>
            </a:r>
            <a:r>
              <a:rPr lang="en-US" sz="1700" i="1" dirty="0" smtClean="0"/>
              <a:t>both</a:t>
            </a:r>
            <a:r>
              <a:rPr lang="en-US" sz="1700" dirty="0" smtClean="0"/>
              <a:t> B.1.1.7 </a:t>
            </a:r>
            <a:r>
              <a:rPr lang="en-US" sz="1700" i="1" dirty="0" smtClean="0"/>
              <a:t>and</a:t>
            </a:r>
            <a:r>
              <a:rPr lang="en-US" sz="1700" dirty="0" smtClean="0"/>
              <a:t> omicron, then alt probe option 2 may be a good choice (but this should be confirmed in Biomeme </a:t>
            </a:r>
            <a:r>
              <a:rPr lang="en-US" sz="1700" dirty="0" err="1" smtClean="0"/>
              <a:t>lyo</a:t>
            </a:r>
            <a:r>
              <a:rPr lang="en-US" sz="1700" dirty="0" smtClean="0"/>
              <a:t> mix).</a:t>
            </a:r>
            <a:endParaRPr lang="en-US" sz="1700" dirty="0"/>
          </a:p>
        </p:txBody>
      </p:sp>
      <p:pic>
        <p:nvPicPr>
          <p:cNvPr id="6" name="Picture 5">
            <a:extLst>
              <a:ext uri="{FF2B5EF4-FFF2-40B4-BE49-F238E27FC236}">
                <a16:creationId xmlns:a16="http://schemas.microsoft.com/office/drawing/2014/main" id="{00000000-0008-0000-0000-000004000000}"/>
              </a:ext>
            </a:extLst>
          </p:cNvPr>
          <p:cNvPicPr>
            <a:picLocks noChangeAspect="1"/>
          </p:cNvPicPr>
          <p:nvPr/>
        </p:nvPicPr>
        <p:blipFill>
          <a:blip r:embed="rId2"/>
          <a:stretch>
            <a:fillRect/>
          </a:stretch>
        </p:blipFill>
        <p:spPr>
          <a:xfrm>
            <a:off x="7158800" y="862845"/>
            <a:ext cx="4515886" cy="2766651"/>
          </a:xfrm>
          <a:prstGeom prst="rect">
            <a:avLst/>
          </a:prstGeom>
        </p:spPr>
      </p:pic>
      <p:pic>
        <p:nvPicPr>
          <p:cNvPr id="7" name="Picture 6">
            <a:extLst>
              <a:ext uri="{FF2B5EF4-FFF2-40B4-BE49-F238E27FC236}">
                <a16:creationId xmlns:a16="http://schemas.microsoft.com/office/drawing/2014/main" id="{00000000-0008-0000-0000-000005000000}"/>
              </a:ext>
            </a:extLst>
          </p:cNvPr>
          <p:cNvPicPr>
            <a:picLocks noChangeAspect="1"/>
          </p:cNvPicPr>
          <p:nvPr/>
        </p:nvPicPr>
        <p:blipFill>
          <a:blip r:embed="rId3"/>
          <a:stretch>
            <a:fillRect/>
          </a:stretch>
        </p:blipFill>
        <p:spPr>
          <a:xfrm>
            <a:off x="7291255" y="3434980"/>
            <a:ext cx="4481754" cy="2766651"/>
          </a:xfrm>
          <a:prstGeom prst="rect">
            <a:avLst/>
          </a:prstGeom>
        </p:spPr>
      </p:pic>
      <p:sp>
        <p:nvSpPr>
          <p:cNvPr id="8" name="TextBox 7"/>
          <p:cNvSpPr txBox="1"/>
          <p:nvPr/>
        </p:nvSpPr>
        <p:spPr>
          <a:xfrm>
            <a:off x="11226800" y="3111500"/>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1.351</a:t>
            </a:r>
          </a:p>
        </p:txBody>
      </p:sp>
      <p:sp>
        <p:nvSpPr>
          <p:cNvPr id="9" name="TextBox 8"/>
          <p:cNvSpPr txBox="1"/>
          <p:nvPr/>
        </p:nvSpPr>
        <p:spPr>
          <a:xfrm>
            <a:off x="11379200" y="2768600"/>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1.1.7</a:t>
            </a:r>
          </a:p>
        </p:txBody>
      </p:sp>
      <p:sp>
        <p:nvSpPr>
          <p:cNvPr id="10" name="TextBox 9"/>
          <p:cNvSpPr txBox="1"/>
          <p:nvPr/>
        </p:nvSpPr>
        <p:spPr>
          <a:xfrm>
            <a:off x="11430000" y="1905000"/>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A1</a:t>
            </a:r>
          </a:p>
        </p:txBody>
      </p:sp>
      <p:sp>
        <p:nvSpPr>
          <p:cNvPr id="11" name="TextBox 10"/>
          <p:cNvSpPr txBox="1"/>
          <p:nvPr/>
        </p:nvSpPr>
        <p:spPr>
          <a:xfrm>
            <a:off x="11379200" y="5562600"/>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1.351</a:t>
            </a:r>
          </a:p>
        </p:txBody>
      </p:sp>
      <p:sp>
        <p:nvSpPr>
          <p:cNvPr id="12" name="TextBox 11"/>
          <p:cNvSpPr txBox="1"/>
          <p:nvPr/>
        </p:nvSpPr>
        <p:spPr>
          <a:xfrm>
            <a:off x="11328400" y="4153655"/>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1.1.7</a:t>
            </a:r>
          </a:p>
        </p:txBody>
      </p:sp>
      <p:sp>
        <p:nvSpPr>
          <p:cNvPr id="13" name="TextBox 12"/>
          <p:cNvSpPr txBox="1"/>
          <p:nvPr/>
        </p:nvSpPr>
        <p:spPr>
          <a:xfrm>
            <a:off x="11239609" y="3729132"/>
            <a:ext cx="965200" cy="323480"/>
          </a:xfrm>
          <a:prstGeom prst="rect">
            <a:avLst/>
          </a:prstGeom>
          <a:noFill/>
          <a:ln w="9525" cap="rnd">
            <a:noFill/>
            <a:prstDash val="solid"/>
            <a:round/>
          </a:ln>
          <a:extLst>
            <a:ext uri="{909E8E84-426E-40DD-AFC4-6F175D3DCCD1}">
              <a14:hiddenFill xmlns:a14="http://schemas.microsoft.com/office/drawing/2010/main">
                <a:solidFill>
                  <a:srgbClr val="29BA74"/>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dirty="0" smtClean="0">
                <a:solidFill>
                  <a:schemeClr val="tx1"/>
                </a:solidFill>
                <a:sym typeface="+mn-lt"/>
              </a:rPr>
              <a:t>BA1</a:t>
            </a:r>
          </a:p>
        </p:txBody>
      </p:sp>
      <p:sp>
        <p:nvSpPr>
          <p:cNvPr id="15" name="TextBox 14"/>
          <p:cNvSpPr txBox="1"/>
          <p:nvPr/>
        </p:nvSpPr>
        <p:spPr>
          <a:xfrm>
            <a:off x="7737986" y="1150374"/>
            <a:ext cx="1317524" cy="646331"/>
          </a:xfrm>
          <a:prstGeom prst="rect">
            <a:avLst/>
          </a:prstGeom>
          <a:solidFill>
            <a:schemeClr val="bg1"/>
          </a:solidFill>
        </p:spPr>
        <p:txBody>
          <a:bodyPr wrap="square" rtlCol="0">
            <a:spAutoFit/>
          </a:bodyPr>
          <a:lstStyle/>
          <a:p>
            <a:pPr algn="ctr"/>
            <a:r>
              <a:rPr lang="en-US" b="1" dirty="0" smtClean="0"/>
              <a:t>Alt. probe 1 (shorter)</a:t>
            </a:r>
            <a:endParaRPr lang="en-US" b="1" dirty="0"/>
          </a:p>
        </p:txBody>
      </p:sp>
      <p:sp>
        <p:nvSpPr>
          <p:cNvPr id="16" name="TextBox 15"/>
          <p:cNvSpPr txBox="1"/>
          <p:nvPr/>
        </p:nvSpPr>
        <p:spPr>
          <a:xfrm>
            <a:off x="1213236" y="5993295"/>
            <a:ext cx="5198667" cy="784830"/>
          </a:xfrm>
          <a:prstGeom prst="rect">
            <a:avLst/>
          </a:prstGeom>
          <a:noFill/>
        </p:spPr>
        <p:txBody>
          <a:bodyPr wrap="none" rtlCol="0">
            <a:spAutoFit/>
          </a:bodyPr>
          <a:lstStyle/>
          <a:p>
            <a:r>
              <a:rPr lang="en-US" sz="1500" dirty="0" smtClean="0"/>
              <a:t>Red, pink, orange, and green- Omicron RNA; 50k – 50 copies/</a:t>
            </a:r>
            <a:r>
              <a:rPr lang="en-US" sz="1500" dirty="0" err="1" smtClean="0"/>
              <a:t>rxn</a:t>
            </a:r>
            <a:endParaRPr lang="en-US" sz="1500" dirty="0" smtClean="0"/>
          </a:p>
          <a:p>
            <a:r>
              <a:rPr lang="en-US" sz="1500" dirty="0" smtClean="0"/>
              <a:t>Blue traces with amplification- B.1.1.7 RNA; 50k copies/</a:t>
            </a:r>
            <a:r>
              <a:rPr lang="en-US" sz="1500" dirty="0" err="1" smtClean="0"/>
              <a:t>rxn</a:t>
            </a:r>
            <a:endParaRPr lang="en-US" sz="1500" dirty="0" smtClean="0"/>
          </a:p>
          <a:p>
            <a:r>
              <a:rPr lang="en-US" sz="1500" dirty="0" smtClean="0"/>
              <a:t>Blue traces w/out amplification- B.1.351 RNA; 50k copies/</a:t>
            </a:r>
            <a:r>
              <a:rPr lang="en-US" sz="1500" dirty="0" err="1" smtClean="0"/>
              <a:t>rxn</a:t>
            </a:r>
            <a:endParaRPr lang="en-US" sz="1500" dirty="0"/>
          </a:p>
        </p:txBody>
      </p:sp>
      <p:sp>
        <p:nvSpPr>
          <p:cNvPr id="17" name="TextBox 16"/>
          <p:cNvSpPr txBox="1"/>
          <p:nvPr/>
        </p:nvSpPr>
        <p:spPr>
          <a:xfrm>
            <a:off x="7880553" y="3771687"/>
            <a:ext cx="1317524" cy="646331"/>
          </a:xfrm>
          <a:prstGeom prst="rect">
            <a:avLst/>
          </a:prstGeom>
          <a:solidFill>
            <a:schemeClr val="bg1"/>
          </a:solidFill>
        </p:spPr>
        <p:txBody>
          <a:bodyPr wrap="square" rtlCol="0">
            <a:spAutoFit/>
          </a:bodyPr>
          <a:lstStyle/>
          <a:p>
            <a:pPr algn="ctr"/>
            <a:r>
              <a:rPr lang="en-US" b="1" dirty="0" smtClean="0"/>
              <a:t>Alt. probe 2 (longer)</a:t>
            </a:r>
            <a:endParaRPr lang="en-US" b="1" dirty="0"/>
          </a:p>
        </p:txBody>
      </p:sp>
    </p:spTree>
    <p:extLst>
      <p:ext uri="{BB962C8B-B14F-4D97-AF65-F5344CB8AC3E}">
        <p14:creationId xmlns:p14="http://schemas.microsoft.com/office/powerpoint/2010/main" val="203858411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p:nvPr>
            <p:extLst>
              <p:ext uri="{D42A27DB-BD31-4B8C-83A1-F6EECF244321}">
                <p14:modId xmlns:p14="http://schemas.microsoft.com/office/powerpoint/2010/main" val="2354287383"/>
              </p:ext>
            </p:extLst>
          </p:nvPr>
        </p:nvGraphicFramePr>
        <p:xfrm>
          <a:off x="901262" y="769389"/>
          <a:ext cx="8841828" cy="5789066"/>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440871" y="277586"/>
            <a:ext cx="7299998" cy="369332"/>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Figure </a:t>
            </a:r>
            <a:r>
              <a:rPr lang="en-US" b="1" dirty="0" smtClean="0">
                <a:latin typeface="Times New Roman" panose="02020603050405020304" pitchFamily="18" charset="0"/>
                <a:cs typeface="Times New Roman" panose="02020603050405020304" pitchFamily="18" charset="0"/>
              </a:rPr>
              <a:t>S5-a: </a:t>
            </a:r>
            <a:r>
              <a:rPr lang="en-US" b="1" dirty="0" err="1" smtClean="0">
                <a:latin typeface="Times New Roman" panose="02020603050405020304" pitchFamily="18" charset="0"/>
                <a:cs typeface="Times New Roman" panose="02020603050405020304" pitchFamily="18" charset="0"/>
              </a:rPr>
              <a:t>RADx</a:t>
            </a:r>
            <a:r>
              <a:rPr lang="en-US" b="1" dirty="0" smtClean="0">
                <a:latin typeface="Times New Roman" panose="02020603050405020304" pitchFamily="18" charset="0"/>
                <a:cs typeface="Times New Roman" panose="02020603050405020304" pitchFamily="18" charset="0"/>
              </a:rPr>
              <a:t> Samples </a:t>
            </a:r>
            <a:r>
              <a:rPr lang="en-US" b="1" dirty="0">
                <a:latin typeface="Times New Roman" panose="02020603050405020304" pitchFamily="18" charset="0"/>
                <a:cs typeface="Times New Roman" panose="02020603050405020304" pitchFamily="18" charset="0"/>
              </a:rPr>
              <a:t>data (summarized in Table 4</a:t>
            </a:r>
            <a:r>
              <a:rPr lang="en-US" b="1" dirty="0" smtClean="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27457504"/>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440871" y="326572"/>
            <a:ext cx="7662605" cy="369332"/>
          </a:xfrm>
          <a:prstGeom prst="rect">
            <a:avLst/>
          </a:prstGeom>
          <a:noFill/>
        </p:spPr>
        <p:txBody>
          <a:bodyPr wrap="square" rtlCol="0">
            <a:spAutoFit/>
          </a:bodyPr>
          <a:lstStyle/>
          <a:p>
            <a:r>
              <a:rPr lang="en-US" b="1" dirty="0" smtClean="0">
                <a:latin typeface="Times New Roman" panose="02020603050405020304" pitchFamily="18" charset="0"/>
                <a:cs typeface="Times New Roman" panose="02020603050405020304" pitchFamily="18" charset="0"/>
              </a:rPr>
              <a:t>Figure </a:t>
            </a:r>
            <a:r>
              <a:rPr lang="en-US" b="1" dirty="0" smtClean="0">
                <a:latin typeface="Times New Roman" panose="02020603050405020304" pitchFamily="18" charset="0"/>
                <a:cs typeface="Times New Roman" panose="02020603050405020304" pitchFamily="18" charset="0"/>
              </a:rPr>
              <a:t>S5-b: </a:t>
            </a:r>
            <a:r>
              <a:rPr lang="en-US" b="1" dirty="0" smtClean="0">
                <a:latin typeface="Times New Roman" panose="02020603050405020304" pitchFamily="18" charset="0"/>
                <a:cs typeface="Times New Roman" panose="02020603050405020304" pitchFamily="18" charset="0"/>
              </a:rPr>
              <a:t>NHRC Samples Validation data (summarized in Table </a:t>
            </a:r>
            <a:r>
              <a:rPr lang="en-US" b="1" dirty="0">
                <a:latin typeface="Times New Roman" panose="02020603050405020304" pitchFamily="18" charset="0"/>
                <a:cs typeface="Times New Roman" panose="02020603050405020304" pitchFamily="18" charset="0"/>
              </a:rPr>
              <a:t>4</a:t>
            </a:r>
            <a:r>
              <a:rPr lang="en-US" b="1" dirty="0" smtClean="0">
                <a:latin typeface="Times New Roman" panose="02020603050405020304" pitchFamily="18" charset="0"/>
                <a:cs typeface="Times New Roman" panose="02020603050405020304" pitchFamily="18" charset="0"/>
              </a:rPr>
              <a:t>)</a:t>
            </a:r>
            <a:endParaRPr lang="en-US" b="1" dirty="0">
              <a:latin typeface="Times New Roman" panose="02020603050405020304" pitchFamily="18" charset="0"/>
              <a:cs typeface="Times New Roman" panose="02020603050405020304" pitchFamily="18" charset="0"/>
            </a:endParaRPr>
          </a:p>
        </p:txBody>
      </p:sp>
      <p:grpSp>
        <p:nvGrpSpPr>
          <p:cNvPr id="2" name="Group 1"/>
          <p:cNvGrpSpPr/>
          <p:nvPr/>
        </p:nvGrpSpPr>
        <p:grpSpPr>
          <a:xfrm>
            <a:off x="822434" y="900934"/>
            <a:ext cx="9172904" cy="5689052"/>
            <a:chOff x="3124200" y="1704975"/>
            <a:chExt cx="5943600" cy="3448050"/>
          </a:xfrm>
        </p:grpSpPr>
        <p:graphicFrame>
          <p:nvGraphicFramePr>
            <p:cNvPr id="4" name="Chart 3"/>
            <p:cNvGraphicFramePr/>
            <p:nvPr>
              <p:extLst>
                <p:ext uri="{D42A27DB-BD31-4B8C-83A1-F6EECF244321}">
                  <p14:modId xmlns:p14="http://schemas.microsoft.com/office/powerpoint/2010/main" val="2028790536"/>
                </p:ext>
              </p:extLst>
            </p:nvPr>
          </p:nvGraphicFramePr>
          <p:xfrm>
            <a:off x="3124200" y="1704975"/>
            <a:ext cx="5943600" cy="3448050"/>
          </p:xfrm>
          <a:graphic>
            <a:graphicData uri="http://schemas.openxmlformats.org/drawingml/2006/chart">
              <c:chart xmlns:c="http://schemas.openxmlformats.org/drawingml/2006/chart" xmlns:r="http://schemas.openxmlformats.org/officeDocument/2006/relationships" r:id="rId2"/>
            </a:graphicData>
          </a:graphic>
        </p:graphicFrame>
        <p:sp>
          <p:nvSpPr>
            <p:cNvPr id="6" name="Oval 5"/>
            <p:cNvSpPr/>
            <p:nvPr/>
          </p:nvSpPr>
          <p:spPr>
            <a:xfrm>
              <a:off x="4348334" y="3624185"/>
              <a:ext cx="909162" cy="1117965"/>
            </a:xfrm>
            <a:prstGeom prst="ellipse">
              <a:avLst/>
            </a:prstGeom>
            <a:noFill/>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grpSp>
    </p:spTree>
    <p:extLst>
      <p:ext uri="{BB962C8B-B14F-4D97-AF65-F5344CB8AC3E}">
        <p14:creationId xmlns:p14="http://schemas.microsoft.com/office/powerpoint/2010/main" val="405938105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16</TotalTime>
  <Words>634</Words>
  <Application>Microsoft Office PowerPoint</Application>
  <PresentationFormat>Widescreen</PresentationFormat>
  <Paragraphs>49</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Figure S4-a. Triplex 2 Testing with a Dilution Series of Omicron Synthetic RNA (Twist)</vt:lpstr>
      <vt:lpstr>Figure S4-b. Triplex 2 Testing with a Dilution Series of Omicron Synthetic RNA (Twist)</vt:lpstr>
      <vt:lpstr>Figure S4-c. Testing alternative S:69/70 del plus S:A67V probes</vt:lpstr>
      <vt:lpstr>PowerPoint Presentation</vt:lpstr>
      <vt:lpstr>PowerPoint Presentation</vt:lpstr>
    </vt:vector>
  </TitlesOfParts>
  <Company>US Arm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zhamannan, Shanmuga</dc:creator>
  <cp:lastModifiedBy>Sozhamannan, Shanmuga</cp:lastModifiedBy>
  <cp:revision>24</cp:revision>
  <dcterms:created xsi:type="dcterms:W3CDTF">2022-05-04T13:39:36Z</dcterms:created>
  <dcterms:modified xsi:type="dcterms:W3CDTF">2022-07-07T17:12:07Z</dcterms:modified>
</cp:coreProperties>
</file>